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6"/>
  </p:notesMasterIdLst>
  <p:sldIdLst>
    <p:sldId id="259" r:id="rId2"/>
    <p:sldId id="258" r:id="rId3"/>
    <p:sldId id="260" r:id="rId4"/>
    <p:sldId id="261" r:id="rId5"/>
  </p:sldIdLst>
  <p:sldSz cx="7315200" cy="3200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E19EBDC-2132-A248-9866-491E046F890B}" v="1" dt="2024-06-18T23:10:17.66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718"/>
  </p:normalViewPr>
  <p:slideViewPr>
    <p:cSldViewPr snapToGrid="0">
      <p:cViewPr varScale="1">
        <p:scale>
          <a:sx n="198" d="100"/>
          <a:sy n="198" d="100"/>
        </p:scale>
        <p:origin x="200" y="7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inda Peng" userId="0fc38252-2983-43a6-a7c7-e7e17d643643" providerId="ADAL" clId="{5E19EBDC-2132-A248-9866-491E046F890B}"/>
    <pc:docChg chg="addSld modSld">
      <pc:chgData name="Linda Peng" userId="0fc38252-2983-43a6-a7c7-e7e17d643643" providerId="ADAL" clId="{5E19EBDC-2132-A248-9866-491E046F890B}" dt="2024-06-18T23:10:17.658" v="0"/>
      <pc:docMkLst>
        <pc:docMk/>
      </pc:docMkLst>
      <pc:sldChg chg="add">
        <pc:chgData name="Linda Peng" userId="0fc38252-2983-43a6-a7c7-e7e17d643643" providerId="ADAL" clId="{5E19EBDC-2132-A248-9866-491E046F890B}" dt="2024-06-18T23:10:17.658" v="0"/>
        <pc:sldMkLst>
          <pc:docMk/>
          <pc:sldMk cId="3781626750" sldId="260"/>
        </pc:sldMkLst>
      </pc:sldChg>
      <pc:sldChg chg="add">
        <pc:chgData name="Linda Peng" userId="0fc38252-2983-43a6-a7c7-e7e17d643643" providerId="ADAL" clId="{5E19EBDC-2132-A248-9866-491E046F890B}" dt="2024-06-18T23:10:17.658" v="0"/>
        <pc:sldMkLst>
          <pc:docMk/>
          <pc:sldMk cId="566478664" sldId="261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9EA6E43-16D2-4CF9-A08C-C4B22E94C491}" type="datetimeFigureOut">
              <a:rPr lang="en-US" smtClean="0"/>
              <a:t>6/18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-96838" y="1143000"/>
            <a:ext cx="7051676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0BCE0BF-89E8-455A-A846-C894BD8D57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48146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0BCE0BF-89E8-455A-A846-C894BD8D57A7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389977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0BCE0BF-89E8-455A-A846-C894BD8D57A7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38997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523770"/>
            <a:ext cx="5486400" cy="1114213"/>
          </a:xfrm>
        </p:spPr>
        <p:txBody>
          <a:bodyPr anchor="b"/>
          <a:lstStyle>
            <a:lvl1pPr algn="ctr">
              <a:defRPr sz="2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1680951"/>
            <a:ext cx="5486400" cy="772689"/>
          </a:xfrm>
        </p:spPr>
        <p:txBody>
          <a:bodyPr/>
          <a:lstStyle>
            <a:lvl1pPr marL="0" indent="0" algn="ctr">
              <a:buNone/>
              <a:defRPr sz="1120"/>
            </a:lvl1pPr>
            <a:lvl2pPr marL="213375" indent="0" algn="ctr">
              <a:buNone/>
              <a:defRPr sz="933"/>
            </a:lvl2pPr>
            <a:lvl3pPr marL="426750" indent="0" algn="ctr">
              <a:buNone/>
              <a:defRPr sz="840"/>
            </a:lvl3pPr>
            <a:lvl4pPr marL="640126" indent="0" algn="ctr">
              <a:buNone/>
              <a:defRPr sz="747"/>
            </a:lvl4pPr>
            <a:lvl5pPr marL="853501" indent="0" algn="ctr">
              <a:buNone/>
              <a:defRPr sz="747"/>
            </a:lvl5pPr>
            <a:lvl6pPr marL="1066876" indent="0" algn="ctr">
              <a:buNone/>
              <a:defRPr sz="747"/>
            </a:lvl6pPr>
            <a:lvl7pPr marL="1280251" indent="0" algn="ctr">
              <a:buNone/>
              <a:defRPr sz="747"/>
            </a:lvl7pPr>
            <a:lvl8pPr marL="1493627" indent="0" algn="ctr">
              <a:buNone/>
              <a:defRPr sz="747"/>
            </a:lvl8pPr>
            <a:lvl9pPr marL="1707002" indent="0" algn="ctr">
              <a:buNone/>
              <a:defRPr sz="747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B2285-4DD0-4344-851B-863183656B85}" type="datetimeFigureOut">
              <a:rPr lang="en-US" smtClean="0"/>
              <a:t>6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BAB604-8BD2-449E-B847-AE6F1B3FB2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15928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B2285-4DD0-4344-851B-863183656B85}" type="datetimeFigureOut">
              <a:rPr lang="en-US" smtClean="0"/>
              <a:t>6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BAB604-8BD2-449E-B847-AE6F1B3FB2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70671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170392"/>
            <a:ext cx="1577340" cy="2712191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170392"/>
            <a:ext cx="4640580" cy="271219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B2285-4DD0-4344-851B-863183656B85}" type="datetimeFigureOut">
              <a:rPr lang="en-US" smtClean="0"/>
              <a:t>6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BAB604-8BD2-449E-B847-AE6F1B3FB2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12257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B2285-4DD0-4344-851B-863183656B85}" type="datetimeFigureOut">
              <a:rPr lang="en-US" smtClean="0"/>
              <a:t>6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BAB604-8BD2-449E-B847-AE6F1B3FB2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05989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797878"/>
            <a:ext cx="6309360" cy="1331277"/>
          </a:xfrm>
        </p:spPr>
        <p:txBody>
          <a:bodyPr anchor="b"/>
          <a:lstStyle>
            <a:lvl1pPr>
              <a:defRPr sz="2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2141750"/>
            <a:ext cx="6309360" cy="700087"/>
          </a:xfrm>
        </p:spPr>
        <p:txBody>
          <a:bodyPr/>
          <a:lstStyle>
            <a:lvl1pPr marL="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1pPr>
            <a:lvl2pPr marL="213375" indent="0">
              <a:buNone/>
              <a:defRPr sz="933">
                <a:solidFill>
                  <a:schemeClr val="tx1">
                    <a:tint val="75000"/>
                  </a:schemeClr>
                </a:solidFill>
              </a:defRPr>
            </a:lvl2pPr>
            <a:lvl3pPr marL="426750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3pPr>
            <a:lvl4pPr marL="640126" indent="0">
              <a:buNone/>
              <a:defRPr sz="747">
                <a:solidFill>
                  <a:schemeClr val="tx1">
                    <a:tint val="75000"/>
                  </a:schemeClr>
                </a:solidFill>
              </a:defRPr>
            </a:lvl4pPr>
            <a:lvl5pPr marL="853501" indent="0">
              <a:buNone/>
              <a:defRPr sz="747">
                <a:solidFill>
                  <a:schemeClr val="tx1">
                    <a:tint val="75000"/>
                  </a:schemeClr>
                </a:solidFill>
              </a:defRPr>
            </a:lvl5pPr>
            <a:lvl6pPr marL="1066876" indent="0">
              <a:buNone/>
              <a:defRPr sz="747">
                <a:solidFill>
                  <a:schemeClr val="tx1">
                    <a:tint val="75000"/>
                  </a:schemeClr>
                </a:solidFill>
              </a:defRPr>
            </a:lvl6pPr>
            <a:lvl7pPr marL="1280251" indent="0">
              <a:buNone/>
              <a:defRPr sz="747">
                <a:solidFill>
                  <a:schemeClr val="tx1">
                    <a:tint val="75000"/>
                  </a:schemeClr>
                </a:solidFill>
              </a:defRPr>
            </a:lvl7pPr>
            <a:lvl8pPr marL="1493627" indent="0">
              <a:buNone/>
              <a:defRPr sz="747">
                <a:solidFill>
                  <a:schemeClr val="tx1">
                    <a:tint val="75000"/>
                  </a:schemeClr>
                </a:solidFill>
              </a:defRPr>
            </a:lvl8pPr>
            <a:lvl9pPr marL="1707002" indent="0">
              <a:buNone/>
              <a:defRPr sz="74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B2285-4DD0-4344-851B-863183656B85}" type="datetimeFigureOut">
              <a:rPr lang="en-US" smtClean="0"/>
              <a:t>6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BAB604-8BD2-449E-B847-AE6F1B3FB2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49113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851959"/>
            <a:ext cx="3108960" cy="203062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851959"/>
            <a:ext cx="3108960" cy="203062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B2285-4DD0-4344-851B-863183656B85}" type="datetimeFigureOut">
              <a:rPr lang="en-US" smtClean="0"/>
              <a:t>6/1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BAB604-8BD2-449E-B847-AE6F1B3FB2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90181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170392"/>
            <a:ext cx="6309360" cy="61859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3" y="784543"/>
            <a:ext cx="3094672" cy="384492"/>
          </a:xfrm>
        </p:spPr>
        <p:txBody>
          <a:bodyPr anchor="b"/>
          <a:lstStyle>
            <a:lvl1pPr marL="0" indent="0">
              <a:buNone/>
              <a:defRPr sz="1120" b="1"/>
            </a:lvl1pPr>
            <a:lvl2pPr marL="213375" indent="0">
              <a:buNone/>
              <a:defRPr sz="933" b="1"/>
            </a:lvl2pPr>
            <a:lvl3pPr marL="426750" indent="0">
              <a:buNone/>
              <a:defRPr sz="840" b="1"/>
            </a:lvl3pPr>
            <a:lvl4pPr marL="640126" indent="0">
              <a:buNone/>
              <a:defRPr sz="747" b="1"/>
            </a:lvl4pPr>
            <a:lvl5pPr marL="853501" indent="0">
              <a:buNone/>
              <a:defRPr sz="747" b="1"/>
            </a:lvl5pPr>
            <a:lvl6pPr marL="1066876" indent="0">
              <a:buNone/>
              <a:defRPr sz="747" b="1"/>
            </a:lvl6pPr>
            <a:lvl7pPr marL="1280251" indent="0">
              <a:buNone/>
              <a:defRPr sz="747" b="1"/>
            </a:lvl7pPr>
            <a:lvl8pPr marL="1493627" indent="0">
              <a:buNone/>
              <a:defRPr sz="747" b="1"/>
            </a:lvl8pPr>
            <a:lvl9pPr marL="1707002" indent="0">
              <a:buNone/>
              <a:defRPr sz="74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3" y="1169035"/>
            <a:ext cx="3094672" cy="171947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784543"/>
            <a:ext cx="3109913" cy="384492"/>
          </a:xfrm>
        </p:spPr>
        <p:txBody>
          <a:bodyPr anchor="b"/>
          <a:lstStyle>
            <a:lvl1pPr marL="0" indent="0">
              <a:buNone/>
              <a:defRPr sz="1120" b="1"/>
            </a:lvl1pPr>
            <a:lvl2pPr marL="213375" indent="0">
              <a:buNone/>
              <a:defRPr sz="933" b="1"/>
            </a:lvl2pPr>
            <a:lvl3pPr marL="426750" indent="0">
              <a:buNone/>
              <a:defRPr sz="840" b="1"/>
            </a:lvl3pPr>
            <a:lvl4pPr marL="640126" indent="0">
              <a:buNone/>
              <a:defRPr sz="747" b="1"/>
            </a:lvl4pPr>
            <a:lvl5pPr marL="853501" indent="0">
              <a:buNone/>
              <a:defRPr sz="747" b="1"/>
            </a:lvl5pPr>
            <a:lvl6pPr marL="1066876" indent="0">
              <a:buNone/>
              <a:defRPr sz="747" b="1"/>
            </a:lvl6pPr>
            <a:lvl7pPr marL="1280251" indent="0">
              <a:buNone/>
              <a:defRPr sz="747" b="1"/>
            </a:lvl7pPr>
            <a:lvl8pPr marL="1493627" indent="0">
              <a:buNone/>
              <a:defRPr sz="747" b="1"/>
            </a:lvl8pPr>
            <a:lvl9pPr marL="1707002" indent="0">
              <a:buNone/>
              <a:defRPr sz="74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1169035"/>
            <a:ext cx="3109913" cy="171947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B2285-4DD0-4344-851B-863183656B85}" type="datetimeFigureOut">
              <a:rPr lang="en-US" smtClean="0"/>
              <a:t>6/18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BAB604-8BD2-449E-B847-AE6F1B3FB2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19385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B2285-4DD0-4344-851B-863183656B85}" type="datetimeFigureOut">
              <a:rPr lang="en-US" smtClean="0"/>
              <a:t>6/18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BAB604-8BD2-449E-B847-AE6F1B3FB2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98311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B2285-4DD0-4344-851B-863183656B85}" type="datetimeFigureOut">
              <a:rPr lang="en-US" smtClean="0"/>
              <a:t>6/18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BAB604-8BD2-449E-B847-AE6F1B3FB2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47443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213360"/>
            <a:ext cx="2359342" cy="746760"/>
          </a:xfrm>
        </p:spPr>
        <p:txBody>
          <a:bodyPr anchor="b"/>
          <a:lstStyle>
            <a:lvl1pPr>
              <a:defRPr sz="149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460799"/>
            <a:ext cx="3703320" cy="2274358"/>
          </a:xfrm>
        </p:spPr>
        <p:txBody>
          <a:bodyPr/>
          <a:lstStyle>
            <a:lvl1pPr>
              <a:defRPr sz="1493"/>
            </a:lvl1pPr>
            <a:lvl2pPr>
              <a:defRPr sz="1307"/>
            </a:lvl2pPr>
            <a:lvl3pPr>
              <a:defRPr sz="1120"/>
            </a:lvl3pPr>
            <a:lvl4pPr>
              <a:defRPr sz="933"/>
            </a:lvl4pPr>
            <a:lvl5pPr>
              <a:defRPr sz="933"/>
            </a:lvl5pPr>
            <a:lvl6pPr>
              <a:defRPr sz="933"/>
            </a:lvl6pPr>
            <a:lvl7pPr>
              <a:defRPr sz="933"/>
            </a:lvl7pPr>
            <a:lvl8pPr>
              <a:defRPr sz="933"/>
            </a:lvl8pPr>
            <a:lvl9pPr>
              <a:defRPr sz="93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960120"/>
            <a:ext cx="2359342" cy="1778741"/>
          </a:xfrm>
        </p:spPr>
        <p:txBody>
          <a:bodyPr/>
          <a:lstStyle>
            <a:lvl1pPr marL="0" indent="0">
              <a:buNone/>
              <a:defRPr sz="747"/>
            </a:lvl1pPr>
            <a:lvl2pPr marL="213375" indent="0">
              <a:buNone/>
              <a:defRPr sz="653"/>
            </a:lvl2pPr>
            <a:lvl3pPr marL="426750" indent="0">
              <a:buNone/>
              <a:defRPr sz="560"/>
            </a:lvl3pPr>
            <a:lvl4pPr marL="640126" indent="0">
              <a:buNone/>
              <a:defRPr sz="467"/>
            </a:lvl4pPr>
            <a:lvl5pPr marL="853501" indent="0">
              <a:buNone/>
              <a:defRPr sz="467"/>
            </a:lvl5pPr>
            <a:lvl6pPr marL="1066876" indent="0">
              <a:buNone/>
              <a:defRPr sz="467"/>
            </a:lvl6pPr>
            <a:lvl7pPr marL="1280251" indent="0">
              <a:buNone/>
              <a:defRPr sz="467"/>
            </a:lvl7pPr>
            <a:lvl8pPr marL="1493627" indent="0">
              <a:buNone/>
              <a:defRPr sz="467"/>
            </a:lvl8pPr>
            <a:lvl9pPr marL="1707002" indent="0">
              <a:buNone/>
              <a:defRPr sz="46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B2285-4DD0-4344-851B-863183656B85}" type="datetimeFigureOut">
              <a:rPr lang="en-US" smtClean="0"/>
              <a:t>6/1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BAB604-8BD2-449E-B847-AE6F1B3FB2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57785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213360"/>
            <a:ext cx="2359342" cy="746760"/>
          </a:xfrm>
        </p:spPr>
        <p:txBody>
          <a:bodyPr anchor="b"/>
          <a:lstStyle>
            <a:lvl1pPr>
              <a:defRPr sz="149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460799"/>
            <a:ext cx="3703320" cy="2274358"/>
          </a:xfrm>
        </p:spPr>
        <p:txBody>
          <a:bodyPr anchor="t"/>
          <a:lstStyle>
            <a:lvl1pPr marL="0" indent="0">
              <a:buNone/>
              <a:defRPr sz="1493"/>
            </a:lvl1pPr>
            <a:lvl2pPr marL="213375" indent="0">
              <a:buNone/>
              <a:defRPr sz="1307"/>
            </a:lvl2pPr>
            <a:lvl3pPr marL="426750" indent="0">
              <a:buNone/>
              <a:defRPr sz="1120"/>
            </a:lvl3pPr>
            <a:lvl4pPr marL="640126" indent="0">
              <a:buNone/>
              <a:defRPr sz="933"/>
            </a:lvl4pPr>
            <a:lvl5pPr marL="853501" indent="0">
              <a:buNone/>
              <a:defRPr sz="933"/>
            </a:lvl5pPr>
            <a:lvl6pPr marL="1066876" indent="0">
              <a:buNone/>
              <a:defRPr sz="933"/>
            </a:lvl6pPr>
            <a:lvl7pPr marL="1280251" indent="0">
              <a:buNone/>
              <a:defRPr sz="933"/>
            </a:lvl7pPr>
            <a:lvl8pPr marL="1493627" indent="0">
              <a:buNone/>
              <a:defRPr sz="933"/>
            </a:lvl8pPr>
            <a:lvl9pPr marL="1707002" indent="0">
              <a:buNone/>
              <a:defRPr sz="933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960120"/>
            <a:ext cx="2359342" cy="1778741"/>
          </a:xfrm>
        </p:spPr>
        <p:txBody>
          <a:bodyPr/>
          <a:lstStyle>
            <a:lvl1pPr marL="0" indent="0">
              <a:buNone/>
              <a:defRPr sz="747"/>
            </a:lvl1pPr>
            <a:lvl2pPr marL="213375" indent="0">
              <a:buNone/>
              <a:defRPr sz="653"/>
            </a:lvl2pPr>
            <a:lvl3pPr marL="426750" indent="0">
              <a:buNone/>
              <a:defRPr sz="560"/>
            </a:lvl3pPr>
            <a:lvl4pPr marL="640126" indent="0">
              <a:buNone/>
              <a:defRPr sz="467"/>
            </a:lvl4pPr>
            <a:lvl5pPr marL="853501" indent="0">
              <a:buNone/>
              <a:defRPr sz="467"/>
            </a:lvl5pPr>
            <a:lvl6pPr marL="1066876" indent="0">
              <a:buNone/>
              <a:defRPr sz="467"/>
            </a:lvl6pPr>
            <a:lvl7pPr marL="1280251" indent="0">
              <a:buNone/>
              <a:defRPr sz="467"/>
            </a:lvl7pPr>
            <a:lvl8pPr marL="1493627" indent="0">
              <a:buNone/>
              <a:defRPr sz="467"/>
            </a:lvl8pPr>
            <a:lvl9pPr marL="1707002" indent="0">
              <a:buNone/>
              <a:defRPr sz="46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B2285-4DD0-4344-851B-863183656B85}" type="datetimeFigureOut">
              <a:rPr lang="en-US" smtClean="0"/>
              <a:t>6/1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BAB604-8BD2-449E-B847-AE6F1B3FB2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22614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170392"/>
            <a:ext cx="6309360" cy="6185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851959"/>
            <a:ext cx="6309360" cy="20306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2966297"/>
            <a:ext cx="1645920" cy="1703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5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3B2285-4DD0-4344-851B-863183656B85}" type="datetimeFigureOut">
              <a:rPr lang="en-US" smtClean="0"/>
              <a:t>6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2966297"/>
            <a:ext cx="2468880" cy="1703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5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2966297"/>
            <a:ext cx="1645920" cy="1703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5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BAB604-8BD2-449E-B847-AE6F1B3FB2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28302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426750" rtl="0" eaLnBrk="1" latinLnBrk="0" hangingPunct="1">
        <a:lnSpc>
          <a:spcPct val="90000"/>
        </a:lnSpc>
        <a:spcBef>
          <a:spcPct val="0"/>
        </a:spcBef>
        <a:buNone/>
        <a:defRPr sz="205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06688" indent="-106688" algn="l" defTabSz="426750" rtl="0" eaLnBrk="1" latinLnBrk="0" hangingPunct="1">
        <a:lnSpc>
          <a:spcPct val="90000"/>
        </a:lnSpc>
        <a:spcBef>
          <a:spcPts val="467"/>
        </a:spcBef>
        <a:buFont typeface="Arial" panose="020B0604020202020204" pitchFamily="34" charset="0"/>
        <a:buChar char="•"/>
        <a:defRPr sz="1307" kern="1200">
          <a:solidFill>
            <a:schemeClr val="tx1"/>
          </a:solidFill>
          <a:latin typeface="+mn-lt"/>
          <a:ea typeface="+mn-ea"/>
          <a:cs typeface="+mn-cs"/>
        </a:defRPr>
      </a:lvl1pPr>
      <a:lvl2pPr marL="320063" indent="-106688" algn="l" defTabSz="426750" rtl="0" eaLnBrk="1" latinLnBrk="0" hangingPunct="1">
        <a:lnSpc>
          <a:spcPct val="90000"/>
        </a:lnSpc>
        <a:spcBef>
          <a:spcPts val="233"/>
        </a:spcBef>
        <a:buFont typeface="Arial" panose="020B0604020202020204" pitchFamily="34" charset="0"/>
        <a:buChar char="•"/>
        <a:defRPr sz="1120" kern="1200">
          <a:solidFill>
            <a:schemeClr val="tx1"/>
          </a:solidFill>
          <a:latin typeface="+mn-lt"/>
          <a:ea typeface="+mn-ea"/>
          <a:cs typeface="+mn-cs"/>
        </a:defRPr>
      </a:lvl2pPr>
      <a:lvl3pPr marL="533438" indent="-106688" algn="l" defTabSz="426750" rtl="0" eaLnBrk="1" latinLnBrk="0" hangingPunct="1">
        <a:lnSpc>
          <a:spcPct val="90000"/>
        </a:lnSpc>
        <a:spcBef>
          <a:spcPts val="233"/>
        </a:spcBef>
        <a:buFont typeface="Arial" panose="020B0604020202020204" pitchFamily="34" charset="0"/>
        <a:buChar char="•"/>
        <a:defRPr sz="933" kern="1200">
          <a:solidFill>
            <a:schemeClr val="tx1"/>
          </a:solidFill>
          <a:latin typeface="+mn-lt"/>
          <a:ea typeface="+mn-ea"/>
          <a:cs typeface="+mn-cs"/>
        </a:defRPr>
      </a:lvl3pPr>
      <a:lvl4pPr marL="746813" indent="-106688" algn="l" defTabSz="426750" rtl="0" eaLnBrk="1" latinLnBrk="0" hangingPunct="1">
        <a:lnSpc>
          <a:spcPct val="90000"/>
        </a:lnSpc>
        <a:spcBef>
          <a:spcPts val="233"/>
        </a:spcBef>
        <a:buFont typeface="Arial" panose="020B0604020202020204" pitchFamily="34" charset="0"/>
        <a:buChar char="•"/>
        <a:defRPr sz="840" kern="1200">
          <a:solidFill>
            <a:schemeClr val="tx1"/>
          </a:solidFill>
          <a:latin typeface="+mn-lt"/>
          <a:ea typeface="+mn-ea"/>
          <a:cs typeface="+mn-cs"/>
        </a:defRPr>
      </a:lvl4pPr>
      <a:lvl5pPr marL="960189" indent="-106688" algn="l" defTabSz="426750" rtl="0" eaLnBrk="1" latinLnBrk="0" hangingPunct="1">
        <a:lnSpc>
          <a:spcPct val="90000"/>
        </a:lnSpc>
        <a:spcBef>
          <a:spcPts val="233"/>
        </a:spcBef>
        <a:buFont typeface="Arial" panose="020B0604020202020204" pitchFamily="34" charset="0"/>
        <a:buChar char="•"/>
        <a:defRPr sz="840" kern="1200">
          <a:solidFill>
            <a:schemeClr val="tx1"/>
          </a:solidFill>
          <a:latin typeface="+mn-lt"/>
          <a:ea typeface="+mn-ea"/>
          <a:cs typeface="+mn-cs"/>
        </a:defRPr>
      </a:lvl5pPr>
      <a:lvl6pPr marL="1173564" indent="-106688" algn="l" defTabSz="426750" rtl="0" eaLnBrk="1" latinLnBrk="0" hangingPunct="1">
        <a:lnSpc>
          <a:spcPct val="90000"/>
        </a:lnSpc>
        <a:spcBef>
          <a:spcPts val="233"/>
        </a:spcBef>
        <a:buFont typeface="Arial" panose="020B0604020202020204" pitchFamily="34" charset="0"/>
        <a:buChar char="•"/>
        <a:defRPr sz="840" kern="1200">
          <a:solidFill>
            <a:schemeClr val="tx1"/>
          </a:solidFill>
          <a:latin typeface="+mn-lt"/>
          <a:ea typeface="+mn-ea"/>
          <a:cs typeface="+mn-cs"/>
        </a:defRPr>
      </a:lvl6pPr>
      <a:lvl7pPr marL="1386939" indent="-106688" algn="l" defTabSz="426750" rtl="0" eaLnBrk="1" latinLnBrk="0" hangingPunct="1">
        <a:lnSpc>
          <a:spcPct val="90000"/>
        </a:lnSpc>
        <a:spcBef>
          <a:spcPts val="233"/>
        </a:spcBef>
        <a:buFont typeface="Arial" panose="020B0604020202020204" pitchFamily="34" charset="0"/>
        <a:buChar char="•"/>
        <a:defRPr sz="840" kern="1200">
          <a:solidFill>
            <a:schemeClr val="tx1"/>
          </a:solidFill>
          <a:latin typeface="+mn-lt"/>
          <a:ea typeface="+mn-ea"/>
          <a:cs typeface="+mn-cs"/>
        </a:defRPr>
      </a:lvl7pPr>
      <a:lvl8pPr marL="1600314" indent="-106688" algn="l" defTabSz="426750" rtl="0" eaLnBrk="1" latinLnBrk="0" hangingPunct="1">
        <a:lnSpc>
          <a:spcPct val="90000"/>
        </a:lnSpc>
        <a:spcBef>
          <a:spcPts val="233"/>
        </a:spcBef>
        <a:buFont typeface="Arial" panose="020B0604020202020204" pitchFamily="34" charset="0"/>
        <a:buChar char="•"/>
        <a:defRPr sz="840" kern="1200">
          <a:solidFill>
            <a:schemeClr val="tx1"/>
          </a:solidFill>
          <a:latin typeface="+mn-lt"/>
          <a:ea typeface="+mn-ea"/>
          <a:cs typeface="+mn-cs"/>
        </a:defRPr>
      </a:lvl8pPr>
      <a:lvl9pPr marL="1813690" indent="-106688" algn="l" defTabSz="426750" rtl="0" eaLnBrk="1" latinLnBrk="0" hangingPunct="1">
        <a:lnSpc>
          <a:spcPct val="90000"/>
        </a:lnSpc>
        <a:spcBef>
          <a:spcPts val="233"/>
        </a:spcBef>
        <a:buFont typeface="Arial" panose="020B0604020202020204" pitchFamily="34" charset="0"/>
        <a:buChar char="•"/>
        <a:defRPr sz="8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26750" rtl="0" eaLnBrk="1" latinLnBrk="0" hangingPunct="1">
        <a:defRPr sz="840" kern="1200">
          <a:solidFill>
            <a:schemeClr val="tx1"/>
          </a:solidFill>
          <a:latin typeface="+mn-lt"/>
          <a:ea typeface="+mn-ea"/>
          <a:cs typeface="+mn-cs"/>
        </a:defRPr>
      </a:lvl1pPr>
      <a:lvl2pPr marL="213375" algn="l" defTabSz="426750" rtl="0" eaLnBrk="1" latinLnBrk="0" hangingPunct="1">
        <a:defRPr sz="840" kern="1200">
          <a:solidFill>
            <a:schemeClr val="tx1"/>
          </a:solidFill>
          <a:latin typeface="+mn-lt"/>
          <a:ea typeface="+mn-ea"/>
          <a:cs typeface="+mn-cs"/>
        </a:defRPr>
      </a:lvl2pPr>
      <a:lvl3pPr marL="426750" algn="l" defTabSz="426750" rtl="0" eaLnBrk="1" latinLnBrk="0" hangingPunct="1">
        <a:defRPr sz="840" kern="1200">
          <a:solidFill>
            <a:schemeClr val="tx1"/>
          </a:solidFill>
          <a:latin typeface="+mn-lt"/>
          <a:ea typeface="+mn-ea"/>
          <a:cs typeface="+mn-cs"/>
        </a:defRPr>
      </a:lvl3pPr>
      <a:lvl4pPr marL="640126" algn="l" defTabSz="426750" rtl="0" eaLnBrk="1" latinLnBrk="0" hangingPunct="1">
        <a:defRPr sz="840" kern="1200">
          <a:solidFill>
            <a:schemeClr val="tx1"/>
          </a:solidFill>
          <a:latin typeface="+mn-lt"/>
          <a:ea typeface="+mn-ea"/>
          <a:cs typeface="+mn-cs"/>
        </a:defRPr>
      </a:lvl4pPr>
      <a:lvl5pPr marL="853501" algn="l" defTabSz="426750" rtl="0" eaLnBrk="1" latinLnBrk="0" hangingPunct="1">
        <a:defRPr sz="840" kern="1200">
          <a:solidFill>
            <a:schemeClr val="tx1"/>
          </a:solidFill>
          <a:latin typeface="+mn-lt"/>
          <a:ea typeface="+mn-ea"/>
          <a:cs typeface="+mn-cs"/>
        </a:defRPr>
      </a:lvl5pPr>
      <a:lvl6pPr marL="1066876" algn="l" defTabSz="426750" rtl="0" eaLnBrk="1" latinLnBrk="0" hangingPunct="1">
        <a:defRPr sz="840" kern="1200">
          <a:solidFill>
            <a:schemeClr val="tx1"/>
          </a:solidFill>
          <a:latin typeface="+mn-lt"/>
          <a:ea typeface="+mn-ea"/>
          <a:cs typeface="+mn-cs"/>
        </a:defRPr>
      </a:lvl6pPr>
      <a:lvl7pPr marL="1280251" algn="l" defTabSz="426750" rtl="0" eaLnBrk="1" latinLnBrk="0" hangingPunct="1">
        <a:defRPr sz="840" kern="1200">
          <a:solidFill>
            <a:schemeClr val="tx1"/>
          </a:solidFill>
          <a:latin typeface="+mn-lt"/>
          <a:ea typeface="+mn-ea"/>
          <a:cs typeface="+mn-cs"/>
        </a:defRPr>
      </a:lvl7pPr>
      <a:lvl8pPr marL="1493627" algn="l" defTabSz="426750" rtl="0" eaLnBrk="1" latinLnBrk="0" hangingPunct="1">
        <a:defRPr sz="840" kern="1200">
          <a:solidFill>
            <a:schemeClr val="tx1"/>
          </a:solidFill>
          <a:latin typeface="+mn-lt"/>
          <a:ea typeface="+mn-ea"/>
          <a:cs typeface="+mn-cs"/>
        </a:defRPr>
      </a:lvl8pPr>
      <a:lvl9pPr marL="1707002" algn="l" defTabSz="426750" rtl="0" eaLnBrk="1" latinLnBrk="0" hangingPunct="1">
        <a:defRPr sz="8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svg"/><Relationship Id="rId3" Type="http://schemas.openxmlformats.org/officeDocument/2006/relationships/image" Target="../media/image4.png"/><Relationship Id="rId7" Type="http://schemas.openxmlformats.org/officeDocument/2006/relationships/image" Target="../media/image8.png"/><Relationship Id="rId12" Type="http://schemas.openxmlformats.org/officeDocument/2006/relationships/image" Target="../media/image13.sv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.svg"/><Relationship Id="rId11" Type="http://schemas.openxmlformats.org/officeDocument/2006/relationships/image" Target="../media/image12.png"/><Relationship Id="rId5" Type="http://schemas.openxmlformats.org/officeDocument/2006/relationships/image" Target="../media/image6.png"/><Relationship Id="rId10" Type="http://schemas.openxmlformats.org/officeDocument/2006/relationships/image" Target="../media/image11.svg"/><Relationship Id="rId4" Type="http://schemas.openxmlformats.org/officeDocument/2006/relationships/image" Target="../media/image5.svg"/><Relationship Id="rId9" Type="http://schemas.openxmlformats.org/officeDocument/2006/relationships/image" Target="../media/image10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6.png"/><Relationship Id="rId5" Type="http://schemas.microsoft.com/office/2007/relationships/hdphoto" Target="../media/hdphoto2.wdp"/><Relationship Id="rId4" Type="http://schemas.openxmlformats.org/officeDocument/2006/relationships/image" Target="../media/image1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microsoft.com/office/2007/relationships/hdphoto" Target="../media/hdphoto3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2" name="Rectangle 221">
            <a:extLst>
              <a:ext uri="{FF2B5EF4-FFF2-40B4-BE49-F238E27FC236}">
                <a16:creationId xmlns:a16="http://schemas.microsoft.com/office/drawing/2014/main" id="{50C7EF86-F81C-B235-D8D7-33A407B4A9B8}"/>
              </a:ext>
            </a:extLst>
          </p:cNvPr>
          <p:cNvSpPr/>
          <p:nvPr/>
        </p:nvSpPr>
        <p:spPr>
          <a:xfrm>
            <a:off x="3661106" y="1788"/>
            <a:ext cx="3651923" cy="3200400"/>
          </a:xfrm>
          <a:prstGeom prst="rect">
            <a:avLst/>
          </a:prstGeom>
          <a:solidFill>
            <a:schemeClr val="accent2">
              <a:lumMod val="75000"/>
            </a:schemeClr>
          </a:solidFill>
          <a:ln>
            <a:noFill/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85" dirty="0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79B1B53B-70B6-DA0A-2E75-7496B3B03DE4}"/>
              </a:ext>
            </a:extLst>
          </p:cNvPr>
          <p:cNvSpPr/>
          <p:nvPr/>
        </p:nvSpPr>
        <p:spPr>
          <a:xfrm>
            <a:off x="0" y="0"/>
            <a:ext cx="7315200" cy="3200400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150" dirty="0"/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CFCE2E8E-B4B4-A976-DFA0-E07F9930D3D4}"/>
              </a:ext>
            </a:extLst>
          </p:cNvPr>
          <p:cNvCxnSpPr>
            <a:cxnSpLocks/>
          </p:cNvCxnSpPr>
          <p:nvPr/>
        </p:nvCxnSpPr>
        <p:spPr>
          <a:xfrm>
            <a:off x="1828800" y="-2385"/>
            <a:ext cx="0" cy="320040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D72266AE-6017-E383-BA58-6E4A9CA16BD9}"/>
              </a:ext>
            </a:extLst>
          </p:cNvPr>
          <p:cNvCxnSpPr>
            <a:cxnSpLocks/>
          </p:cNvCxnSpPr>
          <p:nvPr/>
        </p:nvCxnSpPr>
        <p:spPr>
          <a:xfrm>
            <a:off x="3654095" y="24581"/>
            <a:ext cx="0" cy="320040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15" name="Group 114">
            <a:extLst>
              <a:ext uri="{FF2B5EF4-FFF2-40B4-BE49-F238E27FC236}">
                <a16:creationId xmlns:a16="http://schemas.microsoft.com/office/drawing/2014/main" id="{113B21A3-3341-EC6D-3474-B761C3FB9FE9}"/>
              </a:ext>
            </a:extLst>
          </p:cNvPr>
          <p:cNvGrpSpPr/>
          <p:nvPr/>
        </p:nvGrpSpPr>
        <p:grpSpPr>
          <a:xfrm>
            <a:off x="-144864" y="73679"/>
            <a:ext cx="2145612" cy="3028947"/>
            <a:chOff x="-2297191" y="73679"/>
            <a:chExt cx="2145612" cy="3028947"/>
          </a:xfrm>
        </p:grpSpPr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E8A2EC8F-1406-CBAF-AF49-21104BB1D84A}"/>
                </a:ext>
              </a:extLst>
            </p:cNvPr>
            <p:cNvSpPr txBox="1"/>
            <p:nvPr/>
          </p:nvSpPr>
          <p:spPr>
            <a:xfrm>
              <a:off x="-2297191" y="154783"/>
              <a:ext cx="21456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AVOID OVERDOSE</a:t>
              </a:r>
            </a:p>
          </p:txBody>
        </p: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A6BD3497-6287-9257-FDAB-F5F12A80F1A8}"/>
                </a:ext>
              </a:extLst>
            </p:cNvPr>
            <p:cNvSpPr txBox="1"/>
            <p:nvPr/>
          </p:nvSpPr>
          <p:spPr>
            <a:xfrm>
              <a:off x="-2036988" y="583404"/>
              <a:ext cx="1618283" cy="24622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235745" indent="-235745">
                <a:buFont typeface="Wingdings" panose="05000000000000000000" pitchFamily="2" charset="2"/>
                <a:buChar char="§"/>
              </a:pPr>
              <a:r>
                <a:rPr lang="en-US" sz="1100" dirty="0"/>
                <a:t>Use with a friend or around other people</a:t>
              </a:r>
            </a:p>
            <a:p>
              <a:pPr marL="235745" indent="-235745">
                <a:buFont typeface="Wingdings" panose="05000000000000000000" pitchFamily="2" charset="2"/>
                <a:buChar char="§"/>
              </a:pPr>
              <a:r>
                <a:rPr lang="en-US" sz="1100" dirty="0"/>
                <a:t>If using with a friend, take turns in case it is a strong drug</a:t>
              </a:r>
            </a:p>
            <a:p>
              <a:pPr marL="235745" indent="-235745">
                <a:buFont typeface="Wingdings" panose="05000000000000000000" pitchFamily="2" charset="2"/>
                <a:buChar char="§"/>
              </a:pPr>
              <a:r>
                <a:rPr lang="en-US" sz="1100" dirty="0"/>
                <a:t>Have naloxone out and ready</a:t>
              </a:r>
            </a:p>
            <a:p>
              <a:pPr marL="235745" indent="-235745">
                <a:buFont typeface="Wingdings" panose="05000000000000000000" pitchFamily="2" charset="2"/>
                <a:buChar char="§"/>
              </a:pPr>
              <a:r>
                <a:rPr lang="en-US" sz="1100" dirty="0"/>
                <a:t>Use one drug at a time</a:t>
              </a:r>
            </a:p>
            <a:p>
              <a:pPr marL="235745" indent="-235745">
                <a:buFont typeface="Wingdings" panose="05000000000000000000" pitchFamily="2" charset="2"/>
                <a:buChar char="§"/>
              </a:pPr>
              <a:r>
                <a:rPr lang="en-US" sz="1100" dirty="0"/>
                <a:t>Do a tester shot or small amount</a:t>
              </a:r>
            </a:p>
            <a:p>
              <a:pPr marL="235745" indent="-235745">
                <a:buFont typeface="Wingdings" panose="05000000000000000000" pitchFamily="2" charset="2"/>
                <a:buChar char="§"/>
              </a:pPr>
              <a:r>
                <a:rPr lang="en-US" sz="1100" dirty="0"/>
                <a:t>Go slow, especially if you haven’t used in a few days</a:t>
              </a:r>
            </a:p>
          </p:txBody>
        </p:sp>
        <p:sp>
          <p:nvSpPr>
            <p:cNvPr id="119" name="Rectangle 118">
              <a:extLst>
                <a:ext uri="{FF2B5EF4-FFF2-40B4-BE49-F238E27FC236}">
                  <a16:creationId xmlns:a16="http://schemas.microsoft.com/office/drawing/2014/main" id="{0E939060-2322-2DFB-1FD1-18D63F9A68A9}"/>
                </a:ext>
              </a:extLst>
            </p:cNvPr>
            <p:cNvSpPr/>
            <p:nvPr/>
          </p:nvSpPr>
          <p:spPr>
            <a:xfrm>
              <a:off x="-2036988" y="73679"/>
              <a:ext cx="1610374" cy="3028947"/>
            </a:xfrm>
            <a:custGeom>
              <a:avLst/>
              <a:gdLst>
                <a:gd name="connsiteX0" fmla="*/ 0 w 1610374"/>
                <a:gd name="connsiteY0" fmla="*/ 0 h 3028947"/>
                <a:gd name="connsiteX1" fmla="*/ 552895 w 1610374"/>
                <a:gd name="connsiteY1" fmla="*/ 0 h 3028947"/>
                <a:gd name="connsiteX2" fmla="*/ 1057479 w 1610374"/>
                <a:gd name="connsiteY2" fmla="*/ 0 h 3028947"/>
                <a:gd name="connsiteX3" fmla="*/ 1610374 w 1610374"/>
                <a:gd name="connsiteY3" fmla="*/ 0 h 3028947"/>
                <a:gd name="connsiteX4" fmla="*/ 1610374 w 1610374"/>
                <a:gd name="connsiteY4" fmla="*/ 504825 h 3028947"/>
                <a:gd name="connsiteX5" fmla="*/ 1610374 w 1610374"/>
                <a:gd name="connsiteY5" fmla="*/ 918781 h 3028947"/>
                <a:gd name="connsiteX6" fmla="*/ 1610374 w 1610374"/>
                <a:gd name="connsiteY6" fmla="*/ 1363026 h 3028947"/>
                <a:gd name="connsiteX7" fmla="*/ 1610374 w 1610374"/>
                <a:gd name="connsiteY7" fmla="*/ 1898140 h 3028947"/>
                <a:gd name="connsiteX8" fmla="*/ 1610374 w 1610374"/>
                <a:gd name="connsiteY8" fmla="*/ 2433254 h 3028947"/>
                <a:gd name="connsiteX9" fmla="*/ 1610374 w 1610374"/>
                <a:gd name="connsiteY9" fmla="*/ 3028947 h 3028947"/>
                <a:gd name="connsiteX10" fmla="*/ 1057479 w 1610374"/>
                <a:gd name="connsiteY10" fmla="*/ 3028947 h 3028947"/>
                <a:gd name="connsiteX11" fmla="*/ 552895 w 1610374"/>
                <a:gd name="connsiteY11" fmla="*/ 3028947 h 3028947"/>
                <a:gd name="connsiteX12" fmla="*/ 0 w 1610374"/>
                <a:gd name="connsiteY12" fmla="*/ 3028947 h 3028947"/>
                <a:gd name="connsiteX13" fmla="*/ 0 w 1610374"/>
                <a:gd name="connsiteY13" fmla="*/ 2493833 h 3028947"/>
                <a:gd name="connsiteX14" fmla="*/ 0 w 1610374"/>
                <a:gd name="connsiteY14" fmla="*/ 2049587 h 3028947"/>
                <a:gd name="connsiteX15" fmla="*/ 0 w 1610374"/>
                <a:gd name="connsiteY15" fmla="*/ 1544763 h 3028947"/>
                <a:gd name="connsiteX16" fmla="*/ 0 w 1610374"/>
                <a:gd name="connsiteY16" fmla="*/ 1039938 h 3028947"/>
                <a:gd name="connsiteX17" fmla="*/ 0 w 1610374"/>
                <a:gd name="connsiteY17" fmla="*/ 474535 h 3028947"/>
                <a:gd name="connsiteX18" fmla="*/ 0 w 1610374"/>
                <a:gd name="connsiteY18" fmla="*/ 0 h 30289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</a:cxnLst>
              <a:rect l="l" t="t" r="r" b="b"/>
              <a:pathLst>
                <a:path w="1610374" h="3028947" extrusionOk="0">
                  <a:moveTo>
                    <a:pt x="0" y="0"/>
                  </a:moveTo>
                  <a:cubicBezTo>
                    <a:pt x="149963" y="-17306"/>
                    <a:pt x="357556" y="32579"/>
                    <a:pt x="552895" y="0"/>
                  </a:cubicBezTo>
                  <a:cubicBezTo>
                    <a:pt x="748235" y="-32579"/>
                    <a:pt x="940687" y="15313"/>
                    <a:pt x="1057479" y="0"/>
                  </a:cubicBezTo>
                  <a:cubicBezTo>
                    <a:pt x="1174271" y="-15313"/>
                    <a:pt x="1432326" y="31288"/>
                    <a:pt x="1610374" y="0"/>
                  </a:cubicBezTo>
                  <a:cubicBezTo>
                    <a:pt x="1649219" y="180544"/>
                    <a:pt x="1600477" y="285331"/>
                    <a:pt x="1610374" y="504825"/>
                  </a:cubicBezTo>
                  <a:cubicBezTo>
                    <a:pt x="1620271" y="724319"/>
                    <a:pt x="1584199" y="722125"/>
                    <a:pt x="1610374" y="918781"/>
                  </a:cubicBezTo>
                  <a:cubicBezTo>
                    <a:pt x="1636549" y="1115437"/>
                    <a:pt x="1557983" y="1270599"/>
                    <a:pt x="1610374" y="1363026"/>
                  </a:cubicBezTo>
                  <a:cubicBezTo>
                    <a:pt x="1662765" y="1455453"/>
                    <a:pt x="1598359" y="1726189"/>
                    <a:pt x="1610374" y="1898140"/>
                  </a:cubicBezTo>
                  <a:cubicBezTo>
                    <a:pt x="1622389" y="2070091"/>
                    <a:pt x="1601903" y="2176907"/>
                    <a:pt x="1610374" y="2433254"/>
                  </a:cubicBezTo>
                  <a:cubicBezTo>
                    <a:pt x="1618845" y="2689601"/>
                    <a:pt x="1610021" y="2796764"/>
                    <a:pt x="1610374" y="3028947"/>
                  </a:cubicBezTo>
                  <a:cubicBezTo>
                    <a:pt x="1374133" y="3061085"/>
                    <a:pt x="1229307" y="3028670"/>
                    <a:pt x="1057479" y="3028947"/>
                  </a:cubicBezTo>
                  <a:cubicBezTo>
                    <a:pt x="885651" y="3029224"/>
                    <a:pt x="663805" y="3013274"/>
                    <a:pt x="552895" y="3028947"/>
                  </a:cubicBezTo>
                  <a:cubicBezTo>
                    <a:pt x="441985" y="3044620"/>
                    <a:pt x="271411" y="3005135"/>
                    <a:pt x="0" y="3028947"/>
                  </a:cubicBezTo>
                  <a:cubicBezTo>
                    <a:pt x="-19804" y="2882108"/>
                    <a:pt x="32825" y="2743854"/>
                    <a:pt x="0" y="2493833"/>
                  </a:cubicBezTo>
                  <a:cubicBezTo>
                    <a:pt x="-32825" y="2243812"/>
                    <a:pt x="41440" y="2270169"/>
                    <a:pt x="0" y="2049587"/>
                  </a:cubicBezTo>
                  <a:cubicBezTo>
                    <a:pt x="-41440" y="1829005"/>
                    <a:pt x="3152" y="1717784"/>
                    <a:pt x="0" y="1544763"/>
                  </a:cubicBezTo>
                  <a:cubicBezTo>
                    <a:pt x="-3152" y="1371742"/>
                    <a:pt x="58884" y="1147506"/>
                    <a:pt x="0" y="1039938"/>
                  </a:cubicBezTo>
                  <a:cubicBezTo>
                    <a:pt x="-58884" y="932370"/>
                    <a:pt x="16612" y="648009"/>
                    <a:pt x="0" y="474535"/>
                  </a:cubicBezTo>
                  <a:cubicBezTo>
                    <a:pt x="-16612" y="301061"/>
                    <a:pt x="15856" y="105615"/>
                    <a:pt x="0" y="0"/>
                  </a:cubicBezTo>
                  <a:close/>
                </a:path>
              </a:pathLst>
            </a:custGeom>
            <a:noFill/>
            <a:ln w="28575">
              <a:solidFill>
                <a:schemeClr val="tx1"/>
              </a:solidFill>
              <a:extLst>
                <a:ext uri="{C807C97D-BFC1-408E-A445-0C87EB9F89A2}">
                  <ask:lineSketchStyleProps xmlns:ask="http://schemas.microsoft.com/office/drawing/2018/sketchyshapes" sd="3788527064">
                    <a:prstGeom prst="rect">
                      <a:avLst/>
                    </a:prstGeom>
                    <ask:type>
                      <ask:lineSketchScribble/>
                    </ask:type>
                  </ask:lineSketchStyleProps>
                </a:ext>
              </a:extLst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85"/>
            </a:p>
          </p:txBody>
        </p:sp>
        <p:cxnSp>
          <p:nvCxnSpPr>
            <p:cNvPr id="120" name="Straight Connector 119">
              <a:extLst>
                <a:ext uri="{FF2B5EF4-FFF2-40B4-BE49-F238E27FC236}">
                  <a16:creationId xmlns:a16="http://schemas.microsoft.com/office/drawing/2014/main" id="{E943FA1E-A566-5728-861A-08DE6F67F66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858444" y="536603"/>
              <a:ext cx="1253285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3" name="Group 132">
            <a:extLst>
              <a:ext uri="{FF2B5EF4-FFF2-40B4-BE49-F238E27FC236}">
                <a16:creationId xmlns:a16="http://schemas.microsoft.com/office/drawing/2014/main" id="{FB1B81AC-2287-20CC-741C-7A4290ACA13B}"/>
              </a:ext>
            </a:extLst>
          </p:cNvPr>
          <p:cNvGrpSpPr/>
          <p:nvPr/>
        </p:nvGrpSpPr>
        <p:grpSpPr>
          <a:xfrm>
            <a:off x="1669315" y="73680"/>
            <a:ext cx="2145612" cy="3028946"/>
            <a:chOff x="-2297191" y="73680"/>
            <a:chExt cx="2145612" cy="3028946"/>
          </a:xfrm>
        </p:grpSpPr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C1F965D3-185A-324D-25C0-7402FFB546F5}"/>
                </a:ext>
              </a:extLst>
            </p:cNvPr>
            <p:cNvSpPr txBox="1"/>
            <p:nvPr/>
          </p:nvSpPr>
          <p:spPr>
            <a:xfrm>
              <a:off x="-2297191" y="154783"/>
              <a:ext cx="21456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KNOW THE SIGNS</a:t>
              </a:r>
            </a:p>
          </p:txBody>
        </p: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8FDCAD2A-7E75-0916-1F11-826869BA56CE}"/>
                </a:ext>
              </a:extLst>
            </p:cNvPr>
            <p:cNvSpPr txBox="1"/>
            <p:nvPr/>
          </p:nvSpPr>
          <p:spPr>
            <a:xfrm>
              <a:off x="-2045168" y="590158"/>
              <a:ext cx="1618283" cy="23083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235745" indent="-235745">
                <a:buFont typeface="Wingdings" panose="05000000000000000000" pitchFamily="2" charset="2"/>
                <a:buChar char="§"/>
              </a:pPr>
              <a:r>
                <a:rPr lang="en-US" sz="1200" dirty="0"/>
                <a:t>Not responding to yelling or rubbing your knuckles on breastbone</a:t>
              </a:r>
            </a:p>
            <a:p>
              <a:pPr marL="235745" indent="-235745">
                <a:buFont typeface="Wingdings" panose="05000000000000000000" pitchFamily="2" charset="2"/>
                <a:buChar char="§"/>
              </a:pPr>
              <a:r>
                <a:rPr lang="en-US" sz="1200" dirty="0"/>
                <a:t>Slow or no breathing </a:t>
              </a:r>
            </a:p>
            <a:p>
              <a:pPr marL="235745" indent="-235745">
                <a:buFont typeface="Wingdings" panose="05000000000000000000" pitchFamily="2" charset="2"/>
                <a:buChar char="§"/>
              </a:pPr>
              <a:r>
                <a:rPr lang="en-US" sz="1200" dirty="0"/>
                <a:t>Turning gray; blue lips &amp; fingertips</a:t>
              </a:r>
            </a:p>
            <a:p>
              <a:pPr marL="235745" indent="-235745">
                <a:buFont typeface="Wingdings" panose="05000000000000000000" pitchFamily="2" charset="2"/>
                <a:buChar char="§"/>
              </a:pPr>
              <a:r>
                <a:rPr lang="en-US" sz="1200" dirty="0"/>
                <a:t>Cold, clammy skin </a:t>
              </a:r>
            </a:p>
            <a:p>
              <a:pPr marL="235745" indent="-235745">
                <a:buFont typeface="Wingdings" panose="05000000000000000000" pitchFamily="2" charset="2"/>
                <a:buChar char="§"/>
              </a:pPr>
              <a:r>
                <a:rPr lang="en-US" sz="1200" dirty="0"/>
                <a:t>Vomiting</a:t>
              </a:r>
            </a:p>
            <a:p>
              <a:pPr marL="235745" indent="-235745">
                <a:buFont typeface="Wingdings" panose="05000000000000000000" pitchFamily="2" charset="2"/>
                <a:buChar char="§"/>
              </a:pPr>
              <a:r>
                <a:rPr lang="en-US" sz="1200" dirty="0"/>
                <a:t>Snore-like gurgling, choking sounds</a:t>
              </a:r>
            </a:p>
          </p:txBody>
        </p:sp>
        <p:sp>
          <p:nvSpPr>
            <p:cNvPr id="137" name="Rectangle 136">
              <a:extLst>
                <a:ext uri="{FF2B5EF4-FFF2-40B4-BE49-F238E27FC236}">
                  <a16:creationId xmlns:a16="http://schemas.microsoft.com/office/drawing/2014/main" id="{649064DC-E964-EE47-F60A-61C204E98631}"/>
                </a:ext>
              </a:extLst>
            </p:cNvPr>
            <p:cNvSpPr/>
            <p:nvPr/>
          </p:nvSpPr>
          <p:spPr>
            <a:xfrm>
              <a:off x="-2036988" y="73680"/>
              <a:ext cx="1610374" cy="3028946"/>
            </a:xfrm>
            <a:custGeom>
              <a:avLst/>
              <a:gdLst>
                <a:gd name="connsiteX0" fmla="*/ 0 w 1610374"/>
                <a:gd name="connsiteY0" fmla="*/ 0 h 3028946"/>
                <a:gd name="connsiteX1" fmla="*/ 552895 w 1610374"/>
                <a:gd name="connsiteY1" fmla="*/ 0 h 3028946"/>
                <a:gd name="connsiteX2" fmla="*/ 1057479 w 1610374"/>
                <a:gd name="connsiteY2" fmla="*/ 0 h 3028946"/>
                <a:gd name="connsiteX3" fmla="*/ 1610374 w 1610374"/>
                <a:gd name="connsiteY3" fmla="*/ 0 h 3028946"/>
                <a:gd name="connsiteX4" fmla="*/ 1610374 w 1610374"/>
                <a:gd name="connsiteY4" fmla="*/ 504824 h 3028946"/>
                <a:gd name="connsiteX5" fmla="*/ 1610374 w 1610374"/>
                <a:gd name="connsiteY5" fmla="*/ 918780 h 3028946"/>
                <a:gd name="connsiteX6" fmla="*/ 1610374 w 1610374"/>
                <a:gd name="connsiteY6" fmla="*/ 1363026 h 3028946"/>
                <a:gd name="connsiteX7" fmla="*/ 1610374 w 1610374"/>
                <a:gd name="connsiteY7" fmla="*/ 1898139 h 3028946"/>
                <a:gd name="connsiteX8" fmla="*/ 1610374 w 1610374"/>
                <a:gd name="connsiteY8" fmla="*/ 2433253 h 3028946"/>
                <a:gd name="connsiteX9" fmla="*/ 1610374 w 1610374"/>
                <a:gd name="connsiteY9" fmla="*/ 3028946 h 3028946"/>
                <a:gd name="connsiteX10" fmla="*/ 1057479 w 1610374"/>
                <a:gd name="connsiteY10" fmla="*/ 3028946 h 3028946"/>
                <a:gd name="connsiteX11" fmla="*/ 552895 w 1610374"/>
                <a:gd name="connsiteY11" fmla="*/ 3028946 h 3028946"/>
                <a:gd name="connsiteX12" fmla="*/ 0 w 1610374"/>
                <a:gd name="connsiteY12" fmla="*/ 3028946 h 3028946"/>
                <a:gd name="connsiteX13" fmla="*/ 0 w 1610374"/>
                <a:gd name="connsiteY13" fmla="*/ 2493832 h 3028946"/>
                <a:gd name="connsiteX14" fmla="*/ 0 w 1610374"/>
                <a:gd name="connsiteY14" fmla="*/ 2049587 h 3028946"/>
                <a:gd name="connsiteX15" fmla="*/ 0 w 1610374"/>
                <a:gd name="connsiteY15" fmla="*/ 1544762 h 3028946"/>
                <a:gd name="connsiteX16" fmla="*/ 0 w 1610374"/>
                <a:gd name="connsiteY16" fmla="*/ 1039938 h 3028946"/>
                <a:gd name="connsiteX17" fmla="*/ 0 w 1610374"/>
                <a:gd name="connsiteY17" fmla="*/ 474535 h 3028946"/>
                <a:gd name="connsiteX18" fmla="*/ 0 w 1610374"/>
                <a:gd name="connsiteY18" fmla="*/ 0 h 302894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</a:cxnLst>
              <a:rect l="l" t="t" r="r" b="b"/>
              <a:pathLst>
                <a:path w="1610374" h="3028946" extrusionOk="0">
                  <a:moveTo>
                    <a:pt x="0" y="0"/>
                  </a:moveTo>
                  <a:cubicBezTo>
                    <a:pt x="149963" y="-17306"/>
                    <a:pt x="357556" y="32579"/>
                    <a:pt x="552895" y="0"/>
                  </a:cubicBezTo>
                  <a:cubicBezTo>
                    <a:pt x="748235" y="-32579"/>
                    <a:pt x="940687" y="15313"/>
                    <a:pt x="1057479" y="0"/>
                  </a:cubicBezTo>
                  <a:cubicBezTo>
                    <a:pt x="1174271" y="-15313"/>
                    <a:pt x="1432326" y="31288"/>
                    <a:pt x="1610374" y="0"/>
                  </a:cubicBezTo>
                  <a:cubicBezTo>
                    <a:pt x="1648633" y="180857"/>
                    <a:pt x="1596343" y="289092"/>
                    <a:pt x="1610374" y="504824"/>
                  </a:cubicBezTo>
                  <a:cubicBezTo>
                    <a:pt x="1624405" y="720556"/>
                    <a:pt x="1584199" y="722124"/>
                    <a:pt x="1610374" y="918780"/>
                  </a:cubicBezTo>
                  <a:cubicBezTo>
                    <a:pt x="1636549" y="1115436"/>
                    <a:pt x="1563366" y="1267319"/>
                    <a:pt x="1610374" y="1363026"/>
                  </a:cubicBezTo>
                  <a:cubicBezTo>
                    <a:pt x="1657382" y="1458733"/>
                    <a:pt x="1592678" y="1726241"/>
                    <a:pt x="1610374" y="1898139"/>
                  </a:cubicBezTo>
                  <a:cubicBezTo>
                    <a:pt x="1628070" y="2070037"/>
                    <a:pt x="1601903" y="2176906"/>
                    <a:pt x="1610374" y="2433253"/>
                  </a:cubicBezTo>
                  <a:cubicBezTo>
                    <a:pt x="1618845" y="2689600"/>
                    <a:pt x="1610021" y="2796763"/>
                    <a:pt x="1610374" y="3028946"/>
                  </a:cubicBezTo>
                  <a:cubicBezTo>
                    <a:pt x="1374133" y="3061084"/>
                    <a:pt x="1229307" y="3028669"/>
                    <a:pt x="1057479" y="3028946"/>
                  </a:cubicBezTo>
                  <a:cubicBezTo>
                    <a:pt x="885651" y="3029223"/>
                    <a:pt x="663805" y="3013273"/>
                    <a:pt x="552895" y="3028946"/>
                  </a:cubicBezTo>
                  <a:cubicBezTo>
                    <a:pt x="441985" y="3044619"/>
                    <a:pt x="271411" y="3005134"/>
                    <a:pt x="0" y="3028946"/>
                  </a:cubicBezTo>
                  <a:cubicBezTo>
                    <a:pt x="-19804" y="2882107"/>
                    <a:pt x="32825" y="2743853"/>
                    <a:pt x="0" y="2493832"/>
                  </a:cubicBezTo>
                  <a:cubicBezTo>
                    <a:pt x="-32825" y="2243811"/>
                    <a:pt x="48065" y="2263972"/>
                    <a:pt x="0" y="2049587"/>
                  </a:cubicBezTo>
                  <a:cubicBezTo>
                    <a:pt x="-48065" y="1835202"/>
                    <a:pt x="2797" y="1721245"/>
                    <a:pt x="0" y="1544762"/>
                  </a:cubicBezTo>
                  <a:cubicBezTo>
                    <a:pt x="-2797" y="1368279"/>
                    <a:pt x="4983" y="1290565"/>
                    <a:pt x="0" y="1039938"/>
                  </a:cubicBezTo>
                  <a:cubicBezTo>
                    <a:pt x="-4983" y="789311"/>
                    <a:pt x="16612" y="648009"/>
                    <a:pt x="0" y="474535"/>
                  </a:cubicBezTo>
                  <a:cubicBezTo>
                    <a:pt x="-16612" y="301061"/>
                    <a:pt x="15856" y="105615"/>
                    <a:pt x="0" y="0"/>
                  </a:cubicBezTo>
                  <a:close/>
                </a:path>
              </a:pathLst>
            </a:custGeom>
            <a:noFill/>
            <a:ln w="28575">
              <a:solidFill>
                <a:schemeClr val="tx1"/>
              </a:solidFill>
              <a:extLst>
                <a:ext uri="{C807C97D-BFC1-408E-A445-0C87EB9F89A2}">
                  <ask:lineSketchStyleProps xmlns:ask="http://schemas.microsoft.com/office/drawing/2018/sketchyshapes" sd="3788527064">
                    <a:prstGeom prst="rect">
                      <a:avLst/>
                    </a:prstGeom>
                    <ask:type>
                      <ask:lineSketchScribble/>
                    </ask:type>
                  </ask:lineSketchStyleProps>
                </a:ext>
              </a:extLst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85"/>
            </a:p>
          </p:txBody>
        </p:sp>
        <p:cxnSp>
          <p:nvCxnSpPr>
            <p:cNvPr id="138" name="Straight Connector 137">
              <a:extLst>
                <a:ext uri="{FF2B5EF4-FFF2-40B4-BE49-F238E27FC236}">
                  <a16:creationId xmlns:a16="http://schemas.microsoft.com/office/drawing/2014/main" id="{2A3AA51D-E37A-81A1-7A63-C48D84D6A8F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858444" y="536603"/>
              <a:ext cx="1253285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6" name="Group 145">
            <a:extLst>
              <a:ext uri="{FF2B5EF4-FFF2-40B4-BE49-F238E27FC236}">
                <a16:creationId xmlns:a16="http://schemas.microsoft.com/office/drawing/2014/main" id="{65795FC9-C420-3A91-28F9-77D28A704D10}"/>
              </a:ext>
            </a:extLst>
          </p:cNvPr>
          <p:cNvGrpSpPr/>
          <p:nvPr/>
        </p:nvGrpSpPr>
        <p:grpSpPr>
          <a:xfrm>
            <a:off x="2890409" y="32087"/>
            <a:ext cx="3374398" cy="3134597"/>
            <a:chOff x="3882261" y="3556337"/>
            <a:chExt cx="3374398" cy="3134597"/>
          </a:xfrm>
        </p:grpSpPr>
        <p:sp>
          <p:nvSpPr>
            <p:cNvPr id="149" name="Rectangle 148">
              <a:extLst>
                <a:ext uri="{FF2B5EF4-FFF2-40B4-BE49-F238E27FC236}">
                  <a16:creationId xmlns:a16="http://schemas.microsoft.com/office/drawing/2014/main" id="{100A1330-7278-C4D0-CED2-964F2E6CCB91}"/>
                </a:ext>
              </a:extLst>
            </p:cNvPr>
            <p:cNvSpPr/>
            <p:nvPr/>
          </p:nvSpPr>
          <p:spPr>
            <a:xfrm>
              <a:off x="4707745" y="3856532"/>
              <a:ext cx="1704792" cy="1144287"/>
            </a:xfrm>
            <a:custGeom>
              <a:avLst/>
              <a:gdLst>
                <a:gd name="connsiteX0" fmla="*/ 0 w 1704792"/>
                <a:gd name="connsiteY0" fmla="*/ 0 h 1144287"/>
                <a:gd name="connsiteX1" fmla="*/ 551216 w 1704792"/>
                <a:gd name="connsiteY1" fmla="*/ 0 h 1144287"/>
                <a:gd name="connsiteX2" fmla="*/ 1136528 w 1704792"/>
                <a:gd name="connsiteY2" fmla="*/ 0 h 1144287"/>
                <a:gd name="connsiteX3" fmla="*/ 1704792 w 1704792"/>
                <a:gd name="connsiteY3" fmla="*/ 0 h 1144287"/>
                <a:gd name="connsiteX4" fmla="*/ 1704792 w 1704792"/>
                <a:gd name="connsiteY4" fmla="*/ 537815 h 1144287"/>
                <a:gd name="connsiteX5" fmla="*/ 1704792 w 1704792"/>
                <a:gd name="connsiteY5" fmla="*/ 1144287 h 1144287"/>
                <a:gd name="connsiteX6" fmla="*/ 1119480 w 1704792"/>
                <a:gd name="connsiteY6" fmla="*/ 1144287 h 1144287"/>
                <a:gd name="connsiteX7" fmla="*/ 568264 w 1704792"/>
                <a:gd name="connsiteY7" fmla="*/ 1144287 h 1144287"/>
                <a:gd name="connsiteX8" fmla="*/ 0 w 1704792"/>
                <a:gd name="connsiteY8" fmla="*/ 1144287 h 1144287"/>
                <a:gd name="connsiteX9" fmla="*/ 0 w 1704792"/>
                <a:gd name="connsiteY9" fmla="*/ 560701 h 1144287"/>
                <a:gd name="connsiteX10" fmla="*/ 0 w 1704792"/>
                <a:gd name="connsiteY10" fmla="*/ 0 h 114428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</a:cxnLst>
              <a:rect l="l" t="t" r="r" b="b"/>
              <a:pathLst>
                <a:path w="1704792" h="1144287" fill="none" extrusionOk="0">
                  <a:moveTo>
                    <a:pt x="0" y="0"/>
                  </a:moveTo>
                  <a:cubicBezTo>
                    <a:pt x="209785" y="-54312"/>
                    <a:pt x="434830" y="20122"/>
                    <a:pt x="551216" y="0"/>
                  </a:cubicBezTo>
                  <a:cubicBezTo>
                    <a:pt x="667602" y="-20122"/>
                    <a:pt x="936499" y="62320"/>
                    <a:pt x="1136528" y="0"/>
                  </a:cubicBezTo>
                  <a:cubicBezTo>
                    <a:pt x="1336557" y="-62320"/>
                    <a:pt x="1591126" y="30797"/>
                    <a:pt x="1704792" y="0"/>
                  </a:cubicBezTo>
                  <a:cubicBezTo>
                    <a:pt x="1728453" y="119244"/>
                    <a:pt x="1659584" y="290507"/>
                    <a:pt x="1704792" y="537815"/>
                  </a:cubicBezTo>
                  <a:cubicBezTo>
                    <a:pt x="1750000" y="785124"/>
                    <a:pt x="1637944" y="906644"/>
                    <a:pt x="1704792" y="1144287"/>
                  </a:cubicBezTo>
                  <a:cubicBezTo>
                    <a:pt x="1448007" y="1161829"/>
                    <a:pt x="1365979" y="1141821"/>
                    <a:pt x="1119480" y="1144287"/>
                  </a:cubicBezTo>
                  <a:cubicBezTo>
                    <a:pt x="872981" y="1146753"/>
                    <a:pt x="757379" y="1087071"/>
                    <a:pt x="568264" y="1144287"/>
                  </a:cubicBezTo>
                  <a:cubicBezTo>
                    <a:pt x="379149" y="1201503"/>
                    <a:pt x="174678" y="1107954"/>
                    <a:pt x="0" y="1144287"/>
                  </a:cubicBezTo>
                  <a:cubicBezTo>
                    <a:pt x="-33744" y="1022711"/>
                    <a:pt x="37954" y="780747"/>
                    <a:pt x="0" y="560701"/>
                  </a:cubicBezTo>
                  <a:cubicBezTo>
                    <a:pt x="-37954" y="340655"/>
                    <a:pt x="21082" y="131811"/>
                    <a:pt x="0" y="0"/>
                  </a:cubicBezTo>
                  <a:close/>
                </a:path>
                <a:path w="1704792" h="1144287" stroke="0" extrusionOk="0">
                  <a:moveTo>
                    <a:pt x="0" y="0"/>
                  </a:moveTo>
                  <a:cubicBezTo>
                    <a:pt x="124829" y="-1553"/>
                    <a:pt x="373584" y="60202"/>
                    <a:pt x="585312" y="0"/>
                  </a:cubicBezTo>
                  <a:cubicBezTo>
                    <a:pt x="797040" y="-60202"/>
                    <a:pt x="873752" y="1460"/>
                    <a:pt x="1119480" y="0"/>
                  </a:cubicBezTo>
                  <a:cubicBezTo>
                    <a:pt x="1365208" y="-1460"/>
                    <a:pt x="1488101" y="62808"/>
                    <a:pt x="1704792" y="0"/>
                  </a:cubicBezTo>
                  <a:cubicBezTo>
                    <a:pt x="1720021" y="201737"/>
                    <a:pt x="1691372" y="431947"/>
                    <a:pt x="1704792" y="572144"/>
                  </a:cubicBezTo>
                  <a:cubicBezTo>
                    <a:pt x="1718212" y="712341"/>
                    <a:pt x="1669489" y="909336"/>
                    <a:pt x="1704792" y="1144287"/>
                  </a:cubicBezTo>
                  <a:cubicBezTo>
                    <a:pt x="1544135" y="1166663"/>
                    <a:pt x="1316922" y="1094422"/>
                    <a:pt x="1170624" y="1144287"/>
                  </a:cubicBezTo>
                  <a:cubicBezTo>
                    <a:pt x="1024326" y="1194152"/>
                    <a:pt x="724790" y="1136424"/>
                    <a:pt x="602360" y="1144287"/>
                  </a:cubicBezTo>
                  <a:cubicBezTo>
                    <a:pt x="479930" y="1152150"/>
                    <a:pt x="131218" y="1113731"/>
                    <a:pt x="0" y="1144287"/>
                  </a:cubicBezTo>
                  <a:cubicBezTo>
                    <a:pt x="-56531" y="937965"/>
                    <a:pt x="48186" y="850210"/>
                    <a:pt x="0" y="583586"/>
                  </a:cubicBezTo>
                  <a:cubicBezTo>
                    <a:pt x="-48186" y="316962"/>
                    <a:pt x="32208" y="260895"/>
                    <a:pt x="0" y="0"/>
                  </a:cubicBezTo>
                  <a:close/>
                </a:path>
              </a:pathLst>
            </a:custGeom>
            <a:solidFill>
              <a:schemeClr val="bg1"/>
            </a:solidFill>
            <a:ln w="28575">
              <a:solidFill>
                <a:schemeClr val="tx1"/>
              </a:solidFill>
              <a:extLst>
                <a:ext uri="{C807C97D-BFC1-408E-A445-0C87EB9F89A2}">
                  <ask:lineSketchStyleProps xmlns:ask="http://schemas.microsoft.com/office/drawing/2018/sketchyshapes" sd="3788527064">
                    <a:prstGeom prst="rect">
                      <a:avLst/>
                    </a:prstGeom>
                    <ask:type>
                      <ask:lineSketchScribble/>
                    </ask:type>
                  </ask:lineSketchStyleProps>
                </a:ext>
              </a:extLst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85"/>
            </a:p>
          </p:txBody>
        </p:sp>
        <p:sp>
          <p:nvSpPr>
            <p:cNvPr id="150" name="TextBox 149">
              <a:extLst>
                <a:ext uri="{FF2B5EF4-FFF2-40B4-BE49-F238E27FC236}">
                  <a16:creationId xmlns:a16="http://schemas.microsoft.com/office/drawing/2014/main" id="{BBF34150-D098-231E-FF54-57D0E8D9EFBC}"/>
                </a:ext>
              </a:extLst>
            </p:cNvPr>
            <p:cNvSpPr txBox="1"/>
            <p:nvPr/>
          </p:nvSpPr>
          <p:spPr>
            <a:xfrm>
              <a:off x="4713231" y="3889370"/>
              <a:ext cx="166311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u="sng" dirty="0"/>
                <a:t>Telehealth Suboxone</a:t>
              </a:r>
            </a:p>
          </p:txBody>
        </p:sp>
        <p:sp>
          <p:nvSpPr>
            <p:cNvPr id="151" name="TextBox 150">
              <a:extLst>
                <a:ext uri="{FF2B5EF4-FFF2-40B4-BE49-F238E27FC236}">
                  <a16:creationId xmlns:a16="http://schemas.microsoft.com/office/drawing/2014/main" id="{31D3E997-77F9-2A49-68A2-A7FBE0683FF3}"/>
                </a:ext>
              </a:extLst>
            </p:cNvPr>
            <p:cNvSpPr txBox="1"/>
            <p:nvPr/>
          </p:nvSpPr>
          <p:spPr>
            <a:xfrm>
              <a:off x="3882261" y="3566833"/>
              <a:ext cx="33606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/>
                <a:t>RESOURCES</a:t>
              </a:r>
            </a:p>
          </p:txBody>
        </p:sp>
        <p:sp>
          <p:nvSpPr>
            <p:cNvPr id="152" name="TextBox 151">
              <a:extLst>
                <a:ext uri="{FF2B5EF4-FFF2-40B4-BE49-F238E27FC236}">
                  <a16:creationId xmlns:a16="http://schemas.microsoft.com/office/drawing/2014/main" id="{662A10CC-8711-C10B-7AB8-ADC3B1DB9D83}"/>
                </a:ext>
              </a:extLst>
            </p:cNvPr>
            <p:cNvSpPr txBox="1"/>
            <p:nvPr/>
          </p:nvSpPr>
          <p:spPr>
            <a:xfrm>
              <a:off x="4744262" y="4584196"/>
              <a:ext cx="163881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/>
                <a:t>(503) 494-2100</a:t>
              </a:r>
            </a:p>
          </p:txBody>
        </p:sp>
        <p:sp>
          <p:nvSpPr>
            <p:cNvPr id="153" name="TextBox 152">
              <a:extLst>
                <a:ext uri="{FF2B5EF4-FFF2-40B4-BE49-F238E27FC236}">
                  <a16:creationId xmlns:a16="http://schemas.microsoft.com/office/drawing/2014/main" id="{F46116B5-8A60-8F9D-5781-F387E7AB6483}"/>
                </a:ext>
              </a:extLst>
            </p:cNvPr>
            <p:cNvSpPr txBox="1"/>
            <p:nvPr/>
          </p:nvSpPr>
          <p:spPr>
            <a:xfrm>
              <a:off x="5020069" y="4251825"/>
              <a:ext cx="106686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(888) 595-5427</a:t>
              </a:r>
            </a:p>
          </p:txBody>
        </p:sp>
        <p:sp>
          <p:nvSpPr>
            <p:cNvPr id="154" name="TextBox 153">
              <a:extLst>
                <a:ext uri="{FF2B5EF4-FFF2-40B4-BE49-F238E27FC236}">
                  <a16:creationId xmlns:a16="http://schemas.microsoft.com/office/drawing/2014/main" id="{3895D90D-4E59-052E-2CC8-0B82FE6B2C33}"/>
                </a:ext>
              </a:extLst>
            </p:cNvPr>
            <p:cNvSpPr txBox="1"/>
            <p:nvPr/>
          </p:nvSpPr>
          <p:spPr>
            <a:xfrm>
              <a:off x="3895998" y="3556337"/>
              <a:ext cx="33606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solidFill>
                    <a:schemeClr val="bg1"/>
                  </a:solidFill>
                </a:rPr>
                <a:t>RESOURCES</a:t>
              </a:r>
            </a:p>
          </p:txBody>
        </p:sp>
        <p:sp>
          <p:nvSpPr>
            <p:cNvPr id="155" name="TextBox 154">
              <a:extLst>
                <a:ext uri="{FF2B5EF4-FFF2-40B4-BE49-F238E27FC236}">
                  <a16:creationId xmlns:a16="http://schemas.microsoft.com/office/drawing/2014/main" id="{7D55BDD5-03B5-0689-0ACA-40373352647C}"/>
                </a:ext>
              </a:extLst>
            </p:cNvPr>
            <p:cNvSpPr txBox="1"/>
            <p:nvPr/>
          </p:nvSpPr>
          <p:spPr>
            <a:xfrm>
              <a:off x="5062217" y="4102136"/>
              <a:ext cx="98256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/>
                <a:t>Boulder Care:</a:t>
              </a:r>
            </a:p>
          </p:txBody>
        </p:sp>
        <p:sp>
          <p:nvSpPr>
            <p:cNvPr id="156" name="TextBox 155">
              <a:extLst>
                <a:ext uri="{FF2B5EF4-FFF2-40B4-BE49-F238E27FC236}">
                  <a16:creationId xmlns:a16="http://schemas.microsoft.com/office/drawing/2014/main" id="{D45C7D72-18E4-3882-9B06-E742495C0883}"/>
                </a:ext>
              </a:extLst>
            </p:cNvPr>
            <p:cNvSpPr txBox="1"/>
            <p:nvPr/>
          </p:nvSpPr>
          <p:spPr>
            <a:xfrm>
              <a:off x="4707745" y="4458873"/>
              <a:ext cx="17787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/>
                <a:t>OHSU HRBR (Harbor)Clinic:</a:t>
              </a:r>
            </a:p>
          </p:txBody>
        </p:sp>
        <p:sp>
          <p:nvSpPr>
            <p:cNvPr id="157" name="Rectangle 156">
              <a:extLst>
                <a:ext uri="{FF2B5EF4-FFF2-40B4-BE49-F238E27FC236}">
                  <a16:creationId xmlns:a16="http://schemas.microsoft.com/office/drawing/2014/main" id="{4BCDDFCE-5139-0610-C5AC-34B15E67D0AC}"/>
                </a:ext>
              </a:extLst>
            </p:cNvPr>
            <p:cNvSpPr/>
            <p:nvPr/>
          </p:nvSpPr>
          <p:spPr>
            <a:xfrm>
              <a:off x="4707874" y="5122065"/>
              <a:ext cx="1719375" cy="1528061"/>
            </a:xfrm>
            <a:custGeom>
              <a:avLst/>
              <a:gdLst>
                <a:gd name="connsiteX0" fmla="*/ 0 w 1719375"/>
                <a:gd name="connsiteY0" fmla="*/ 0 h 1528061"/>
                <a:gd name="connsiteX1" fmla="*/ 538737 w 1719375"/>
                <a:gd name="connsiteY1" fmla="*/ 0 h 1528061"/>
                <a:gd name="connsiteX2" fmla="*/ 1060281 w 1719375"/>
                <a:gd name="connsiteY2" fmla="*/ 0 h 1528061"/>
                <a:gd name="connsiteX3" fmla="*/ 1719375 w 1719375"/>
                <a:gd name="connsiteY3" fmla="*/ 0 h 1528061"/>
                <a:gd name="connsiteX4" fmla="*/ 1719375 w 1719375"/>
                <a:gd name="connsiteY4" fmla="*/ 509354 h 1528061"/>
                <a:gd name="connsiteX5" fmla="*/ 1719375 w 1719375"/>
                <a:gd name="connsiteY5" fmla="*/ 1033988 h 1528061"/>
                <a:gd name="connsiteX6" fmla="*/ 1719375 w 1719375"/>
                <a:gd name="connsiteY6" fmla="*/ 1528061 h 1528061"/>
                <a:gd name="connsiteX7" fmla="*/ 1197831 w 1719375"/>
                <a:gd name="connsiteY7" fmla="*/ 1528061 h 1528061"/>
                <a:gd name="connsiteX8" fmla="*/ 624706 w 1719375"/>
                <a:gd name="connsiteY8" fmla="*/ 1528061 h 1528061"/>
                <a:gd name="connsiteX9" fmla="*/ 0 w 1719375"/>
                <a:gd name="connsiteY9" fmla="*/ 1528061 h 1528061"/>
                <a:gd name="connsiteX10" fmla="*/ 0 w 1719375"/>
                <a:gd name="connsiteY10" fmla="*/ 1064549 h 1528061"/>
                <a:gd name="connsiteX11" fmla="*/ 0 w 1719375"/>
                <a:gd name="connsiteY11" fmla="*/ 524634 h 1528061"/>
                <a:gd name="connsiteX12" fmla="*/ 0 w 1719375"/>
                <a:gd name="connsiteY12" fmla="*/ 0 h 152806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</a:cxnLst>
              <a:rect l="l" t="t" r="r" b="b"/>
              <a:pathLst>
                <a:path w="1719375" h="1528061" fill="none" extrusionOk="0">
                  <a:moveTo>
                    <a:pt x="0" y="0"/>
                  </a:moveTo>
                  <a:cubicBezTo>
                    <a:pt x="211591" y="-22008"/>
                    <a:pt x="341426" y="61960"/>
                    <a:pt x="538737" y="0"/>
                  </a:cubicBezTo>
                  <a:cubicBezTo>
                    <a:pt x="736048" y="-61960"/>
                    <a:pt x="830175" y="18842"/>
                    <a:pt x="1060281" y="0"/>
                  </a:cubicBezTo>
                  <a:cubicBezTo>
                    <a:pt x="1290387" y="-18842"/>
                    <a:pt x="1517460" y="77571"/>
                    <a:pt x="1719375" y="0"/>
                  </a:cubicBezTo>
                  <a:cubicBezTo>
                    <a:pt x="1736777" y="250937"/>
                    <a:pt x="1716967" y="375613"/>
                    <a:pt x="1719375" y="509354"/>
                  </a:cubicBezTo>
                  <a:cubicBezTo>
                    <a:pt x="1721783" y="643095"/>
                    <a:pt x="1694652" y="880426"/>
                    <a:pt x="1719375" y="1033988"/>
                  </a:cubicBezTo>
                  <a:cubicBezTo>
                    <a:pt x="1744098" y="1187550"/>
                    <a:pt x="1661083" y="1394455"/>
                    <a:pt x="1719375" y="1528061"/>
                  </a:cubicBezTo>
                  <a:cubicBezTo>
                    <a:pt x="1535983" y="1562666"/>
                    <a:pt x="1382999" y="1513614"/>
                    <a:pt x="1197831" y="1528061"/>
                  </a:cubicBezTo>
                  <a:cubicBezTo>
                    <a:pt x="1012663" y="1542508"/>
                    <a:pt x="828096" y="1517549"/>
                    <a:pt x="624706" y="1528061"/>
                  </a:cubicBezTo>
                  <a:cubicBezTo>
                    <a:pt x="421317" y="1538573"/>
                    <a:pt x="228842" y="1461700"/>
                    <a:pt x="0" y="1528061"/>
                  </a:cubicBezTo>
                  <a:cubicBezTo>
                    <a:pt x="-32776" y="1415903"/>
                    <a:pt x="52799" y="1217954"/>
                    <a:pt x="0" y="1064549"/>
                  </a:cubicBezTo>
                  <a:cubicBezTo>
                    <a:pt x="-52799" y="911144"/>
                    <a:pt x="17549" y="700689"/>
                    <a:pt x="0" y="524634"/>
                  </a:cubicBezTo>
                  <a:cubicBezTo>
                    <a:pt x="-17549" y="348580"/>
                    <a:pt x="18510" y="185133"/>
                    <a:pt x="0" y="0"/>
                  </a:cubicBezTo>
                  <a:close/>
                </a:path>
                <a:path w="1719375" h="1528061" stroke="0" extrusionOk="0">
                  <a:moveTo>
                    <a:pt x="0" y="0"/>
                  </a:moveTo>
                  <a:cubicBezTo>
                    <a:pt x="120382" y="-70299"/>
                    <a:pt x="431496" y="11884"/>
                    <a:pt x="590319" y="0"/>
                  </a:cubicBezTo>
                  <a:cubicBezTo>
                    <a:pt x="749142" y="-11884"/>
                    <a:pt x="882007" y="4203"/>
                    <a:pt x="1129056" y="0"/>
                  </a:cubicBezTo>
                  <a:cubicBezTo>
                    <a:pt x="1376105" y="-4203"/>
                    <a:pt x="1503567" y="33680"/>
                    <a:pt x="1719375" y="0"/>
                  </a:cubicBezTo>
                  <a:cubicBezTo>
                    <a:pt x="1723187" y="136873"/>
                    <a:pt x="1665589" y="365263"/>
                    <a:pt x="1719375" y="509354"/>
                  </a:cubicBezTo>
                  <a:cubicBezTo>
                    <a:pt x="1773161" y="653445"/>
                    <a:pt x="1672007" y="774624"/>
                    <a:pt x="1719375" y="972866"/>
                  </a:cubicBezTo>
                  <a:cubicBezTo>
                    <a:pt x="1766743" y="1171108"/>
                    <a:pt x="1680871" y="1407762"/>
                    <a:pt x="1719375" y="1528061"/>
                  </a:cubicBezTo>
                  <a:cubicBezTo>
                    <a:pt x="1426447" y="1543418"/>
                    <a:pt x="1383204" y="1514497"/>
                    <a:pt x="1129056" y="1528061"/>
                  </a:cubicBezTo>
                  <a:cubicBezTo>
                    <a:pt x="874908" y="1541625"/>
                    <a:pt x="719911" y="1483000"/>
                    <a:pt x="521544" y="1528061"/>
                  </a:cubicBezTo>
                  <a:cubicBezTo>
                    <a:pt x="323177" y="1573122"/>
                    <a:pt x="127996" y="1500070"/>
                    <a:pt x="0" y="1528061"/>
                  </a:cubicBezTo>
                  <a:cubicBezTo>
                    <a:pt x="-3994" y="1364419"/>
                    <a:pt x="33381" y="1209343"/>
                    <a:pt x="0" y="1064549"/>
                  </a:cubicBezTo>
                  <a:cubicBezTo>
                    <a:pt x="-33381" y="919755"/>
                    <a:pt x="42755" y="687502"/>
                    <a:pt x="0" y="570476"/>
                  </a:cubicBezTo>
                  <a:cubicBezTo>
                    <a:pt x="-42755" y="453450"/>
                    <a:pt x="60669" y="232661"/>
                    <a:pt x="0" y="0"/>
                  </a:cubicBezTo>
                  <a:close/>
                </a:path>
              </a:pathLst>
            </a:custGeom>
            <a:solidFill>
              <a:schemeClr val="bg1"/>
            </a:solidFill>
            <a:ln w="28575">
              <a:solidFill>
                <a:schemeClr val="tx1"/>
              </a:solidFill>
              <a:extLst>
                <a:ext uri="{C807C97D-BFC1-408E-A445-0C87EB9F89A2}">
                  <ask:lineSketchStyleProps xmlns:ask="http://schemas.microsoft.com/office/drawing/2018/sketchyshapes" sd="3788527064">
                    <a:prstGeom prst="rect">
                      <a:avLst/>
                    </a:prstGeom>
                    <ask:type>
                      <ask:lineSketchScribble/>
                    </ask:type>
                  </ask:lineSketchStyleProps>
                </a:ext>
              </a:extLst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85"/>
            </a:p>
          </p:txBody>
        </p:sp>
        <p:sp>
          <p:nvSpPr>
            <p:cNvPr id="158" name="TextBox 157">
              <a:extLst>
                <a:ext uri="{FF2B5EF4-FFF2-40B4-BE49-F238E27FC236}">
                  <a16:creationId xmlns:a16="http://schemas.microsoft.com/office/drawing/2014/main" id="{8BDD5A69-14DD-55CF-C95D-A3DE088E1AB3}"/>
                </a:ext>
              </a:extLst>
            </p:cNvPr>
            <p:cNvSpPr txBox="1"/>
            <p:nvPr/>
          </p:nvSpPr>
          <p:spPr>
            <a:xfrm>
              <a:off x="4658410" y="5123054"/>
              <a:ext cx="18288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u="sng" dirty="0"/>
                <a:t>Confidential “Spotting” Hotline:</a:t>
              </a:r>
            </a:p>
          </p:txBody>
        </p:sp>
        <p:sp>
          <p:nvSpPr>
            <p:cNvPr id="159" name="TextBox 158">
              <a:extLst>
                <a:ext uri="{FF2B5EF4-FFF2-40B4-BE49-F238E27FC236}">
                  <a16:creationId xmlns:a16="http://schemas.microsoft.com/office/drawing/2014/main" id="{D75384BA-415C-786E-9060-C805A9517C46}"/>
                </a:ext>
              </a:extLst>
            </p:cNvPr>
            <p:cNvSpPr txBox="1"/>
            <p:nvPr/>
          </p:nvSpPr>
          <p:spPr>
            <a:xfrm>
              <a:off x="4731830" y="5505994"/>
              <a:ext cx="1709913" cy="11849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i="1" dirty="0"/>
                <a:t>Call before you use alone. They’ll call EMS if you become unresponsive. </a:t>
              </a:r>
            </a:p>
            <a:p>
              <a:pPr algn="ctr"/>
              <a:endParaRPr lang="en-US" sz="500" i="1" dirty="0"/>
            </a:p>
            <a:p>
              <a:pPr algn="ctr"/>
              <a:r>
                <a:rPr lang="en-US" sz="1100" b="1" dirty="0"/>
                <a:t>Never Use Alone: </a:t>
              </a:r>
            </a:p>
            <a:p>
              <a:r>
                <a:rPr lang="en-US" sz="1100" dirty="0"/>
                <a:t>800-484-3731 for English,</a:t>
              </a:r>
            </a:p>
            <a:p>
              <a:r>
                <a:rPr lang="en-US" sz="1100" dirty="0"/>
                <a:t>800-928-5330 for Spanish</a:t>
              </a:r>
            </a:p>
          </p:txBody>
        </p:sp>
      </p:grpSp>
      <p:sp>
        <p:nvSpPr>
          <p:cNvPr id="2" name="Rectangle 1">
            <a:extLst>
              <a:ext uri="{FF2B5EF4-FFF2-40B4-BE49-F238E27FC236}">
                <a16:creationId xmlns:a16="http://schemas.microsoft.com/office/drawing/2014/main" id="{EC344BAE-E049-D41D-029C-0E7B5C8638F3}"/>
              </a:ext>
            </a:extLst>
          </p:cNvPr>
          <p:cNvSpPr/>
          <p:nvPr/>
        </p:nvSpPr>
        <p:spPr>
          <a:xfrm>
            <a:off x="5517039" y="2700859"/>
            <a:ext cx="1771120" cy="464878"/>
          </a:xfrm>
          <a:prstGeom prst="rect">
            <a:avLst/>
          </a:prstGeom>
          <a:solidFill>
            <a:schemeClr val="bg1"/>
          </a:solidFill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23" name="Group 22">
            <a:extLst>
              <a:ext uri="{FF2B5EF4-FFF2-40B4-BE49-F238E27FC236}">
                <a16:creationId xmlns:a16="http://schemas.microsoft.com/office/drawing/2014/main" id="{B8AD0828-AAA9-390D-28E6-1770858C2EF4}"/>
              </a:ext>
            </a:extLst>
          </p:cNvPr>
          <p:cNvGrpSpPr/>
          <p:nvPr/>
        </p:nvGrpSpPr>
        <p:grpSpPr>
          <a:xfrm>
            <a:off x="5266436" y="-240658"/>
            <a:ext cx="2106739" cy="3441058"/>
            <a:chOff x="5266436" y="-240658"/>
            <a:chExt cx="2106739" cy="3441058"/>
          </a:xfrm>
        </p:grpSpPr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93F6C8B5-E813-15B4-D55E-7018FCEB2DCF}"/>
                </a:ext>
              </a:extLst>
            </p:cNvPr>
            <p:cNvCxnSpPr>
              <a:cxnSpLocks/>
            </p:cNvCxnSpPr>
            <p:nvPr/>
          </p:nvCxnSpPr>
          <p:spPr>
            <a:xfrm>
              <a:off x="5481697" y="0"/>
              <a:ext cx="0" cy="3200400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4" name="Cloud 223">
              <a:extLst>
                <a:ext uri="{FF2B5EF4-FFF2-40B4-BE49-F238E27FC236}">
                  <a16:creationId xmlns:a16="http://schemas.microsoft.com/office/drawing/2014/main" id="{D1BEA1B8-42D5-5E4C-CA18-C1F738BD9605}"/>
                </a:ext>
              </a:extLst>
            </p:cNvPr>
            <p:cNvSpPr/>
            <p:nvPr/>
          </p:nvSpPr>
          <p:spPr>
            <a:xfrm rot="10800000">
              <a:off x="5501226" y="800088"/>
              <a:ext cx="1794774" cy="600750"/>
            </a:xfrm>
            <a:prstGeom prst="cloud">
              <a:avLst/>
            </a:prstGeom>
            <a:solidFill>
              <a:schemeClr val="bg1"/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85" dirty="0"/>
            </a:p>
          </p:txBody>
        </p:sp>
        <p:sp>
          <p:nvSpPr>
            <p:cNvPr id="225" name="Rectangle 224">
              <a:extLst>
                <a:ext uri="{FF2B5EF4-FFF2-40B4-BE49-F238E27FC236}">
                  <a16:creationId xmlns:a16="http://schemas.microsoft.com/office/drawing/2014/main" id="{ADB1BE7A-E69A-2401-27FC-EC0ED71936B7}"/>
                </a:ext>
              </a:extLst>
            </p:cNvPr>
            <p:cNvSpPr/>
            <p:nvPr/>
          </p:nvSpPr>
          <p:spPr>
            <a:xfrm>
              <a:off x="5488118" y="10254"/>
              <a:ext cx="1824560" cy="109495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85" dirty="0"/>
            </a:p>
          </p:txBody>
        </p:sp>
        <p:sp>
          <p:nvSpPr>
            <p:cNvPr id="226" name="Isosceles Triangle 225">
              <a:extLst>
                <a:ext uri="{FF2B5EF4-FFF2-40B4-BE49-F238E27FC236}">
                  <a16:creationId xmlns:a16="http://schemas.microsoft.com/office/drawing/2014/main" id="{E38816CD-15EF-0DAC-06D7-0FF5F6E5AA90}"/>
                </a:ext>
              </a:extLst>
            </p:cNvPr>
            <p:cNvSpPr/>
            <p:nvPr/>
          </p:nvSpPr>
          <p:spPr>
            <a:xfrm rot="9457660">
              <a:off x="6236972" y="1005643"/>
              <a:ext cx="285101" cy="766138"/>
            </a:xfrm>
            <a:prstGeom prst="triangle">
              <a:avLst>
                <a:gd name="adj" fmla="val 51635"/>
              </a:avLst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85"/>
            </a:p>
          </p:txBody>
        </p:sp>
        <p:sp>
          <p:nvSpPr>
            <p:cNvPr id="227" name="TextBox 226">
              <a:extLst>
                <a:ext uri="{FF2B5EF4-FFF2-40B4-BE49-F238E27FC236}">
                  <a16:creationId xmlns:a16="http://schemas.microsoft.com/office/drawing/2014/main" id="{8669A352-E2C2-B3F6-A4E5-B0B21C953904}"/>
                </a:ext>
              </a:extLst>
            </p:cNvPr>
            <p:cNvSpPr txBox="1"/>
            <p:nvPr/>
          </p:nvSpPr>
          <p:spPr>
            <a:xfrm>
              <a:off x="5617429" y="91468"/>
              <a:ext cx="1562400" cy="10772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cs typeface="Dreaming Outloud Pro" panose="03050502040302030504" pitchFamily="66" charset="0"/>
                </a:rPr>
                <a:t>AVOIDING </a:t>
              </a:r>
            </a:p>
            <a:p>
              <a:pPr algn="ctr"/>
              <a:r>
                <a:rPr lang="en-US" sz="1600" b="1" dirty="0">
                  <a:cs typeface="Dreaming Outloud Pro" panose="03050502040302030504" pitchFamily="66" charset="0"/>
                </a:rPr>
                <a:t>OVERDOSE, </a:t>
              </a:r>
            </a:p>
            <a:p>
              <a:pPr algn="ctr"/>
              <a:r>
                <a:rPr lang="en-US" sz="1600" b="1" dirty="0">
                  <a:cs typeface="Dreaming Outloud Pro" panose="03050502040302030504" pitchFamily="66" charset="0"/>
                </a:rPr>
                <a:t>REVERSING</a:t>
              </a:r>
            </a:p>
            <a:p>
              <a:pPr algn="ctr"/>
              <a:r>
                <a:rPr lang="en-US" sz="1600" b="1" dirty="0">
                  <a:cs typeface="Dreaming Outloud Pro" panose="03050502040302030504" pitchFamily="66" charset="0"/>
                </a:rPr>
                <a:t>OVERDOSE</a:t>
              </a:r>
            </a:p>
          </p:txBody>
        </p:sp>
        <p:sp>
          <p:nvSpPr>
            <p:cNvPr id="228" name="Arc 227">
              <a:extLst>
                <a:ext uri="{FF2B5EF4-FFF2-40B4-BE49-F238E27FC236}">
                  <a16:creationId xmlns:a16="http://schemas.microsoft.com/office/drawing/2014/main" id="{26920DC9-87B3-1B26-46A4-3BF9AF80F11F}"/>
                </a:ext>
              </a:extLst>
            </p:cNvPr>
            <p:cNvSpPr/>
            <p:nvPr/>
          </p:nvSpPr>
          <p:spPr>
            <a:xfrm rot="15164204" flipV="1">
              <a:off x="5722881" y="-4477"/>
              <a:ext cx="1160845" cy="1977971"/>
            </a:xfrm>
            <a:prstGeom prst="arc">
              <a:avLst>
                <a:gd name="adj1" fmla="val 15895882"/>
                <a:gd name="adj2" fmla="val 16958079"/>
              </a:avLst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9" name="Arc 228">
              <a:extLst>
                <a:ext uri="{FF2B5EF4-FFF2-40B4-BE49-F238E27FC236}">
                  <a16:creationId xmlns:a16="http://schemas.microsoft.com/office/drawing/2014/main" id="{8F2C7780-CED7-C9F5-E32F-70BE48F20F63}"/>
                </a:ext>
              </a:extLst>
            </p:cNvPr>
            <p:cNvSpPr/>
            <p:nvPr/>
          </p:nvSpPr>
          <p:spPr>
            <a:xfrm rot="16422694" flipV="1">
              <a:off x="5665903" y="-640125"/>
              <a:ext cx="1160845" cy="1959779"/>
            </a:xfrm>
            <a:prstGeom prst="arc">
              <a:avLst>
                <a:gd name="adj1" fmla="val 15631524"/>
                <a:gd name="adj2" fmla="val 16815326"/>
              </a:avLst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0" name="Arc 229">
              <a:extLst>
                <a:ext uri="{FF2B5EF4-FFF2-40B4-BE49-F238E27FC236}">
                  <a16:creationId xmlns:a16="http://schemas.microsoft.com/office/drawing/2014/main" id="{73DF0EF0-0B8F-66DF-7788-7190684F6BC2}"/>
                </a:ext>
              </a:extLst>
            </p:cNvPr>
            <p:cNvSpPr/>
            <p:nvPr/>
          </p:nvSpPr>
          <p:spPr>
            <a:xfrm rot="8135052" flipV="1">
              <a:off x="5907233" y="-110037"/>
              <a:ext cx="1160845" cy="2055330"/>
            </a:xfrm>
            <a:prstGeom prst="arc">
              <a:avLst>
                <a:gd name="adj1" fmla="val 15609327"/>
                <a:gd name="adj2" fmla="val 16656922"/>
              </a:avLst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1" name="Arc 230">
              <a:extLst>
                <a:ext uri="{FF2B5EF4-FFF2-40B4-BE49-F238E27FC236}">
                  <a16:creationId xmlns:a16="http://schemas.microsoft.com/office/drawing/2014/main" id="{80AA8E25-DAA2-34A4-B9B0-C778C34608DE}"/>
                </a:ext>
              </a:extLst>
            </p:cNvPr>
            <p:cNvSpPr/>
            <p:nvPr/>
          </p:nvSpPr>
          <p:spPr>
            <a:xfrm rot="8972222" flipV="1">
              <a:off x="5447244" y="214497"/>
              <a:ext cx="1160845" cy="1880449"/>
            </a:xfrm>
            <a:prstGeom prst="arc">
              <a:avLst>
                <a:gd name="adj1" fmla="val 15459923"/>
                <a:gd name="adj2" fmla="val 16376470"/>
              </a:avLst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232" name="Straight Connector 231">
              <a:extLst>
                <a:ext uri="{FF2B5EF4-FFF2-40B4-BE49-F238E27FC236}">
                  <a16:creationId xmlns:a16="http://schemas.microsoft.com/office/drawing/2014/main" id="{5F4A55E6-FC33-CC8B-0E82-78890155DD1A}"/>
                </a:ext>
              </a:extLst>
            </p:cNvPr>
            <p:cNvCxnSpPr>
              <a:cxnSpLocks/>
            </p:cNvCxnSpPr>
            <p:nvPr/>
          </p:nvCxnSpPr>
          <p:spPr>
            <a:xfrm rot="19231198" flipH="1">
              <a:off x="6373279" y="1375648"/>
              <a:ext cx="256350" cy="46911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3" name="Straight Connector 232">
              <a:extLst>
                <a:ext uri="{FF2B5EF4-FFF2-40B4-BE49-F238E27FC236}">
                  <a16:creationId xmlns:a16="http://schemas.microsoft.com/office/drawing/2014/main" id="{1A7D09F9-FAF6-0F85-E571-A50B71869E06}"/>
                </a:ext>
              </a:extLst>
            </p:cNvPr>
            <p:cNvCxnSpPr>
              <a:cxnSpLocks/>
            </p:cNvCxnSpPr>
            <p:nvPr/>
          </p:nvCxnSpPr>
          <p:spPr>
            <a:xfrm>
              <a:off x="6265200" y="1361159"/>
              <a:ext cx="267624" cy="38657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4" name="Straight Connector 233">
              <a:extLst>
                <a:ext uri="{FF2B5EF4-FFF2-40B4-BE49-F238E27FC236}">
                  <a16:creationId xmlns:a16="http://schemas.microsoft.com/office/drawing/2014/main" id="{3A792BC8-86C9-F093-9F23-2E1B4979DE8B}"/>
                </a:ext>
              </a:extLst>
            </p:cNvPr>
            <p:cNvCxnSpPr>
              <a:cxnSpLocks/>
            </p:cNvCxnSpPr>
            <p:nvPr/>
          </p:nvCxnSpPr>
          <p:spPr>
            <a:xfrm rot="19231198" flipH="1">
              <a:off x="6425248" y="1470656"/>
              <a:ext cx="137602" cy="401586"/>
            </a:xfrm>
            <a:prstGeom prst="line">
              <a:avLst/>
            </a:prstGeom>
            <a:ln w="9525">
              <a:solidFill>
                <a:schemeClr val="tx1"/>
              </a:solidFill>
              <a:prstDash val="lgDash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35" name="Group 234">
              <a:extLst>
                <a:ext uri="{FF2B5EF4-FFF2-40B4-BE49-F238E27FC236}">
                  <a16:creationId xmlns:a16="http://schemas.microsoft.com/office/drawing/2014/main" id="{36A63053-B9CA-B4E6-36C5-829BB0B0ED45}"/>
                </a:ext>
              </a:extLst>
            </p:cNvPr>
            <p:cNvGrpSpPr/>
            <p:nvPr/>
          </p:nvGrpSpPr>
          <p:grpSpPr>
            <a:xfrm flipH="1">
              <a:off x="5946685" y="1483648"/>
              <a:ext cx="1426490" cy="1116628"/>
              <a:chOff x="12476875" y="1379089"/>
              <a:chExt cx="2475279" cy="2423100"/>
            </a:xfrm>
          </p:grpSpPr>
          <p:pic>
            <p:nvPicPr>
              <p:cNvPr id="241" name="Picture 2" descr="Post-Overdose Section | U-M Injury Center">
                <a:extLst>
                  <a:ext uri="{FF2B5EF4-FFF2-40B4-BE49-F238E27FC236}">
                    <a16:creationId xmlns:a16="http://schemas.microsoft.com/office/drawing/2014/main" id="{10183349-6B16-FDA1-DC39-9C9E0E3B0162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2">
                <a:duotone>
                  <a:prstClr val="black"/>
                  <a:schemeClr val="tx2">
                    <a:tint val="45000"/>
                    <a:satMod val="400000"/>
                  </a:schemeClr>
                </a:duoton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 rot="1563544">
                <a:off x="12476875" y="1388232"/>
                <a:ext cx="2413957" cy="241395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42" name="Picture 2" descr="Post-Overdose Section | U-M Injury Center">
                <a:extLst>
                  <a:ext uri="{FF2B5EF4-FFF2-40B4-BE49-F238E27FC236}">
                    <a16:creationId xmlns:a16="http://schemas.microsoft.com/office/drawing/2014/main" id="{B9C99AA6-6B9B-6564-7B5E-3F471B4007E6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3">
                <a:duotone>
                  <a:schemeClr val="accent3">
                    <a:shade val="45000"/>
                    <a:satMod val="135000"/>
                  </a:schemeClr>
                  <a:prstClr val="white"/>
                </a:duotone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artisticMarker/>
                        </a14:imgEffect>
                        <a14:imgEffect>
                          <a14:sharpenSoften amoun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 rot="1563544">
                <a:off x="12538197" y="1379089"/>
                <a:ext cx="2413957" cy="241395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pic>
          <p:nvPicPr>
            <p:cNvPr id="236" name="Picture 235" descr="A white text on a black background&#10;&#10;Description automatically generated with medium confidence">
              <a:extLst>
                <a:ext uri="{FF2B5EF4-FFF2-40B4-BE49-F238E27FC236}">
                  <a16:creationId xmlns:a16="http://schemas.microsoft.com/office/drawing/2014/main" id="{7CB917E9-92A2-9327-0454-D6CA7742B6F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20616" y="2380207"/>
              <a:ext cx="881543" cy="338512"/>
            </a:xfrm>
            <a:prstGeom prst="rect">
              <a:avLst/>
            </a:prstGeom>
          </p:spPr>
        </p:pic>
        <p:sp>
          <p:nvSpPr>
            <p:cNvPr id="237" name="TextBox 236">
              <a:extLst>
                <a:ext uri="{FF2B5EF4-FFF2-40B4-BE49-F238E27FC236}">
                  <a16:creationId xmlns:a16="http://schemas.microsoft.com/office/drawing/2014/main" id="{AA02E3B9-8DF4-BD72-2390-3F657B024636}"/>
                </a:ext>
              </a:extLst>
            </p:cNvPr>
            <p:cNvSpPr txBox="1"/>
            <p:nvPr/>
          </p:nvSpPr>
          <p:spPr>
            <a:xfrm>
              <a:off x="5462281" y="2917094"/>
              <a:ext cx="179920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/>
                <a:t>Phone:</a:t>
              </a:r>
            </a:p>
          </p:txBody>
        </p:sp>
        <p:sp>
          <p:nvSpPr>
            <p:cNvPr id="238" name="TextBox 237">
              <a:extLst>
                <a:ext uri="{FF2B5EF4-FFF2-40B4-BE49-F238E27FC236}">
                  <a16:creationId xmlns:a16="http://schemas.microsoft.com/office/drawing/2014/main" id="{0D65CE46-C097-37EA-B54C-CF359215860A}"/>
                </a:ext>
              </a:extLst>
            </p:cNvPr>
            <p:cNvSpPr txBox="1"/>
            <p:nvPr/>
          </p:nvSpPr>
          <p:spPr>
            <a:xfrm>
              <a:off x="5455271" y="2700858"/>
              <a:ext cx="179920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/>
                <a:t>Peer Name:</a:t>
              </a:r>
            </a:p>
          </p:txBody>
        </p:sp>
        <p:cxnSp>
          <p:nvCxnSpPr>
            <p:cNvPr id="239" name="Straight Connector 238">
              <a:extLst>
                <a:ext uri="{FF2B5EF4-FFF2-40B4-BE49-F238E27FC236}">
                  <a16:creationId xmlns:a16="http://schemas.microsoft.com/office/drawing/2014/main" id="{C492529D-960C-1AD7-1C4E-010524F91581}"/>
                </a:ext>
              </a:extLst>
            </p:cNvPr>
            <p:cNvCxnSpPr>
              <a:cxnSpLocks/>
            </p:cNvCxnSpPr>
            <p:nvPr/>
          </p:nvCxnSpPr>
          <p:spPr>
            <a:xfrm>
              <a:off x="5978863" y="3104414"/>
              <a:ext cx="117926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0" name="Straight Connector 239">
              <a:extLst>
                <a:ext uri="{FF2B5EF4-FFF2-40B4-BE49-F238E27FC236}">
                  <a16:creationId xmlns:a16="http://schemas.microsoft.com/office/drawing/2014/main" id="{1A38A071-D317-60C1-BCB4-A62E21D86505}"/>
                </a:ext>
              </a:extLst>
            </p:cNvPr>
            <p:cNvCxnSpPr>
              <a:cxnSpLocks/>
            </p:cNvCxnSpPr>
            <p:nvPr/>
          </p:nvCxnSpPr>
          <p:spPr>
            <a:xfrm>
              <a:off x="6240975" y="2875830"/>
              <a:ext cx="90989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3637669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6511397B-E232-6B4F-60FC-E20D73A5613E}"/>
              </a:ext>
            </a:extLst>
          </p:cNvPr>
          <p:cNvCxnSpPr>
            <a:cxnSpLocks/>
          </p:cNvCxnSpPr>
          <p:nvPr/>
        </p:nvCxnSpPr>
        <p:spPr>
          <a:xfrm>
            <a:off x="5484293" y="0"/>
            <a:ext cx="0" cy="320040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83CEDD9F-E3AD-A332-96C1-B9226D2BC1F8}"/>
              </a:ext>
            </a:extLst>
          </p:cNvPr>
          <p:cNvCxnSpPr>
            <a:cxnSpLocks/>
          </p:cNvCxnSpPr>
          <p:nvPr/>
        </p:nvCxnSpPr>
        <p:spPr>
          <a:xfrm>
            <a:off x="3654095" y="24581"/>
            <a:ext cx="0" cy="320040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Rectangle 4">
            <a:extLst>
              <a:ext uri="{FF2B5EF4-FFF2-40B4-BE49-F238E27FC236}">
                <a16:creationId xmlns:a16="http://schemas.microsoft.com/office/drawing/2014/main" id="{79B1B53B-70B6-DA0A-2E75-7496B3B03DE4}"/>
              </a:ext>
            </a:extLst>
          </p:cNvPr>
          <p:cNvSpPr/>
          <p:nvPr/>
        </p:nvSpPr>
        <p:spPr>
          <a:xfrm>
            <a:off x="0" y="0"/>
            <a:ext cx="7315200" cy="3200400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150" dirty="0"/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7AAF8B53-81AA-C455-45A2-00CD130F5F33}"/>
              </a:ext>
            </a:extLst>
          </p:cNvPr>
          <p:cNvCxnSpPr>
            <a:cxnSpLocks/>
          </p:cNvCxnSpPr>
          <p:nvPr/>
        </p:nvCxnSpPr>
        <p:spPr>
          <a:xfrm>
            <a:off x="1828119" y="0"/>
            <a:ext cx="0" cy="320040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1" name="Group 40">
            <a:extLst>
              <a:ext uri="{FF2B5EF4-FFF2-40B4-BE49-F238E27FC236}">
                <a16:creationId xmlns:a16="http://schemas.microsoft.com/office/drawing/2014/main" id="{C3D3EA92-F29F-A7AE-07D2-1933055F408C}"/>
              </a:ext>
            </a:extLst>
          </p:cNvPr>
          <p:cNvGrpSpPr/>
          <p:nvPr/>
        </p:nvGrpSpPr>
        <p:grpSpPr>
          <a:xfrm>
            <a:off x="1828119" y="24581"/>
            <a:ext cx="5487084" cy="3008404"/>
            <a:chOff x="12538271" y="2957977"/>
            <a:chExt cx="8412589" cy="4490118"/>
          </a:xfrm>
        </p:grpSpPr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35520456-598B-6B56-B29E-1A636C8D3FFF}"/>
                </a:ext>
              </a:extLst>
            </p:cNvPr>
            <p:cNvSpPr txBox="1"/>
            <p:nvPr/>
          </p:nvSpPr>
          <p:spPr>
            <a:xfrm>
              <a:off x="12538271" y="3045230"/>
              <a:ext cx="2803846" cy="10565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 b="1" dirty="0"/>
                <a:t>REVERSE AN OVERDOSE</a:t>
              </a:r>
              <a:endParaRPr lang="en-US" sz="2400" b="1" dirty="0"/>
            </a:p>
          </p:txBody>
        </p:sp>
        <p:grpSp>
          <p:nvGrpSpPr>
            <p:cNvPr id="43" name="Group 42">
              <a:extLst>
                <a:ext uri="{FF2B5EF4-FFF2-40B4-BE49-F238E27FC236}">
                  <a16:creationId xmlns:a16="http://schemas.microsoft.com/office/drawing/2014/main" id="{62C89E36-878B-F4DB-BC50-59656B20DAF2}"/>
                </a:ext>
              </a:extLst>
            </p:cNvPr>
            <p:cNvGrpSpPr/>
            <p:nvPr/>
          </p:nvGrpSpPr>
          <p:grpSpPr>
            <a:xfrm>
              <a:off x="12631334" y="4192214"/>
              <a:ext cx="2708969" cy="1294670"/>
              <a:chOff x="12861137" y="4197454"/>
              <a:chExt cx="1924404" cy="1133871"/>
            </a:xfrm>
          </p:grpSpPr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4D616A09-2C62-0CBE-F299-91ADE6E43A9F}"/>
                  </a:ext>
                </a:extLst>
              </p:cNvPr>
              <p:cNvSpPr txBox="1"/>
              <p:nvPr/>
            </p:nvSpPr>
            <p:spPr>
              <a:xfrm>
                <a:off x="13115783" y="4197454"/>
                <a:ext cx="1669758" cy="40231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solidFill>
                      <a:srgbClr val="C00000"/>
                    </a:solidFill>
                  </a:rPr>
                  <a:t>WAKE THEM UP</a:t>
                </a:r>
              </a:p>
            </p:txBody>
          </p: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5E1ABEB4-80AA-5EE4-3F80-1D6D916FCC5C}"/>
                  </a:ext>
                </a:extLst>
              </p:cNvPr>
              <p:cNvSpPr txBox="1"/>
              <p:nvPr/>
            </p:nvSpPr>
            <p:spPr>
              <a:xfrm>
                <a:off x="12861137" y="4546819"/>
                <a:ext cx="1889390" cy="7845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141447" indent="-141447">
                  <a:buFont typeface="Wingdings" panose="05000000000000000000" pitchFamily="2" charset="2"/>
                  <a:buChar char="§"/>
                </a:pPr>
                <a:r>
                  <a:rPr lang="en-US" sz="1100" dirty="0"/>
                  <a:t>Shake them &amp; yell</a:t>
                </a:r>
              </a:p>
              <a:p>
                <a:pPr marL="141447" indent="-141447">
                  <a:buFont typeface="Wingdings" panose="05000000000000000000" pitchFamily="2" charset="2"/>
                  <a:buChar char="§"/>
                </a:pPr>
                <a:r>
                  <a:rPr lang="en-US" sz="1100" dirty="0"/>
                  <a:t>Rub your knuckles hard over their breastbone</a:t>
                </a:r>
              </a:p>
            </p:txBody>
          </p:sp>
        </p:grpSp>
        <p:grpSp>
          <p:nvGrpSpPr>
            <p:cNvPr id="44" name="Group 43">
              <a:extLst>
                <a:ext uri="{FF2B5EF4-FFF2-40B4-BE49-F238E27FC236}">
                  <a16:creationId xmlns:a16="http://schemas.microsoft.com/office/drawing/2014/main" id="{A613A106-5601-BC0F-6EEE-39DC90BB6749}"/>
                </a:ext>
              </a:extLst>
            </p:cNvPr>
            <p:cNvGrpSpPr/>
            <p:nvPr/>
          </p:nvGrpSpPr>
          <p:grpSpPr>
            <a:xfrm>
              <a:off x="12602298" y="5625337"/>
              <a:ext cx="2699971" cy="1541953"/>
              <a:chOff x="12804411" y="4685580"/>
              <a:chExt cx="1936888" cy="1377780"/>
            </a:xfrm>
          </p:grpSpPr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51198AF3-419E-A782-BD0A-CD4B4BB12CF5}"/>
                  </a:ext>
                </a:extLst>
              </p:cNvPr>
              <p:cNvSpPr txBox="1"/>
              <p:nvPr/>
            </p:nvSpPr>
            <p:spPr>
              <a:xfrm>
                <a:off x="13071541" y="4685580"/>
                <a:ext cx="1669758" cy="41045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solidFill>
                      <a:srgbClr val="C00000"/>
                    </a:solidFill>
                  </a:rPr>
                  <a:t>CALL 9-1-1</a:t>
                </a: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4076D998-B1C6-6B4E-1A5E-132E10D5FF4A}"/>
                  </a:ext>
                </a:extLst>
              </p:cNvPr>
              <p:cNvSpPr txBox="1"/>
              <p:nvPr/>
            </p:nvSpPr>
            <p:spPr>
              <a:xfrm>
                <a:off x="12804411" y="5037223"/>
                <a:ext cx="1891159" cy="10261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141447" indent="-141447">
                  <a:buFont typeface="Wingdings" panose="05000000000000000000" pitchFamily="2" charset="2"/>
                  <a:buChar char="§"/>
                </a:pPr>
                <a:r>
                  <a:rPr lang="en-US" sz="1100" dirty="0"/>
                  <a:t>You will NOT get in trouble for being in a drug house, possession, or intent to sell</a:t>
                </a:r>
              </a:p>
            </p:txBody>
          </p:sp>
        </p:grpSp>
        <p:grpSp>
          <p:nvGrpSpPr>
            <p:cNvPr id="45" name="Group 44">
              <a:extLst>
                <a:ext uri="{FF2B5EF4-FFF2-40B4-BE49-F238E27FC236}">
                  <a16:creationId xmlns:a16="http://schemas.microsoft.com/office/drawing/2014/main" id="{7BA2C345-D8EB-3D60-3207-B042FAC5CF24}"/>
                </a:ext>
              </a:extLst>
            </p:cNvPr>
            <p:cNvGrpSpPr/>
            <p:nvPr/>
          </p:nvGrpSpPr>
          <p:grpSpPr>
            <a:xfrm>
              <a:off x="15421052" y="2994951"/>
              <a:ext cx="2778105" cy="1526916"/>
              <a:chOff x="14498654" y="1427665"/>
              <a:chExt cx="1509576" cy="1380261"/>
            </a:xfrm>
          </p:grpSpPr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691CD2F6-293C-928C-8EEE-9A19E2222D81}"/>
                  </a:ext>
                </a:extLst>
              </p:cNvPr>
              <p:cNvSpPr txBox="1"/>
              <p:nvPr/>
            </p:nvSpPr>
            <p:spPr>
              <a:xfrm>
                <a:off x="14734441" y="1427665"/>
                <a:ext cx="1230136" cy="4152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solidFill>
                      <a:srgbClr val="C00000"/>
                    </a:solidFill>
                  </a:rPr>
                  <a:t>GIVE NALOXONE</a:t>
                </a:r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4CBBB886-58FC-1092-975D-940530D71D69}"/>
                  </a:ext>
                </a:extLst>
              </p:cNvPr>
              <p:cNvSpPr txBox="1"/>
              <p:nvPr/>
            </p:nvSpPr>
            <p:spPr>
              <a:xfrm>
                <a:off x="14498654" y="1769817"/>
                <a:ext cx="1509576" cy="103810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141447" indent="-141447">
                  <a:buFont typeface="Wingdings" panose="05000000000000000000" pitchFamily="2" charset="2"/>
                  <a:buChar char="§"/>
                </a:pPr>
                <a:r>
                  <a:rPr lang="en-US" sz="1100" dirty="0"/>
                  <a:t>Give a second dose if they haven’t started breathing after 3 minutes of rescue breathing (step 4)</a:t>
                </a:r>
              </a:p>
            </p:txBody>
          </p:sp>
        </p:grpSp>
        <p:grpSp>
          <p:nvGrpSpPr>
            <p:cNvPr id="46" name="Group 45">
              <a:extLst>
                <a:ext uri="{FF2B5EF4-FFF2-40B4-BE49-F238E27FC236}">
                  <a16:creationId xmlns:a16="http://schemas.microsoft.com/office/drawing/2014/main" id="{5F7F7D86-CFF7-A237-3F77-6FE60C990AF1}"/>
                </a:ext>
              </a:extLst>
            </p:cNvPr>
            <p:cNvGrpSpPr/>
            <p:nvPr/>
          </p:nvGrpSpPr>
          <p:grpSpPr>
            <a:xfrm>
              <a:off x="15421050" y="4621009"/>
              <a:ext cx="2829590" cy="2827086"/>
              <a:chOff x="16689933" y="4540431"/>
              <a:chExt cx="1786767" cy="2806986"/>
            </a:xfrm>
          </p:grpSpPr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20FA0E12-C5A1-4FE2-7312-C2420EF5B9D7}"/>
                  </a:ext>
                </a:extLst>
              </p:cNvPr>
              <p:cNvSpPr txBox="1"/>
              <p:nvPr/>
            </p:nvSpPr>
            <p:spPr>
              <a:xfrm>
                <a:off x="16899826" y="4540431"/>
                <a:ext cx="1493635" cy="77536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solidFill>
                      <a:srgbClr val="C00000"/>
                    </a:solidFill>
                  </a:rPr>
                  <a:t>DO RESCUE BREATHING!</a:t>
                </a:r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3946D341-A75C-67AA-3D18-D69F146DDA31}"/>
                  </a:ext>
                </a:extLst>
              </p:cNvPr>
              <p:cNvSpPr txBox="1"/>
              <p:nvPr/>
            </p:nvSpPr>
            <p:spPr>
              <a:xfrm>
                <a:off x="16689933" y="5203756"/>
                <a:ext cx="1786767" cy="214366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141447" indent="-141447">
                  <a:buFont typeface="Wingdings" panose="05000000000000000000" pitchFamily="2" charset="2"/>
                  <a:buChar char="§"/>
                </a:pPr>
                <a:r>
                  <a:rPr lang="en-US" sz="1100" dirty="0"/>
                  <a:t>Clear the inside of their mouth  </a:t>
                </a:r>
              </a:p>
              <a:p>
                <a:pPr marL="141447" indent="-141447">
                  <a:buFont typeface="Wingdings" panose="05000000000000000000" pitchFamily="2" charset="2"/>
                  <a:buChar char="§"/>
                </a:pPr>
                <a:r>
                  <a:rPr lang="en-US" sz="1100" dirty="0"/>
                  <a:t>Tilt their chin up, pinch the nose  </a:t>
                </a:r>
              </a:p>
              <a:p>
                <a:pPr marL="141447" indent="-141447">
                  <a:buFont typeface="Wingdings" panose="05000000000000000000" pitchFamily="2" charset="2"/>
                  <a:buChar char="§"/>
                </a:pPr>
                <a:r>
                  <a:rPr lang="en-US" sz="1100" dirty="0"/>
                  <a:t>Give 1 breath every 5 seconds</a:t>
                </a:r>
              </a:p>
              <a:p>
                <a:pPr marL="141447" indent="-141447">
                  <a:buFont typeface="Wingdings" panose="05000000000000000000" pitchFamily="2" charset="2"/>
                  <a:buChar char="§"/>
                </a:pPr>
                <a:r>
                  <a:rPr lang="en-US" sz="1100" dirty="0"/>
                  <a:t>Continue until help comes or they are breathing</a:t>
                </a:r>
              </a:p>
            </p:txBody>
          </p:sp>
        </p:grpSp>
        <p:grpSp>
          <p:nvGrpSpPr>
            <p:cNvPr id="47" name="Group 46">
              <a:extLst>
                <a:ext uri="{FF2B5EF4-FFF2-40B4-BE49-F238E27FC236}">
                  <a16:creationId xmlns:a16="http://schemas.microsoft.com/office/drawing/2014/main" id="{999EEB33-38F4-BC4B-10BD-8F27971144BF}"/>
                </a:ext>
              </a:extLst>
            </p:cNvPr>
            <p:cNvGrpSpPr/>
            <p:nvPr/>
          </p:nvGrpSpPr>
          <p:grpSpPr>
            <a:xfrm>
              <a:off x="18240699" y="2957977"/>
              <a:ext cx="2710161" cy="2556054"/>
              <a:chOff x="18570667" y="3241582"/>
              <a:chExt cx="1837084" cy="2680374"/>
            </a:xfrm>
          </p:grpSpPr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16F0981B-11FE-5739-AE80-8AFD15B93747}"/>
                  </a:ext>
                </a:extLst>
              </p:cNvPr>
              <p:cNvSpPr txBox="1"/>
              <p:nvPr/>
            </p:nvSpPr>
            <p:spPr>
              <a:xfrm>
                <a:off x="18814407" y="3241582"/>
                <a:ext cx="1593344" cy="8189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solidFill>
                      <a:srgbClr val="C00000"/>
                    </a:solidFill>
                  </a:rPr>
                  <a:t>PROVIDE AFTER-CARE</a:t>
                </a: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7D70D2D8-A7EC-4E0D-5A92-D2FA9A404680}"/>
                  </a:ext>
                </a:extLst>
              </p:cNvPr>
              <p:cNvSpPr txBox="1"/>
              <p:nvPr/>
            </p:nvSpPr>
            <p:spPr>
              <a:xfrm>
                <a:off x="18570667" y="3922874"/>
                <a:ext cx="1828683" cy="19990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141447" indent="-141447">
                  <a:buFont typeface="Wingdings" panose="05000000000000000000" pitchFamily="2" charset="2"/>
                  <a:buChar char="§"/>
                </a:pPr>
                <a:r>
                  <a:rPr lang="en-US" sz="1100" dirty="0"/>
                  <a:t>Put them on their side to prevent choking on vomit</a:t>
                </a:r>
              </a:p>
              <a:p>
                <a:pPr marL="141447" indent="-141447">
                  <a:buFont typeface="Wingdings" panose="05000000000000000000" pitchFamily="2" charset="2"/>
                  <a:buChar char="§"/>
                </a:pPr>
                <a:r>
                  <a:rPr lang="en-US" sz="1100" dirty="0"/>
                  <a:t>Stay with them until help comes or for 1 or 2 hours to make sure they don’t go back into overdose</a:t>
                </a:r>
              </a:p>
            </p:txBody>
          </p:sp>
        </p:grpSp>
        <p:pic>
          <p:nvPicPr>
            <p:cNvPr id="48" name="Graphic 47" descr="Badge 5 with solid fill">
              <a:extLst>
                <a:ext uri="{FF2B5EF4-FFF2-40B4-BE49-F238E27FC236}">
                  <a16:creationId xmlns:a16="http://schemas.microsoft.com/office/drawing/2014/main" id="{7ED56550-B432-07AE-AA2C-ED1E64E9B96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>
              <a:off x="18201649" y="2973788"/>
              <a:ext cx="459364" cy="459365"/>
            </a:xfrm>
            <a:prstGeom prst="rect">
              <a:avLst/>
            </a:prstGeom>
          </p:spPr>
        </p:pic>
        <p:pic>
          <p:nvPicPr>
            <p:cNvPr id="49" name="Graphic 48" descr="Badge 4 with solid fill">
              <a:extLst>
                <a:ext uri="{FF2B5EF4-FFF2-40B4-BE49-F238E27FC236}">
                  <a16:creationId xmlns:a16="http://schemas.microsoft.com/office/drawing/2014/main" id="{917F2E64-AD98-3C7B-EA08-6D515B60E67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6"/>
                </a:ext>
              </a:extLst>
            </a:blip>
            <a:stretch>
              <a:fillRect/>
            </a:stretch>
          </p:blipFill>
          <p:spPr>
            <a:xfrm>
              <a:off x="15392450" y="4636977"/>
              <a:ext cx="459364" cy="459365"/>
            </a:xfrm>
            <a:prstGeom prst="rect">
              <a:avLst/>
            </a:prstGeom>
          </p:spPr>
        </p:pic>
        <p:pic>
          <p:nvPicPr>
            <p:cNvPr id="50" name="Graphic 49" descr="Badge 3 with solid fill">
              <a:extLst>
                <a:ext uri="{FF2B5EF4-FFF2-40B4-BE49-F238E27FC236}">
                  <a16:creationId xmlns:a16="http://schemas.microsoft.com/office/drawing/2014/main" id="{AE453641-3AD7-1F58-7BBA-6719B86037BB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8"/>
                </a:ext>
              </a:extLst>
            </a:blip>
            <a:stretch>
              <a:fillRect/>
            </a:stretch>
          </p:blipFill>
          <p:spPr>
            <a:xfrm>
              <a:off x="15392758" y="2994954"/>
              <a:ext cx="459364" cy="459365"/>
            </a:xfrm>
            <a:prstGeom prst="rect">
              <a:avLst/>
            </a:prstGeom>
          </p:spPr>
        </p:pic>
        <p:pic>
          <p:nvPicPr>
            <p:cNvPr id="51" name="Graphic 50" descr="Badge with solid fill">
              <a:extLst>
                <a:ext uri="{FF2B5EF4-FFF2-40B4-BE49-F238E27FC236}">
                  <a16:creationId xmlns:a16="http://schemas.microsoft.com/office/drawing/2014/main" id="{C8C8355C-A243-4032-1F8A-D15C765817AB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10"/>
                </a:ext>
              </a:extLst>
            </a:blip>
            <a:stretch>
              <a:fillRect/>
            </a:stretch>
          </p:blipFill>
          <p:spPr>
            <a:xfrm>
              <a:off x="12579469" y="5632271"/>
              <a:ext cx="459364" cy="459365"/>
            </a:xfrm>
            <a:prstGeom prst="rect">
              <a:avLst/>
            </a:prstGeom>
          </p:spPr>
        </p:pic>
        <p:pic>
          <p:nvPicPr>
            <p:cNvPr id="52" name="Graphic 51" descr="Badge 1 with solid fill">
              <a:extLst>
                <a:ext uri="{FF2B5EF4-FFF2-40B4-BE49-F238E27FC236}">
                  <a16:creationId xmlns:a16="http://schemas.microsoft.com/office/drawing/2014/main" id="{C15AA472-6717-D11C-4236-9D553D1580C0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12"/>
                </a:ext>
              </a:extLst>
            </a:blip>
            <a:stretch>
              <a:fillRect/>
            </a:stretch>
          </p:blipFill>
          <p:spPr>
            <a:xfrm>
              <a:off x="12602127" y="4199870"/>
              <a:ext cx="459364" cy="459365"/>
            </a:xfrm>
            <a:prstGeom prst="rect">
              <a:avLst/>
            </a:prstGeom>
          </p:spPr>
        </p:pic>
      </p:grpSp>
      <p:grpSp>
        <p:nvGrpSpPr>
          <p:cNvPr id="63" name="Group 62">
            <a:extLst>
              <a:ext uri="{FF2B5EF4-FFF2-40B4-BE49-F238E27FC236}">
                <a16:creationId xmlns:a16="http://schemas.microsoft.com/office/drawing/2014/main" id="{4255A6A0-112D-A494-2F97-CAEF67118891}"/>
              </a:ext>
            </a:extLst>
          </p:cNvPr>
          <p:cNvGrpSpPr/>
          <p:nvPr/>
        </p:nvGrpSpPr>
        <p:grpSpPr>
          <a:xfrm>
            <a:off x="16742" y="40442"/>
            <a:ext cx="1792558" cy="3059945"/>
            <a:chOff x="52116" y="3645447"/>
            <a:chExt cx="3993248" cy="4276783"/>
          </a:xfrm>
        </p:grpSpPr>
        <p:sp>
          <p:nvSpPr>
            <p:cNvPr id="65" name="Rectangle 64">
              <a:extLst>
                <a:ext uri="{FF2B5EF4-FFF2-40B4-BE49-F238E27FC236}">
                  <a16:creationId xmlns:a16="http://schemas.microsoft.com/office/drawing/2014/main" id="{E9BF3553-171B-4D77-3840-F7452A48D292}"/>
                </a:ext>
              </a:extLst>
            </p:cNvPr>
            <p:cNvSpPr/>
            <p:nvPr/>
          </p:nvSpPr>
          <p:spPr>
            <a:xfrm>
              <a:off x="219456" y="4195208"/>
              <a:ext cx="3640080" cy="3727022"/>
            </a:xfrm>
            <a:custGeom>
              <a:avLst/>
              <a:gdLst>
                <a:gd name="connsiteX0" fmla="*/ 0 w 3640080"/>
                <a:gd name="connsiteY0" fmla="*/ 0 h 3727022"/>
                <a:gd name="connsiteX1" fmla="*/ 556412 w 3640080"/>
                <a:gd name="connsiteY1" fmla="*/ 0 h 3727022"/>
                <a:gd name="connsiteX2" fmla="*/ 1003622 w 3640080"/>
                <a:gd name="connsiteY2" fmla="*/ 0 h 3727022"/>
                <a:gd name="connsiteX3" fmla="*/ 1560034 w 3640080"/>
                <a:gd name="connsiteY3" fmla="*/ 0 h 3727022"/>
                <a:gd name="connsiteX4" fmla="*/ 2080046 w 3640080"/>
                <a:gd name="connsiteY4" fmla="*/ 0 h 3727022"/>
                <a:gd name="connsiteX5" fmla="*/ 2490855 w 3640080"/>
                <a:gd name="connsiteY5" fmla="*/ 0 h 3727022"/>
                <a:gd name="connsiteX6" fmla="*/ 2938065 w 3640080"/>
                <a:gd name="connsiteY6" fmla="*/ 0 h 3727022"/>
                <a:gd name="connsiteX7" fmla="*/ 3640080 w 3640080"/>
                <a:gd name="connsiteY7" fmla="*/ 0 h 3727022"/>
                <a:gd name="connsiteX8" fmla="*/ 3640080 w 3640080"/>
                <a:gd name="connsiteY8" fmla="*/ 569702 h 3727022"/>
                <a:gd name="connsiteX9" fmla="*/ 3640080 w 3640080"/>
                <a:gd name="connsiteY9" fmla="*/ 1027593 h 3727022"/>
                <a:gd name="connsiteX10" fmla="*/ 3640080 w 3640080"/>
                <a:gd name="connsiteY10" fmla="*/ 1597295 h 3727022"/>
                <a:gd name="connsiteX11" fmla="*/ 3640080 w 3640080"/>
                <a:gd name="connsiteY11" fmla="*/ 2092457 h 3727022"/>
                <a:gd name="connsiteX12" fmla="*/ 3640080 w 3640080"/>
                <a:gd name="connsiteY12" fmla="*/ 2513078 h 3727022"/>
                <a:gd name="connsiteX13" fmla="*/ 3640080 w 3640080"/>
                <a:gd name="connsiteY13" fmla="*/ 2933699 h 3727022"/>
                <a:gd name="connsiteX14" fmla="*/ 3640080 w 3640080"/>
                <a:gd name="connsiteY14" fmla="*/ 3727022 h 3727022"/>
                <a:gd name="connsiteX15" fmla="*/ 3192870 w 3640080"/>
                <a:gd name="connsiteY15" fmla="*/ 3727022 h 3727022"/>
                <a:gd name="connsiteX16" fmla="*/ 2782061 w 3640080"/>
                <a:gd name="connsiteY16" fmla="*/ 3727022 h 3727022"/>
                <a:gd name="connsiteX17" fmla="*/ 2371252 w 3640080"/>
                <a:gd name="connsiteY17" fmla="*/ 3727022 h 3727022"/>
                <a:gd name="connsiteX18" fmla="*/ 1814840 w 3640080"/>
                <a:gd name="connsiteY18" fmla="*/ 3727022 h 3727022"/>
                <a:gd name="connsiteX19" fmla="*/ 1258428 w 3640080"/>
                <a:gd name="connsiteY19" fmla="*/ 3727022 h 3727022"/>
                <a:gd name="connsiteX20" fmla="*/ 811218 w 3640080"/>
                <a:gd name="connsiteY20" fmla="*/ 3727022 h 3727022"/>
                <a:gd name="connsiteX21" fmla="*/ 0 w 3640080"/>
                <a:gd name="connsiteY21" fmla="*/ 3727022 h 3727022"/>
                <a:gd name="connsiteX22" fmla="*/ 0 w 3640080"/>
                <a:gd name="connsiteY22" fmla="*/ 3306401 h 3727022"/>
                <a:gd name="connsiteX23" fmla="*/ 0 w 3640080"/>
                <a:gd name="connsiteY23" fmla="*/ 2885780 h 3727022"/>
                <a:gd name="connsiteX24" fmla="*/ 0 w 3640080"/>
                <a:gd name="connsiteY24" fmla="*/ 2465159 h 3727022"/>
                <a:gd name="connsiteX25" fmla="*/ 0 w 3640080"/>
                <a:gd name="connsiteY25" fmla="*/ 1858187 h 3727022"/>
                <a:gd name="connsiteX26" fmla="*/ 0 w 3640080"/>
                <a:gd name="connsiteY26" fmla="*/ 1325755 h 3727022"/>
                <a:gd name="connsiteX27" fmla="*/ 0 w 3640080"/>
                <a:gd name="connsiteY27" fmla="*/ 793323 h 3727022"/>
                <a:gd name="connsiteX28" fmla="*/ 0 w 3640080"/>
                <a:gd name="connsiteY28" fmla="*/ 0 h 372702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3640080" h="3727022" extrusionOk="0">
                  <a:moveTo>
                    <a:pt x="0" y="0"/>
                  </a:moveTo>
                  <a:cubicBezTo>
                    <a:pt x="265327" y="-2923"/>
                    <a:pt x="305839" y="38604"/>
                    <a:pt x="556412" y="0"/>
                  </a:cubicBezTo>
                  <a:cubicBezTo>
                    <a:pt x="806985" y="-38604"/>
                    <a:pt x="912741" y="30287"/>
                    <a:pt x="1003622" y="0"/>
                  </a:cubicBezTo>
                  <a:cubicBezTo>
                    <a:pt x="1094503" y="-30287"/>
                    <a:pt x="1425227" y="45270"/>
                    <a:pt x="1560034" y="0"/>
                  </a:cubicBezTo>
                  <a:cubicBezTo>
                    <a:pt x="1694841" y="-45270"/>
                    <a:pt x="1974637" y="46165"/>
                    <a:pt x="2080046" y="0"/>
                  </a:cubicBezTo>
                  <a:cubicBezTo>
                    <a:pt x="2185455" y="-46165"/>
                    <a:pt x="2360497" y="48573"/>
                    <a:pt x="2490855" y="0"/>
                  </a:cubicBezTo>
                  <a:cubicBezTo>
                    <a:pt x="2621213" y="-48573"/>
                    <a:pt x="2716015" y="6649"/>
                    <a:pt x="2938065" y="0"/>
                  </a:cubicBezTo>
                  <a:cubicBezTo>
                    <a:pt x="3160115" y="-6649"/>
                    <a:pt x="3482314" y="56927"/>
                    <a:pt x="3640080" y="0"/>
                  </a:cubicBezTo>
                  <a:cubicBezTo>
                    <a:pt x="3679881" y="189578"/>
                    <a:pt x="3639206" y="320922"/>
                    <a:pt x="3640080" y="569702"/>
                  </a:cubicBezTo>
                  <a:cubicBezTo>
                    <a:pt x="3640954" y="818482"/>
                    <a:pt x="3589846" y="893263"/>
                    <a:pt x="3640080" y="1027593"/>
                  </a:cubicBezTo>
                  <a:cubicBezTo>
                    <a:pt x="3690314" y="1161923"/>
                    <a:pt x="3629822" y="1408947"/>
                    <a:pt x="3640080" y="1597295"/>
                  </a:cubicBezTo>
                  <a:cubicBezTo>
                    <a:pt x="3650338" y="1785643"/>
                    <a:pt x="3590572" y="1857124"/>
                    <a:pt x="3640080" y="2092457"/>
                  </a:cubicBezTo>
                  <a:cubicBezTo>
                    <a:pt x="3689588" y="2327790"/>
                    <a:pt x="3626107" y="2329859"/>
                    <a:pt x="3640080" y="2513078"/>
                  </a:cubicBezTo>
                  <a:cubicBezTo>
                    <a:pt x="3654053" y="2696297"/>
                    <a:pt x="3619849" y="2811056"/>
                    <a:pt x="3640080" y="2933699"/>
                  </a:cubicBezTo>
                  <a:cubicBezTo>
                    <a:pt x="3660311" y="3056342"/>
                    <a:pt x="3599594" y="3560041"/>
                    <a:pt x="3640080" y="3727022"/>
                  </a:cubicBezTo>
                  <a:cubicBezTo>
                    <a:pt x="3499877" y="3744586"/>
                    <a:pt x="3365413" y="3717333"/>
                    <a:pt x="3192870" y="3727022"/>
                  </a:cubicBezTo>
                  <a:cubicBezTo>
                    <a:pt x="3020327" y="3736711"/>
                    <a:pt x="2869254" y="3709307"/>
                    <a:pt x="2782061" y="3727022"/>
                  </a:cubicBezTo>
                  <a:cubicBezTo>
                    <a:pt x="2694868" y="3744737"/>
                    <a:pt x="2569343" y="3685498"/>
                    <a:pt x="2371252" y="3727022"/>
                  </a:cubicBezTo>
                  <a:cubicBezTo>
                    <a:pt x="2173161" y="3768546"/>
                    <a:pt x="2085574" y="3687320"/>
                    <a:pt x="1814840" y="3727022"/>
                  </a:cubicBezTo>
                  <a:cubicBezTo>
                    <a:pt x="1544106" y="3766724"/>
                    <a:pt x="1436632" y="3681767"/>
                    <a:pt x="1258428" y="3727022"/>
                  </a:cubicBezTo>
                  <a:cubicBezTo>
                    <a:pt x="1080224" y="3772277"/>
                    <a:pt x="922793" y="3692696"/>
                    <a:pt x="811218" y="3727022"/>
                  </a:cubicBezTo>
                  <a:cubicBezTo>
                    <a:pt x="699643" y="3761348"/>
                    <a:pt x="323089" y="3659358"/>
                    <a:pt x="0" y="3727022"/>
                  </a:cubicBezTo>
                  <a:cubicBezTo>
                    <a:pt x="-8001" y="3565571"/>
                    <a:pt x="19412" y="3473714"/>
                    <a:pt x="0" y="3306401"/>
                  </a:cubicBezTo>
                  <a:cubicBezTo>
                    <a:pt x="-19412" y="3139088"/>
                    <a:pt x="9463" y="3028074"/>
                    <a:pt x="0" y="2885780"/>
                  </a:cubicBezTo>
                  <a:cubicBezTo>
                    <a:pt x="-9463" y="2743486"/>
                    <a:pt x="27982" y="2597756"/>
                    <a:pt x="0" y="2465159"/>
                  </a:cubicBezTo>
                  <a:cubicBezTo>
                    <a:pt x="-27982" y="2332562"/>
                    <a:pt x="58134" y="2100290"/>
                    <a:pt x="0" y="1858187"/>
                  </a:cubicBezTo>
                  <a:cubicBezTo>
                    <a:pt x="-58134" y="1616084"/>
                    <a:pt x="37456" y="1471422"/>
                    <a:pt x="0" y="1325755"/>
                  </a:cubicBezTo>
                  <a:cubicBezTo>
                    <a:pt x="-37456" y="1180088"/>
                    <a:pt x="26170" y="971509"/>
                    <a:pt x="0" y="793323"/>
                  </a:cubicBezTo>
                  <a:cubicBezTo>
                    <a:pt x="-26170" y="615137"/>
                    <a:pt x="62884" y="292044"/>
                    <a:pt x="0" y="0"/>
                  </a:cubicBezTo>
                  <a:close/>
                </a:path>
              </a:pathLst>
            </a:custGeom>
            <a:noFill/>
            <a:ln w="28575">
              <a:solidFill>
                <a:schemeClr val="tx1"/>
              </a:solidFill>
              <a:extLst>
                <a:ext uri="{C807C97D-BFC1-408E-A445-0C87EB9F89A2}">
                  <ask:lineSketchStyleProps xmlns:ask="http://schemas.microsoft.com/office/drawing/2018/sketchyshapes" sd="3788527064">
                    <a:prstGeom prst="rect">
                      <a:avLst/>
                    </a:prstGeom>
                    <ask:type>
                      <ask:lineSketchScribble/>
                    </ask:type>
                  </ask:lineSketchStyleProps>
                </a:ext>
              </a:extLst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85"/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C450CD89-A814-8804-292D-62F7B7CA3B82}"/>
                </a:ext>
              </a:extLst>
            </p:cNvPr>
            <p:cNvSpPr txBox="1"/>
            <p:nvPr/>
          </p:nvSpPr>
          <p:spPr>
            <a:xfrm>
              <a:off x="52116" y="3645447"/>
              <a:ext cx="3993248" cy="4550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My Plan:</a:t>
              </a:r>
              <a:endParaRPr lang="en-US" sz="1600" b="1" dirty="0"/>
            </a:p>
          </p:txBody>
        </p:sp>
      </p:grpSp>
      <p:sp>
        <p:nvSpPr>
          <p:cNvPr id="94" name="Rectangle 93">
            <a:extLst>
              <a:ext uri="{FF2B5EF4-FFF2-40B4-BE49-F238E27FC236}">
                <a16:creationId xmlns:a16="http://schemas.microsoft.com/office/drawing/2014/main" id="{9ACF1604-A8A5-2B42-9DD7-169450BB9B13}"/>
              </a:ext>
            </a:extLst>
          </p:cNvPr>
          <p:cNvSpPr/>
          <p:nvPr/>
        </p:nvSpPr>
        <p:spPr>
          <a:xfrm>
            <a:off x="5544121" y="1866289"/>
            <a:ext cx="1704792" cy="1206893"/>
          </a:xfrm>
          <a:custGeom>
            <a:avLst/>
            <a:gdLst>
              <a:gd name="connsiteX0" fmla="*/ 0 w 1704792"/>
              <a:gd name="connsiteY0" fmla="*/ 0 h 1206893"/>
              <a:gd name="connsiteX1" fmla="*/ 534168 w 1704792"/>
              <a:gd name="connsiteY1" fmla="*/ 0 h 1206893"/>
              <a:gd name="connsiteX2" fmla="*/ 1051288 w 1704792"/>
              <a:gd name="connsiteY2" fmla="*/ 0 h 1206893"/>
              <a:gd name="connsiteX3" fmla="*/ 1704792 w 1704792"/>
              <a:gd name="connsiteY3" fmla="*/ 0 h 1206893"/>
              <a:gd name="connsiteX4" fmla="*/ 1704792 w 1704792"/>
              <a:gd name="connsiteY4" fmla="*/ 402298 h 1206893"/>
              <a:gd name="connsiteX5" fmla="*/ 1704792 w 1704792"/>
              <a:gd name="connsiteY5" fmla="*/ 816664 h 1206893"/>
              <a:gd name="connsiteX6" fmla="*/ 1704792 w 1704792"/>
              <a:gd name="connsiteY6" fmla="*/ 1206893 h 1206893"/>
              <a:gd name="connsiteX7" fmla="*/ 1187672 w 1704792"/>
              <a:gd name="connsiteY7" fmla="*/ 1206893 h 1206893"/>
              <a:gd name="connsiteX8" fmla="*/ 619408 w 1704792"/>
              <a:gd name="connsiteY8" fmla="*/ 1206893 h 1206893"/>
              <a:gd name="connsiteX9" fmla="*/ 0 w 1704792"/>
              <a:gd name="connsiteY9" fmla="*/ 1206893 h 1206893"/>
              <a:gd name="connsiteX10" fmla="*/ 0 w 1704792"/>
              <a:gd name="connsiteY10" fmla="*/ 840802 h 1206893"/>
              <a:gd name="connsiteX11" fmla="*/ 0 w 1704792"/>
              <a:gd name="connsiteY11" fmla="*/ 414367 h 1206893"/>
              <a:gd name="connsiteX12" fmla="*/ 0 w 1704792"/>
              <a:gd name="connsiteY12" fmla="*/ 0 h 12068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</a:cxnLst>
            <a:rect l="l" t="t" r="r" b="b"/>
            <a:pathLst>
              <a:path w="1704792" h="1206893" fill="none" extrusionOk="0">
                <a:moveTo>
                  <a:pt x="0" y="0"/>
                </a:moveTo>
                <a:cubicBezTo>
                  <a:pt x="122320" y="-15871"/>
                  <a:pt x="355590" y="11164"/>
                  <a:pt x="534168" y="0"/>
                </a:cubicBezTo>
                <a:cubicBezTo>
                  <a:pt x="712746" y="-11164"/>
                  <a:pt x="918234" y="9479"/>
                  <a:pt x="1051288" y="0"/>
                </a:cubicBezTo>
                <a:cubicBezTo>
                  <a:pt x="1184342" y="-9479"/>
                  <a:pt x="1409620" y="1228"/>
                  <a:pt x="1704792" y="0"/>
                </a:cubicBezTo>
                <a:cubicBezTo>
                  <a:pt x="1728621" y="97400"/>
                  <a:pt x="1677883" y="227863"/>
                  <a:pt x="1704792" y="402298"/>
                </a:cubicBezTo>
                <a:cubicBezTo>
                  <a:pt x="1731701" y="576733"/>
                  <a:pt x="1666568" y="615667"/>
                  <a:pt x="1704792" y="816664"/>
                </a:cubicBezTo>
                <a:cubicBezTo>
                  <a:pt x="1743016" y="1017661"/>
                  <a:pt x="1698485" y="1105608"/>
                  <a:pt x="1704792" y="1206893"/>
                </a:cubicBezTo>
                <a:cubicBezTo>
                  <a:pt x="1555576" y="1235475"/>
                  <a:pt x="1399688" y="1166781"/>
                  <a:pt x="1187672" y="1206893"/>
                </a:cubicBezTo>
                <a:cubicBezTo>
                  <a:pt x="975656" y="1247005"/>
                  <a:pt x="886984" y="1144184"/>
                  <a:pt x="619408" y="1206893"/>
                </a:cubicBezTo>
                <a:cubicBezTo>
                  <a:pt x="351832" y="1269602"/>
                  <a:pt x="181216" y="1145354"/>
                  <a:pt x="0" y="1206893"/>
                </a:cubicBezTo>
                <a:cubicBezTo>
                  <a:pt x="-42759" y="1059016"/>
                  <a:pt x="10620" y="1003023"/>
                  <a:pt x="0" y="840802"/>
                </a:cubicBezTo>
                <a:cubicBezTo>
                  <a:pt x="-10620" y="678581"/>
                  <a:pt x="31248" y="514040"/>
                  <a:pt x="0" y="414367"/>
                </a:cubicBezTo>
                <a:cubicBezTo>
                  <a:pt x="-31248" y="314695"/>
                  <a:pt x="4539" y="111587"/>
                  <a:pt x="0" y="0"/>
                </a:cubicBezTo>
                <a:close/>
              </a:path>
              <a:path w="1704792" h="1206893" stroke="0" extrusionOk="0">
                <a:moveTo>
                  <a:pt x="0" y="0"/>
                </a:moveTo>
                <a:cubicBezTo>
                  <a:pt x="124829" y="-1553"/>
                  <a:pt x="373584" y="60202"/>
                  <a:pt x="585312" y="0"/>
                </a:cubicBezTo>
                <a:cubicBezTo>
                  <a:pt x="797040" y="-60202"/>
                  <a:pt x="873752" y="1460"/>
                  <a:pt x="1119480" y="0"/>
                </a:cubicBezTo>
                <a:cubicBezTo>
                  <a:pt x="1365208" y="-1460"/>
                  <a:pt x="1488101" y="62808"/>
                  <a:pt x="1704792" y="0"/>
                </a:cubicBezTo>
                <a:cubicBezTo>
                  <a:pt x="1709658" y="198606"/>
                  <a:pt x="1662111" y="304055"/>
                  <a:pt x="1704792" y="402298"/>
                </a:cubicBezTo>
                <a:cubicBezTo>
                  <a:pt x="1747473" y="500541"/>
                  <a:pt x="1683672" y="626818"/>
                  <a:pt x="1704792" y="768389"/>
                </a:cubicBezTo>
                <a:cubicBezTo>
                  <a:pt x="1725912" y="909960"/>
                  <a:pt x="1686914" y="1003726"/>
                  <a:pt x="1704792" y="1206893"/>
                </a:cubicBezTo>
                <a:cubicBezTo>
                  <a:pt x="1523719" y="1213742"/>
                  <a:pt x="1281008" y="1160975"/>
                  <a:pt x="1119480" y="1206893"/>
                </a:cubicBezTo>
                <a:cubicBezTo>
                  <a:pt x="957952" y="1252811"/>
                  <a:pt x="648338" y="1176337"/>
                  <a:pt x="517120" y="1206893"/>
                </a:cubicBezTo>
                <a:cubicBezTo>
                  <a:pt x="385902" y="1237449"/>
                  <a:pt x="253232" y="1144971"/>
                  <a:pt x="0" y="1206893"/>
                </a:cubicBezTo>
                <a:cubicBezTo>
                  <a:pt x="-39061" y="1093336"/>
                  <a:pt x="13620" y="1010453"/>
                  <a:pt x="0" y="840802"/>
                </a:cubicBezTo>
                <a:cubicBezTo>
                  <a:pt x="-13620" y="671151"/>
                  <a:pt x="24615" y="550505"/>
                  <a:pt x="0" y="450573"/>
                </a:cubicBezTo>
                <a:cubicBezTo>
                  <a:pt x="-24615" y="350641"/>
                  <a:pt x="37725" y="217812"/>
                  <a:pt x="0" y="0"/>
                </a:cubicBezTo>
                <a:close/>
              </a:path>
            </a:pathLst>
          </a:custGeom>
          <a:solidFill>
            <a:schemeClr val="bg1"/>
          </a:solidFill>
          <a:ln w="28575">
            <a:solidFill>
              <a:schemeClr val="tx1"/>
            </a:solidFill>
            <a:extLst>
              <a:ext uri="{C807C97D-BFC1-408E-A445-0C87EB9F89A2}">
                <ask:lineSketchStyleProps xmlns:ask="http://schemas.microsoft.com/office/drawing/2018/sketchyshapes" sd="3788527064">
                  <a:prstGeom prst="rect">
                    <a:avLst/>
                  </a:prstGeom>
                  <ask:type>
                    <ask:lineSketchScribble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85"/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2089386E-99F8-7C90-5E1B-42A2E7DB5D33}"/>
              </a:ext>
            </a:extLst>
          </p:cNvPr>
          <p:cNvSpPr txBox="1"/>
          <p:nvPr/>
        </p:nvSpPr>
        <p:spPr>
          <a:xfrm>
            <a:off x="5484293" y="1877425"/>
            <a:ext cx="183301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u="sng" dirty="0"/>
              <a:t>Naloxone – Where to Get a Refill</a:t>
            </a:r>
          </a:p>
        </p:txBody>
      </p:sp>
    </p:spTree>
    <p:extLst>
      <p:ext uri="{BB962C8B-B14F-4D97-AF65-F5344CB8AC3E}">
        <p14:creationId xmlns:p14="http://schemas.microsoft.com/office/powerpoint/2010/main" val="5268187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F950DC3F-3207-3D81-D1E8-CED2EDADD5B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62734" y="323581"/>
            <a:ext cx="625874" cy="625874"/>
          </a:xfrm>
          <a:prstGeom prst="rect">
            <a:avLst/>
          </a:prstGeom>
        </p:spPr>
      </p:pic>
      <p:sp>
        <p:nvSpPr>
          <p:cNvPr id="222" name="Rectangle 221">
            <a:extLst>
              <a:ext uri="{FF2B5EF4-FFF2-40B4-BE49-F238E27FC236}">
                <a16:creationId xmlns:a16="http://schemas.microsoft.com/office/drawing/2014/main" id="{50C7EF86-F81C-B235-D8D7-33A407B4A9B8}"/>
              </a:ext>
            </a:extLst>
          </p:cNvPr>
          <p:cNvSpPr/>
          <p:nvPr/>
        </p:nvSpPr>
        <p:spPr>
          <a:xfrm>
            <a:off x="3661106" y="1788"/>
            <a:ext cx="3651923" cy="3200400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>
            <a:noFill/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85" dirty="0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79B1B53B-70B6-DA0A-2E75-7496B3B03DE4}"/>
              </a:ext>
            </a:extLst>
          </p:cNvPr>
          <p:cNvSpPr/>
          <p:nvPr/>
        </p:nvSpPr>
        <p:spPr>
          <a:xfrm>
            <a:off x="0" y="0"/>
            <a:ext cx="7315200" cy="3200400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150" dirty="0"/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CFCE2E8E-B4B4-A976-DFA0-E07F9930D3D4}"/>
              </a:ext>
            </a:extLst>
          </p:cNvPr>
          <p:cNvCxnSpPr>
            <a:cxnSpLocks/>
          </p:cNvCxnSpPr>
          <p:nvPr/>
        </p:nvCxnSpPr>
        <p:spPr>
          <a:xfrm>
            <a:off x="1828800" y="-2385"/>
            <a:ext cx="0" cy="320040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D72266AE-6017-E383-BA58-6E4A9CA16BD9}"/>
              </a:ext>
            </a:extLst>
          </p:cNvPr>
          <p:cNvCxnSpPr>
            <a:cxnSpLocks/>
          </p:cNvCxnSpPr>
          <p:nvPr/>
        </p:nvCxnSpPr>
        <p:spPr>
          <a:xfrm>
            <a:off x="3654095" y="24581"/>
            <a:ext cx="3505" cy="315332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5" name="Group 34">
            <a:extLst>
              <a:ext uri="{FF2B5EF4-FFF2-40B4-BE49-F238E27FC236}">
                <a16:creationId xmlns:a16="http://schemas.microsoft.com/office/drawing/2014/main" id="{9C676DBD-ECC0-1131-8781-0E145ED6B950}"/>
              </a:ext>
            </a:extLst>
          </p:cNvPr>
          <p:cNvGrpSpPr/>
          <p:nvPr/>
        </p:nvGrpSpPr>
        <p:grpSpPr>
          <a:xfrm>
            <a:off x="100438" y="61971"/>
            <a:ext cx="1625130" cy="3042443"/>
            <a:chOff x="100438" y="61971"/>
            <a:chExt cx="1625130" cy="3042443"/>
          </a:xfrm>
        </p:grpSpPr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E8A2EC8F-1406-CBAF-AF49-21104BB1D84A}"/>
                </a:ext>
              </a:extLst>
            </p:cNvPr>
            <p:cNvSpPr txBox="1"/>
            <p:nvPr/>
          </p:nvSpPr>
          <p:spPr>
            <a:xfrm>
              <a:off x="118308" y="61971"/>
              <a:ext cx="160726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OVERAMP SYMPTOMS</a:t>
              </a:r>
            </a:p>
          </p:txBody>
        </p: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A6BD3497-6287-9257-FDAB-F5F12A80F1A8}"/>
                </a:ext>
              </a:extLst>
            </p:cNvPr>
            <p:cNvSpPr txBox="1"/>
            <p:nvPr/>
          </p:nvSpPr>
          <p:spPr>
            <a:xfrm>
              <a:off x="100438" y="585192"/>
              <a:ext cx="1618283" cy="24929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235745" indent="-235745">
                <a:buFont typeface="Wingdings" panose="05000000000000000000" pitchFamily="2" charset="2"/>
                <a:buChar char="§"/>
              </a:pPr>
              <a:r>
                <a:rPr lang="en-US" sz="1200" dirty="0"/>
                <a:t>Restlessness</a:t>
              </a:r>
            </a:p>
            <a:p>
              <a:pPr marL="235745" indent="-235745">
                <a:buFont typeface="Wingdings" panose="05000000000000000000" pitchFamily="2" charset="2"/>
                <a:buChar char="§"/>
              </a:pPr>
              <a:r>
                <a:rPr lang="en-US" sz="1200" dirty="0"/>
                <a:t>Extreme paranoia</a:t>
              </a:r>
            </a:p>
            <a:p>
              <a:pPr marL="235745" indent="-235745">
                <a:buFont typeface="Wingdings" panose="05000000000000000000" pitchFamily="2" charset="2"/>
                <a:buChar char="§"/>
              </a:pPr>
              <a:r>
                <a:rPr lang="en-US" sz="1200" dirty="0"/>
                <a:t>Hallucinations</a:t>
              </a:r>
            </a:p>
            <a:p>
              <a:pPr marL="235745" indent="-235745">
                <a:buFont typeface="Wingdings" panose="05000000000000000000" pitchFamily="2" charset="2"/>
                <a:buChar char="§"/>
              </a:pPr>
              <a:r>
                <a:rPr lang="en-US" sz="1200" dirty="0"/>
                <a:t>Delusions</a:t>
              </a:r>
            </a:p>
            <a:p>
              <a:pPr marL="235745" indent="-235745">
                <a:buFont typeface="Wingdings" panose="05000000000000000000" pitchFamily="2" charset="2"/>
                <a:buChar char="§"/>
              </a:pPr>
              <a:r>
                <a:rPr lang="en-US" sz="1200" dirty="0"/>
                <a:t>Jerking movements</a:t>
              </a:r>
            </a:p>
            <a:p>
              <a:pPr marL="235745" indent="-235745">
                <a:buFont typeface="Wingdings" panose="05000000000000000000" pitchFamily="2" charset="2"/>
                <a:buChar char="§"/>
              </a:pPr>
              <a:r>
                <a:rPr lang="en-US" sz="1200" dirty="0"/>
                <a:t>Difficultly or irregular breathing </a:t>
              </a:r>
            </a:p>
            <a:p>
              <a:pPr marL="235745" indent="-235745">
                <a:buFont typeface="Wingdings" panose="05000000000000000000" pitchFamily="2" charset="2"/>
                <a:buChar char="§"/>
              </a:pPr>
              <a:r>
                <a:rPr lang="en-US" sz="1200" dirty="0"/>
                <a:t>Can’t walk or move</a:t>
              </a:r>
            </a:p>
            <a:p>
              <a:pPr marL="235745" indent="-235745">
                <a:buFont typeface="Wingdings" panose="05000000000000000000" pitchFamily="2" charset="2"/>
                <a:buChar char="§"/>
              </a:pPr>
              <a:r>
                <a:rPr lang="en-US" sz="1200" dirty="0"/>
                <a:t>High body temperature </a:t>
              </a:r>
            </a:p>
            <a:p>
              <a:pPr marL="235745" indent="-235745">
                <a:buFont typeface="Wingdings" panose="05000000000000000000" pitchFamily="2" charset="2"/>
                <a:buChar char="§"/>
              </a:pPr>
              <a:r>
                <a:rPr lang="en-US" sz="1200" dirty="0"/>
                <a:t>Teeth grinding</a:t>
              </a:r>
            </a:p>
            <a:p>
              <a:pPr marL="235745" indent="-235745">
                <a:buFont typeface="Wingdings" panose="05000000000000000000" pitchFamily="2" charset="2"/>
                <a:buChar char="§"/>
              </a:pPr>
              <a:r>
                <a:rPr lang="en-US" sz="1200" dirty="0"/>
                <a:t>Fast, racing heart</a:t>
              </a:r>
            </a:p>
          </p:txBody>
        </p:sp>
        <p:sp>
          <p:nvSpPr>
            <p:cNvPr id="119" name="Rectangle 118">
              <a:extLst>
                <a:ext uri="{FF2B5EF4-FFF2-40B4-BE49-F238E27FC236}">
                  <a16:creationId xmlns:a16="http://schemas.microsoft.com/office/drawing/2014/main" id="{0E939060-2322-2DFB-1FD1-18D63F9A68A9}"/>
                </a:ext>
              </a:extLst>
            </p:cNvPr>
            <p:cNvSpPr/>
            <p:nvPr/>
          </p:nvSpPr>
          <p:spPr>
            <a:xfrm>
              <a:off x="100438" y="75467"/>
              <a:ext cx="1610374" cy="3028947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prstDash val="solid"/>
              <a:extLst>
                <a:ext uri="{C807C97D-BFC1-408E-A445-0C87EB9F89A2}">
                  <ask:lineSketchStyleProps xmlns:ask="http://schemas.microsoft.com/office/drawing/2018/sketchyshapes" sd="3788527064">
                    <a:custGeom>
                      <a:avLst/>
                      <a:gdLst>
                        <a:gd name="connsiteX0" fmla="*/ 0 w 1610374"/>
                        <a:gd name="connsiteY0" fmla="*/ 0 h 3028947"/>
                        <a:gd name="connsiteX1" fmla="*/ 552895 w 1610374"/>
                        <a:gd name="connsiteY1" fmla="*/ 0 h 3028947"/>
                        <a:gd name="connsiteX2" fmla="*/ 1057479 w 1610374"/>
                        <a:gd name="connsiteY2" fmla="*/ 0 h 3028947"/>
                        <a:gd name="connsiteX3" fmla="*/ 1610374 w 1610374"/>
                        <a:gd name="connsiteY3" fmla="*/ 0 h 3028947"/>
                        <a:gd name="connsiteX4" fmla="*/ 1610374 w 1610374"/>
                        <a:gd name="connsiteY4" fmla="*/ 504825 h 3028947"/>
                        <a:gd name="connsiteX5" fmla="*/ 1610374 w 1610374"/>
                        <a:gd name="connsiteY5" fmla="*/ 918781 h 3028947"/>
                        <a:gd name="connsiteX6" fmla="*/ 1610374 w 1610374"/>
                        <a:gd name="connsiteY6" fmla="*/ 1363026 h 3028947"/>
                        <a:gd name="connsiteX7" fmla="*/ 1610374 w 1610374"/>
                        <a:gd name="connsiteY7" fmla="*/ 1898140 h 3028947"/>
                        <a:gd name="connsiteX8" fmla="*/ 1610374 w 1610374"/>
                        <a:gd name="connsiteY8" fmla="*/ 2433254 h 3028947"/>
                        <a:gd name="connsiteX9" fmla="*/ 1610374 w 1610374"/>
                        <a:gd name="connsiteY9" fmla="*/ 3028947 h 3028947"/>
                        <a:gd name="connsiteX10" fmla="*/ 1057479 w 1610374"/>
                        <a:gd name="connsiteY10" fmla="*/ 3028947 h 3028947"/>
                        <a:gd name="connsiteX11" fmla="*/ 552895 w 1610374"/>
                        <a:gd name="connsiteY11" fmla="*/ 3028947 h 3028947"/>
                        <a:gd name="connsiteX12" fmla="*/ 0 w 1610374"/>
                        <a:gd name="connsiteY12" fmla="*/ 3028947 h 3028947"/>
                        <a:gd name="connsiteX13" fmla="*/ 0 w 1610374"/>
                        <a:gd name="connsiteY13" fmla="*/ 2493833 h 3028947"/>
                        <a:gd name="connsiteX14" fmla="*/ 0 w 1610374"/>
                        <a:gd name="connsiteY14" fmla="*/ 2049587 h 3028947"/>
                        <a:gd name="connsiteX15" fmla="*/ 0 w 1610374"/>
                        <a:gd name="connsiteY15" fmla="*/ 1544763 h 3028947"/>
                        <a:gd name="connsiteX16" fmla="*/ 0 w 1610374"/>
                        <a:gd name="connsiteY16" fmla="*/ 1039938 h 3028947"/>
                        <a:gd name="connsiteX17" fmla="*/ 0 w 1610374"/>
                        <a:gd name="connsiteY17" fmla="*/ 474535 h 3028947"/>
                        <a:gd name="connsiteX18" fmla="*/ 0 w 1610374"/>
                        <a:gd name="connsiteY18" fmla="*/ 0 h 3028947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</a:cxnLst>
                      <a:rect l="l" t="t" r="r" b="b"/>
                      <a:pathLst>
                        <a:path w="1610374" h="3028947" extrusionOk="0">
                          <a:moveTo>
                            <a:pt x="0" y="0"/>
                          </a:moveTo>
                          <a:cubicBezTo>
                            <a:pt x="149963" y="-17306"/>
                            <a:pt x="357556" y="32579"/>
                            <a:pt x="552895" y="0"/>
                          </a:cubicBezTo>
                          <a:cubicBezTo>
                            <a:pt x="748235" y="-32579"/>
                            <a:pt x="940687" y="15313"/>
                            <a:pt x="1057479" y="0"/>
                          </a:cubicBezTo>
                          <a:cubicBezTo>
                            <a:pt x="1174271" y="-15313"/>
                            <a:pt x="1432326" y="31288"/>
                            <a:pt x="1610374" y="0"/>
                          </a:cubicBezTo>
                          <a:cubicBezTo>
                            <a:pt x="1649219" y="180544"/>
                            <a:pt x="1600477" y="285331"/>
                            <a:pt x="1610374" y="504825"/>
                          </a:cubicBezTo>
                          <a:cubicBezTo>
                            <a:pt x="1620271" y="724319"/>
                            <a:pt x="1584199" y="722125"/>
                            <a:pt x="1610374" y="918781"/>
                          </a:cubicBezTo>
                          <a:cubicBezTo>
                            <a:pt x="1636549" y="1115437"/>
                            <a:pt x="1557983" y="1270599"/>
                            <a:pt x="1610374" y="1363026"/>
                          </a:cubicBezTo>
                          <a:cubicBezTo>
                            <a:pt x="1662765" y="1455453"/>
                            <a:pt x="1598359" y="1726189"/>
                            <a:pt x="1610374" y="1898140"/>
                          </a:cubicBezTo>
                          <a:cubicBezTo>
                            <a:pt x="1622389" y="2070091"/>
                            <a:pt x="1601903" y="2176907"/>
                            <a:pt x="1610374" y="2433254"/>
                          </a:cubicBezTo>
                          <a:cubicBezTo>
                            <a:pt x="1618845" y="2689601"/>
                            <a:pt x="1610021" y="2796764"/>
                            <a:pt x="1610374" y="3028947"/>
                          </a:cubicBezTo>
                          <a:cubicBezTo>
                            <a:pt x="1374133" y="3061085"/>
                            <a:pt x="1229307" y="3028670"/>
                            <a:pt x="1057479" y="3028947"/>
                          </a:cubicBezTo>
                          <a:cubicBezTo>
                            <a:pt x="885651" y="3029224"/>
                            <a:pt x="663805" y="3013274"/>
                            <a:pt x="552895" y="3028947"/>
                          </a:cubicBezTo>
                          <a:cubicBezTo>
                            <a:pt x="441985" y="3044620"/>
                            <a:pt x="271411" y="3005135"/>
                            <a:pt x="0" y="3028947"/>
                          </a:cubicBezTo>
                          <a:cubicBezTo>
                            <a:pt x="-19804" y="2882108"/>
                            <a:pt x="32825" y="2743854"/>
                            <a:pt x="0" y="2493833"/>
                          </a:cubicBezTo>
                          <a:cubicBezTo>
                            <a:pt x="-32825" y="2243812"/>
                            <a:pt x="41440" y="2270169"/>
                            <a:pt x="0" y="2049587"/>
                          </a:cubicBezTo>
                          <a:cubicBezTo>
                            <a:pt x="-41440" y="1829005"/>
                            <a:pt x="3152" y="1717784"/>
                            <a:pt x="0" y="1544763"/>
                          </a:cubicBezTo>
                          <a:cubicBezTo>
                            <a:pt x="-3152" y="1371742"/>
                            <a:pt x="58884" y="1147506"/>
                            <a:pt x="0" y="1039938"/>
                          </a:cubicBezTo>
                          <a:cubicBezTo>
                            <a:pt x="-58884" y="932370"/>
                            <a:pt x="16612" y="648009"/>
                            <a:pt x="0" y="474535"/>
                          </a:cubicBezTo>
                          <a:cubicBezTo>
                            <a:pt x="-16612" y="301061"/>
                            <a:pt x="15856" y="105615"/>
                            <a:pt x="0" y="0"/>
                          </a:cubicBezTo>
                          <a:close/>
                        </a:path>
                      </a:pathLst>
                    </a:custGeom>
                    <ask:type>
                      <ask:lineSketchNone/>
                    </ask:type>
                  </ask:lineSketchStyleProps>
                </a:ext>
              </a:extLst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85" dirty="0"/>
            </a:p>
          </p:txBody>
        </p:sp>
        <p:cxnSp>
          <p:nvCxnSpPr>
            <p:cNvPr id="120" name="Straight Connector 119">
              <a:extLst>
                <a:ext uri="{FF2B5EF4-FFF2-40B4-BE49-F238E27FC236}">
                  <a16:creationId xmlns:a16="http://schemas.microsoft.com/office/drawing/2014/main" id="{E943FA1E-A566-5728-861A-08DE6F67F66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78982" y="585192"/>
              <a:ext cx="125328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3" name="Group 32">
            <a:extLst>
              <a:ext uri="{FF2B5EF4-FFF2-40B4-BE49-F238E27FC236}">
                <a16:creationId xmlns:a16="http://schemas.microsoft.com/office/drawing/2014/main" id="{964E3242-E7AE-30A7-FE17-367A4323A2CF}"/>
              </a:ext>
            </a:extLst>
          </p:cNvPr>
          <p:cNvGrpSpPr/>
          <p:nvPr/>
        </p:nvGrpSpPr>
        <p:grpSpPr>
          <a:xfrm>
            <a:off x="3655702" y="72994"/>
            <a:ext cx="1834203" cy="3047566"/>
            <a:chOff x="3655702" y="72994"/>
            <a:chExt cx="1834203" cy="3047566"/>
          </a:xfrm>
        </p:grpSpPr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AEB99134-03AF-5006-A551-544D01477511}"/>
                </a:ext>
              </a:extLst>
            </p:cNvPr>
            <p:cNvSpPr/>
            <p:nvPr/>
          </p:nvSpPr>
          <p:spPr>
            <a:xfrm>
              <a:off x="3765640" y="667420"/>
              <a:ext cx="1610374" cy="2453140"/>
            </a:xfrm>
            <a:prstGeom prst="rect">
              <a:avLst/>
            </a:prstGeom>
            <a:solidFill>
              <a:schemeClr val="bg1"/>
            </a:solidFill>
            <a:ln w="19050">
              <a:solidFill>
                <a:schemeClr val="tx1"/>
              </a:solidFill>
              <a:prstDash val="solid"/>
              <a:extLst>
                <a:ext uri="{C807C97D-BFC1-408E-A445-0C87EB9F89A2}">
                  <ask:lineSketchStyleProps xmlns:ask="http://schemas.microsoft.com/office/drawing/2018/sketchyshapes" sd="3788527064">
                    <a:custGeom>
                      <a:avLst/>
                      <a:gdLst>
                        <a:gd name="connsiteX0" fmla="*/ 0 w 1610374"/>
                        <a:gd name="connsiteY0" fmla="*/ 0 h 3028947"/>
                        <a:gd name="connsiteX1" fmla="*/ 552895 w 1610374"/>
                        <a:gd name="connsiteY1" fmla="*/ 0 h 3028947"/>
                        <a:gd name="connsiteX2" fmla="*/ 1057479 w 1610374"/>
                        <a:gd name="connsiteY2" fmla="*/ 0 h 3028947"/>
                        <a:gd name="connsiteX3" fmla="*/ 1610374 w 1610374"/>
                        <a:gd name="connsiteY3" fmla="*/ 0 h 3028947"/>
                        <a:gd name="connsiteX4" fmla="*/ 1610374 w 1610374"/>
                        <a:gd name="connsiteY4" fmla="*/ 504825 h 3028947"/>
                        <a:gd name="connsiteX5" fmla="*/ 1610374 w 1610374"/>
                        <a:gd name="connsiteY5" fmla="*/ 918781 h 3028947"/>
                        <a:gd name="connsiteX6" fmla="*/ 1610374 w 1610374"/>
                        <a:gd name="connsiteY6" fmla="*/ 1363026 h 3028947"/>
                        <a:gd name="connsiteX7" fmla="*/ 1610374 w 1610374"/>
                        <a:gd name="connsiteY7" fmla="*/ 1898140 h 3028947"/>
                        <a:gd name="connsiteX8" fmla="*/ 1610374 w 1610374"/>
                        <a:gd name="connsiteY8" fmla="*/ 2433254 h 3028947"/>
                        <a:gd name="connsiteX9" fmla="*/ 1610374 w 1610374"/>
                        <a:gd name="connsiteY9" fmla="*/ 3028947 h 3028947"/>
                        <a:gd name="connsiteX10" fmla="*/ 1057479 w 1610374"/>
                        <a:gd name="connsiteY10" fmla="*/ 3028947 h 3028947"/>
                        <a:gd name="connsiteX11" fmla="*/ 552895 w 1610374"/>
                        <a:gd name="connsiteY11" fmla="*/ 3028947 h 3028947"/>
                        <a:gd name="connsiteX12" fmla="*/ 0 w 1610374"/>
                        <a:gd name="connsiteY12" fmla="*/ 3028947 h 3028947"/>
                        <a:gd name="connsiteX13" fmla="*/ 0 w 1610374"/>
                        <a:gd name="connsiteY13" fmla="*/ 2493833 h 3028947"/>
                        <a:gd name="connsiteX14" fmla="*/ 0 w 1610374"/>
                        <a:gd name="connsiteY14" fmla="*/ 2049587 h 3028947"/>
                        <a:gd name="connsiteX15" fmla="*/ 0 w 1610374"/>
                        <a:gd name="connsiteY15" fmla="*/ 1544763 h 3028947"/>
                        <a:gd name="connsiteX16" fmla="*/ 0 w 1610374"/>
                        <a:gd name="connsiteY16" fmla="*/ 1039938 h 3028947"/>
                        <a:gd name="connsiteX17" fmla="*/ 0 w 1610374"/>
                        <a:gd name="connsiteY17" fmla="*/ 474535 h 3028947"/>
                        <a:gd name="connsiteX18" fmla="*/ 0 w 1610374"/>
                        <a:gd name="connsiteY18" fmla="*/ 0 h 3028947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</a:cxnLst>
                      <a:rect l="l" t="t" r="r" b="b"/>
                      <a:pathLst>
                        <a:path w="1610374" h="3028947" extrusionOk="0">
                          <a:moveTo>
                            <a:pt x="0" y="0"/>
                          </a:moveTo>
                          <a:cubicBezTo>
                            <a:pt x="149963" y="-17306"/>
                            <a:pt x="357556" y="32579"/>
                            <a:pt x="552895" y="0"/>
                          </a:cubicBezTo>
                          <a:cubicBezTo>
                            <a:pt x="748235" y="-32579"/>
                            <a:pt x="940687" y="15313"/>
                            <a:pt x="1057479" y="0"/>
                          </a:cubicBezTo>
                          <a:cubicBezTo>
                            <a:pt x="1174271" y="-15313"/>
                            <a:pt x="1432326" y="31288"/>
                            <a:pt x="1610374" y="0"/>
                          </a:cubicBezTo>
                          <a:cubicBezTo>
                            <a:pt x="1649219" y="180544"/>
                            <a:pt x="1600477" y="285331"/>
                            <a:pt x="1610374" y="504825"/>
                          </a:cubicBezTo>
                          <a:cubicBezTo>
                            <a:pt x="1620271" y="724319"/>
                            <a:pt x="1584199" y="722125"/>
                            <a:pt x="1610374" y="918781"/>
                          </a:cubicBezTo>
                          <a:cubicBezTo>
                            <a:pt x="1636549" y="1115437"/>
                            <a:pt x="1557983" y="1270599"/>
                            <a:pt x="1610374" y="1363026"/>
                          </a:cubicBezTo>
                          <a:cubicBezTo>
                            <a:pt x="1662765" y="1455453"/>
                            <a:pt x="1598359" y="1726189"/>
                            <a:pt x="1610374" y="1898140"/>
                          </a:cubicBezTo>
                          <a:cubicBezTo>
                            <a:pt x="1622389" y="2070091"/>
                            <a:pt x="1601903" y="2176907"/>
                            <a:pt x="1610374" y="2433254"/>
                          </a:cubicBezTo>
                          <a:cubicBezTo>
                            <a:pt x="1618845" y="2689601"/>
                            <a:pt x="1610021" y="2796764"/>
                            <a:pt x="1610374" y="3028947"/>
                          </a:cubicBezTo>
                          <a:cubicBezTo>
                            <a:pt x="1374133" y="3061085"/>
                            <a:pt x="1229307" y="3028670"/>
                            <a:pt x="1057479" y="3028947"/>
                          </a:cubicBezTo>
                          <a:cubicBezTo>
                            <a:pt x="885651" y="3029224"/>
                            <a:pt x="663805" y="3013274"/>
                            <a:pt x="552895" y="3028947"/>
                          </a:cubicBezTo>
                          <a:cubicBezTo>
                            <a:pt x="441985" y="3044620"/>
                            <a:pt x="271411" y="3005135"/>
                            <a:pt x="0" y="3028947"/>
                          </a:cubicBezTo>
                          <a:cubicBezTo>
                            <a:pt x="-19804" y="2882108"/>
                            <a:pt x="32825" y="2743854"/>
                            <a:pt x="0" y="2493833"/>
                          </a:cubicBezTo>
                          <a:cubicBezTo>
                            <a:pt x="-32825" y="2243812"/>
                            <a:pt x="41440" y="2270169"/>
                            <a:pt x="0" y="2049587"/>
                          </a:cubicBezTo>
                          <a:cubicBezTo>
                            <a:pt x="-41440" y="1829005"/>
                            <a:pt x="3152" y="1717784"/>
                            <a:pt x="0" y="1544763"/>
                          </a:cubicBezTo>
                          <a:cubicBezTo>
                            <a:pt x="-3152" y="1371742"/>
                            <a:pt x="58884" y="1147506"/>
                            <a:pt x="0" y="1039938"/>
                          </a:cubicBezTo>
                          <a:cubicBezTo>
                            <a:pt x="-58884" y="932370"/>
                            <a:pt x="16612" y="648009"/>
                            <a:pt x="0" y="474535"/>
                          </a:cubicBezTo>
                          <a:cubicBezTo>
                            <a:pt x="-16612" y="301061"/>
                            <a:pt x="15856" y="105615"/>
                            <a:pt x="0" y="0"/>
                          </a:cubicBezTo>
                          <a:close/>
                        </a:path>
                      </a:pathLst>
                    </a:custGeom>
                    <ask:type>
                      <ask:lineSketchNone/>
                    </ask:type>
                  </ask:lineSketchStyleProps>
                </a:ext>
              </a:extLst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85" dirty="0"/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2039F7C5-5ABD-9BED-2EEC-2C0D3920866B}"/>
                </a:ext>
              </a:extLst>
            </p:cNvPr>
            <p:cNvSpPr txBox="1"/>
            <p:nvPr/>
          </p:nvSpPr>
          <p:spPr>
            <a:xfrm>
              <a:off x="3753334" y="1420703"/>
              <a:ext cx="1618283" cy="14465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235745" indent="-235745">
                <a:buFont typeface="Wingdings" panose="05000000000000000000" pitchFamily="2" charset="2"/>
                <a:buChar char="§"/>
              </a:pPr>
              <a:r>
                <a:rPr lang="en-US" sz="1100" dirty="0"/>
                <a:t>Cool down</a:t>
              </a:r>
            </a:p>
            <a:p>
              <a:pPr marL="235745" indent="-235745">
                <a:buFont typeface="Wingdings" panose="05000000000000000000" pitchFamily="2" charset="2"/>
                <a:buChar char="§"/>
              </a:pPr>
              <a:r>
                <a:rPr lang="en-US" sz="1100" dirty="0"/>
                <a:t>Drink water</a:t>
              </a:r>
            </a:p>
            <a:p>
              <a:pPr marL="235745" indent="-235745">
                <a:buFont typeface="Wingdings" panose="05000000000000000000" pitchFamily="2" charset="2"/>
                <a:buChar char="§"/>
              </a:pPr>
              <a:r>
                <a:rPr lang="en-US" sz="1100" dirty="0"/>
                <a:t>Eat food</a:t>
              </a:r>
            </a:p>
            <a:p>
              <a:pPr marL="235745" indent="-235745">
                <a:buFont typeface="Wingdings" panose="05000000000000000000" pitchFamily="2" charset="2"/>
                <a:buChar char="§"/>
              </a:pPr>
              <a:r>
                <a:rPr lang="en-US" sz="1100" dirty="0"/>
                <a:t>Rest</a:t>
              </a:r>
            </a:p>
            <a:p>
              <a:pPr marL="235745" indent="-235745">
                <a:buFont typeface="Wingdings" panose="05000000000000000000" pitchFamily="2" charset="2"/>
                <a:buChar char="§"/>
              </a:pPr>
              <a:r>
                <a:rPr lang="en-US" sz="1100" dirty="0"/>
                <a:t>Shower</a:t>
              </a:r>
            </a:p>
            <a:p>
              <a:pPr marL="235745" indent="-235745">
                <a:buFont typeface="Wingdings" panose="05000000000000000000" pitchFamily="2" charset="2"/>
                <a:buChar char="§"/>
              </a:pPr>
              <a:r>
                <a:rPr lang="en-US" sz="1100" dirty="0"/>
                <a:t>Change environment</a:t>
              </a:r>
            </a:p>
            <a:p>
              <a:pPr marL="235745" indent="-235745">
                <a:buFont typeface="Wingdings" panose="05000000000000000000" pitchFamily="2" charset="2"/>
                <a:buChar char="§"/>
              </a:pPr>
              <a:r>
                <a:rPr lang="en-US" sz="1100" dirty="0"/>
                <a:t>Engage in breath or meditation exercises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0C9A750D-F346-6CD9-54FD-5E1F3DB03FF2}"/>
                </a:ext>
              </a:extLst>
            </p:cNvPr>
            <p:cNvSpPr txBox="1"/>
            <p:nvPr/>
          </p:nvSpPr>
          <p:spPr>
            <a:xfrm>
              <a:off x="3780079" y="674465"/>
              <a:ext cx="1607260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Ways to make yourself (or others) more comfortable:</a:t>
              </a:r>
            </a:p>
          </p:txBody>
        </p: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D6323C82-6FBC-4FCC-6801-C8CCE04EB28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944184" y="1405314"/>
              <a:ext cx="125328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471FDD4F-AA2B-A6CF-CE4F-0A98E4678374}"/>
                </a:ext>
              </a:extLst>
            </p:cNvPr>
            <p:cNvSpPr txBox="1"/>
            <p:nvPr/>
          </p:nvSpPr>
          <p:spPr>
            <a:xfrm>
              <a:off x="3655702" y="72994"/>
              <a:ext cx="1834203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Not all overamps require calling 9-1-1 </a:t>
              </a:r>
            </a:p>
          </p:txBody>
        </p: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D994B5D7-5938-A058-4AEE-A57E7DEF9508}"/>
              </a:ext>
            </a:extLst>
          </p:cNvPr>
          <p:cNvSpPr txBox="1"/>
          <p:nvPr/>
        </p:nvSpPr>
        <p:spPr>
          <a:xfrm>
            <a:off x="1820806" y="559922"/>
            <a:ext cx="1743086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An </a:t>
            </a:r>
            <a:br>
              <a:rPr lang="en-US" sz="1600" dirty="0"/>
            </a:br>
            <a:r>
              <a:rPr lang="en-US" sz="2400" b="1" dirty="0"/>
              <a:t>overamp</a:t>
            </a:r>
            <a:r>
              <a:rPr lang="en-US" sz="1600" dirty="0"/>
              <a:t> is a severe event related to stimulant use that leads to harmful effects.</a:t>
            </a:r>
          </a:p>
        </p:txBody>
      </p:sp>
      <p:grpSp>
        <p:nvGrpSpPr>
          <p:cNvPr id="32" name="Group 31">
            <a:extLst>
              <a:ext uri="{FF2B5EF4-FFF2-40B4-BE49-F238E27FC236}">
                <a16:creationId xmlns:a16="http://schemas.microsoft.com/office/drawing/2014/main" id="{097C4C17-6592-9FAC-7166-54F0FE9B4E3E}"/>
              </a:ext>
            </a:extLst>
          </p:cNvPr>
          <p:cNvGrpSpPr/>
          <p:nvPr/>
        </p:nvGrpSpPr>
        <p:grpSpPr>
          <a:xfrm>
            <a:off x="5455271" y="0"/>
            <a:ext cx="1835165" cy="3200400"/>
            <a:chOff x="5455271" y="0"/>
            <a:chExt cx="1835165" cy="3200400"/>
          </a:xfrm>
        </p:grpSpPr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B8AD0828-AAA9-390D-28E6-1770858C2EF4}"/>
                </a:ext>
              </a:extLst>
            </p:cNvPr>
            <p:cNvGrpSpPr/>
            <p:nvPr/>
          </p:nvGrpSpPr>
          <p:grpSpPr>
            <a:xfrm>
              <a:off x="5455271" y="0"/>
              <a:ext cx="1835165" cy="3200400"/>
              <a:chOff x="5455271" y="0"/>
              <a:chExt cx="1835165" cy="3200400"/>
            </a:xfrm>
          </p:grpSpPr>
          <p:cxnSp>
            <p:nvCxnSpPr>
              <p:cNvPr id="22" name="Straight Connector 21">
                <a:extLst>
                  <a:ext uri="{FF2B5EF4-FFF2-40B4-BE49-F238E27FC236}">
                    <a16:creationId xmlns:a16="http://schemas.microsoft.com/office/drawing/2014/main" id="{93F6C8B5-E813-15B4-D55E-7018FCEB2DC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481697" y="0"/>
                <a:ext cx="0" cy="32004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7" name="TextBox 226">
                <a:extLst>
                  <a:ext uri="{FF2B5EF4-FFF2-40B4-BE49-F238E27FC236}">
                    <a16:creationId xmlns:a16="http://schemas.microsoft.com/office/drawing/2014/main" id="{8669A352-E2C2-B3F6-A4E5-B0B21C953904}"/>
                  </a:ext>
                </a:extLst>
              </p:cNvPr>
              <p:cNvSpPr txBox="1"/>
              <p:nvPr/>
            </p:nvSpPr>
            <p:spPr>
              <a:xfrm>
                <a:off x="5524655" y="994786"/>
                <a:ext cx="1765781" cy="7078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000" b="1" dirty="0">
                    <a:cs typeface="Dreaming Outloud Pro" panose="03050502040302030504" pitchFamily="66" charset="0"/>
                  </a:rPr>
                  <a:t>STIMULANT OVERAMPING</a:t>
                </a:r>
              </a:p>
            </p:txBody>
          </p:sp>
          <p:pic>
            <p:nvPicPr>
              <p:cNvPr id="236" name="Picture 235" descr="A white text on a black background&#10;&#10;Description automatically generated with medium confidence">
                <a:extLst>
                  <a:ext uri="{FF2B5EF4-FFF2-40B4-BE49-F238E27FC236}">
                    <a16:creationId xmlns:a16="http://schemas.microsoft.com/office/drawing/2014/main" id="{7CB917E9-92A2-9327-0454-D6CA7742B6F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571901" y="72994"/>
                <a:ext cx="881543" cy="338512"/>
              </a:xfrm>
              <a:prstGeom prst="rect">
                <a:avLst/>
              </a:prstGeom>
            </p:spPr>
          </p:pic>
          <p:sp>
            <p:nvSpPr>
              <p:cNvPr id="237" name="TextBox 236">
                <a:extLst>
                  <a:ext uri="{FF2B5EF4-FFF2-40B4-BE49-F238E27FC236}">
                    <a16:creationId xmlns:a16="http://schemas.microsoft.com/office/drawing/2014/main" id="{AA02E3B9-8DF4-BD72-2390-3F657B024636}"/>
                  </a:ext>
                </a:extLst>
              </p:cNvPr>
              <p:cNvSpPr txBox="1"/>
              <p:nvPr/>
            </p:nvSpPr>
            <p:spPr>
              <a:xfrm>
                <a:off x="5462527" y="2916291"/>
                <a:ext cx="179920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/>
                  <a:t>Phone:</a:t>
                </a:r>
              </a:p>
            </p:txBody>
          </p:sp>
          <p:sp>
            <p:nvSpPr>
              <p:cNvPr id="238" name="TextBox 237">
                <a:extLst>
                  <a:ext uri="{FF2B5EF4-FFF2-40B4-BE49-F238E27FC236}">
                    <a16:creationId xmlns:a16="http://schemas.microsoft.com/office/drawing/2014/main" id="{0D65CE46-C097-37EA-B54C-CF359215860A}"/>
                  </a:ext>
                </a:extLst>
              </p:cNvPr>
              <p:cNvSpPr txBox="1"/>
              <p:nvPr/>
            </p:nvSpPr>
            <p:spPr>
              <a:xfrm>
                <a:off x="5455271" y="2631008"/>
                <a:ext cx="179920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/>
                  <a:t>Peer Name:</a:t>
                </a:r>
              </a:p>
            </p:txBody>
          </p:sp>
          <p:cxnSp>
            <p:nvCxnSpPr>
              <p:cNvPr id="239" name="Straight Connector 238">
                <a:extLst>
                  <a:ext uri="{FF2B5EF4-FFF2-40B4-BE49-F238E27FC236}">
                    <a16:creationId xmlns:a16="http://schemas.microsoft.com/office/drawing/2014/main" id="{C492529D-960C-1AD7-1C4E-010524F9158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978863" y="3104414"/>
                <a:ext cx="1179264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0" name="Straight Connector 239">
                <a:extLst>
                  <a:ext uri="{FF2B5EF4-FFF2-40B4-BE49-F238E27FC236}">
                    <a16:creationId xmlns:a16="http://schemas.microsoft.com/office/drawing/2014/main" id="{1A38A071-D317-60C1-BCB4-A62E21D8650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240975" y="2805980"/>
                <a:ext cx="90989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28" name="Picture 2" descr="Hand drawn doodle electric lightning bolt symbol Vector Image">
              <a:extLst>
                <a:ext uri="{FF2B5EF4-FFF2-40B4-BE49-F238E27FC236}">
                  <a16:creationId xmlns:a16="http://schemas.microsoft.com/office/drawing/2014/main" id="{3775BEEF-A46A-C58D-F5F6-4AAC41EC7CFB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>
              <a:duotone>
                <a:schemeClr val="accent1">
                  <a:shade val="45000"/>
                  <a:satMod val="135000"/>
                </a:schemeClr>
                <a:prstClr val="white"/>
              </a:duotone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ackgroundRemoval t="10000" b="90000" l="10000" r="90000">
                          <a14:foregroundMark x1="36200" y1="65278" x2="36200" y2="65278"/>
                          <a14:foregroundMark x1="55400" y1="77407" x2="55400" y2="77407"/>
                        </a14:backgroundRemoval>
                      </a14:imgEffect>
                      <a14:imgEffect>
                        <a14:artisticPencilGrayscale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915" t="5156" r="20485" b="11811"/>
            <a:stretch/>
          </p:blipFill>
          <p:spPr bwMode="auto">
            <a:xfrm rot="10800000">
              <a:off x="5587381" y="1602511"/>
              <a:ext cx="604181" cy="99212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0" name="Picture 2" descr="Hand drawn doodle electric lightning bolt symbol Vector Image">
              <a:extLst>
                <a:ext uri="{FF2B5EF4-FFF2-40B4-BE49-F238E27FC236}">
                  <a16:creationId xmlns:a16="http://schemas.microsoft.com/office/drawing/2014/main" id="{E3C7A96D-C918-6093-7D71-0DD1209499FD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>
              <a:duotone>
                <a:schemeClr val="accent1">
                  <a:shade val="45000"/>
                  <a:satMod val="135000"/>
                </a:schemeClr>
                <a:prstClr val="white"/>
              </a:duotone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ackgroundRemoval t="10000" b="90000" l="10000" r="90000">
                          <a14:foregroundMark x1="36200" y1="65278" x2="36200" y2="65278"/>
                          <a14:foregroundMark x1="55400" y1="77407" x2="55400" y2="77407"/>
                        </a14:backgroundRemoval>
                      </a14:imgEffect>
                      <a14:imgEffect>
                        <a14:artisticPencilGrayscale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915" t="5156" r="20485" b="11811"/>
            <a:stretch/>
          </p:blipFill>
          <p:spPr bwMode="auto">
            <a:xfrm rot="376277">
              <a:off x="6463259" y="4500"/>
              <a:ext cx="642643" cy="105527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pic>
        <p:nvPicPr>
          <p:cNvPr id="8" name="Picture 7">
            <a:extLst>
              <a:ext uri="{FF2B5EF4-FFF2-40B4-BE49-F238E27FC236}">
                <a16:creationId xmlns:a16="http://schemas.microsoft.com/office/drawing/2014/main" id="{A2C5174F-A829-D2C3-4ACE-2847B7C6370B}"/>
              </a:ext>
            </a:extLst>
          </p:cNvPr>
          <p:cNvPicPr>
            <a:picLocks noChangeAspect="1"/>
          </p:cNvPicPr>
          <p:nvPr/>
        </p:nvPicPr>
        <p:blipFill>
          <a:blip r:embed="rId6">
            <a:duotone>
              <a:schemeClr val="accent2">
                <a:shade val="45000"/>
                <a:satMod val="135000"/>
              </a:schemeClr>
              <a:prstClr val="white"/>
            </a:duotone>
          </a:blip>
          <a:stretch>
            <a:fillRect/>
          </a:stretch>
        </p:blipFill>
        <p:spPr>
          <a:xfrm>
            <a:off x="4767371" y="1791795"/>
            <a:ext cx="475049" cy="4750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8162675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Rectangle 32">
            <a:extLst>
              <a:ext uri="{FF2B5EF4-FFF2-40B4-BE49-F238E27FC236}">
                <a16:creationId xmlns:a16="http://schemas.microsoft.com/office/drawing/2014/main" id="{78329885-A9D0-9A3A-D6B2-33E8C08EBAA4}"/>
              </a:ext>
            </a:extLst>
          </p:cNvPr>
          <p:cNvSpPr/>
          <p:nvPr/>
        </p:nvSpPr>
        <p:spPr>
          <a:xfrm>
            <a:off x="5620940" y="183594"/>
            <a:ext cx="1576450" cy="313321"/>
          </a:xfrm>
          <a:prstGeom prst="rect">
            <a:avLst/>
          </a:prstGeom>
          <a:noFill/>
          <a:ln w="19050">
            <a:solidFill>
              <a:schemeClr val="tx1"/>
            </a:solidFill>
            <a:prstDash val="solid"/>
            <a:extLst>
              <a:ext uri="{C807C97D-BFC1-408E-A445-0C87EB9F89A2}">
                <ask:lineSketchStyleProps xmlns:ask="http://schemas.microsoft.com/office/drawing/2018/sketchyshapes" sd="3788527064">
                  <a:custGeom>
                    <a:avLst/>
                    <a:gdLst>
                      <a:gd name="connsiteX0" fmla="*/ 0 w 1610374"/>
                      <a:gd name="connsiteY0" fmla="*/ 0 h 3028947"/>
                      <a:gd name="connsiteX1" fmla="*/ 552895 w 1610374"/>
                      <a:gd name="connsiteY1" fmla="*/ 0 h 3028947"/>
                      <a:gd name="connsiteX2" fmla="*/ 1057479 w 1610374"/>
                      <a:gd name="connsiteY2" fmla="*/ 0 h 3028947"/>
                      <a:gd name="connsiteX3" fmla="*/ 1610374 w 1610374"/>
                      <a:gd name="connsiteY3" fmla="*/ 0 h 3028947"/>
                      <a:gd name="connsiteX4" fmla="*/ 1610374 w 1610374"/>
                      <a:gd name="connsiteY4" fmla="*/ 504825 h 3028947"/>
                      <a:gd name="connsiteX5" fmla="*/ 1610374 w 1610374"/>
                      <a:gd name="connsiteY5" fmla="*/ 918781 h 3028947"/>
                      <a:gd name="connsiteX6" fmla="*/ 1610374 w 1610374"/>
                      <a:gd name="connsiteY6" fmla="*/ 1363026 h 3028947"/>
                      <a:gd name="connsiteX7" fmla="*/ 1610374 w 1610374"/>
                      <a:gd name="connsiteY7" fmla="*/ 1898140 h 3028947"/>
                      <a:gd name="connsiteX8" fmla="*/ 1610374 w 1610374"/>
                      <a:gd name="connsiteY8" fmla="*/ 2433254 h 3028947"/>
                      <a:gd name="connsiteX9" fmla="*/ 1610374 w 1610374"/>
                      <a:gd name="connsiteY9" fmla="*/ 3028947 h 3028947"/>
                      <a:gd name="connsiteX10" fmla="*/ 1057479 w 1610374"/>
                      <a:gd name="connsiteY10" fmla="*/ 3028947 h 3028947"/>
                      <a:gd name="connsiteX11" fmla="*/ 552895 w 1610374"/>
                      <a:gd name="connsiteY11" fmla="*/ 3028947 h 3028947"/>
                      <a:gd name="connsiteX12" fmla="*/ 0 w 1610374"/>
                      <a:gd name="connsiteY12" fmla="*/ 3028947 h 3028947"/>
                      <a:gd name="connsiteX13" fmla="*/ 0 w 1610374"/>
                      <a:gd name="connsiteY13" fmla="*/ 2493833 h 3028947"/>
                      <a:gd name="connsiteX14" fmla="*/ 0 w 1610374"/>
                      <a:gd name="connsiteY14" fmla="*/ 2049587 h 3028947"/>
                      <a:gd name="connsiteX15" fmla="*/ 0 w 1610374"/>
                      <a:gd name="connsiteY15" fmla="*/ 1544763 h 3028947"/>
                      <a:gd name="connsiteX16" fmla="*/ 0 w 1610374"/>
                      <a:gd name="connsiteY16" fmla="*/ 1039938 h 3028947"/>
                      <a:gd name="connsiteX17" fmla="*/ 0 w 1610374"/>
                      <a:gd name="connsiteY17" fmla="*/ 474535 h 3028947"/>
                      <a:gd name="connsiteX18" fmla="*/ 0 w 1610374"/>
                      <a:gd name="connsiteY18" fmla="*/ 0 h 3028947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</a:cxnLst>
                    <a:rect l="l" t="t" r="r" b="b"/>
                    <a:pathLst>
                      <a:path w="1610374" h="3028947" extrusionOk="0">
                        <a:moveTo>
                          <a:pt x="0" y="0"/>
                        </a:moveTo>
                        <a:cubicBezTo>
                          <a:pt x="149963" y="-17306"/>
                          <a:pt x="357556" y="32579"/>
                          <a:pt x="552895" y="0"/>
                        </a:cubicBezTo>
                        <a:cubicBezTo>
                          <a:pt x="748235" y="-32579"/>
                          <a:pt x="940687" y="15313"/>
                          <a:pt x="1057479" y="0"/>
                        </a:cubicBezTo>
                        <a:cubicBezTo>
                          <a:pt x="1174271" y="-15313"/>
                          <a:pt x="1432326" y="31288"/>
                          <a:pt x="1610374" y="0"/>
                        </a:cubicBezTo>
                        <a:cubicBezTo>
                          <a:pt x="1649219" y="180544"/>
                          <a:pt x="1600477" y="285331"/>
                          <a:pt x="1610374" y="504825"/>
                        </a:cubicBezTo>
                        <a:cubicBezTo>
                          <a:pt x="1620271" y="724319"/>
                          <a:pt x="1584199" y="722125"/>
                          <a:pt x="1610374" y="918781"/>
                        </a:cubicBezTo>
                        <a:cubicBezTo>
                          <a:pt x="1636549" y="1115437"/>
                          <a:pt x="1557983" y="1270599"/>
                          <a:pt x="1610374" y="1363026"/>
                        </a:cubicBezTo>
                        <a:cubicBezTo>
                          <a:pt x="1662765" y="1455453"/>
                          <a:pt x="1598359" y="1726189"/>
                          <a:pt x="1610374" y="1898140"/>
                        </a:cubicBezTo>
                        <a:cubicBezTo>
                          <a:pt x="1622389" y="2070091"/>
                          <a:pt x="1601903" y="2176907"/>
                          <a:pt x="1610374" y="2433254"/>
                        </a:cubicBezTo>
                        <a:cubicBezTo>
                          <a:pt x="1618845" y="2689601"/>
                          <a:pt x="1610021" y="2796764"/>
                          <a:pt x="1610374" y="3028947"/>
                        </a:cubicBezTo>
                        <a:cubicBezTo>
                          <a:pt x="1374133" y="3061085"/>
                          <a:pt x="1229307" y="3028670"/>
                          <a:pt x="1057479" y="3028947"/>
                        </a:cubicBezTo>
                        <a:cubicBezTo>
                          <a:pt x="885651" y="3029224"/>
                          <a:pt x="663805" y="3013274"/>
                          <a:pt x="552895" y="3028947"/>
                        </a:cubicBezTo>
                        <a:cubicBezTo>
                          <a:pt x="441985" y="3044620"/>
                          <a:pt x="271411" y="3005135"/>
                          <a:pt x="0" y="3028947"/>
                        </a:cubicBezTo>
                        <a:cubicBezTo>
                          <a:pt x="-19804" y="2882108"/>
                          <a:pt x="32825" y="2743854"/>
                          <a:pt x="0" y="2493833"/>
                        </a:cubicBezTo>
                        <a:cubicBezTo>
                          <a:pt x="-32825" y="2243812"/>
                          <a:pt x="41440" y="2270169"/>
                          <a:pt x="0" y="2049587"/>
                        </a:cubicBezTo>
                        <a:cubicBezTo>
                          <a:pt x="-41440" y="1829005"/>
                          <a:pt x="3152" y="1717784"/>
                          <a:pt x="0" y="1544763"/>
                        </a:cubicBezTo>
                        <a:cubicBezTo>
                          <a:pt x="-3152" y="1371742"/>
                          <a:pt x="58884" y="1147506"/>
                          <a:pt x="0" y="1039938"/>
                        </a:cubicBezTo>
                        <a:cubicBezTo>
                          <a:pt x="-58884" y="932370"/>
                          <a:pt x="16612" y="648009"/>
                          <a:pt x="0" y="474535"/>
                        </a:cubicBezTo>
                        <a:cubicBezTo>
                          <a:pt x="-16612" y="301061"/>
                          <a:pt x="15856" y="105615"/>
                          <a:pt x="0" y="0"/>
                        </a:cubicBezTo>
                        <a:close/>
                      </a:path>
                    </a:pathLst>
                  </a:custGeom>
                  <ask:type>
                    <ask:lineSketchNone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85" dirty="0"/>
          </a:p>
        </p:txBody>
      </p: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6511397B-E232-6B4F-60FC-E20D73A5613E}"/>
              </a:ext>
            </a:extLst>
          </p:cNvPr>
          <p:cNvCxnSpPr>
            <a:cxnSpLocks/>
          </p:cNvCxnSpPr>
          <p:nvPr/>
        </p:nvCxnSpPr>
        <p:spPr>
          <a:xfrm>
            <a:off x="5484293" y="0"/>
            <a:ext cx="0" cy="320040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83CEDD9F-E3AD-A332-96C1-B9226D2BC1F8}"/>
              </a:ext>
            </a:extLst>
          </p:cNvPr>
          <p:cNvCxnSpPr>
            <a:cxnSpLocks/>
          </p:cNvCxnSpPr>
          <p:nvPr/>
        </p:nvCxnSpPr>
        <p:spPr>
          <a:xfrm>
            <a:off x="3654095" y="24581"/>
            <a:ext cx="0" cy="320040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Rectangle 4">
            <a:extLst>
              <a:ext uri="{FF2B5EF4-FFF2-40B4-BE49-F238E27FC236}">
                <a16:creationId xmlns:a16="http://schemas.microsoft.com/office/drawing/2014/main" id="{79B1B53B-70B6-DA0A-2E75-7496B3B03DE4}"/>
              </a:ext>
            </a:extLst>
          </p:cNvPr>
          <p:cNvSpPr/>
          <p:nvPr/>
        </p:nvSpPr>
        <p:spPr>
          <a:xfrm>
            <a:off x="0" y="0"/>
            <a:ext cx="7315200" cy="3200400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150" dirty="0"/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7AAF8B53-81AA-C455-45A2-00CD130F5F33}"/>
              </a:ext>
            </a:extLst>
          </p:cNvPr>
          <p:cNvCxnSpPr>
            <a:cxnSpLocks/>
          </p:cNvCxnSpPr>
          <p:nvPr/>
        </p:nvCxnSpPr>
        <p:spPr>
          <a:xfrm>
            <a:off x="1828119" y="0"/>
            <a:ext cx="0" cy="320040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3" name="Group 62">
            <a:extLst>
              <a:ext uri="{FF2B5EF4-FFF2-40B4-BE49-F238E27FC236}">
                <a16:creationId xmlns:a16="http://schemas.microsoft.com/office/drawing/2014/main" id="{4255A6A0-112D-A494-2F97-CAEF67118891}"/>
              </a:ext>
            </a:extLst>
          </p:cNvPr>
          <p:cNvGrpSpPr/>
          <p:nvPr/>
        </p:nvGrpSpPr>
        <p:grpSpPr>
          <a:xfrm>
            <a:off x="8080" y="28683"/>
            <a:ext cx="1792558" cy="3071704"/>
            <a:chOff x="32820" y="3380403"/>
            <a:chExt cx="3993248" cy="4541828"/>
          </a:xfrm>
        </p:grpSpPr>
        <p:sp>
          <p:nvSpPr>
            <p:cNvPr id="65" name="Rectangle 64">
              <a:extLst>
                <a:ext uri="{FF2B5EF4-FFF2-40B4-BE49-F238E27FC236}">
                  <a16:creationId xmlns:a16="http://schemas.microsoft.com/office/drawing/2014/main" id="{E9BF3553-171B-4D77-3840-F7452A48D292}"/>
                </a:ext>
              </a:extLst>
            </p:cNvPr>
            <p:cNvSpPr/>
            <p:nvPr/>
          </p:nvSpPr>
          <p:spPr>
            <a:xfrm>
              <a:off x="219455" y="3835484"/>
              <a:ext cx="3640080" cy="4086747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extLst>
                <a:ext uri="{C807C97D-BFC1-408E-A445-0C87EB9F89A2}">
                  <ask:lineSketchStyleProps xmlns:ask="http://schemas.microsoft.com/office/drawing/2018/sketchyshapes" sd="3788527064">
                    <a:custGeom>
                      <a:avLst/>
                      <a:gdLst>
                        <a:gd name="connsiteX0" fmla="*/ 0 w 3640080"/>
                        <a:gd name="connsiteY0" fmla="*/ 0 h 3727022"/>
                        <a:gd name="connsiteX1" fmla="*/ 556412 w 3640080"/>
                        <a:gd name="connsiteY1" fmla="*/ 0 h 3727022"/>
                        <a:gd name="connsiteX2" fmla="*/ 1003622 w 3640080"/>
                        <a:gd name="connsiteY2" fmla="*/ 0 h 3727022"/>
                        <a:gd name="connsiteX3" fmla="*/ 1560034 w 3640080"/>
                        <a:gd name="connsiteY3" fmla="*/ 0 h 3727022"/>
                        <a:gd name="connsiteX4" fmla="*/ 2080046 w 3640080"/>
                        <a:gd name="connsiteY4" fmla="*/ 0 h 3727022"/>
                        <a:gd name="connsiteX5" fmla="*/ 2490855 w 3640080"/>
                        <a:gd name="connsiteY5" fmla="*/ 0 h 3727022"/>
                        <a:gd name="connsiteX6" fmla="*/ 2938065 w 3640080"/>
                        <a:gd name="connsiteY6" fmla="*/ 0 h 3727022"/>
                        <a:gd name="connsiteX7" fmla="*/ 3640080 w 3640080"/>
                        <a:gd name="connsiteY7" fmla="*/ 0 h 3727022"/>
                        <a:gd name="connsiteX8" fmla="*/ 3640080 w 3640080"/>
                        <a:gd name="connsiteY8" fmla="*/ 569702 h 3727022"/>
                        <a:gd name="connsiteX9" fmla="*/ 3640080 w 3640080"/>
                        <a:gd name="connsiteY9" fmla="*/ 1027593 h 3727022"/>
                        <a:gd name="connsiteX10" fmla="*/ 3640080 w 3640080"/>
                        <a:gd name="connsiteY10" fmla="*/ 1597295 h 3727022"/>
                        <a:gd name="connsiteX11" fmla="*/ 3640080 w 3640080"/>
                        <a:gd name="connsiteY11" fmla="*/ 2092457 h 3727022"/>
                        <a:gd name="connsiteX12" fmla="*/ 3640080 w 3640080"/>
                        <a:gd name="connsiteY12" fmla="*/ 2513078 h 3727022"/>
                        <a:gd name="connsiteX13" fmla="*/ 3640080 w 3640080"/>
                        <a:gd name="connsiteY13" fmla="*/ 2933699 h 3727022"/>
                        <a:gd name="connsiteX14" fmla="*/ 3640080 w 3640080"/>
                        <a:gd name="connsiteY14" fmla="*/ 3727022 h 3727022"/>
                        <a:gd name="connsiteX15" fmla="*/ 3192870 w 3640080"/>
                        <a:gd name="connsiteY15" fmla="*/ 3727022 h 3727022"/>
                        <a:gd name="connsiteX16" fmla="*/ 2782061 w 3640080"/>
                        <a:gd name="connsiteY16" fmla="*/ 3727022 h 3727022"/>
                        <a:gd name="connsiteX17" fmla="*/ 2371252 w 3640080"/>
                        <a:gd name="connsiteY17" fmla="*/ 3727022 h 3727022"/>
                        <a:gd name="connsiteX18" fmla="*/ 1814840 w 3640080"/>
                        <a:gd name="connsiteY18" fmla="*/ 3727022 h 3727022"/>
                        <a:gd name="connsiteX19" fmla="*/ 1258428 w 3640080"/>
                        <a:gd name="connsiteY19" fmla="*/ 3727022 h 3727022"/>
                        <a:gd name="connsiteX20" fmla="*/ 811218 w 3640080"/>
                        <a:gd name="connsiteY20" fmla="*/ 3727022 h 3727022"/>
                        <a:gd name="connsiteX21" fmla="*/ 0 w 3640080"/>
                        <a:gd name="connsiteY21" fmla="*/ 3727022 h 3727022"/>
                        <a:gd name="connsiteX22" fmla="*/ 0 w 3640080"/>
                        <a:gd name="connsiteY22" fmla="*/ 3306401 h 3727022"/>
                        <a:gd name="connsiteX23" fmla="*/ 0 w 3640080"/>
                        <a:gd name="connsiteY23" fmla="*/ 2885780 h 3727022"/>
                        <a:gd name="connsiteX24" fmla="*/ 0 w 3640080"/>
                        <a:gd name="connsiteY24" fmla="*/ 2465159 h 3727022"/>
                        <a:gd name="connsiteX25" fmla="*/ 0 w 3640080"/>
                        <a:gd name="connsiteY25" fmla="*/ 1858187 h 3727022"/>
                        <a:gd name="connsiteX26" fmla="*/ 0 w 3640080"/>
                        <a:gd name="connsiteY26" fmla="*/ 1325755 h 3727022"/>
                        <a:gd name="connsiteX27" fmla="*/ 0 w 3640080"/>
                        <a:gd name="connsiteY27" fmla="*/ 793323 h 3727022"/>
                        <a:gd name="connsiteX28" fmla="*/ 0 w 3640080"/>
                        <a:gd name="connsiteY28" fmla="*/ 0 h 3727022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</a:cxnLst>
                      <a:rect l="l" t="t" r="r" b="b"/>
                      <a:pathLst>
                        <a:path w="3640080" h="3727022" extrusionOk="0">
                          <a:moveTo>
                            <a:pt x="0" y="0"/>
                          </a:moveTo>
                          <a:cubicBezTo>
                            <a:pt x="265327" y="-2923"/>
                            <a:pt x="305839" y="38604"/>
                            <a:pt x="556412" y="0"/>
                          </a:cubicBezTo>
                          <a:cubicBezTo>
                            <a:pt x="806985" y="-38604"/>
                            <a:pt x="912741" y="30287"/>
                            <a:pt x="1003622" y="0"/>
                          </a:cubicBezTo>
                          <a:cubicBezTo>
                            <a:pt x="1094503" y="-30287"/>
                            <a:pt x="1425227" y="45270"/>
                            <a:pt x="1560034" y="0"/>
                          </a:cubicBezTo>
                          <a:cubicBezTo>
                            <a:pt x="1694841" y="-45270"/>
                            <a:pt x="1974637" y="46165"/>
                            <a:pt x="2080046" y="0"/>
                          </a:cubicBezTo>
                          <a:cubicBezTo>
                            <a:pt x="2185455" y="-46165"/>
                            <a:pt x="2360497" y="48573"/>
                            <a:pt x="2490855" y="0"/>
                          </a:cubicBezTo>
                          <a:cubicBezTo>
                            <a:pt x="2621213" y="-48573"/>
                            <a:pt x="2716015" y="6649"/>
                            <a:pt x="2938065" y="0"/>
                          </a:cubicBezTo>
                          <a:cubicBezTo>
                            <a:pt x="3160115" y="-6649"/>
                            <a:pt x="3482314" y="56927"/>
                            <a:pt x="3640080" y="0"/>
                          </a:cubicBezTo>
                          <a:cubicBezTo>
                            <a:pt x="3679881" y="189578"/>
                            <a:pt x="3639206" y="320922"/>
                            <a:pt x="3640080" y="569702"/>
                          </a:cubicBezTo>
                          <a:cubicBezTo>
                            <a:pt x="3640954" y="818482"/>
                            <a:pt x="3589846" y="893263"/>
                            <a:pt x="3640080" y="1027593"/>
                          </a:cubicBezTo>
                          <a:cubicBezTo>
                            <a:pt x="3690314" y="1161923"/>
                            <a:pt x="3629822" y="1408947"/>
                            <a:pt x="3640080" y="1597295"/>
                          </a:cubicBezTo>
                          <a:cubicBezTo>
                            <a:pt x="3650338" y="1785643"/>
                            <a:pt x="3590572" y="1857124"/>
                            <a:pt x="3640080" y="2092457"/>
                          </a:cubicBezTo>
                          <a:cubicBezTo>
                            <a:pt x="3689588" y="2327790"/>
                            <a:pt x="3626107" y="2329859"/>
                            <a:pt x="3640080" y="2513078"/>
                          </a:cubicBezTo>
                          <a:cubicBezTo>
                            <a:pt x="3654053" y="2696297"/>
                            <a:pt x="3619849" y="2811056"/>
                            <a:pt x="3640080" y="2933699"/>
                          </a:cubicBezTo>
                          <a:cubicBezTo>
                            <a:pt x="3660311" y="3056342"/>
                            <a:pt x="3599594" y="3560041"/>
                            <a:pt x="3640080" y="3727022"/>
                          </a:cubicBezTo>
                          <a:cubicBezTo>
                            <a:pt x="3499877" y="3744586"/>
                            <a:pt x="3365413" y="3717333"/>
                            <a:pt x="3192870" y="3727022"/>
                          </a:cubicBezTo>
                          <a:cubicBezTo>
                            <a:pt x="3020327" y="3736711"/>
                            <a:pt x="2869254" y="3709307"/>
                            <a:pt x="2782061" y="3727022"/>
                          </a:cubicBezTo>
                          <a:cubicBezTo>
                            <a:pt x="2694868" y="3744737"/>
                            <a:pt x="2569343" y="3685498"/>
                            <a:pt x="2371252" y="3727022"/>
                          </a:cubicBezTo>
                          <a:cubicBezTo>
                            <a:pt x="2173161" y="3768546"/>
                            <a:pt x="2085574" y="3687320"/>
                            <a:pt x="1814840" y="3727022"/>
                          </a:cubicBezTo>
                          <a:cubicBezTo>
                            <a:pt x="1544106" y="3766724"/>
                            <a:pt x="1436632" y="3681767"/>
                            <a:pt x="1258428" y="3727022"/>
                          </a:cubicBezTo>
                          <a:cubicBezTo>
                            <a:pt x="1080224" y="3772277"/>
                            <a:pt x="922793" y="3692696"/>
                            <a:pt x="811218" y="3727022"/>
                          </a:cubicBezTo>
                          <a:cubicBezTo>
                            <a:pt x="699643" y="3761348"/>
                            <a:pt x="323089" y="3659358"/>
                            <a:pt x="0" y="3727022"/>
                          </a:cubicBezTo>
                          <a:cubicBezTo>
                            <a:pt x="-8001" y="3565571"/>
                            <a:pt x="19412" y="3473714"/>
                            <a:pt x="0" y="3306401"/>
                          </a:cubicBezTo>
                          <a:cubicBezTo>
                            <a:pt x="-19412" y="3139088"/>
                            <a:pt x="9463" y="3028074"/>
                            <a:pt x="0" y="2885780"/>
                          </a:cubicBezTo>
                          <a:cubicBezTo>
                            <a:pt x="-9463" y="2743486"/>
                            <a:pt x="27982" y="2597756"/>
                            <a:pt x="0" y="2465159"/>
                          </a:cubicBezTo>
                          <a:cubicBezTo>
                            <a:pt x="-27982" y="2332562"/>
                            <a:pt x="58134" y="2100290"/>
                            <a:pt x="0" y="1858187"/>
                          </a:cubicBezTo>
                          <a:cubicBezTo>
                            <a:pt x="-58134" y="1616084"/>
                            <a:pt x="37456" y="1471422"/>
                            <a:pt x="0" y="1325755"/>
                          </a:cubicBezTo>
                          <a:cubicBezTo>
                            <a:pt x="-37456" y="1180088"/>
                            <a:pt x="26170" y="971509"/>
                            <a:pt x="0" y="793323"/>
                          </a:cubicBezTo>
                          <a:cubicBezTo>
                            <a:pt x="-26170" y="615137"/>
                            <a:pt x="62884" y="292044"/>
                            <a:pt x="0" y="0"/>
                          </a:cubicBezTo>
                          <a:close/>
                        </a:path>
                      </a:pathLst>
                    </a:custGeom>
                    <ask:type>
                      <ask:lineSketchNone/>
                    </ask:type>
                  </ask:lineSketchStyleProps>
                </a:ext>
              </a:extLst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85"/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C450CD89-A814-8804-292D-62F7B7CA3B82}"/>
                </a:ext>
              </a:extLst>
            </p:cNvPr>
            <p:cNvSpPr txBox="1"/>
            <p:nvPr/>
          </p:nvSpPr>
          <p:spPr>
            <a:xfrm>
              <a:off x="32820" y="3380403"/>
              <a:ext cx="3993248" cy="4550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My Plan:</a:t>
              </a:r>
              <a:endParaRPr lang="en-US" sz="1600" b="1" dirty="0"/>
            </a:p>
          </p:txBody>
        </p:sp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id="{18C95B76-0A5D-E26D-52C1-2936899FDD7E}"/>
              </a:ext>
            </a:extLst>
          </p:cNvPr>
          <p:cNvSpPr txBox="1"/>
          <p:nvPr/>
        </p:nvSpPr>
        <p:spPr>
          <a:xfrm>
            <a:off x="5571779" y="170978"/>
            <a:ext cx="160946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If you call 9-1-1</a:t>
            </a:r>
          </a:p>
        </p:txBody>
      </p:sp>
      <p:grpSp>
        <p:nvGrpSpPr>
          <p:cNvPr id="32" name="Group 31">
            <a:extLst>
              <a:ext uri="{FF2B5EF4-FFF2-40B4-BE49-F238E27FC236}">
                <a16:creationId xmlns:a16="http://schemas.microsoft.com/office/drawing/2014/main" id="{F50534FA-9CB6-D051-0BC8-F26972FF8C5D}"/>
              </a:ext>
            </a:extLst>
          </p:cNvPr>
          <p:cNvGrpSpPr/>
          <p:nvPr/>
        </p:nvGrpSpPr>
        <p:grpSpPr>
          <a:xfrm>
            <a:off x="1827421" y="45182"/>
            <a:ext cx="3694687" cy="3156268"/>
            <a:chOff x="1827421" y="45182"/>
            <a:chExt cx="3694687" cy="3156268"/>
          </a:xfrm>
        </p:grpSpPr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35520456-598B-6B56-B29E-1A636C8D3FFF}"/>
                </a:ext>
              </a:extLst>
            </p:cNvPr>
            <p:cNvSpPr txBox="1"/>
            <p:nvPr/>
          </p:nvSpPr>
          <p:spPr>
            <a:xfrm>
              <a:off x="1827421" y="116115"/>
              <a:ext cx="1828799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i="1" dirty="0"/>
                <a:t>Call emergency services immediately </a:t>
              </a:r>
              <a:r>
                <a:rPr lang="en-US" sz="1400" dirty="0"/>
                <a:t>if you see these signs:</a:t>
              </a:r>
              <a:endParaRPr lang="en-US" sz="1600" dirty="0"/>
            </a:p>
          </p:txBody>
        </p: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59AE6A33-8CE2-C9DE-1F25-D1D76C15AC64}"/>
                </a:ext>
              </a:extLst>
            </p:cNvPr>
            <p:cNvGrpSpPr/>
            <p:nvPr/>
          </p:nvGrpSpPr>
          <p:grpSpPr>
            <a:xfrm>
              <a:off x="1874748" y="970894"/>
              <a:ext cx="1734767" cy="932144"/>
              <a:chOff x="1854584" y="3429037"/>
              <a:chExt cx="1734767" cy="932144"/>
            </a:xfrm>
          </p:grpSpPr>
          <p:sp>
            <p:nvSpPr>
              <p:cNvPr id="4" name="Graphic 2" descr="A brushstroke">
                <a:extLst>
                  <a:ext uri="{FF2B5EF4-FFF2-40B4-BE49-F238E27FC236}">
                    <a16:creationId xmlns:a16="http://schemas.microsoft.com/office/drawing/2014/main" id="{EADEAFBE-CAE5-615F-0694-E4B7F95E3856}"/>
                  </a:ext>
                </a:extLst>
              </p:cNvPr>
              <p:cNvSpPr/>
              <p:nvPr/>
            </p:nvSpPr>
            <p:spPr>
              <a:xfrm>
                <a:off x="1891360" y="3429037"/>
                <a:ext cx="1032813" cy="320246"/>
              </a:xfrm>
              <a:custGeom>
                <a:avLst/>
                <a:gdLst>
                  <a:gd name="connsiteX0" fmla="*/ 42687 w 2401948"/>
                  <a:gd name="connsiteY0" fmla="*/ 296990 h 320246"/>
                  <a:gd name="connsiteX1" fmla="*/ 10363 w 2401948"/>
                  <a:gd name="connsiteY1" fmla="*/ 288863 h 320246"/>
                  <a:gd name="connsiteX2" fmla="*/ 42687 w 2401948"/>
                  <a:gd name="connsiteY2" fmla="*/ 296990 h 320246"/>
                  <a:gd name="connsiteX3" fmla="*/ 42927 w 2401948"/>
                  <a:gd name="connsiteY3" fmla="*/ 297130 h 320246"/>
                  <a:gd name="connsiteX4" fmla="*/ 43114 w 2401948"/>
                  <a:gd name="connsiteY4" fmla="*/ 297044 h 320246"/>
                  <a:gd name="connsiteX5" fmla="*/ 42687 w 2401948"/>
                  <a:gd name="connsiteY5" fmla="*/ 296990 h 320246"/>
                  <a:gd name="connsiteX6" fmla="*/ 42927 w 2401948"/>
                  <a:gd name="connsiteY6" fmla="*/ 297130 h 320246"/>
                  <a:gd name="connsiteX7" fmla="*/ 2392981 w 2401948"/>
                  <a:gd name="connsiteY7" fmla="*/ 9101 h 320246"/>
                  <a:gd name="connsiteX8" fmla="*/ 2383013 w 2401948"/>
                  <a:gd name="connsiteY8" fmla="*/ 9501 h 320246"/>
                  <a:gd name="connsiteX9" fmla="*/ 2392981 w 2401948"/>
                  <a:gd name="connsiteY9" fmla="*/ 9101 h 320246"/>
                  <a:gd name="connsiteX10" fmla="*/ 629607 w 2401948"/>
                  <a:gd name="connsiteY10" fmla="*/ 315626 h 320246"/>
                  <a:gd name="connsiteX11" fmla="*/ 631454 w 2401948"/>
                  <a:gd name="connsiteY11" fmla="*/ 304972 h 320246"/>
                  <a:gd name="connsiteX12" fmla="*/ 666385 w 2401948"/>
                  <a:gd name="connsiteY12" fmla="*/ 314533 h 320246"/>
                  <a:gd name="connsiteX13" fmla="*/ 719698 w 2401948"/>
                  <a:gd name="connsiteY13" fmla="*/ 308085 h 320246"/>
                  <a:gd name="connsiteX14" fmla="*/ 731673 w 2401948"/>
                  <a:gd name="connsiteY14" fmla="*/ 314459 h 320246"/>
                  <a:gd name="connsiteX15" fmla="*/ 753256 w 2401948"/>
                  <a:gd name="connsiteY15" fmla="*/ 310465 h 320246"/>
                  <a:gd name="connsiteX16" fmla="*/ 748848 w 2401948"/>
                  <a:gd name="connsiteY16" fmla="*/ 305552 h 320246"/>
                  <a:gd name="connsiteX17" fmla="*/ 767644 w 2401948"/>
                  <a:gd name="connsiteY17" fmla="*/ 302658 h 320246"/>
                  <a:gd name="connsiteX18" fmla="*/ 768818 w 2401948"/>
                  <a:gd name="connsiteY18" fmla="*/ 310999 h 320246"/>
                  <a:gd name="connsiteX19" fmla="*/ 1106660 w 2401948"/>
                  <a:gd name="connsiteY19" fmla="*/ 317686 h 320246"/>
                  <a:gd name="connsiteX20" fmla="*/ 1077316 w 2401948"/>
                  <a:gd name="connsiteY20" fmla="*/ 305958 h 320246"/>
                  <a:gd name="connsiteX21" fmla="*/ 1104080 w 2401948"/>
                  <a:gd name="connsiteY21" fmla="*/ 302138 h 320246"/>
                  <a:gd name="connsiteX22" fmla="*/ 1145411 w 2401948"/>
                  <a:gd name="connsiteY22" fmla="*/ 320247 h 320246"/>
                  <a:gd name="connsiteX23" fmla="*/ 1149425 w 2401948"/>
                  <a:gd name="connsiteY23" fmla="*/ 312052 h 320246"/>
                  <a:gd name="connsiteX24" fmla="*/ 1156379 w 2401948"/>
                  <a:gd name="connsiteY24" fmla="*/ 317066 h 320246"/>
                  <a:gd name="connsiteX25" fmla="*/ 1224975 w 2401948"/>
                  <a:gd name="connsiteY25" fmla="*/ 314839 h 320246"/>
                  <a:gd name="connsiteX26" fmla="*/ 1289103 w 2401948"/>
                  <a:gd name="connsiteY26" fmla="*/ 306398 h 320246"/>
                  <a:gd name="connsiteX27" fmla="*/ 1287709 w 2401948"/>
                  <a:gd name="connsiteY27" fmla="*/ 299204 h 320246"/>
                  <a:gd name="connsiteX28" fmla="*/ 1313459 w 2401948"/>
                  <a:gd name="connsiteY28" fmla="*/ 301304 h 320246"/>
                  <a:gd name="connsiteX29" fmla="*/ 1338635 w 2401948"/>
                  <a:gd name="connsiteY29" fmla="*/ 291490 h 320246"/>
                  <a:gd name="connsiteX30" fmla="*/ 1352411 w 2401948"/>
                  <a:gd name="connsiteY30" fmla="*/ 302671 h 320246"/>
                  <a:gd name="connsiteX31" fmla="*/ 1373406 w 2401948"/>
                  <a:gd name="connsiteY31" fmla="*/ 302238 h 320246"/>
                  <a:gd name="connsiteX32" fmla="*/ 1363379 w 2401948"/>
                  <a:gd name="connsiteY32" fmla="*/ 299497 h 320246"/>
                  <a:gd name="connsiteX33" fmla="*/ 1421306 w 2401948"/>
                  <a:gd name="connsiteY33" fmla="*/ 296784 h 320246"/>
                  <a:gd name="connsiteX34" fmla="*/ 1411558 w 2401948"/>
                  <a:gd name="connsiteY34" fmla="*/ 292877 h 320246"/>
                  <a:gd name="connsiteX35" fmla="*/ 1446702 w 2401948"/>
                  <a:gd name="connsiteY35" fmla="*/ 301244 h 320246"/>
                  <a:gd name="connsiteX36" fmla="*/ 1430514 w 2401948"/>
                  <a:gd name="connsiteY36" fmla="*/ 304238 h 320246"/>
                  <a:gd name="connsiteX37" fmla="*/ 1494235 w 2401948"/>
                  <a:gd name="connsiteY37" fmla="*/ 298171 h 320246"/>
                  <a:gd name="connsiteX38" fmla="*/ 1486454 w 2401948"/>
                  <a:gd name="connsiteY38" fmla="*/ 297904 h 320246"/>
                  <a:gd name="connsiteX39" fmla="*/ 1685072 w 2401948"/>
                  <a:gd name="connsiteY39" fmla="*/ 267987 h 320246"/>
                  <a:gd name="connsiteX40" fmla="*/ 1673291 w 2401948"/>
                  <a:gd name="connsiteY40" fmla="*/ 260433 h 320246"/>
                  <a:gd name="connsiteX41" fmla="*/ 1695293 w 2401948"/>
                  <a:gd name="connsiteY41" fmla="*/ 254072 h 320246"/>
                  <a:gd name="connsiteX42" fmla="*/ 1682492 w 2401948"/>
                  <a:gd name="connsiteY42" fmla="*/ 276135 h 320246"/>
                  <a:gd name="connsiteX43" fmla="*/ 2018440 w 2401948"/>
                  <a:gd name="connsiteY43" fmla="*/ 274661 h 320246"/>
                  <a:gd name="connsiteX44" fmla="*/ 2021401 w 2401948"/>
                  <a:gd name="connsiteY44" fmla="*/ 287849 h 320246"/>
                  <a:gd name="connsiteX45" fmla="*/ 2048804 w 2401948"/>
                  <a:gd name="connsiteY45" fmla="*/ 280488 h 320246"/>
                  <a:gd name="connsiteX46" fmla="*/ 2044984 w 2401948"/>
                  <a:gd name="connsiteY46" fmla="*/ 287489 h 320246"/>
                  <a:gd name="connsiteX47" fmla="*/ 2060946 w 2401948"/>
                  <a:gd name="connsiteY47" fmla="*/ 285682 h 320246"/>
                  <a:gd name="connsiteX48" fmla="*/ 2050985 w 2401948"/>
                  <a:gd name="connsiteY48" fmla="*/ 267494 h 320246"/>
                  <a:gd name="connsiteX49" fmla="*/ 2074367 w 2401948"/>
                  <a:gd name="connsiteY49" fmla="*/ 268307 h 320246"/>
                  <a:gd name="connsiteX50" fmla="*/ 2073327 w 2401948"/>
                  <a:gd name="connsiteY50" fmla="*/ 274221 h 320246"/>
                  <a:gd name="connsiteX51" fmla="*/ 2109519 w 2401948"/>
                  <a:gd name="connsiteY51" fmla="*/ 261226 h 320246"/>
                  <a:gd name="connsiteX52" fmla="*/ 2229334 w 2401948"/>
                  <a:gd name="connsiteY52" fmla="*/ 263080 h 320246"/>
                  <a:gd name="connsiteX53" fmla="*/ 2212345 w 2401948"/>
                  <a:gd name="connsiteY53" fmla="*/ 270801 h 320246"/>
                  <a:gd name="connsiteX54" fmla="*/ 2230347 w 2401948"/>
                  <a:gd name="connsiteY54" fmla="*/ 272621 h 320246"/>
                  <a:gd name="connsiteX55" fmla="*/ 2239342 w 2401948"/>
                  <a:gd name="connsiteY55" fmla="*/ 265807 h 320246"/>
                  <a:gd name="connsiteX56" fmla="*/ 2330006 w 2401948"/>
                  <a:gd name="connsiteY56" fmla="*/ 254738 h 320246"/>
                  <a:gd name="connsiteX57" fmla="*/ 2383953 w 2401948"/>
                  <a:gd name="connsiteY57" fmla="*/ 15909 h 320246"/>
                  <a:gd name="connsiteX58" fmla="*/ 2401949 w 2401948"/>
                  <a:gd name="connsiteY58" fmla="*/ 17742 h 320246"/>
                  <a:gd name="connsiteX59" fmla="*/ 2376385 w 2401948"/>
                  <a:gd name="connsiteY59" fmla="*/ 14449 h 320246"/>
                  <a:gd name="connsiteX60" fmla="*/ 2374978 w 2401948"/>
                  <a:gd name="connsiteY60" fmla="*/ 22736 h 320246"/>
                  <a:gd name="connsiteX61" fmla="*/ 2352222 w 2401948"/>
                  <a:gd name="connsiteY61" fmla="*/ 18376 h 320246"/>
                  <a:gd name="connsiteX62" fmla="*/ 2383006 w 2401948"/>
                  <a:gd name="connsiteY62" fmla="*/ 9495 h 320246"/>
                  <a:gd name="connsiteX63" fmla="*/ 2350822 w 2401948"/>
                  <a:gd name="connsiteY63" fmla="*/ 11188 h 320246"/>
                  <a:gd name="connsiteX64" fmla="*/ 2337060 w 2401948"/>
                  <a:gd name="connsiteY64" fmla="*/ 0 h 320246"/>
                  <a:gd name="connsiteX65" fmla="*/ 2299676 w 2401948"/>
                  <a:gd name="connsiteY65" fmla="*/ 4621 h 320246"/>
                  <a:gd name="connsiteX66" fmla="*/ 2299896 w 2401948"/>
                  <a:gd name="connsiteY66" fmla="*/ 3427 h 320246"/>
                  <a:gd name="connsiteX67" fmla="*/ 2226207 w 2401948"/>
                  <a:gd name="connsiteY67" fmla="*/ 6788 h 320246"/>
                  <a:gd name="connsiteX68" fmla="*/ 2229174 w 2401948"/>
                  <a:gd name="connsiteY68" fmla="*/ 4521 h 320246"/>
                  <a:gd name="connsiteX69" fmla="*/ 2182688 w 2401948"/>
                  <a:gd name="connsiteY69" fmla="*/ 1687 h 320246"/>
                  <a:gd name="connsiteX70" fmla="*/ 2181494 w 2401948"/>
                  <a:gd name="connsiteY70" fmla="*/ 8768 h 320246"/>
                  <a:gd name="connsiteX71" fmla="*/ 2132742 w 2401948"/>
                  <a:gd name="connsiteY71" fmla="*/ 3487 h 320246"/>
                  <a:gd name="connsiteX72" fmla="*/ 2118566 w 2401948"/>
                  <a:gd name="connsiteY72" fmla="*/ 10128 h 320246"/>
                  <a:gd name="connsiteX73" fmla="*/ 1699761 w 2401948"/>
                  <a:gd name="connsiteY73" fmla="*/ 19329 h 320246"/>
                  <a:gd name="connsiteX74" fmla="*/ 1702528 w 2401948"/>
                  <a:gd name="connsiteY74" fmla="*/ 18269 h 320246"/>
                  <a:gd name="connsiteX75" fmla="*/ 1262633 w 2401948"/>
                  <a:gd name="connsiteY75" fmla="*/ 30217 h 320246"/>
                  <a:gd name="connsiteX76" fmla="*/ 1203739 w 2401948"/>
                  <a:gd name="connsiteY76" fmla="*/ 23390 h 320246"/>
                  <a:gd name="connsiteX77" fmla="*/ 1202505 w 2401948"/>
                  <a:gd name="connsiteY77" fmla="*/ 30484 h 320246"/>
                  <a:gd name="connsiteX78" fmla="*/ 1143491 w 2401948"/>
                  <a:gd name="connsiteY78" fmla="*/ 37798 h 320246"/>
                  <a:gd name="connsiteX79" fmla="*/ 779472 w 2401948"/>
                  <a:gd name="connsiteY79" fmla="*/ 31391 h 320246"/>
                  <a:gd name="connsiteX80" fmla="*/ 681427 w 2401948"/>
                  <a:gd name="connsiteY80" fmla="*/ 39832 h 320246"/>
                  <a:gd name="connsiteX81" fmla="*/ 684420 w 2401948"/>
                  <a:gd name="connsiteY81" fmla="*/ 37558 h 320246"/>
                  <a:gd name="connsiteX82" fmla="*/ 434409 w 2401948"/>
                  <a:gd name="connsiteY82" fmla="*/ 35705 h 320246"/>
                  <a:gd name="connsiteX83" fmla="*/ 439403 w 2401948"/>
                  <a:gd name="connsiteY83" fmla="*/ 37085 h 320246"/>
                  <a:gd name="connsiteX84" fmla="*/ 385903 w 2401948"/>
                  <a:gd name="connsiteY84" fmla="*/ 29244 h 320246"/>
                  <a:gd name="connsiteX85" fmla="*/ 350919 w 2401948"/>
                  <a:gd name="connsiteY85" fmla="*/ 47006 h 320246"/>
                  <a:gd name="connsiteX86" fmla="*/ 351319 w 2401948"/>
                  <a:gd name="connsiteY86" fmla="*/ 44639 h 320246"/>
                  <a:gd name="connsiteX87" fmla="*/ 272842 w 2401948"/>
                  <a:gd name="connsiteY87" fmla="*/ 57301 h 320246"/>
                  <a:gd name="connsiteX88" fmla="*/ 273876 w 2401948"/>
                  <a:gd name="connsiteY88" fmla="*/ 51386 h 320246"/>
                  <a:gd name="connsiteX89" fmla="*/ 194759 w 2401948"/>
                  <a:gd name="connsiteY89" fmla="*/ 55720 h 320246"/>
                  <a:gd name="connsiteX90" fmla="*/ 54588 w 2401948"/>
                  <a:gd name="connsiteY90" fmla="*/ 50793 h 320246"/>
                  <a:gd name="connsiteX91" fmla="*/ 23378 w 2401948"/>
                  <a:gd name="connsiteY91" fmla="*/ 33938 h 320246"/>
                  <a:gd name="connsiteX92" fmla="*/ 18811 w 2401948"/>
                  <a:gd name="connsiteY92" fmla="*/ 35611 h 320246"/>
                  <a:gd name="connsiteX93" fmla="*/ 32352 w 2401948"/>
                  <a:gd name="connsiteY93" fmla="*/ 282502 h 320246"/>
                  <a:gd name="connsiteX94" fmla="*/ 31339 w 2401948"/>
                  <a:gd name="connsiteY94" fmla="*/ 288403 h 320246"/>
                  <a:gd name="connsiteX95" fmla="*/ 43954 w 2401948"/>
                  <a:gd name="connsiteY95" fmla="*/ 287643 h 320246"/>
                  <a:gd name="connsiteX96" fmla="*/ 65063 w 2401948"/>
                  <a:gd name="connsiteY96" fmla="*/ 289596 h 320246"/>
                  <a:gd name="connsiteX97" fmla="*/ 44327 w 2401948"/>
                  <a:gd name="connsiteY97" fmla="*/ 288876 h 320246"/>
                  <a:gd name="connsiteX98" fmla="*/ 43114 w 2401948"/>
                  <a:gd name="connsiteY98" fmla="*/ 297057 h 320246"/>
                  <a:gd name="connsiteX99" fmla="*/ 60682 w 2401948"/>
                  <a:gd name="connsiteY99" fmla="*/ 300144 h 320246"/>
                  <a:gd name="connsiteX100" fmla="*/ 56115 w 2401948"/>
                  <a:gd name="connsiteY100" fmla="*/ 296410 h 320246"/>
                  <a:gd name="connsiteX101" fmla="*/ 85652 w 2401948"/>
                  <a:gd name="connsiteY101" fmla="*/ 291503 h 320246"/>
                  <a:gd name="connsiteX102" fmla="*/ 104821 w 2401948"/>
                  <a:gd name="connsiteY102" fmla="*/ 301704 h 320246"/>
                  <a:gd name="connsiteX103" fmla="*/ 390404 w 2401948"/>
                  <a:gd name="connsiteY103" fmla="*/ 311779 h 320246"/>
                  <a:gd name="connsiteX104" fmla="*/ 387183 w 2401948"/>
                  <a:gd name="connsiteY104" fmla="*/ 315239 h 320246"/>
                  <a:gd name="connsiteX105" fmla="*/ 468880 w 2401948"/>
                  <a:gd name="connsiteY105" fmla="*/ 310972 h 320246"/>
                  <a:gd name="connsiteX106" fmla="*/ 480462 w 2401948"/>
                  <a:gd name="connsiteY106" fmla="*/ 319707 h 320246"/>
                  <a:gd name="connsiteX107" fmla="*/ 629607 w 2401948"/>
                  <a:gd name="connsiteY107" fmla="*/ 315626 h 3202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  <a:cxn ang="0">
                    <a:pos x="connsiteX69" y="connsiteY69"/>
                  </a:cxn>
                  <a:cxn ang="0">
                    <a:pos x="connsiteX70" y="connsiteY70"/>
                  </a:cxn>
                  <a:cxn ang="0">
                    <a:pos x="connsiteX71" y="connsiteY71"/>
                  </a:cxn>
                  <a:cxn ang="0">
                    <a:pos x="connsiteX72" y="connsiteY72"/>
                  </a:cxn>
                  <a:cxn ang="0">
                    <a:pos x="connsiteX73" y="connsiteY73"/>
                  </a:cxn>
                  <a:cxn ang="0">
                    <a:pos x="connsiteX74" y="connsiteY74"/>
                  </a:cxn>
                  <a:cxn ang="0">
                    <a:pos x="connsiteX75" y="connsiteY75"/>
                  </a:cxn>
                  <a:cxn ang="0">
                    <a:pos x="connsiteX76" y="connsiteY76"/>
                  </a:cxn>
                  <a:cxn ang="0">
                    <a:pos x="connsiteX77" y="connsiteY77"/>
                  </a:cxn>
                  <a:cxn ang="0">
                    <a:pos x="connsiteX78" y="connsiteY78"/>
                  </a:cxn>
                  <a:cxn ang="0">
                    <a:pos x="connsiteX79" y="connsiteY79"/>
                  </a:cxn>
                  <a:cxn ang="0">
                    <a:pos x="connsiteX80" y="connsiteY80"/>
                  </a:cxn>
                  <a:cxn ang="0">
                    <a:pos x="connsiteX81" y="connsiteY81"/>
                  </a:cxn>
                  <a:cxn ang="0">
                    <a:pos x="connsiteX82" y="connsiteY82"/>
                  </a:cxn>
                  <a:cxn ang="0">
                    <a:pos x="connsiteX83" y="connsiteY83"/>
                  </a:cxn>
                  <a:cxn ang="0">
                    <a:pos x="connsiteX84" y="connsiteY84"/>
                  </a:cxn>
                  <a:cxn ang="0">
                    <a:pos x="connsiteX85" y="connsiteY85"/>
                  </a:cxn>
                  <a:cxn ang="0">
                    <a:pos x="connsiteX86" y="connsiteY86"/>
                  </a:cxn>
                  <a:cxn ang="0">
                    <a:pos x="connsiteX87" y="connsiteY87"/>
                  </a:cxn>
                  <a:cxn ang="0">
                    <a:pos x="connsiteX88" y="connsiteY88"/>
                  </a:cxn>
                  <a:cxn ang="0">
                    <a:pos x="connsiteX89" y="connsiteY89"/>
                  </a:cxn>
                  <a:cxn ang="0">
                    <a:pos x="connsiteX90" y="connsiteY90"/>
                  </a:cxn>
                  <a:cxn ang="0">
                    <a:pos x="connsiteX91" y="connsiteY91"/>
                  </a:cxn>
                  <a:cxn ang="0">
                    <a:pos x="connsiteX92" y="connsiteY92"/>
                  </a:cxn>
                  <a:cxn ang="0">
                    <a:pos x="connsiteX93" y="connsiteY93"/>
                  </a:cxn>
                  <a:cxn ang="0">
                    <a:pos x="connsiteX94" y="connsiteY94"/>
                  </a:cxn>
                  <a:cxn ang="0">
                    <a:pos x="connsiteX95" y="connsiteY95"/>
                  </a:cxn>
                  <a:cxn ang="0">
                    <a:pos x="connsiteX96" y="connsiteY96"/>
                  </a:cxn>
                  <a:cxn ang="0">
                    <a:pos x="connsiteX97" y="connsiteY97"/>
                  </a:cxn>
                  <a:cxn ang="0">
                    <a:pos x="connsiteX98" y="connsiteY98"/>
                  </a:cxn>
                  <a:cxn ang="0">
                    <a:pos x="connsiteX99" y="connsiteY99"/>
                  </a:cxn>
                  <a:cxn ang="0">
                    <a:pos x="connsiteX100" y="connsiteY100"/>
                  </a:cxn>
                  <a:cxn ang="0">
                    <a:pos x="connsiteX101" y="connsiteY101"/>
                  </a:cxn>
                  <a:cxn ang="0">
                    <a:pos x="connsiteX102" y="connsiteY102"/>
                  </a:cxn>
                  <a:cxn ang="0">
                    <a:pos x="connsiteX103" y="connsiteY103"/>
                  </a:cxn>
                  <a:cxn ang="0">
                    <a:pos x="connsiteX104" y="connsiteY104"/>
                  </a:cxn>
                  <a:cxn ang="0">
                    <a:pos x="connsiteX105" y="connsiteY105"/>
                  </a:cxn>
                  <a:cxn ang="0">
                    <a:pos x="connsiteX106" y="connsiteY106"/>
                  </a:cxn>
                  <a:cxn ang="0">
                    <a:pos x="connsiteX107" y="connsiteY107"/>
                  </a:cxn>
                </a:cxnLst>
                <a:rect l="l" t="t" r="r" b="b"/>
                <a:pathLst>
                  <a:path w="2401948" h="320246">
                    <a:moveTo>
                      <a:pt x="42687" y="296990"/>
                    </a:moveTo>
                    <a:cubicBezTo>
                      <a:pt x="30572" y="295917"/>
                      <a:pt x="17777" y="295297"/>
                      <a:pt x="10363" y="288863"/>
                    </a:cubicBezTo>
                    <a:cubicBezTo>
                      <a:pt x="23451" y="288149"/>
                      <a:pt x="33366" y="290830"/>
                      <a:pt x="42687" y="296990"/>
                    </a:cubicBezTo>
                    <a:close/>
                    <a:moveTo>
                      <a:pt x="42927" y="297130"/>
                    </a:moveTo>
                    <a:cubicBezTo>
                      <a:pt x="42974" y="297097"/>
                      <a:pt x="43060" y="297070"/>
                      <a:pt x="43114" y="297044"/>
                    </a:cubicBezTo>
                    <a:cubicBezTo>
                      <a:pt x="42947" y="297037"/>
                      <a:pt x="42827" y="297011"/>
                      <a:pt x="42687" y="296990"/>
                    </a:cubicBezTo>
                    <a:cubicBezTo>
                      <a:pt x="42780" y="297057"/>
                      <a:pt x="42854" y="297070"/>
                      <a:pt x="42927" y="297130"/>
                    </a:cubicBezTo>
                    <a:close/>
                    <a:moveTo>
                      <a:pt x="2392981" y="9101"/>
                    </a:moveTo>
                    <a:cubicBezTo>
                      <a:pt x="2389954" y="9228"/>
                      <a:pt x="2386507" y="9355"/>
                      <a:pt x="2383013" y="9501"/>
                    </a:cubicBezTo>
                    <a:cubicBezTo>
                      <a:pt x="2386347" y="9695"/>
                      <a:pt x="2389747" y="9715"/>
                      <a:pt x="2392981" y="9101"/>
                    </a:cubicBezTo>
                    <a:close/>
                    <a:moveTo>
                      <a:pt x="629607" y="315626"/>
                    </a:moveTo>
                    <a:lnTo>
                      <a:pt x="631454" y="304972"/>
                    </a:lnTo>
                    <a:cubicBezTo>
                      <a:pt x="660191" y="304818"/>
                      <a:pt x="639821" y="317166"/>
                      <a:pt x="666385" y="314533"/>
                    </a:cubicBezTo>
                    <a:cubicBezTo>
                      <a:pt x="676779" y="299457"/>
                      <a:pt x="710517" y="316093"/>
                      <a:pt x="719698" y="308085"/>
                    </a:cubicBezTo>
                    <a:cubicBezTo>
                      <a:pt x="719491" y="309285"/>
                      <a:pt x="732500" y="309739"/>
                      <a:pt x="731673" y="314459"/>
                    </a:cubicBezTo>
                    <a:cubicBezTo>
                      <a:pt x="735653" y="306272"/>
                      <a:pt x="745055" y="312559"/>
                      <a:pt x="753256" y="310465"/>
                    </a:cubicBezTo>
                    <a:cubicBezTo>
                      <a:pt x="756229" y="308192"/>
                      <a:pt x="751075" y="308019"/>
                      <a:pt x="748848" y="305552"/>
                    </a:cubicBezTo>
                    <a:lnTo>
                      <a:pt x="767644" y="302658"/>
                    </a:lnTo>
                    <a:cubicBezTo>
                      <a:pt x="774992" y="305291"/>
                      <a:pt x="776805" y="310106"/>
                      <a:pt x="768818" y="310999"/>
                    </a:cubicBezTo>
                    <a:cubicBezTo>
                      <a:pt x="817937" y="313933"/>
                      <a:pt x="1053747" y="321774"/>
                      <a:pt x="1106660" y="317686"/>
                    </a:cubicBezTo>
                    <a:cubicBezTo>
                      <a:pt x="1099859" y="311506"/>
                      <a:pt x="1083524" y="315680"/>
                      <a:pt x="1077316" y="305958"/>
                    </a:cubicBezTo>
                    <a:cubicBezTo>
                      <a:pt x="1091305" y="300511"/>
                      <a:pt x="1097912" y="307865"/>
                      <a:pt x="1104080" y="302138"/>
                    </a:cubicBezTo>
                    <a:cubicBezTo>
                      <a:pt x="1109447" y="316593"/>
                      <a:pt x="1134823" y="305598"/>
                      <a:pt x="1145411" y="320247"/>
                    </a:cubicBezTo>
                    <a:lnTo>
                      <a:pt x="1149425" y="312052"/>
                    </a:lnTo>
                    <a:lnTo>
                      <a:pt x="1156379" y="317066"/>
                    </a:lnTo>
                    <a:cubicBezTo>
                      <a:pt x="1217900" y="308539"/>
                      <a:pt x="1170435" y="312906"/>
                      <a:pt x="1224975" y="314839"/>
                    </a:cubicBezTo>
                    <a:cubicBezTo>
                      <a:pt x="1256539" y="313579"/>
                      <a:pt x="1271540" y="302211"/>
                      <a:pt x="1289103" y="306398"/>
                    </a:cubicBezTo>
                    <a:cubicBezTo>
                      <a:pt x="1286496" y="306312"/>
                      <a:pt x="1279535" y="301298"/>
                      <a:pt x="1287709" y="299204"/>
                    </a:cubicBezTo>
                    <a:cubicBezTo>
                      <a:pt x="1289103" y="306398"/>
                      <a:pt x="1309479" y="294044"/>
                      <a:pt x="1313459" y="301304"/>
                    </a:cubicBezTo>
                    <a:cubicBezTo>
                      <a:pt x="1321467" y="300398"/>
                      <a:pt x="1347417" y="301324"/>
                      <a:pt x="1338635" y="291490"/>
                    </a:cubicBezTo>
                    <a:cubicBezTo>
                      <a:pt x="1343043" y="296397"/>
                      <a:pt x="1366192" y="298411"/>
                      <a:pt x="1352411" y="302671"/>
                    </a:cubicBezTo>
                    <a:cubicBezTo>
                      <a:pt x="1360218" y="302958"/>
                      <a:pt x="1367786" y="304405"/>
                      <a:pt x="1373406" y="302238"/>
                    </a:cubicBezTo>
                    <a:lnTo>
                      <a:pt x="1363379" y="299497"/>
                    </a:lnTo>
                    <a:cubicBezTo>
                      <a:pt x="1389755" y="298071"/>
                      <a:pt x="1404124" y="305685"/>
                      <a:pt x="1421306" y="296784"/>
                    </a:cubicBezTo>
                    <a:lnTo>
                      <a:pt x="1411558" y="292877"/>
                    </a:lnTo>
                    <a:cubicBezTo>
                      <a:pt x="1427327" y="292257"/>
                      <a:pt x="1440515" y="291517"/>
                      <a:pt x="1446702" y="301244"/>
                    </a:cubicBezTo>
                    <a:lnTo>
                      <a:pt x="1430514" y="304238"/>
                    </a:lnTo>
                    <a:cubicBezTo>
                      <a:pt x="1456664" y="303985"/>
                      <a:pt x="1472439" y="303351"/>
                      <a:pt x="1494235" y="298171"/>
                    </a:cubicBezTo>
                    <a:lnTo>
                      <a:pt x="1486454" y="297904"/>
                    </a:lnTo>
                    <a:cubicBezTo>
                      <a:pt x="1514224" y="288183"/>
                      <a:pt x="1659489" y="280155"/>
                      <a:pt x="1685072" y="267987"/>
                    </a:cubicBezTo>
                    <a:lnTo>
                      <a:pt x="1673291" y="260433"/>
                    </a:lnTo>
                    <a:lnTo>
                      <a:pt x="1695293" y="254072"/>
                    </a:lnTo>
                    <a:cubicBezTo>
                      <a:pt x="1692686" y="253978"/>
                      <a:pt x="1684672" y="278595"/>
                      <a:pt x="1682492" y="276135"/>
                    </a:cubicBezTo>
                    <a:cubicBezTo>
                      <a:pt x="1729638" y="275434"/>
                      <a:pt x="1974895" y="269574"/>
                      <a:pt x="2018440" y="274661"/>
                    </a:cubicBezTo>
                    <a:cubicBezTo>
                      <a:pt x="2036009" y="278848"/>
                      <a:pt x="2021601" y="286656"/>
                      <a:pt x="2021401" y="287849"/>
                    </a:cubicBezTo>
                    <a:cubicBezTo>
                      <a:pt x="2042784" y="285029"/>
                      <a:pt x="2030622" y="279842"/>
                      <a:pt x="2048804" y="280488"/>
                    </a:cubicBezTo>
                    <a:cubicBezTo>
                      <a:pt x="2053765" y="281849"/>
                      <a:pt x="2047777" y="286409"/>
                      <a:pt x="2044984" y="287489"/>
                    </a:cubicBezTo>
                    <a:cubicBezTo>
                      <a:pt x="2052951" y="286596"/>
                      <a:pt x="2060339" y="289210"/>
                      <a:pt x="2060946" y="285682"/>
                    </a:cubicBezTo>
                    <a:cubicBezTo>
                      <a:pt x="2050985" y="282942"/>
                      <a:pt x="2055198" y="273581"/>
                      <a:pt x="2050985" y="267494"/>
                    </a:cubicBezTo>
                    <a:lnTo>
                      <a:pt x="2074367" y="268307"/>
                    </a:lnTo>
                    <a:lnTo>
                      <a:pt x="2073327" y="274221"/>
                    </a:lnTo>
                    <a:cubicBezTo>
                      <a:pt x="2078541" y="274401"/>
                      <a:pt x="2086549" y="258046"/>
                      <a:pt x="2109519" y="261226"/>
                    </a:cubicBezTo>
                    <a:cubicBezTo>
                      <a:pt x="2148270" y="263786"/>
                      <a:pt x="2190362" y="261713"/>
                      <a:pt x="2229334" y="263080"/>
                    </a:cubicBezTo>
                    <a:cubicBezTo>
                      <a:pt x="2228727" y="266627"/>
                      <a:pt x="2220546" y="268720"/>
                      <a:pt x="2212345" y="270801"/>
                    </a:cubicBezTo>
                    <a:cubicBezTo>
                      <a:pt x="2217572" y="270981"/>
                      <a:pt x="2225533" y="270074"/>
                      <a:pt x="2230347" y="272621"/>
                    </a:cubicBezTo>
                    <a:cubicBezTo>
                      <a:pt x="2220932" y="266353"/>
                      <a:pt x="2246703" y="268447"/>
                      <a:pt x="2239342" y="265807"/>
                    </a:cubicBezTo>
                    <a:cubicBezTo>
                      <a:pt x="2267885" y="251352"/>
                      <a:pt x="2304810" y="264553"/>
                      <a:pt x="2330006" y="254738"/>
                    </a:cubicBezTo>
                    <a:cubicBezTo>
                      <a:pt x="2332206" y="241737"/>
                      <a:pt x="2383953" y="31371"/>
                      <a:pt x="2383953" y="15909"/>
                    </a:cubicBezTo>
                    <a:cubicBezTo>
                      <a:pt x="2391774" y="16189"/>
                      <a:pt x="2399555" y="16469"/>
                      <a:pt x="2401949" y="17742"/>
                    </a:cubicBezTo>
                    <a:cubicBezTo>
                      <a:pt x="2399928" y="14109"/>
                      <a:pt x="2384553" y="12368"/>
                      <a:pt x="2376385" y="14449"/>
                    </a:cubicBezTo>
                    <a:lnTo>
                      <a:pt x="2374978" y="22736"/>
                    </a:lnTo>
                    <a:cubicBezTo>
                      <a:pt x="2356176" y="25643"/>
                      <a:pt x="2370571" y="17816"/>
                      <a:pt x="2352222" y="18376"/>
                    </a:cubicBezTo>
                    <a:cubicBezTo>
                      <a:pt x="2351242" y="11595"/>
                      <a:pt x="2368131" y="10148"/>
                      <a:pt x="2383006" y="9495"/>
                    </a:cubicBezTo>
                    <a:cubicBezTo>
                      <a:pt x="2369611" y="8708"/>
                      <a:pt x="2356276" y="3767"/>
                      <a:pt x="2350822" y="11188"/>
                    </a:cubicBezTo>
                    <a:cubicBezTo>
                      <a:pt x="2338234" y="8368"/>
                      <a:pt x="2352222" y="2900"/>
                      <a:pt x="2337060" y="0"/>
                    </a:cubicBezTo>
                    <a:cubicBezTo>
                      <a:pt x="2326266" y="1994"/>
                      <a:pt x="2312077" y="8628"/>
                      <a:pt x="2299676" y="4621"/>
                    </a:cubicBezTo>
                    <a:lnTo>
                      <a:pt x="2299896" y="3427"/>
                    </a:lnTo>
                    <a:cubicBezTo>
                      <a:pt x="2269739" y="-3574"/>
                      <a:pt x="2253757" y="13708"/>
                      <a:pt x="2226207" y="6788"/>
                    </a:cubicBezTo>
                    <a:lnTo>
                      <a:pt x="2229174" y="4521"/>
                    </a:lnTo>
                    <a:cubicBezTo>
                      <a:pt x="2219432" y="600"/>
                      <a:pt x="2200257" y="5867"/>
                      <a:pt x="2182688" y="1687"/>
                    </a:cubicBezTo>
                    <a:cubicBezTo>
                      <a:pt x="2187702" y="3054"/>
                      <a:pt x="2192056" y="7961"/>
                      <a:pt x="2181494" y="8768"/>
                    </a:cubicBezTo>
                    <a:cubicBezTo>
                      <a:pt x="2161292" y="4494"/>
                      <a:pt x="2147510" y="8768"/>
                      <a:pt x="2132742" y="3487"/>
                    </a:cubicBezTo>
                    <a:lnTo>
                      <a:pt x="2118566" y="10128"/>
                    </a:lnTo>
                    <a:cubicBezTo>
                      <a:pt x="2048231" y="8835"/>
                      <a:pt x="1770416" y="18269"/>
                      <a:pt x="1699761" y="19329"/>
                    </a:cubicBezTo>
                    <a:lnTo>
                      <a:pt x="1702528" y="18269"/>
                    </a:lnTo>
                    <a:cubicBezTo>
                      <a:pt x="1594874" y="21589"/>
                      <a:pt x="1373893" y="21069"/>
                      <a:pt x="1262633" y="30217"/>
                    </a:cubicBezTo>
                    <a:cubicBezTo>
                      <a:pt x="1245424" y="23683"/>
                      <a:pt x="1221694" y="25217"/>
                      <a:pt x="1203739" y="23390"/>
                    </a:cubicBezTo>
                    <a:cubicBezTo>
                      <a:pt x="1213720" y="26117"/>
                      <a:pt x="1210300" y="30751"/>
                      <a:pt x="1202505" y="30484"/>
                    </a:cubicBezTo>
                    <a:cubicBezTo>
                      <a:pt x="1147805" y="29730"/>
                      <a:pt x="1198811" y="35004"/>
                      <a:pt x="1143491" y="37798"/>
                    </a:cubicBezTo>
                    <a:cubicBezTo>
                      <a:pt x="1079790" y="43879"/>
                      <a:pt x="836019" y="36958"/>
                      <a:pt x="779472" y="31391"/>
                    </a:cubicBezTo>
                    <a:cubicBezTo>
                      <a:pt x="749102" y="41025"/>
                      <a:pt x="711184" y="33738"/>
                      <a:pt x="681427" y="39832"/>
                    </a:cubicBezTo>
                    <a:lnTo>
                      <a:pt x="684420" y="37558"/>
                    </a:lnTo>
                    <a:cubicBezTo>
                      <a:pt x="652463" y="41185"/>
                      <a:pt x="471554" y="32257"/>
                      <a:pt x="434409" y="35705"/>
                    </a:cubicBezTo>
                    <a:lnTo>
                      <a:pt x="439403" y="37085"/>
                    </a:lnTo>
                    <a:cubicBezTo>
                      <a:pt x="407012" y="43065"/>
                      <a:pt x="411426" y="32524"/>
                      <a:pt x="385903" y="29244"/>
                    </a:cubicBezTo>
                    <a:cubicBezTo>
                      <a:pt x="389257" y="40052"/>
                      <a:pt x="361500" y="46193"/>
                      <a:pt x="350919" y="47006"/>
                    </a:cubicBezTo>
                    <a:lnTo>
                      <a:pt x="351319" y="44639"/>
                    </a:lnTo>
                    <a:cubicBezTo>
                      <a:pt x="335357" y="46459"/>
                      <a:pt x="299199" y="55847"/>
                      <a:pt x="272842" y="57301"/>
                    </a:cubicBezTo>
                    <a:lnTo>
                      <a:pt x="273876" y="51386"/>
                    </a:lnTo>
                    <a:cubicBezTo>
                      <a:pt x="251893" y="57741"/>
                      <a:pt x="210561" y="55100"/>
                      <a:pt x="194759" y="55720"/>
                    </a:cubicBezTo>
                    <a:cubicBezTo>
                      <a:pt x="158628" y="53273"/>
                      <a:pt x="102901" y="42979"/>
                      <a:pt x="54588" y="50793"/>
                    </a:cubicBezTo>
                    <a:lnTo>
                      <a:pt x="23378" y="33938"/>
                    </a:lnTo>
                    <a:lnTo>
                      <a:pt x="18811" y="35611"/>
                    </a:lnTo>
                    <a:cubicBezTo>
                      <a:pt x="18811" y="35611"/>
                      <a:pt x="-31456" y="239150"/>
                      <a:pt x="32352" y="282502"/>
                    </a:cubicBezTo>
                    <a:lnTo>
                      <a:pt x="31339" y="288403"/>
                    </a:lnTo>
                    <a:lnTo>
                      <a:pt x="43954" y="287643"/>
                    </a:lnTo>
                    <a:cubicBezTo>
                      <a:pt x="59089" y="290550"/>
                      <a:pt x="66090" y="283709"/>
                      <a:pt x="65063" y="289596"/>
                    </a:cubicBezTo>
                    <a:lnTo>
                      <a:pt x="44327" y="288876"/>
                    </a:lnTo>
                    <a:cubicBezTo>
                      <a:pt x="59536" y="290583"/>
                      <a:pt x="48914" y="293717"/>
                      <a:pt x="43114" y="297057"/>
                    </a:cubicBezTo>
                    <a:cubicBezTo>
                      <a:pt x="49461" y="297624"/>
                      <a:pt x="55628" y="298337"/>
                      <a:pt x="60682" y="300144"/>
                    </a:cubicBezTo>
                    <a:cubicBezTo>
                      <a:pt x="63676" y="297877"/>
                      <a:pt x="58482" y="297697"/>
                      <a:pt x="56115" y="296410"/>
                    </a:cubicBezTo>
                    <a:cubicBezTo>
                      <a:pt x="64296" y="294330"/>
                      <a:pt x="75691" y="288783"/>
                      <a:pt x="85652" y="291503"/>
                    </a:cubicBezTo>
                    <a:cubicBezTo>
                      <a:pt x="101227" y="292057"/>
                      <a:pt x="86646" y="301064"/>
                      <a:pt x="104821" y="301704"/>
                    </a:cubicBezTo>
                    <a:cubicBezTo>
                      <a:pt x="200667" y="306272"/>
                      <a:pt x="293532" y="313112"/>
                      <a:pt x="390404" y="311779"/>
                    </a:cubicBezTo>
                    <a:cubicBezTo>
                      <a:pt x="392604" y="314226"/>
                      <a:pt x="389984" y="314139"/>
                      <a:pt x="387183" y="315239"/>
                    </a:cubicBezTo>
                    <a:cubicBezTo>
                      <a:pt x="416367" y="312692"/>
                      <a:pt x="442310" y="313613"/>
                      <a:pt x="468880" y="310972"/>
                    </a:cubicBezTo>
                    <a:cubicBezTo>
                      <a:pt x="476261" y="313613"/>
                      <a:pt x="478275" y="317253"/>
                      <a:pt x="480462" y="319707"/>
                    </a:cubicBezTo>
                    <a:cubicBezTo>
                      <a:pt x="476068" y="314799"/>
                      <a:pt x="627213" y="314353"/>
                      <a:pt x="629607" y="315626"/>
                    </a:cubicBezTo>
                    <a:close/>
                  </a:path>
                </a:pathLst>
              </a:custGeom>
              <a:ln/>
            </p:spPr>
            <p:style>
              <a:lnRef idx="2">
                <a:schemeClr val="accent2">
                  <a:shade val="50000"/>
                </a:schemeClr>
              </a:lnRef>
              <a:fillRef idx="1">
                <a:schemeClr val="accent2"/>
              </a:fillRef>
              <a:effectRef idx="0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en-US" b="1">
                  <a:ln w="22225">
                    <a:solidFill>
                      <a:schemeClr val="accent2"/>
                    </a:solidFill>
                    <a:prstDash val="solid"/>
                  </a:ln>
                  <a:solidFill>
                    <a:schemeClr val="accent2">
                      <a:lumMod val="40000"/>
                      <a:lumOff val="60000"/>
                    </a:schemeClr>
                  </a:solidFill>
                </a:endParaRPr>
              </a:p>
            </p:txBody>
          </p:sp>
          <p:grpSp>
            <p:nvGrpSpPr>
              <p:cNvPr id="43" name="Group 42">
                <a:extLst>
                  <a:ext uri="{FF2B5EF4-FFF2-40B4-BE49-F238E27FC236}">
                    <a16:creationId xmlns:a16="http://schemas.microsoft.com/office/drawing/2014/main" id="{62C89E36-878B-F4DB-BC50-59656B20DAF2}"/>
                  </a:ext>
                </a:extLst>
              </p:cNvPr>
              <p:cNvGrpSpPr/>
              <p:nvPr/>
            </p:nvGrpSpPr>
            <p:grpSpPr>
              <a:xfrm>
                <a:off x="1854584" y="3435271"/>
                <a:ext cx="1734767" cy="925910"/>
                <a:chOff x="12738721" y="4106786"/>
                <a:chExt cx="1889389" cy="1210306"/>
              </a:xfrm>
            </p:grpSpPr>
            <p:sp>
              <p:nvSpPr>
                <p:cNvPr id="61" name="TextBox 60">
                  <a:extLst>
                    <a:ext uri="{FF2B5EF4-FFF2-40B4-BE49-F238E27FC236}">
                      <a16:creationId xmlns:a16="http://schemas.microsoft.com/office/drawing/2014/main" id="{4D616A09-2C62-0CBE-F299-91ADE6E43A9F}"/>
                    </a:ext>
                  </a:extLst>
                </p:cNvPr>
                <p:cNvSpPr txBox="1"/>
                <p:nvPr/>
              </p:nvSpPr>
              <p:spPr>
                <a:xfrm>
                  <a:off x="12927236" y="4106786"/>
                  <a:ext cx="827950" cy="40231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>
                      <a:solidFill>
                        <a:schemeClr val="bg1"/>
                      </a:solidFill>
                    </a:rPr>
                    <a:t>STROKE</a:t>
                  </a:r>
                </a:p>
              </p:txBody>
            </p:sp>
            <p:sp>
              <p:nvSpPr>
                <p:cNvPr id="62" name="TextBox 61">
                  <a:extLst>
                    <a:ext uri="{FF2B5EF4-FFF2-40B4-BE49-F238E27FC236}">
                      <a16:creationId xmlns:a16="http://schemas.microsoft.com/office/drawing/2014/main" id="{5E1ABEB4-80AA-5EE4-3F80-1D6D916FCC5C}"/>
                    </a:ext>
                  </a:extLst>
                </p:cNvPr>
                <p:cNvSpPr txBox="1"/>
                <p:nvPr/>
              </p:nvSpPr>
              <p:spPr>
                <a:xfrm>
                  <a:off x="12738721" y="4532586"/>
                  <a:ext cx="1889389" cy="78450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dirty="0"/>
                    <a:t>Mild weakness to paralysis or numbness on one side of the face or body</a:t>
                  </a:r>
                </a:p>
              </p:txBody>
            </p:sp>
          </p:grpSp>
        </p:grp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38782C84-6344-8B56-82A6-394BDD286DAC}"/>
                </a:ext>
              </a:extLst>
            </p:cNvPr>
            <p:cNvGrpSpPr/>
            <p:nvPr/>
          </p:nvGrpSpPr>
          <p:grpSpPr>
            <a:xfrm>
              <a:off x="1874748" y="2001197"/>
              <a:ext cx="1734767" cy="1101422"/>
              <a:chOff x="1854584" y="3429037"/>
              <a:chExt cx="1734767" cy="1101422"/>
            </a:xfrm>
          </p:grpSpPr>
          <p:sp>
            <p:nvSpPr>
              <p:cNvPr id="10" name="Graphic 2" descr="A brushstroke">
                <a:extLst>
                  <a:ext uri="{FF2B5EF4-FFF2-40B4-BE49-F238E27FC236}">
                    <a16:creationId xmlns:a16="http://schemas.microsoft.com/office/drawing/2014/main" id="{0D8B8FC3-55F8-2E37-1183-1493A0921411}"/>
                  </a:ext>
                </a:extLst>
              </p:cNvPr>
              <p:cNvSpPr/>
              <p:nvPr/>
            </p:nvSpPr>
            <p:spPr>
              <a:xfrm>
                <a:off x="1891360" y="3429037"/>
                <a:ext cx="1434796" cy="320246"/>
              </a:xfrm>
              <a:custGeom>
                <a:avLst/>
                <a:gdLst>
                  <a:gd name="connsiteX0" fmla="*/ 42687 w 2401948"/>
                  <a:gd name="connsiteY0" fmla="*/ 296990 h 320246"/>
                  <a:gd name="connsiteX1" fmla="*/ 10363 w 2401948"/>
                  <a:gd name="connsiteY1" fmla="*/ 288863 h 320246"/>
                  <a:gd name="connsiteX2" fmla="*/ 42687 w 2401948"/>
                  <a:gd name="connsiteY2" fmla="*/ 296990 h 320246"/>
                  <a:gd name="connsiteX3" fmla="*/ 42927 w 2401948"/>
                  <a:gd name="connsiteY3" fmla="*/ 297130 h 320246"/>
                  <a:gd name="connsiteX4" fmla="*/ 43114 w 2401948"/>
                  <a:gd name="connsiteY4" fmla="*/ 297044 h 320246"/>
                  <a:gd name="connsiteX5" fmla="*/ 42687 w 2401948"/>
                  <a:gd name="connsiteY5" fmla="*/ 296990 h 320246"/>
                  <a:gd name="connsiteX6" fmla="*/ 42927 w 2401948"/>
                  <a:gd name="connsiteY6" fmla="*/ 297130 h 320246"/>
                  <a:gd name="connsiteX7" fmla="*/ 2392981 w 2401948"/>
                  <a:gd name="connsiteY7" fmla="*/ 9101 h 320246"/>
                  <a:gd name="connsiteX8" fmla="*/ 2383013 w 2401948"/>
                  <a:gd name="connsiteY8" fmla="*/ 9501 h 320246"/>
                  <a:gd name="connsiteX9" fmla="*/ 2392981 w 2401948"/>
                  <a:gd name="connsiteY9" fmla="*/ 9101 h 320246"/>
                  <a:gd name="connsiteX10" fmla="*/ 629607 w 2401948"/>
                  <a:gd name="connsiteY10" fmla="*/ 315626 h 320246"/>
                  <a:gd name="connsiteX11" fmla="*/ 631454 w 2401948"/>
                  <a:gd name="connsiteY11" fmla="*/ 304972 h 320246"/>
                  <a:gd name="connsiteX12" fmla="*/ 666385 w 2401948"/>
                  <a:gd name="connsiteY12" fmla="*/ 314533 h 320246"/>
                  <a:gd name="connsiteX13" fmla="*/ 719698 w 2401948"/>
                  <a:gd name="connsiteY13" fmla="*/ 308085 h 320246"/>
                  <a:gd name="connsiteX14" fmla="*/ 731673 w 2401948"/>
                  <a:gd name="connsiteY14" fmla="*/ 314459 h 320246"/>
                  <a:gd name="connsiteX15" fmla="*/ 753256 w 2401948"/>
                  <a:gd name="connsiteY15" fmla="*/ 310465 h 320246"/>
                  <a:gd name="connsiteX16" fmla="*/ 748848 w 2401948"/>
                  <a:gd name="connsiteY16" fmla="*/ 305552 h 320246"/>
                  <a:gd name="connsiteX17" fmla="*/ 767644 w 2401948"/>
                  <a:gd name="connsiteY17" fmla="*/ 302658 h 320246"/>
                  <a:gd name="connsiteX18" fmla="*/ 768818 w 2401948"/>
                  <a:gd name="connsiteY18" fmla="*/ 310999 h 320246"/>
                  <a:gd name="connsiteX19" fmla="*/ 1106660 w 2401948"/>
                  <a:gd name="connsiteY19" fmla="*/ 317686 h 320246"/>
                  <a:gd name="connsiteX20" fmla="*/ 1077316 w 2401948"/>
                  <a:gd name="connsiteY20" fmla="*/ 305958 h 320246"/>
                  <a:gd name="connsiteX21" fmla="*/ 1104080 w 2401948"/>
                  <a:gd name="connsiteY21" fmla="*/ 302138 h 320246"/>
                  <a:gd name="connsiteX22" fmla="*/ 1145411 w 2401948"/>
                  <a:gd name="connsiteY22" fmla="*/ 320247 h 320246"/>
                  <a:gd name="connsiteX23" fmla="*/ 1149425 w 2401948"/>
                  <a:gd name="connsiteY23" fmla="*/ 312052 h 320246"/>
                  <a:gd name="connsiteX24" fmla="*/ 1156379 w 2401948"/>
                  <a:gd name="connsiteY24" fmla="*/ 317066 h 320246"/>
                  <a:gd name="connsiteX25" fmla="*/ 1224975 w 2401948"/>
                  <a:gd name="connsiteY25" fmla="*/ 314839 h 320246"/>
                  <a:gd name="connsiteX26" fmla="*/ 1289103 w 2401948"/>
                  <a:gd name="connsiteY26" fmla="*/ 306398 h 320246"/>
                  <a:gd name="connsiteX27" fmla="*/ 1287709 w 2401948"/>
                  <a:gd name="connsiteY27" fmla="*/ 299204 h 320246"/>
                  <a:gd name="connsiteX28" fmla="*/ 1313459 w 2401948"/>
                  <a:gd name="connsiteY28" fmla="*/ 301304 h 320246"/>
                  <a:gd name="connsiteX29" fmla="*/ 1338635 w 2401948"/>
                  <a:gd name="connsiteY29" fmla="*/ 291490 h 320246"/>
                  <a:gd name="connsiteX30" fmla="*/ 1352411 w 2401948"/>
                  <a:gd name="connsiteY30" fmla="*/ 302671 h 320246"/>
                  <a:gd name="connsiteX31" fmla="*/ 1373406 w 2401948"/>
                  <a:gd name="connsiteY31" fmla="*/ 302238 h 320246"/>
                  <a:gd name="connsiteX32" fmla="*/ 1363379 w 2401948"/>
                  <a:gd name="connsiteY32" fmla="*/ 299497 h 320246"/>
                  <a:gd name="connsiteX33" fmla="*/ 1421306 w 2401948"/>
                  <a:gd name="connsiteY33" fmla="*/ 296784 h 320246"/>
                  <a:gd name="connsiteX34" fmla="*/ 1411558 w 2401948"/>
                  <a:gd name="connsiteY34" fmla="*/ 292877 h 320246"/>
                  <a:gd name="connsiteX35" fmla="*/ 1446702 w 2401948"/>
                  <a:gd name="connsiteY35" fmla="*/ 301244 h 320246"/>
                  <a:gd name="connsiteX36" fmla="*/ 1430514 w 2401948"/>
                  <a:gd name="connsiteY36" fmla="*/ 304238 h 320246"/>
                  <a:gd name="connsiteX37" fmla="*/ 1494235 w 2401948"/>
                  <a:gd name="connsiteY37" fmla="*/ 298171 h 320246"/>
                  <a:gd name="connsiteX38" fmla="*/ 1486454 w 2401948"/>
                  <a:gd name="connsiteY38" fmla="*/ 297904 h 320246"/>
                  <a:gd name="connsiteX39" fmla="*/ 1685072 w 2401948"/>
                  <a:gd name="connsiteY39" fmla="*/ 267987 h 320246"/>
                  <a:gd name="connsiteX40" fmla="*/ 1673291 w 2401948"/>
                  <a:gd name="connsiteY40" fmla="*/ 260433 h 320246"/>
                  <a:gd name="connsiteX41" fmla="*/ 1695293 w 2401948"/>
                  <a:gd name="connsiteY41" fmla="*/ 254072 h 320246"/>
                  <a:gd name="connsiteX42" fmla="*/ 1682492 w 2401948"/>
                  <a:gd name="connsiteY42" fmla="*/ 276135 h 320246"/>
                  <a:gd name="connsiteX43" fmla="*/ 2018440 w 2401948"/>
                  <a:gd name="connsiteY43" fmla="*/ 274661 h 320246"/>
                  <a:gd name="connsiteX44" fmla="*/ 2021401 w 2401948"/>
                  <a:gd name="connsiteY44" fmla="*/ 287849 h 320246"/>
                  <a:gd name="connsiteX45" fmla="*/ 2048804 w 2401948"/>
                  <a:gd name="connsiteY45" fmla="*/ 280488 h 320246"/>
                  <a:gd name="connsiteX46" fmla="*/ 2044984 w 2401948"/>
                  <a:gd name="connsiteY46" fmla="*/ 287489 h 320246"/>
                  <a:gd name="connsiteX47" fmla="*/ 2060946 w 2401948"/>
                  <a:gd name="connsiteY47" fmla="*/ 285682 h 320246"/>
                  <a:gd name="connsiteX48" fmla="*/ 2050985 w 2401948"/>
                  <a:gd name="connsiteY48" fmla="*/ 267494 h 320246"/>
                  <a:gd name="connsiteX49" fmla="*/ 2074367 w 2401948"/>
                  <a:gd name="connsiteY49" fmla="*/ 268307 h 320246"/>
                  <a:gd name="connsiteX50" fmla="*/ 2073327 w 2401948"/>
                  <a:gd name="connsiteY50" fmla="*/ 274221 h 320246"/>
                  <a:gd name="connsiteX51" fmla="*/ 2109519 w 2401948"/>
                  <a:gd name="connsiteY51" fmla="*/ 261226 h 320246"/>
                  <a:gd name="connsiteX52" fmla="*/ 2229334 w 2401948"/>
                  <a:gd name="connsiteY52" fmla="*/ 263080 h 320246"/>
                  <a:gd name="connsiteX53" fmla="*/ 2212345 w 2401948"/>
                  <a:gd name="connsiteY53" fmla="*/ 270801 h 320246"/>
                  <a:gd name="connsiteX54" fmla="*/ 2230347 w 2401948"/>
                  <a:gd name="connsiteY54" fmla="*/ 272621 h 320246"/>
                  <a:gd name="connsiteX55" fmla="*/ 2239342 w 2401948"/>
                  <a:gd name="connsiteY55" fmla="*/ 265807 h 320246"/>
                  <a:gd name="connsiteX56" fmla="*/ 2330006 w 2401948"/>
                  <a:gd name="connsiteY56" fmla="*/ 254738 h 320246"/>
                  <a:gd name="connsiteX57" fmla="*/ 2383953 w 2401948"/>
                  <a:gd name="connsiteY57" fmla="*/ 15909 h 320246"/>
                  <a:gd name="connsiteX58" fmla="*/ 2401949 w 2401948"/>
                  <a:gd name="connsiteY58" fmla="*/ 17742 h 320246"/>
                  <a:gd name="connsiteX59" fmla="*/ 2376385 w 2401948"/>
                  <a:gd name="connsiteY59" fmla="*/ 14449 h 320246"/>
                  <a:gd name="connsiteX60" fmla="*/ 2374978 w 2401948"/>
                  <a:gd name="connsiteY60" fmla="*/ 22736 h 320246"/>
                  <a:gd name="connsiteX61" fmla="*/ 2352222 w 2401948"/>
                  <a:gd name="connsiteY61" fmla="*/ 18376 h 320246"/>
                  <a:gd name="connsiteX62" fmla="*/ 2383006 w 2401948"/>
                  <a:gd name="connsiteY62" fmla="*/ 9495 h 320246"/>
                  <a:gd name="connsiteX63" fmla="*/ 2350822 w 2401948"/>
                  <a:gd name="connsiteY63" fmla="*/ 11188 h 320246"/>
                  <a:gd name="connsiteX64" fmla="*/ 2337060 w 2401948"/>
                  <a:gd name="connsiteY64" fmla="*/ 0 h 320246"/>
                  <a:gd name="connsiteX65" fmla="*/ 2299676 w 2401948"/>
                  <a:gd name="connsiteY65" fmla="*/ 4621 h 320246"/>
                  <a:gd name="connsiteX66" fmla="*/ 2299896 w 2401948"/>
                  <a:gd name="connsiteY66" fmla="*/ 3427 h 320246"/>
                  <a:gd name="connsiteX67" fmla="*/ 2226207 w 2401948"/>
                  <a:gd name="connsiteY67" fmla="*/ 6788 h 320246"/>
                  <a:gd name="connsiteX68" fmla="*/ 2229174 w 2401948"/>
                  <a:gd name="connsiteY68" fmla="*/ 4521 h 320246"/>
                  <a:gd name="connsiteX69" fmla="*/ 2182688 w 2401948"/>
                  <a:gd name="connsiteY69" fmla="*/ 1687 h 320246"/>
                  <a:gd name="connsiteX70" fmla="*/ 2181494 w 2401948"/>
                  <a:gd name="connsiteY70" fmla="*/ 8768 h 320246"/>
                  <a:gd name="connsiteX71" fmla="*/ 2132742 w 2401948"/>
                  <a:gd name="connsiteY71" fmla="*/ 3487 h 320246"/>
                  <a:gd name="connsiteX72" fmla="*/ 2118566 w 2401948"/>
                  <a:gd name="connsiteY72" fmla="*/ 10128 h 320246"/>
                  <a:gd name="connsiteX73" fmla="*/ 1699761 w 2401948"/>
                  <a:gd name="connsiteY73" fmla="*/ 19329 h 320246"/>
                  <a:gd name="connsiteX74" fmla="*/ 1702528 w 2401948"/>
                  <a:gd name="connsiteY74" fmla="*/ 18269 h 320246"/>
                  <a:gd name="connsiteX75" fmla="*/ 1262633 w 2401948"/>
                  <a:gd name="connsiteY75" fmla="*/ 30217 h 320246"/>
                  <a:gd name="connsiteX76" fmla="*/ 1203739 w 2401948"/>
                  <a:gd name="connsiteY76" fmla="*/ 23390 h 320246"/>
                  <a:gd name="connsiteX77" fmla="*/ 1202505 w 2401948"/>
                  <a:gd name="connsiteY77" fmla="*/ 30484 h 320246"/>
                  <a:gd name="connsiteX78" fmla="*/ 1143491 w 2401948"/>
                  <a:gd name="connsiteY78" fmla="*/ 37798 h 320246"/>
                  <a:gd name="connsiteX79" fmla="*/ 779472 w 2401948"/>
                  <a:gd name="connsiteY79" fmla="*/ 31391 h 320246"/>
                  <a:gd name="connsiteX80" fmla="*/ 681427 w 2401948"/>
                  <a:gd name="connsiteY80" fmla="*/ 39832 h 320246"/>
                  <a:gd name="connsiteX81" fmla="*/ 684420 w 2401948"/>
                  <a:gd name="connsiteY81" fmla="*/ 37558 h 320246"/>
                  <a:gd name="connsiteX82" fmla="*/ 434409 w 2401948"/>
                  <a:gd name="connsiteY82" fmla="*/ 35705 h 320246"/>
                  <a:gd name="connsiteX83" fmla="*/ 439403 w 2401948"/>
                  <a:gd name="connsiteY83" fmla="*/ 37085 h 320246"/>
                  <a:gd name="connsiteX84" fmla="*/ 385903 w 2401948"/>
                  <a:gd name="connsiteY84" fmla="*/ 29244 h 320246"/>
                  <a:gd name="connsiteX85" fmla="*/ 350919 w 2401948"/>
                  <a:gd name="connsiteY85" fmla="*/ 47006 h 320246"/>
                  <a:gd name="connsiteX86" fmla="*/ 351319 w 2401948"/>
                  <a:gd name="connsiteY86" fmla="*/ 44639 h 320246"/>
                  <a:gd name="connsiteX87" fmla="*/ 272842 w 2401948"/>
                  <a:gd name="connsiteY87" fmla="*/ 57301 h 320246"/>
                  <a:gd name="connsiteX88" fmla="*/ 273876 w 2401948"/>
                  <a:gd name="connsiteY88" fmla="*/ 51386 h 320246"/>
                  <a:gd name="connsiteX89" fmla="*/ 194759 w 2401948"/>
                  <a:gd name="connsiteY89" fmla="*/ 55720 h 320246"/>
                  <a:gd name="connsiteX90" fmla="*/ 54588 w 2401948"/>
                  <a:gd name="connsiteY90" fmla="*/ 50793 h 320246"/>
                  <a:gd name="connsiteX91" fmla="*/ 23378 w 2401948"/>
                  <a:gd name="connsiteY91" fmla="*/ 33938 h 320246"/>
                  <a:gd name="connsiteX92" fmla="*/ 18811 w 2401948"/>
                  <a:gd name="connsiteY92" fmla="*/ 35611 h 320246"/>
                  <a:gd name="connsiteX93" fmla="*/ 32352 w 2401948"/>
                  <a:gd name="connsiteY93" fmla="*/ 282502 h 320246"/>
                  <a:gd name="connsiteX94" fmla="*/ 31339 w 2401948"/>
                  <a:gd name="connsiteY94" fmla="*/ 288403 h 320246"/>
                  <a:gd name="connsiteX95" fmla="*/ 43954 w 2401948"/>
                  <a:gd name="connsiteY95" fmla="*/ 287643 h 320246"/>
                  <a:gd name="connsiteX96" fmla="*/ 65063 w 2401948"/>
                  <a:gd name="connsiteY96" fmla="*/ 289596 h 320246"/>
                  <a:gd name="connsiteX97" fmla="*/ 44327 w 2401948"/>
                  <a:gd name="connsiteY97" fmla="*/ 288876 h 320246"/>
                  <a:gd name="connsiteX98" fmla="*/ 43114 w 2401948"/>
                  <a:gd name="connsiteY98" fmla="*/ 297057 h 320246"/>
                  <a:gd name="connsiteX99" fmla="*/ 60682 w 2401948"/>
                  <a:gd name="connsiteY99" fmla="*/ 300144 h 320246"/>
                  <a:gd name="connsiteX100" fmla="*/ 56115 w 2401948"/>
                  <a:gd name="connsiteY100" fmla="*/ 296410 h 320246"/>
                  <a:gd name="connsiteX101" fmla="*/ 85652 w 2401948"/>
                  <a:gd name="connsiteY101" fmla="*/ 291503 h 320246"/>
                  <a:gd name="connsiteX102" fmla="*/ 104821 w 2401948"/>
                  <a:gd name="connsiteY102" fmla="*/ 301704 h 320246"/>
                  <a:gd name="connsiteX103" fmla="*/ 390404 w 2401948"/>
                  <a:gd name="connsiteY103" fmla="*/ 311779 h 320246"/>
                  <a:gd name="connsiteX104" fmla="*/ 387183 w 2401948"/>
                  <a:gd name="connsiteY104" fmla="*/ 315239 h 320246"/>
                  <a:gd name="connsiteX105" fmla="*/ 468880 w 2401948"/>
                  <a:gd name="connsiteY105" fmla="*/ 310972 h 320246"/>
                  <a:gd name="connsiteX106" fmla="*/ 480462 w 2401948"/>
                  <a:gd name="connsiteY106" fmla="*/ 319707 h 320246"/>
                  <a:gd name="connsiteX107" fmla="*/ 629607 w 2401948"/>
                  <a:gd name="connsiteY107" fmla="*/ 315626 h 3202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  <a:cxn ang="0">
                    <a:pos x="connsiteX69" y="connsiteY69"/>
                  </a:cxn>
                  <a:cxn ang="0">
                    <a:pos x="connsiteX70" y="connsiteY70"/>
                  </a:cxn>
                  <a:cxn ang="0">
                    <a:pos x="connsiteX71" y="connsiteY71"/>
                  </a:cxn>
                  <a:cxn ang="0">
                    <a:pos x="connsiteX72" y="connsiteY72"/>
                  </a:cxn>
                  <a:cxn ang="0">
                    <a:pos x="connsiteX73" y="connsiteY73"/>
                  </a:cxn>
                  <a:cxn ang="0">
                    <a:pos x="connsiteX74" y="connsiteY74"/>
                  </a:cxn>
                  <a:cxn ang="0">
                    <a:pos x="connsiteX75" y="connsiteY75"/>
                  </a:cxn>
                  <a:cxn ang="0">
                    <a:pos x="connsiteX76" y="connsiteY76"/>
                  </a:cxn>
                  <a:cxn ang="0">
                    <a:pos x="connsiteX77" y="connsiteY77"/>
                  </a:cxn>
                  <a:cxn ang="0">
                    <a:pos x="connsiteX78" y="connsiteY78"/>
                  </a:cxn>
                  <a:cxn ang="0">
                    <a:pos x="connsiteX79" y="connsiteY79"/>
                  </a:cxn>
                  <a:cxn ang="0">
                    <a:pos x="connsiteX80" y="connsiteY80"/>
                  </a:cxn>
                  <a:cxn ang="0">
                    <a:pos x="connsiteX81" y="connsiteY81"/>
                  </a:cxn>
                  <a:cxn ang="0">
                    <a:pos x="connsiteX82" y="connsiteY82"/>
                  </a:cxn>
                  <a:cxn ang="0">
                    <a:pos x="connsiteX83" y="connsiteY83"/>
                  </a:cxn>
                  <a:cxn ang="0">
                    <a:pos x="connsiteX84" y="connsiteY84"/>
                  </a:cxn>
                  <a:cxn ang="0">
                    <a:pos x="connsiteX85" y="connsiteY85"/>
                  </a:cxn>
                  <a:cxn ang="0">
                    <a:pos x="connsiteX86" y="connsiteY86"/>
                  </a:cxn>
                  <a:cxn ang="0">
                    <a:pos x="connsiteX87" y="connsiteY87"/>
                  </a:cxn>
                  <a:cxn ang="0">
                    <a:pos x="connsiteX88" y="connsiteY88"/>
                  </a:cxn>
                  <a:cxn ang="0">
                    <a:pos x="connsiteX89" y="connsiteY89"/>
                  </a:cxn>
                  <a:cxn ang="0">
                    <a:pos x="connsiteX90" y="connsiteY90"/>
                  </a:cxn>
                  <a:cxn ang="0">
                    <a:pos x="connsiteX91" y="connsiteY91"/>
                  </a:cxn>
                  <a:cxn ang="0">
                    <a:pos x="connsiteX92" y="connsiteY92"/>
                  </a:cxn>
                  <a:cxn ang="0">
                    <a:pos x="connsiteX93" y="connsiteY93"/>
                  </a:cxn>
                  <a:cxn ang="0">
                    <a:pos x="connsiteX94" y="connsiteY94"/>
                  </a:cxn>
                  <a:cxn ang="0">
                    <a:pos x="connsiteX95" y="connsiteY95"/>
                  </a:cxn>
                  <a:cxn ang="0">
                    <a:pos x="connsiteX96" y="connsiteY96"/>
                  </a:cxn>
                  <a:cxn ang="0">
                    <a:pos x="connsiteX97" y="connsiteY97"/>
                  </a:cxn>
                  <a:cxn ang="0">
                    <a:pos x="connsiteX98" y="connsiteY98"/>
                  </a:cxn>
                  <a:cxn ang="0">
                    <a:pos x="connsiteX99" y="connsiteY99"/>
                  </a:cxn>
                  <a:cxn ang="0">
                    <a:pos x="connsiteX100" y="connsiteY100"/>
                  </a:cxn>
                  <a:cxn ang="0">
                    <a:pos x="connsiteX101" y="connsiteY101"/>
                  </a:cxn>
                  <a:cxn ang="0">
                    <a:pos x="connsiteX102" y="connsiteY102"/>
                  </a:cxn>
                  <a:cxn ang="0">
                    <a:pos x="connsiteX103" y="connsiteY103"/>
                  </a:cxn>
                  <a:cxn ang="0">
                    <a:pos x="connsiteX104" y="connsiteY104"/>
                  </a:cxn>
                  <a:cxn ang="0">
                    <a:pos x="connsiteX105" y="connsiteY105"/>
                  </a:cxn>
                  <a:cxn ang="0">
                    <a:pos x="connsiteX106" y="connsiteY106"/>
                  </a:cxn>
                  <a:cxn ang="0">
                    <a:pos x="connsiteX107" y="connsiteY107"/>
                  </a:cxn>
                </a:cxnLst>
                <a:rect l="l" t="t" r="r" b="b"/>
                <a:pathLst>
                  <a:path w="2401948" h="320246">
                    <a:moveTo>
                      <a:pt x="42687" y="296990"/>
                    </a:moveTo>
                    <a:cubicBezTo>
                      <a:pt x="30572" y="295917"/>
                      <a:pt x="17777" y="295297"/>
                      <a:pt x="10363" y="288863"/>
                    </a:cubicBezTo>
                    <a:cubicBezTo>
                      <a:pt x="23451" y="288149"/>
                      <a:pt x="33366" y="290830"/>
                      <a:pt x="42687" y="296990"/>
                    </a:cubicBezTo>
                    <a:close/>
                    <a:moveTo>
                      <a:pt x="42927" y="297130"/>
                    </a:moveTo>
                    <a:cubicBezTo>
                      <a:pt x="42974" y="297097"/>
                      <a:pt x="43060" y="297070"/>
                      <a:pt x="43114" y="297044"/>
                    </a:cubicBezTo>
                    <a:cubicBezTo>
                      <a:pt x="42947" y="297037"/>
                      <a:pt x="42827" y="297011"/>
                      <a:pt x="42687" y="296990"/>
                    </a:cubicBezTo>
                    <a:cubicBezTo>
                      <a:pt x="42780" y="297057"/>
                      <a:pt x="42854" y="297070"/>
                      <a:pt x="42927" y="297130"/>
                    </a:cubicBezTo>
                    <a:close/>
                    <a:moveTo>
                      <a:pt x="2392981" y="9101"/>
                    </a:moveTo>
                    <a:cubicBezTo>
                      <a:pt x="2389954" y="9228"/>
                      <a:pt x="2386507" y="9355"/>
                      <a:pt x="2383013" y="9501"/>
                    </a:cubicBezTo>
                    <a:cubicBezTo>
                      <a:pt x="2386347" y="9695"/>
                      <a:pt x="2389747" y="9715"/>
                      <a:pt x="2392981" y="9101"/>
                    </a:cubicBezTo>
                    <a:close/>
                    <a:moveTo>
                      <a:pt x="629607" y="315626"/>
                    </a:moveTo>
                    <a:lnTo>
                      <a:pt x="631454" y="304972"/>
                    </a:lnTo>
                    <a:cubicBezTo>
                      <a:pt x="660191" y="304818"/>
                      <a:pt x="639821" y="317166"/>
                      <a:pt x="666385" y="314533"/>
                    </a:cubicBezTo>
                    <a:cubicBezTo>
                      <a:pt x="676779" y="299457"/>
                      <a:pt x="710517" y="316093"/>
                      <a:pt x="719698" y="308085"/>
                    </a:cubicBezTo>
                    <a:cubicBezTo>
                      <a:pt x="719491" y="309285"/>
                      <a:pt x="732500" y="309739"/>
                      <a:pt x="731673" y="314459"/>
                    </a:cubicBezTo>
                    <a:cubicBezTo>
                      <a:pt x="735653" y="306272"/>
                      <a:pt x="745055" y="312559"/>
                      <a:pt x="753256" y="310465"/>
                    </a:cubicBezTo>
                    <a:cubicBezTo>
                      <a:pt x="756229" y="308192"/>
                      <a:pt x="751075" y="308019"/>
                      <a:pt x="748848" y="305552"/>
                    </a:cubicBezTo>
                    <a:lnTo>
                      <a:pt x="767644" y="302658"/>
                    </a:lnTo>
                    <a:cubicBezTo>
                      <a:pt x="774992" y="305291"/>
                      <a:pt x="776805" y="310106"/>
                      <a:pt x="768818" y="310999"/>
                    </a:cubicBezTo>
                    <a:cubicBezTo>
                      <a:pt x="817937" y="313933"/>
                      <a:pt x="1053747" y="321774"/>
                      <a:pt x="1106660" y="317686"/>
                    </a:cubicBezTo>
                    <a:cubicBezTo>
                      <a:pt x="1099859" y="311506"/>
                      <a:pt x="1083524" y="315680"/>
                      <a:pt x="1077316" y="305958"/>
                    </a:cubicBezTo>
                    <a:cubicBezTo>
                      <a:pt x="1091305" y="300511"/>
                      <a:pt x="1097912" y="307865"/>
                      <a:pt x="1104080" y="302138"/>
                    </a:cubicBezTo>
                    <a:cubicBezTo>
                      <a:pt x="1109447" y="316593"/>
                      <a:pt x="1134823" y="305598"/>
                      <a:pt x="1145411" y="320247"/>
                    </a:cubicBezTo>
                    <a:lnTo>
                      <a:pt x="1149425" y="312052"/>
                    </a:lnTo>
                    <a:lnTo>
                      <a:pt x="1156379" y="317066"/>
                    </a:lnTo>
                    <a:cubicBezTo>
                      <a:pt x="1217900" y="308539"/>
                      <a:pt x="1170435" y="312906"/>
                      <a:pt x="1224975" y="314839"/>
                    </a:cubicBezTo>
                    <a:cubicBezTo>
                      <a:pt x="1256539" y="313579"/>
                      <a:pt x="1271540" y="302211"/>
                      <a:pt x="1289103" y="306398"/>
                    </a:cubicBezTo>
                    <a:cubicBezTo>
                      <a:pt x="1286496" y="306312"/>
                      <a:pt x="1279535" y="301298"/>
                      <a:pt x="1287709" y="299204"/>
                    </a:cubicBezTo>
                    <a:cubicBezTo>
                      <a:pt x="1289103" y="306398"/>
                      <a:pt x="1309479" y="294044"/>
                      <a:pt x="1313459" y="301304"/>
                    </a:cubicBezTo>
                    <a:cubicBezTo>
                      <a:pt x="1321467" y="300398"/>
                      <a:pt x="1347417" y="301324"/>
                      <a:pt x="1338635" y="291490"/>
                    </a:cubicBezTo>
                    <a:cubicBezTo>
                      <a:pt x="1343043" y="296397"/>
                      <a:pt x="1366192" y="298411"/>
                      <a:pt x="1352411" y="302671"/>
                    </a:cubicBezTo>
                    <a:cubicBezTo>
                      <a:pt x="1360218" y="302958"/>
                      <a:pt x="1367786" y="304405"/>
                      <a:pt x="1373406" y="302238"/>
                    </a:cubicBezTo>
                    <a:lnTo>
                      <a:pt x="1363379" y="299497"/>
                    </a:lnTo>
                    <a:cubicBezTo>
                      <a:pt x="1389755" y="298071"/>
                      <a:pt x="1404124" y="305685"/>
                      <a:pt x="1421306" y="296784"/>
                    </a:cubicBezTo>
                    <a:lnTo>
                      <a:pt x="1411558" y="292877"/>
                    </a:lnTo>
                    <a:cubicBezTo>
                      <a:pt x="1427327" y="292257"/>
                      <a:pt x="1440515" y="291517"/>
                      <a:pt x="1446702" y="301244"/>
                    </a:cubicBezTo>
                    <a:lnTo>
                      <a:pt x="1430514" y="304238"/>
                    </a:lnTo>
                    <a:cubicBezTo>
                      <a:pt x="1456664" y="303985"/>
                      <a:pt x="1472439" y="303351"/>
                      <a:pt x="1494235" y="298171"/>
                    </a:cubicBezTo>
                    <a:lnTo>
                      <a:pt x="1486454" y="297904"/>
                    </a:lnTo>
                    <a:cubicBezTo>
                      <a:pt x="1514224" y="288183"/>
                      <a:pt x="1659489" y="280155"/>
                      <a:pt x="1685072" y="267987"/>
                    </a:cubicBezTo>
                    <a:lnTo>
                      <a:pt x="1673291" y="260433"/>
                    </a:lnTo>
                    <a:lnTo>
                      <a:pt x="1695293" y="254072"/>
                    </a:lnTo>
                    <a:cubicBezTo>
                      <a:pt x="1692686" y="253978"/>
                      <a:pt x="1684672" y="278595"/>
                      <a:pt x="1682492" y="276135"/>
                    </a:cubicBezTo>
                    <a:cubicBezTo>
                      <a:pt x="1729638" y="275434"/>
                      <a:pt x="1974895" y="269574"/>
                      <a:pt x="2018440" y="274661"/>
                    </a:cubicBezTo>
                    <a:cubicBezTo>
                      <a:pt x="2036009" y="278848"/>
                      <a:pt x="2021601" y="286656"/>
                      <a:pt x="2021401" y="287849"/>
                    </a:cubicBezTo>
                    <a:cubicBezTo>
                      <a:pt x="2042784" y="285029"/>
                      <a:pt x="2030622" y="279842"/>
                      <a:pt x="2048804" y="280488"/>
                    </a:cubicBezTo>
                    <a:cubicBezTo>
                      <a:pt x="2053765" y="281849"/>
                      <a:pt x="2047777" y="286409"/>
                      <a:pt x="2044984" y="287489"/>
                    </a:cubicBezTo>
                    <a:cubicBezTo>
                      <a:pt x="2052951" y="286596"/>
                      <a:pt x="2060339" y="289210"/>
                      <a:pt x="2060946" y="285682"/>
                    </a:cubicBezTo>
                    <a:cubicBezTo>
                      <a:pt x="2050985" y="282942"/>
                      <a:pt x="2055198" y="273581"/>
                      <a:pt x="2050985" y="267494"/>
                    </a:cubicBezTo>
                    <a:lnTo>
                      <a:pt x="2074367" y="268307"/>
                    </a:lnTo>
                    <a:lnTo>
                      <a:pt x="2073327" y="274221"/>
                    </a:lnTo>
                    <a:cubicBezTo>
                      <a:pt x="2078541" y="274401"/>
                      <a:pt x="2086549" y="258046"/>
                      <a:pt x="2109519" y="261226"/>
                    </a:cubicBezTo>
                    <a:cubicBezTo>
                      <a:pt x="2148270" y="263786"/>
                      <a:pt x="2190362" y="261713"/>
                      <a:pt x="2229334" y="263080"/>
                    </a:cubicBezTo>
                    <a:cubicBezTo>
                      <a:pt x="2228727" y="266627"/>
                      <a:pt x="2220546" y="268720"/>
                      <a:pt x="2212345" y="270801"/>
                    </a:cubicBezTo>
                    <a:cubicBezTo>
                      <a:pt x="2217572" y="270981"/>
                      <a:pt x="2225533" y="270074"/>
                      <a:pt x="2230347" y="272621"/>
                    </a:cubicBezTo>
                    <a:cubicBezTo>
                      <a:pt x="2220932" y="266353"/>
                      <a:pt x="2246703" y="268447"/>
                      <a:pt x="2239342" y="265807"/>
                    </a:cubicBezTo>
                    <a:cubicBezTo>
                      <a:pt x="2267885" y="251352"/>
                      <a:pt x="2304810" y="264553"/>
                      <a:pt x="2330006" y="254738"/>
                    </a:cubicBezTo>
                    <a:cubicBezTo>
                      <a:pt x="2332206" y="241737"/>
                      <a:pt x="2383953" y="31371"/>
                      <a:pt x="2383953" y="15909"/>
                    </a:cubicBezTo>
                    <a:cubicBezTo>
                      <a:pt x="2391774" y="16189"/>
                      <a:pt x="2399555" y="16469"/>
                      <a:pt x="2401949" y="17742"/>
                    </a:cubicBezTo>
                    <a:cubicBezTo>
                      <a:pt x="2399928" y="14109"/>
                      <a:pt x="2384553" y="12368"/>
                      <a:pt x="2376385" y="14449"/>
                    </a:cubicBezTo>
                    <a:lnTo>
                      <a:pt x="2374978" y="22736"/>
                    </a:lnTo>
                    <a:cubicBezTo>
                      <a:pt x="2356176" y="25643"/>
                      <a:pt x="2370571" y="17816"/>
                      <a:pt x="2352222" y="18376"/>
                    </a:cubicBezTo>
                    <a:cubicBezTo>
                      <a:pt x="2351242" y="11595"/>
                      <a:pt x="2368131" y="10148"/>
                      <a:pt x="2383006" y="9495"/>
                    </a:cubicBezTo>
                    <a:cubicBezTo>
                      <a:pt x="2369611" y="8708"/>
                      <a:pt x="2356276" y="3767"/>
                      <a:pt x="2350822" y="11188"/>
                    </a:cubicBezTo>
                    <a:cubicBezTo>
                      <a:pt x="2338234" y="8368"/>
                      <a:pt x="2352222" y="2900"/>
                      <a:pt x="2337060" y="0"/>
                    </a:cubicBezTo>
                    <a:cubicBezTo>
                      <a:pt x="2326266" y="1994"/>
                      <a:pt x="2312077" y="8628"/>
                      <a:pt x="2299676" y="4621"/>
                    </a:cubicBezTo>
                    <a:lnTo>
                      <a:pt x="2299896" y="3427"/>
                    </a:lnTo>
                    <a:cubicBezTo>
                      <a:pt x="2269739" y="-3574"/>
                      <a:pt x="2253757" y="13708"/>
                      <a:pt x="2226207" y="6788"/>
                    </a:cubicBezTo>
                    <a:lnTo>
                      <a:pt x="2229174" y="4521"/>
                    </a:lnTo>
                    <a:cubicBezTo>
                      <a:pt x="2219432" y="600"/>
                      <a:pt x="2200257" y="5867"/>
                      <a:pt x="2182688" y="1687"/>
                    </a:cubicBezTo>
                    <a:cubicBezTo>
                      <a:pt x="2187702" y="3054"/>
                      <a:pt x="2192056" y="7961"/>
                      <a:pt x="2181494" y="8768"/>
                    </a:cubicBezTo>
                    <a:cubicBezTo>
                      <a:pt x="2161292" y="4494"/>
                      <a:pt x="2147510" y="8768"/>
                      <a:pt x="2132742" y="3487"/>
                    </a:cubicBezTo>
                    <a:lnTo>
                      <a:pt x="2118566" y="10128"/>
                    </a:lnTo>
                    <a:cubicBezTo>
                      <a:pt x="2048231" y="8835"/>
                      <a:pt x="1770416" y="18269"/>
                      <a:pt x="1699761" y="19329"/>
                    </a:cubicBezTo>
                    <a:lnTo>
                      <a:pt x="1702528" y="18269"/>
                    </a:lnTo>
                    <a:cubicBezTo>
                      <a:pt x="1594874" y="21589"/>
                      <a:pt x="1373893" y="21069"/>
                      <a:pt x="1262633" y="30217"/>
                    </a:cubicBezTo>
                    <a:cubicBezTo>
                      <a:pt x="1245424" y="23683"/>
                      <a:pt x="1221694" y="25217"/>
                      <a:pt x="1203739" y="23390"/>
                    </a:cubicBezTo>
                    <a:cubicBezTo>
                      <a:pt x="1213720" y="26117"/>
                      <a:pt x="1210300" y="30751"/>
                      <a:pt x="1202505" y="30484"/>
                    </a:cubicBezTo>
                    <a:cubicBezTo>
                      <a:pt x="1147805" y="29730"/>
                      <a:pt x="1198811" y="35004"/>
                      <a:pt x="1143491" y="37798"/>
                    </a:cubicBezTo>
                    <a:cubicBezTo>
                      <a:pt x="1079790" y="43879"/>
                      <a:pt x="836019" y="36958"/>
                      <a:pt x="779472" y="31391"/>
                    </a:cubicBezTo>
                    <a:cubicBezTo>
                      <a:pt x="749102" y="41025"/>
                      <a:pt x="711184" y="33738"/>
                      <a:pt x="681427" y="39832"/>
                    </a:cubicBezTo>
                    <a:lnTo>
                      <a:pt x="684420" y="37558"/>
                    </a:lnTo>
                    <a:cubicBezTo>
                      <a:pt x="652463" y="41185"/>
                      <a:pt x="471554" y="32257"/>
                      <a:pt x="434409" y="35705"/>
                    </a:cubicBezTo>
                    <a:lnTo>
                      <a:pt x="439403" y="37085"/>
                    </a:lnTo>
                    <a:cubicBezTo>
                      <a:pt x="407012" y="43065"/>
                      <a:pt x="411426" y="32524"/>
                      <a:pt x="385903" y="29244"/>
                    </a:cubicBezTo>
                    <a:cubicBezTo>
                      <a:pt x="389257" y="40052"/>
                      <a:pt x="361500" y="46193"/>
                      <a:pt x="350919" y="47006"/>
                    </a:cubicBezTo>
                    <a:lnTo>
                      <a:pt x="351319" y="44639"/>
                    </a:lnTo>
                    <a:cubicBezTo>
                      <a:pt x="335357" y="46459"/>
                      <a:pt x="299199" y="55847"/>
                      <a:pt x="272842" y="57301"/>
                    </a:cubicBezTo>
                    <a:lnTo>
                      <a:pt x="273876" y="51386"/>
                    </a:lnTo>
                    <a:cubicBezTo>
                      <a:pt x="251893" y="57741"/>
                      <a:pt x="210561" y="55100"/>
                      <a:pt x="194759" y="55720"/>
                    </a:cubicBezTo>
                    <a:cubicBezTo>
                      <a:pt x="158628" y="53273"/>
                      <a:pt x="102901" y="42979"/>
                      <a:pt x="54588" y="50793"/>
                    </a:cubicBezTo>
                    <a:lnTo>
                      <a:pt x="23378" y="33938"/>
                    </a:lnTo>
                    <a:lnTo>
                      <a:pt x="18811" y="35611"/>
                    </a:lnTo>
                    <a:cubicBezTo>
                      <a:pt x="18811" y="35611"/>
                      <a:pt x="-31456" y="239150"/>
                      <a:pt x="32352" y="282502"/>
                    </a:cubicBezTo>
                    <a:lnTo>
                      <a:pt x="31339" y="288403"/>
                    </a:lnTo>
                    <a:lnTo>
                      <a:pt x="43954" y="287643"/>
                    </a:lnTo>
                    <a:cubicBezTo>
                      <a:pt x="59089" y="290550"/>
                      <a:pt x="66090" y="283709"/>
                      <a:pt x="65063" y="289596"/>
                    </a:cubicBezTo>
                    <a:lnTo>
                      <a:pt x="44327" y="288876"/>
                    </a:lnTo>
                    <a:cubicBezTo>
                      <a:pt x="59536" y="290583"/>
                      <a:pt x="48914" y="293717"/>
                      <a:pt x="43114" y="297057"/>
                    </a:cubicBezTo>
                    <a:cubicBezTo>
                      <a:pt x="49461" y="297624"/>
                      <a:pt x="55628" y="298337"/>
                      <a:pt x="60682" y="300144"/>
                    </a:cubicBezTo>
                    <a:cubicBezTo>
                      <a:pt x="63676" y="297877"/>
                      <a:pt x="58482" y="297697"/>
                      <a:pt x="56115" y="296410"/>
                    </a:cubicBezTo>
                    <a:cubicBezTo>
                      <a:pt x="64296" y="294330"/>
                      <a:pt x="75691" y="288783"/>
                      <a:pt x="85652" y="291503"/>
                    </a:cubicBezTo>
                    <a:cubicBezTo>
                      <a:pt x="101227" y="292057"/>
                      <a:pt x="86646" y="301064"/>
                      <a:pt x="104821" y="301704"/>
                    </a:cubicBezTo>
                    <a:cubicBezTo>
                      <a:pt x="200667" y="306272"/>
                      <a:pt x="293532" y="313112"/>
                      <a:pt x="390404" y="311779"/>
                    </a:cubicBezTo>
                    <a:cubicBezTo>
                      <a:pt x="392604" y="314226"/>
                      <a:pt x="389984" y="314139"/>
                      <a:pt x="387183" y="315239"/>
                    </a:cubicBezTo>
                    <a:cubicBezTo>
                      <a:pt x="416367" y="312692"/>
                      <a:pt x="442310" y="313613"/>
                      <a:pt x="468880" y="310972"/>
                    </a:cubicBezTo>
                    <a:cubicBezTo>
                      <a:pt x="476261" y="313613"/>
                      <a:pt x="478275" y="317253"/>
                      <a:pt x="480462" y="319707"/>
                    </a:cubicBezTo>
                    <a:cubicBezTo>
                      <a:pt x="476068" y="314799"/>
                      <a:pt x="627213" y="314353"/>
                      <a:pt x="629607" y="315626"/>
                    </a:cubicBezTo>
                    <a:close/>
                  </a:path>
                </a:pathLst>
              </a:custGeom>
              <a:ln/>
            </p:spPr>
            <p:style>
              <a:lnRef idx="2">
                <a:schemeClr val="accent2">
                  <a:shade val="50000"/>
                </a:schemeClr>
              </a:lnRef>
              <a:fillRef idx="1">
                <a:schemeClr val="accent2"/>
              </a:fillRef>
              <a:effectRef idx="0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en-US"/>
              </a:p>
            </p:txBody>
          </p:sp>
          <p:grpSp>
            <p:nvGrpSpPr>
              <p:cNvPr id="11" name="Group 10">
                <a:extLst>
                  <a:ext uri="{FF2B5EF4-FFF2-40B4-BE49-F238E27FC236}">
                    <a16:creationId xmlns:a16="http://schemas.microsoft.com/office/drawing/2014/main" id="{0D21B9C6-11D2-96DC-563D-66044F75B4B5}"/>
                  </a:ext>
                </a:extLst>
              </p:cNvPr>
              <p:cNvGrpSpPr/>
              <p:nvPr/>
            </p:nvGrpSpPr>
            <p:grpSpPr>
              <a:xfrm>
                <a:off x="1854584" y="3435272"/>
                <a:ext cx="1734767" cy="1095187"/>
                <a:chOff x="12738721" y="4106786"/>
                <a:chExt cx="1889389" cy="1431577"/>
              </a:xfrm>
            </p:grpSpPr>
            <p:sp>
              <p:nvSpPr>
                <p:cNvPr id="12" name="TextBox 11">
                  <a:extLst>
                    <a:ext uri="{FF2B5EF4-FFF2-40B4-BE49-F238E27FC236}">
                      <a16:creationId xmlns:a16="http://schemas.microsoft.com/office/drawing/2014/main" id="{0D279443-F493-DA78-920A-8F7D96D273CA}"/>
                    </a:ext>
                  </a:extLst>
                </p:cNvPr>
                <p:cNvSpPr txBox="1"/>
                <p:nvPr/>
              </p:nvSpPr>
              <p:spPr>
                <a:xfrm>
                  <a:off x="12853005" y="4106786"/>
                  <a:ext cx="1414221" cy="40231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>
                      <a:solidFill>
                        <a:schemeClr val="bg1"/>
                      </a:solidFill>
                    </a:rPr>
                    <a:t>HEART ATTACK</a:t>
                  </a:r>
                </a:p>
              </p:txBody>
            </p:sp>
            <p:sp>
              <p:nvSpPr>
                <p:cNvPr id="13" name="TextBox 12">
                  <a:extLst>
                    <a:ext uri="{FF2B5EF4-FFF2-40B4-BE49-F238E27FC236}">
                      <a16:creationId xmlns:a16="http://schemas.microsoft.com/office/drawing/2014/main" id="{61874A96-B806-07F8-CB53-E04A6A57A41F}"/>
                    </a:ext>
                  </a:extLst>
                </p:cNvPr>
                <p:cNvSpPr txBox="1"/>
                <p:nvPr/>
              </p:nvSpPr>
              <p:spPr>
                <a:xfrm>
                  <a:off x="12738721" y="4532586"/>
                  <a:ext cx="1889389" cy="1005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dirty="0"/>
                    <a:t>Chest pain, pressure, or discomfort that lasts more than a few minutes or comes and goes</a:t>
                  </a:r>
                </a:p>
              </p:txBody>
            </p:sp>
          </p:grpSp>
        </p:grpSp>
        <p:grpSp>
          <p:nvGrpSpPr>
            <p:cNvPr id="31" name="Group 30">
              <a:extLst>
                <a:ext uri="{FF2B5EF4-FFF2-40B4-BE49-F238E27FC236}">
                  <a16:creationId xmlns:a16="http://schemas.microsoft.com/office/drawing/2014/main" id="{F3F294BC-B8DF-8A3E-06E2-2012E6D5232A}"/>
                </a:ext>
              </a:extLst>
            </p:cNvPr>
            <p:cNvGrpSpPr/>
            <p:nvPr/>
          </p:nvGrpSpPr>
          <p:grpSpPr>
            <a:xfrm>
              <a:off x="3771197" y="45182"/>
              <a:ext cx="1734767" cy="1188514"/>
              <a:chOff x="3771197" y="45182"/>
              <a:chExt cx="1734767" cy="1188514"/>
            </a:xfrm>
          </p:grpSpPr>
          <p:sp>
            <p:nvSpPr>
              <p:cNvPr id="15" name="Graphic 2" descr="A brushstroke">
                <a:extLst>
                  <a:ext uri="{FF2B5EF4-FFF2-40B4-BE49-F238E27FC236}">
                    <a16:creationId xmlns:a16="http://schemas.microsoft.com/office/drawing/2014/main" id="{C2BF906D-3C8B-2BCC-7E25-2D3E60D6AC76}"/>
                  </a:ext>
                </a:extLst>
              </p:cNvPr>
              <p:cNvSpPr/>
              <p:nvPr/>
            </p:nvSpPr>
            <p:spPr>
              <a:xfrm>
                <a:off x="3792554" y="45182"/>
                <a:ext cx="1434796" cy="590146"/>
              </a:xfrm>
              <a:custGeom>
                <a:avLst/>
                <a:gdLst>
                  <a:gd name="connsiteX0" fmla="*/ 42687 w 2401948"/>
                  <a:gd name="connsiteY0" fmla="*/ 296990 h 320246"/>
                  <a:gd name="connsiteX1" fmla="*/ 10363 w 2401948"/>
                  <a:gd name="connsiteY1" fmla="*/ 288863 h 320246"/>
                  <a:gd name="connsiteX2" fmla="*/ 42687 w 2401948"/>
                  <a:gd name="connsiteY2" fmla="*/ 296990 h 320246"/>
                  <a:gd name="connsiteX3" fmla="*/ 42927 w 2401948"/>
                  <a:gd name="connsiteY3" fmla="*/ 297130 h 320246"/>
                  <a:gd name="connsiteX4" fmla="*/ 43114 w 2401948"/>
                  <a:gd name="connsiteY4" fmla="*/ 297044 h 320246"/>
                  <a:gd name="connsiteX5" fmla="*/ 42687 w 2401948"/>
                  <a:gd name="connsiteY5" fmla="*/ 296990 h 320246"/>
                  <a:gd name="connsiteX6" fmla="*/ 42927 w 2401948"/>
                  <a:gd name="connsiteY6" fmla="*/ 297130 h 320246"/>
                  <a:gd name="connsiteX7" fmla="*/ 2392981 w 2401948"/>
                  <a:gd name="connsiteY7" fmla="*/ 9101 h 320246"/>
                  <a:gd name="connsiteX8" fmla="*/ 2383013 w 2401948"/>
                  <a:gd name="connsiteY8" fmla="*/ 9501 h 320246"/>
                  <a:gd name="connsiteX9" fmla="*/ 2392981 w 2401948"/>
                  <a:gd name="connsiteY9" fmla="*/ 9101 h 320246"/>
                  <a:gd name="connsiteX10" fmla="*/ 629607 w 2401948"/>
                  <a:gd name="connsiteY10" fmla="*/ 315626 h 320246"/>
                  <a:gd name="connsiteX11" fmla="*/ 631454 w 2401948"/>
                  <a:gd name="connsiteY11" fmla="*/ 304972 h 320246"/>
                  <a:gd name="connsiteX12" fmla="*/ 666385 w 2401948"/>
                  <a:gd name="connsiteY12" fmla="*/ 314533 h 320246"/>
                  <a:gd name="connsiteX13" fmla="*/ 719698 w 2401948"/>
                  <a:gd name="connsiteY13" fmla="*/ 308085 h 320246"/>
                  <a:gd name="connsiteX14" fmla="*/ 731673 w 2401948"/>
                  <a:gd name="connsiteY14" fmla="*/ 314459 h 320246"/>
                  <a:gd name="connsiteX15" fmla="*/ 753256 w 2401948"/>
                  <a:gd name="connsiteY15" fmla="*/ 310465 h 320246"/>
                  <a:gd name="connsiteX16" fmla="*/ 748848 w 2401948"/>
                  <a:gd name="connsiteY16" fmla="*/ 305552 h 320246"/>
                  <a:gd name="connsiteX17" fmla="*/ 767644 w 2401948"/>
                  <a:gd name="connsiteY17" fmla="*/ 302658 h 320246"/>
                  <a:gd name="connsiteX18" fmla="*/ 768818 w 2401948"/>
                  <a:gd name="connsiteY18" fmla="*/ 310999 h 320246"/>
                  <a:gd name="connsiteX19" fmla="*/ 1106660 w 2401948"/>
                  <a:gd name="connsiteY19" fmla="*/ 317686 h 320246"/>
                  <a:gd name="connsiteX20" fmla="*/ 1077316 w 2401948"/>
                  <a:gd name="connsiteY20" fmla="*/ 305958 h 320246"/>
                  <a:gd name="connsiteX21" fmla="*/ 1104080 w 2401948"/>
                  <a:gd name="connsiteY21" fmla="*/ 302138 h 320246"/>
                  <a:gd name="connsiteX22" fmla="*/ 1145411 w 2401948"/>
                  <a:gd name="connsiteY22" fmla="*/ 320247 h 320246"/>
                  <a:gd name="connsiteX23" fmla="*/ 1149425 w 2401948"/>
                  <a:gd name="connsiteY23" fmla="*/ 312052 h 320246"/>
                  <a:gd name="connsiteX24" fmla="*/ 1156379 w 2401948"/>
                  <a:gd name="connsiteY24" fmla="*/ 317066 h 320246"/>
                  <a:gd name="connsiteX25" fmla="*/ 1224975 w 2401948"/>
                  <a:gd name="connsiteY25" fmla="*/ 314839 h 320246"/>
                  <a:gd name="connsiteX26" fmla="*/ 1289103 w 2401948"/>
                  <a:gd name="connsiteY26" fmla="*/ 306398 h 320246"/>
                  <a:gd name="connsiteX27" fmla="*/ 1287709 w 2401948"/>
                  <a:gd name="connsiteY27" fmla="*/ 299204 h 320246"/>
                  <a:gd name="connsiteX28" fmla="*/ 1313459 w 2401948"/>
                  <a:gd name="connsiteY28" fmla="*/ 301304 h 320246"/>
                  <a:gd name="connsiteX29" fmla="*/ 1338635 w 2401948"/>
                  <a:gd name="connsiteY29" fmla="*/ 291490 h 320246"/>
                  <a:gd name="connsiteX30" fmla="*/ 1352411 w 2401948"/>
                  <a:gd name="connsiteY30" fmla="*/ 302671 h 320246"/>
                  <a:gd name="connsiteX31" fmla="*/ 1373406 w 2401948"/>
                  <a:gd name="connsiteY31" fmla="*/ 302238 h 320246"/>
                  <a:gd name="connsiteX32" fmla="*/ 1363379 w 2401948"/>
                  <a:gd name="connsiteY32" fmla="*/ 299497 h 320246"/>
                  <a:gd name="connsiteX33" fmla="*/ 1421306 w 2401948"/>
                  <a:gd name="connsiteY33" fmla="*/ 296784 h 320246"/>
                  <a:gd name="connsiteX34" fmla="*/ 1411558 w 2401948"/>
                  <a:gd name="connsiteY34" fmla="*/ 292877 h 320246"/>
                  <a:gd name="connsiteX35" fmla="*/ 1446702 w 2401948"/>
                  <a:gd name="connsiteY35" fmla="*/ 301244 h 320246"/>
                  <a:gd name="connsiteX36" fmla="*/ 1430514 w 2401948"/>
                  <a:gd name="connsiteY36" fmla="*/ 304238 h 320246"/>
                  <a:gd name="connsiteX37" fmla="*/ 1494235 w 2401948"/>
                  <a:gd name="connsiteY37" fmla="*/ 298171 h 320246"/>
                  <a:gd name="connsiteX38" fmla="*/ 1486454 w 2401948"/>
                  <a:gd name="connsiteY38" fmla="*/ 297904 h 320246"/>
                  <a:gd name="connsiteX39" fmla="*/ 1685072 w 2401948"/>
                  <a:gd name="connsiteY39" fmla="*/ 267987 h 320246"/>
                  <a:gd name="connsiteX40" fmla="*/ 1673291 w 2401948"/>
                  <a:gd name="connsiteY40" fmla="*/ 260433 h 320246"/>
                  <a:gd name="connsiteX41" fmla="*/ 1695293 w 2401948"/>
                  <a:gd name="connsiteY41" fmla="*/ 254072 h 320246"/>
                  <a:gd name="connsiteX42" fmla="*/ 1682492 w 2401948"/>
                  <a:gd name="connsiteY42" fmla="*/ 276135 h 320246"/>
                  <a:gd name="connsiteX43" fmla="*/ 2018440 w 2401948"/>
                  <a:gd name="connsiteY43" fmla="*/ 274661 h 320246"/>
                  <a:gd name="connsiteX44" fmla="*/ 2021401 w 2401948"/>
                  <a:gd name="connsiteY44" fmla="*/ 287849 h 320246"/>
                  <a:gd name="connsiteX45" fmla="*/ 2048804 w 2401948"/>
                  <a:gd name="connsiteY45" fmla="*/ 280488 h 320246"/>
                  <a:gd name="connsiteX46" fmla="*/ 2044984 w 2401948"/>
                  <a:gd name="connsiteY46" fmla="*/ 287489 h 320246"/>
                  <a:gd name="connsiteX47" fmla="*/ 2060946 w 2401948"/>
                  <a:gd name="connsiteY47" fmla="*/ 285682 h 320246"/>
                  <a:gd name="connsiteX48" fmla="*/ 2050985 w 2401948"/>
                  <a:gd name="connsiteY48" fmla="*/ 267494 h 320246"/>
                  <a:gd name="connsiteX49" fmla="*/ 2074367 w 2401948"/>
                  <a:gd name="connsiteY49" fmla="*/ 268307 h 320246"/>
                  <a:gd name="connsiteX50" fmla="*/ 2073327 w 2401948"/>
                  <a:gd name="connsiteY50" fmla="*/ 274221 h 320246"/>
                  <a:gd name="connsiteX51" fmla="*/ 2109519 w 2401948"/>
                  <a:gd name="connsiteY51" fmla="*/ 261226 h 320246"/>
                  <a:gd name="connsiteX52" fmla="*/ 2229334 w 2401948"/>
                  <a:gd name="connsiteY52" fmla="*/ 263080 h 320246"/>
                  <a:gd name="connsiteX53" fmla="*/ 2212345 w 2401948"/>
                  <a:gd name="connsiteY53" fmla="*/ 270801 h 320246"/>
                  <a:gd name="connsiteX54" fmla="*/ 2230347 w 2401948"/>
                  <a:gd name="connsiteY54" fmla="*/ 272621 h 320246"/>
                  <a:gd name="connsiteX55" fmla="*/ 2239342 w 2401948"/>
                  <a:gd name="connsiteY55" fmla="*/ 265807 h 320246"/>
                  <a:gd name="connsiteX56" fmla="*/ 2330006 w 2401948"/>
                  <a:gd name="connsiteY56" fmla="*/ 254738 h 320246"/>
                  <a:gd name="connsiteX57" fmla="*/ 2383953 w 2401948"/>
                  <a:gd name="connsiteY57" fmla="*/ 15909 h 320246"/>
                  <a:gd name="connsiteX58" fmla="*/ 2401949 w 2401948"/>
                  <a:gd name="connsiteY58" fmla="*/ 17742 h 320246"/>
                  <a:gd name="connsiteX59" fmla="*/ 2376385 w 2401948"/>
                  <a:gd name="connsiteY59" fmla="*/ 14449 h 320246"/>
                  <a:gd name="connsiteX60" fmla="*/ 2374978 w 2401948"/>
                  <a:gd name="connsiteY60" fmla="*/ 22736 h 320246"/>
                  <a:gd name="connsiteX61" fmla="*/ 2352222 w 2401948"/>
                  <a:gd name="connsiteY61" fmla="*/ 18376 h 320246"/>
                  <a:gd name="connsiteX62" fmla="*/ 2383006 w 2401948"/>
                  <a:gd name="connsiteY62" fmla="*/ 9495 h 320246"/>
                  <a:gd name="connsiteX63" fmla="*/ 2350822 w 2401948"/>
                  <a:gd name="connsiteY63" fmla="*/ 11188 h 320246"/>
                  <a:gd name="connsiteX64" fmla="*/ 2337060 w 2401948"/>
                  <a:gd name="connsiteY64" fmla="*/ 0 h 320246"/>
                  <a:gd name="connsiteX65" fmla="*/ 2299676 w 2401948"/>
                  <a:gd name="connsiteY65" fmla="*/ 4621 h 320246"/>
                  <a:gd name="connsiteX66" fmla="*/ 2299896 w 2401948"/>
                  <a:gd name="connsiteY66" fmla="*/ 3427 h 320246"/>
                  <a:gd name="connsiteX67" fmla="*/ 2226207 w 2401948"/>
                  <a:gd name="connsiteY67" fmla="*/ 6788 h 320246"/>
                  <a:gd name="connsiteX68" fmla="*/ 2229174 w 2401948"/>
                  <a:gd name="connsiteY68" fmla="*/ 4521 h 320246"/>
                  <a:gd name="connsiteX69" fmla="*/ 2182688 w 2401948"/>
                  <a:gd name="connsiteY69" fmla="*/ 1687 h 320246"/>
                  <a:gd name="connsiteX70" fmla="*/ 2181494 w 2401948"/>
                  <a:gd name="connsiteY70" fmla="*/ 8768 h 320246"/>
                  <a:gd name="connsiteX71" fmla="*/ 2132742 w 2401948"/>
                  <a:gd name="connsiteY71" fmla="*/ 3487 h 320246"/>
                  <a:gd name="connsiteX72" fmla="*/ 2118566 w 2401948"/>
                  <a:gd name="connsiteY72" fmla="*/ 10128 h 320246"/>
                  <a:gd name="connsiteX73" fmla="*/ 1699761 w 2401948"/>
                  <a:gd name="connsiteY73" fmla="*/ 19329 h 320246"/>
                  <a:gd name="connsiteX74" fmla="*/ 1702528 w 2401948"/>
                  <a:gd name="connsiteY74" fmla="*/ 18269 h 320246"/>
                  <a:gd name="connsiteX75" fmla="*/ 1262633 w 2401948"/>
                  <a:gd name="connsiteY75" fmla="*/ 30217 h 320246"/>
                  <a:gd name="connsiteX76" fmla="*/ 1203739 w 2401948"/>
                  <a:gd name="connsiteY76" fmla="*/ 23390 h 320246"/>
                  <a:gd name="connsiteX77" fmla="*/ 1202505 w 2401948"/>
                  <a:gd name="connsiteY77" fmla="*/ 30484 h 320246"/>
                  <a:gd name="connsiteX78" fmla="*/ 1143491 w 2401948"/>
                  <a:gd name="connsiteY78" fmla="*/ 37798 h 320246"/>
                  <a:gd name="connsiteX79" fmla="*/ 779472 w 2401948"/>
                  <a:gd name="connsiteY79" fmla="*/ 31391 h 320246"/>
                  <a:gd name="connsiteX80" fmla="*/ 681427 w 2401948"/>
                  <a:gd name="connsiteY80" fmla="*/ 39832 h 320246"/>
                  <a:gd name="connsiteX81" fmla="*/ 684420 w 2401948"/>
                  <a:gd name="connsiteY81" fmla="*/ 37558 h 320246"/>
                  <a:gd name="connsiteX82" fmla="*/ 434409 w 2401948"/>
                  <a:gd name="connsiteY82" fmla="*/ 35705 h 320246"/>
                  <a:gd name="connsiteX83" fmla="*/ 439403 w 2401948"/>
                  <a:gd name="connsiteY83" fmla="*/ 37085 h 320246"/>
                  <a:gd name="connsiteX84" fmla="*/ 385903 w 2401948"/>
                  <a:gd name="connsiteY84" fmla="*/ 29244 h 320246"/>
                  <a:gd name="connsiteX85" fmla="*/ 350919 w 2401948"/>
                  <a:gd name="connsiteY85" fmla="*/ 47006 h 320246"/>
                  <a:gd name="connsiteX86" fmla="*/ 351319 w 2401948"/>
                  <a:gd name="connsiteY86" fmla="*/ 44639 h 320246"/>
                  <a:gd name="connsiteX87" fmla="*/ 272842 w 2401948"/>
                  <a:gd name="connsiteY87" fmla="*/ 57301 h 320246"/>
                  <a:gd name="connsiteX88" fmla="*/ 273876 w 2401948"/>
                  <a:gd name="connsiteY88" fmla="*/ 51386 h 320246"/>
                  <a:gd name="connsiteX89" fmla="*/ 194759 w 2401948"/>
                  <a:gd name="connsiteY89" fmla="*/ 55720 h 320246"/>
                  <a:gd name="connsiteX90" fmla="*/ 54588 w 2401948"/>
                  <a:gd name="connsiteY90" fmla="*/ 50793 h 320246"/>
                  <a:gd name="connsiteX91" fmla="*/ 23378 w 2401948"/>
                  <a:gd name="connsiteY91" fmla="*/ 33938 h 320246"/>
                  <a:gd name="connsiteX92" fmla="*/ 18811 w 2401948"/>
                  <a:gd name="connsiteY92" fmla="*/ 35611 h 320246"/>
                  <a:gd name="connsiteX93" fmla="*/ 32352 w 2401948"/>
                  <a:gd name="connsiteY93" fmla="*/ 282502 h 320246"/>
                  <a:gd name="connsiteX94" fmla="*/ 31339 w 2401948"/>
                  <a:gd name="connsiteY94" fmla="*/ 288403 h 320246"/>
                  <a:gd name="connsiteX95" fmla="*/ 43954 w 2401948"/>
                  <a:gd name="connsiteY95" fmla="*/ 287643 h 320246"/>
                  <a:gd name="connsiteX96" fmla="*/ 65063 w 2401948"/>
                  <a:gd name="connsiteY96" fmla="*/ 289596 h 320246"/>
                  <a:gd name="connsiteX97" fmla="*/ 44327 w 2401948"/>
                  <a:gd name="connsiteY97" fmla="*/ 288876 h 320246"/>
                  <a:gd name="connsiteX98" fmla="*/ 43114 w 2401948"/>
                  <a:gd name="connsiteY98" fmla="*/ 297057 h 320246"/>
                  <a:gd name="connsiteX99" fmla="*/ 60682 w 2401948"/>
                  <a:gd name="connsiteY99" fmla="*/ 300144 h 320246"/>
                  <a:gd name="connsiteX100" fmla="*/ 56115 w 2401948"/>
                  <a:gd name="connsiteY100" fmla="*/ 296410 h 320246"/>
                  <a:gd name="connsiteX101" fmla="*/ 85652 w 2401948"/>
                  <a:gd name="connsiteY101" fmla="*/ 291503 h 320246"/>
                  <a:gd name="connsiteX102" fmla="*/ 104821 w 2401948"/>
                  <a:gd name="connsiteY102" fmla="*/ 301704 h 320246"/>
                  <a:gd name="connsiteX103" fmla="*/ 390404 w 2401948"/>
                  <a:gd name="connsiteY103" fmla="*/ 311779 h 320246"/>
                  <a:gd name="connsiteX104" fmla="*/ 387183 w 2401948"/>
                  <a:gd name="connsiteY104" fmla="*/ 315239 h 320246"/>
                  <a:gd name="connsiteX105" fmla="*/ 468880 w 2401948"/>
                  <a:gd name="connsiteY105" fmla="*/ 310972 h 320246"/>
                  <a:gd name="connsiteX106" fmla="*/ 480462 w 2401948"/>
                  <a:gd name="connsiteY106" fmla="*/ 319707 h 320246"/>
                  <a:gd name="connsiteX107" fmla="*/ 629607 w 2401948"/>
                  <a:gd name="connsiteY107" fmla="*/ 315626 h 3202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  <a:cxn ang="0">
                    <a:pos x="connsiteX69" y="connsiteY69"/>
                  </a:cxn>
                  <a:cxn ang="0">
                    <a:pos x="connsiteX70" y="connsiteY70"/>
                  </a:cxn>
                  <a:cxn ang="0">
                    <a:pos x="connsiteX71" y="connsiteY71"/>
                  </a:cxn>
                  <a:cxn ang="0">
                    <a:pos x="connsiteX72" y="connsiteY72"/>
                  </a:cxn>
                  <a:cxn ang="0">
                    <a:pos x="connsiteX73" y="connsiteY73"/>
                  </a:cxn>
                  <a:cxn ang="0">
                    <a:pos x="connsiteX74" y="connsiteY74"/>
                  </a:cxn>
                  <a:cxn ang="0">
                    <a:pos x="connsiteX75" y="connsiteY75"/>
                  </a:cxn>
                  <a:cxn ang="0">
                    <a:pos x="connsiteX76" y="connsiteY76"/>
                  </a:cxn>
                  <a:cxn ang="0">
                    <a:pos x="connsiteX77" y="connsiteY77"/>
                  </a:cxn>
                  <a:cxn ang="0">
                    <a:pos x="connsiteX78" y="connsiteY78"/>
                  </a:cxn>
                  <a:cxn ang="0">
                    <a:pos x="connsiteX79" y="connsiteY79"/>
                  </a:cxn>
                  <a:cxn ang="0">
                    <a:pos x="connsiteX80" y="connsiteY80"/>
                  </a:cxn>
                  <a:cxn ang="0">
                    <a:pos x="connsiteX81" y="connsiteY81"/>
                  </a:cxn>
                  <a:cxn ang="0">
                    <a:pos x="connsiteX82" y="connsiteY82"/>
                  </a:cxn>
                  <a:cxn ang="0">
                    <a:pos x="connsiteX83" y="connsiteY83"/>
                  </a:cxn>
                  <a:cxn ang="0">
                    <a:pos x="connsiteX84" y="connsiteY84"/>
                  </a:cxn>
                  <a:cxn ang="0">
                    <a:pos x="connsiteX85" y="connsiteY85"/>
                  </a:cxn>
                  <a:cxn ang="0">
                    <a:pos x="connsiteX86" y="connsiteY86"/>
                  </a:cxn>
                  <a:cxn ang="0">
                    <a:pos x="connsiteX87" y="connsiteY87"/>
                  </a:cxn>
                  <a:cxn ang="0">
                    <a:pos x="connsiteX88" y="connsiteY88"/>
                  </a:cxn>
                  <a:cxn ang="0">
                    <a:pos x="connsiteX89" y="connsiteY89"/>
                  </a:cxn>
                  <a:cxn ang="0">
                    <a:pos x="connsiteX90" y="connsiteY90"/>
                  </a:cxn>
                  <a:cxn ang="0">
                    <a:pos x="connsiteX91" y="connsiteY91"/>
                  </a:cxn>
                  <a:cxn ang="0">
                    <a:pos x="connsiteX92" y="connsiteY92"/>
                  </a:cxn>
                  <a:cxn ang="0">
                    <a:pos x="connsiteX93" y="connsiteY93"/>
                  </a:cxn>
                  <a:cxn ang="0">
                    <a:pos x="connsiteX94" y="connsiteY94"/>
                  </a:cxn>
                  <a:cxn ang="0">
                    <a:pos x="connsiteX95" y="connsiteY95"/>
                  </a:cxn>
                  <a:cxn ang="0">
                    <a:pos x="connsiteX96" y="connsiteY96"/>
                  </a:cxn>
                  <a:cxn ang="0">
                    <a:pos x="connsiteX97" y="connsiteY97"/>
                  </a:cxn>
                  <a:cxn ang="0">
                    <a:pos x="connsiteX98" y="connsiteY98"/>
                  </a:cxn>
                  <a:cxn ang="0">
                    <a:pos x="connsiteX99" y="connsiteY99"/>
                  </a:cxn>
                  <a:cxn ang="0">
                    <a:pos x="connsiteX100" y="connsiteY100"/>
                  </a:cxn>
                  <a:cxn ang="0">
                    <a:pos x="connsiteX101" y="connsiteY101"/>
                  </a:cxn>
                  <a:cxn ang="0">
                    <a:pos x="connsiteX102" y="connsiteY102"/>
                  </a:cxn>
                  <a:cxn ang="0">
                    <a:pos x="connsiteX103" y="connsiteY103"/>
                  </a:cxn>
                  <a:cxn ang="0">
                    <a:pos x="connsiteX104" y="connsiteY104"/>
                  </a:cxn>
                  <a:cxn ang="0">
                    <a:pos x="connsiteX105" y="connsiteY105"/>
                  </a:cxn>
                  <a:cxn ang="0">
                    <a:pos x="connsiteX106" y="connsiteY106"/>
                  </a:cxn>
                  <a:cxn ang="0">
                    <a:pos x="connsiteX107" y="connsiteY107"/>
                  </a:cxn>
                </a:cxnLst>
                <a:rect l="l" t="t" r="r" b="b"/>
                <a:pathLst>
                  <a:path w="2401948" h="320246">
                    <a:moveTo>
                      <a:pt x="42687" y="296990"/>
                    </a:moveTo>
                    <a:cubicBezTo>
                      <a:pt x="30572" y="295917"/>
                      <a:pt x="17777" y="295297"/>
                      <a:pt x="10363" y="288863"/>
                    </a:cubicBezTo>
                    <a:cubicBezTo>
                      <a:pt x="23451" y="288149"/>
                      <a:pt x="33366" y="290830"/>
                      <a:pt x="42687" y="296990"/>
                    </a:cubicBezTo>
                    <a:close/>
                    <a:moveTo>
                      <a:pt x="42927" y="297130"/>
                    </a:moveTo>
                    <a:cubicBezTo>
                      <a:pt x="42974" y="297097"/>
                      <a:pt x="43060" y="297070"/>
                      <a:pt x="43114" y="297044"/>
                    </a:cubicBezTo>
                    <a:cubicBezTo>
                      <a:pt x="42947" y="297037"/>
                      <a:pt x="42827" y="297011"/>
                      <a:pt x="42687" y="296990"/>
                    </a:cubicBezTo>
                    <a:cubicBezTo>
                      <a:pt x="42780" y="297057"/>
                      <a:pt x="42854" y="297070"/>
                      <a:pt x="42927" y="297130"/>
                    </a:cubicBezTo>
                    <a:close/>
                    <a:moveTo>
                      <a:pt x="2392981" y="9101"/>
                    </a:moveTo>
                    <a:cubicBezTo>
                      <a:pt x="2389954" y="9228"/>
                      <a:pt x="2386507" y="9355"/>
                      <a:pt x="2383013" y="9501"/>
                    </a:cubicBezTo>
                    <a:cubicBezTo>
                      <a:pt x="2386347" y="9695"/>
                      <a:pt x="2389747" y="9715"/>
                      <a:pt x="2392981" y="9101"/>
                    </a:cubicBezTo>
                    <a:close/>
                    <a:moveTo>
                      <a:pt x="629607" y="315626"/>
                    </a:moveTo>
                    <a:lnTo>
                      <a:pt x="631454" y="304972"/>
                    </a:lnTo>
                    <a:cubicBezTo>
                      <a:pt x="660191" y="304818"/>
                      <a:pt x="639821" y="317166"/>
                      <a:pt x="666385" y="314533"/>
                    </a:cubicBezTo>
                    <a:cubicBezTo>
                      <a:pt x="676779" y="299457"/>
                      <a:pt x="710517" y="316093"/>
                      <a:pt x="719698" y="308085"/>
                    </a:cubicBezTo>
                    <a:cubicBezTo>
                      <a:pt x="719491" y="309285"/>
                      <a:pt x="732500" y="309739"/>
                      <a:pt x="731673" y="314459"/>
                    </a:cubicBezTo>
                    <a:cubicBezTo>
                      <a:pt x="735653" y="306272"/>
                      <a:pt x="745055" y="312559"/>
                      <a:pt x="753256" y="310465"/>
                    </a:cubicBezTo>
                    <a:cubicBezTo>
                      <a:pt x="756229" y="308192"/>
                      <a:pt x="751075" y="308019"/>
                      <a:pt x="748848" y="305552"/>
                    </a:cubicBezTo>
                    <a:lnTo>
                      <a:pt x="767644" y="302658"/>
                    </a:lnTo>
                    <a:cubicBezTo>
                      <a:pt x="774992" y="305291"/>
                      <a:pt x="776805" y="310106"/>
                      <a:pt x="768818" y="310999"/>
                    </a:cubicBezTo>
                    <a:cubicBezTo>
                      <a:pt x="817937" y="313933"/>
                      <a:pt x="1053747" y="321774"/>
                      <a:pt x="1106660" y="317686"/>
                    </a:cubicBezTo>
                    <a:cubicBezTo>
                      <a:pt x="1099859" y="311506"/>
                      <a:pt x="1083524" y="315680"/>
                      <a:pt x="1077316" y="305958"/>
                    </a:cubicBezTo>
                    <a:cubicBezTo>
                      <a:pt x="1091305" y="300511"/>
                      <a:pt x="1097912" y="307865"/>
                      <a:pt x="1104080" y="302138"/>
                    </a:cubicBezTo>
                    <a:cubicBezTo>
                      <a:pt x="1109447" y="316593"/>
                      <a:pt x="1134823" y="305598"/>
                      <a:pt x="1145411" y="320247"/>
                    </a:cubicBezTo>
                    <a:lnTo>
                      <a:pt x="1149425" y="312052"/>
                    </a:lnTo>
                    <a:lnTo>
                      <a:pt x="1156379" y="317066"/>
                    </a:lnTo>
                    <a:cubicBezTo>
                      <a:pt x="1217900" y="308539"/>
                      <a:pt x="1170435" y="312906"/>
                      <a:pt x="1224975" y="314839"/>
                    </a:cubicBezTo>
                    <a:cubicBezTo>
                      <a:pt x="1256539" y="313579"/>
                      <a:pt x="1271540" y="302211"/>
                      <a:pt x="1289103" y="306398"/>
                    </a:cubicBezTo>
                    <a:cubicBezTo>
                      <a:pt x="1286496" y="306312"/>
                      <a:pt x="1279535" y="301298"/>
                      <a:pt x="1287709" y="299204"/>
                    </a:cubicBezTo>
                    <a:cubicBezTo>
                      <a:pt x="1289103" y="306398"/>
                      <a:pt x="1309479" y="294044"/>
                      <a:pt x="1313459" y="301304"/>
                    </a:cubicBezTo>
                    <a:cubicBezTo>
                      <a:pt x="1321467" y="300398"/>
                      <a:pt x="1347417" y="301324"/>
                      <a:pt x="1338635" y="291490"/>
                    </a:cubicBezTo>
                    <a:cubicBezTo>
                      <a:pt x="1343043" y="296397"/>
                      <a:pt x="1366192" y="298411"/>
                      <a:pt x="1352411" y="302671"/>
                    </a:cubicBezTo>
                    <a:cubicBezTo>
                      <a:pt x="1360218" y="302958"/>
                      <a:pt x="1367786" y="304405"/>
                      <a:pt x="1373406" y="302238"/>
                    </a:cubicBezTo>
                    <a:lnTo>
                      <a:pt x="1363379" y="299497"/>
                    </a:lnTo>
                    <a:cubicBezTo>
                      <a:pt x="1389755" y="298071"/>
                      <a:pt x="1404124" y="305685"/>
                      <a:pt x="1421306" y="296784"/>
                    </a:cubicBezTo>
                    <a:lnTo>
                      <a:pt x="1411558" y="292877"/>
                    </a:lnTo>
                    <a:cubicBezTo>
                      <a:pt x="1427327" y="292257"/>
                      <a:pt x="1440515" y="291517"/>
                      <a:pt x="1446702" y="301244"/>
                    </a:cubicBezTo>
                    <a:lnTo>
                      <a:pt x="1430514" y="304238"/>
                    </a:lnTo>
                    <a:cubicBezTo>
                      <a:pt x="1456664" y="303985"/>
                      <a:pt x="1472439" y="303351"/>
                      <a:pt x="1494235" y="298171"/>
                    </a:cubicBezTo>
                    <a:lnTo>
                      <a:pt x="1486454" y="297904"/>
                    </a:lnTo>
                    <a:cubicBezTo>
                      <a:pt x="1514224" y="288183"/>
                      <a:pt x="1659489" y="280155"/>
                      <a:pt x="1685072" y="267987"/>
                    </a:cubicBezTo>
                    <a:lnTo>
                      <a:pt x="1673291" y="260433"/>
                    </a:lnTo>
                    <a:lnTo>
                      <a:pt x="1695293" y="254072"/>
                    </a:lnTo>
                    <a:cubicBezTo>
                      <a:pt x="1692686" y="253978"/>
                      <a:pt x="1684672" y="278595"/>
                      <a:pt x="1682492" y="276135"/>
                    </a:cubicBezTo>
                    <a:cubicBezTo>
                      <a:pt x="1729638" y="275434"/>
                      <a:pt x="1974895" y="269574"/>
                      <a:pt x="2018440" y="274661"/>
                    </a:cubicBezTo>
                    <a:cubicBezTo>
                      <a:pt x="2036009" y="278848"/>
                      <a:pt x="2021601" y="286656"/>
                      <a:pt x="2021401" y="287849"/>
                    </a:cubicBezTo>
                    <a:cubicBezTo>
                      <a:pt x="2042784" y="285029"/>
                      <a:pt x="2030622" y="279842"/>
                      <a:pt x="2048804" y="280488"/>
                    </a:cubicBezTo>
                    <a:cubicBezTo>
                      <a:pt x="2053765" y="281849"/>
                      <a:pt x="2047777" y="286409"/>
                      <a:pt x="2044984" y="287489"/>
                    </a:cubicBezTo>
                    <a:cubicBezTo>
                      <a:pt x="2052951" y="286596"/>
                      <a:pt x="2060339" y="289210"/>
                      <a:pt x="2060946" y="285682"/>
                    </a:cubicBezTo>
                    <a:cubicBezTo>
                      <a:pt x="2050985" y="282942"/>
                      <a:pt x="2055198" y="273581"/>
                      <a:pt x="2050985" y="267494"/>
                    </a:cubicBezTo>
                    <a:lnTo>
                      <a:pt x="2074367" y="268307"/>
                    </a:lnTo>
                    <a:lnTo>
                      <a:pt x="2073327" y="274221"/>
                    </a:lnTo>
                    <a:cubicBezTo>
                      <a:pt x="2078541" y="274401"/>
                      <a:pt x="2086549" y="258046"/>
                      <a:pt x="2109519" y="261226"/>
                    </a:cubicBezTo>
                    <a:cubicBezTo>
                      <a:pt x="2148270" y="263786"/>
                      <a:pt x="2190362" y="261713"/>
                      <a:pt x="2229334" y="263080"/>
                    </a:cubicBezTo>
                    <a:cubicBezTo>
                      <a:pt x="2228727" y="266627"/>
                      <a:pt x="2220546" y="268720"/>
                      <a:pt x="2212345" y="270801"/>
                    </a:cubicBezTo>
                    <a:cubicBezTo>
                      <a:pt x="2217572" y="270981"/>
                      <a:pt x="2225533" y="270074"/>
                      <a:pt x="2230347" y="272621"/>
                    </a:cubicBezTo>
                    <a:cubicBezTo>
                      <a:pt x="2220932" y="266353"/>
                      <a:pt x="2246703" y="268447"/>
                      <a:pt x="2239342" y="265807"/>
                    </a:cubicBezTo>
                    <a:cubicBezTo>
                      <a:pt x="2267885" y="251352"/>
                      <a:pt x="2304810" y="264553"/>
                      <a:pt x="2330006" y="254738"/>
                    </a:cubicBezTo>
                    <a:cubicBezTo>
                      <a:pt x="2332206" y="241737"/>
                      <a:pt x="2383953" y="31371"/>
                      <a:pt x="2383953" y="15909"/>
                    </a:cubicBezTo>
                    <a:cubicBezTo>
                      <a:pt x="2391774" y="16189"/>
                      <a:pt x="2399555" y="16469"/>
                      <a:pt x="2401949" y="17742"/>
                    </a:cubicBezTo>
                    <a:cubicBezTo>
                      <a:pt x="2399928" y="14109"/>
                      <a:pt x="2384553" y="12368"/>
                      <a:pt x="2376385" y="14449"/>
                    </a:cubicBezTo>
                    <a:lnTo>
                      <a:pt x="2374978" y="22736"/>
                    </a:lnTo>
                    <a:cubicBezTo>
                      <a:pt x="2356176" y="25643"/>
                      <a:pt x="2370571" y="17816"/>
                      <a:pt x="2352222" y="18376"/>
                    </a:cubicBezTo>
                    <a:cubicBezTo>
                      <a:pt x="2351242" y="11595"/>
                      <a:pt x="2368131" y="10148"/>
                      <a:pt x="2383006" y="9495"/>
                    </a:cubicBezTo>
                    <a:cubicBezTo>
                      <a:pt x="2369611" y="8708"/>
                      <a:pt x="2356276" y="3767"/>
                      <a:pt x="2350822" y="11188"/>
                    </a:cubicBezTo>
                    <a:cubicBezTo>
                      <a:pt x="2338234" y="8368"/>
                      <a:pt x="2352222" y="2900"/>
                      <a:pt x="2337060" y="0"/>
                    </a:cubicBezTo>
                    <a:cubicBezTo>
                      <a:pt x="2326266" y="1994"/>
                      <a:pt x="2312077" y="8628"/>
                      <a:pt x="2299676" y="4621"/>
                    </a:cubicBezTo>
                    <a:lnTo>
                      <a:pt x="2299896" y="3427"/>
                    </a:lnTo>
                    <a:cubicBezTo>
                      <a:pt x="2269739" y="-3574"/>
                      <a:pt x="2253757" y="13708"/>
                      <a:pt x="2226207" y="6788"/>
                    </a:cubicBezTo>
                    <a:lnTo>
                      <a:pt x="2229174" y="4521"/>
                    </a:lnTo>
                    <a:cubicBezTo>
                      <a:pt x="2219432" y="600"/>
                      <a:pt x="2200257" y="5867"/>
                      <a:pt x="2182688" y="1687"/>
                    </a:cubicBezTo>
                    <a:cubicBezTo>
                      <a:pt x="2187702" y="3054"/>
                      <a:pt x="2192056" y="7961"/>
                      <a:pt x="2181494" y="8768"/>
                    </a:cubicBezTo>
                    <a:cubicBezTo>
                      <a:pt x="2161292" y="4494"/>
                      <a:pt x="2147510" y="8768"/>
                      <a:pt x="2132742" y="3487"/>
                    </a:cubicBezTo>
                    <a:lnTo>
                      <a:pt x="2118566" y="10128"/>
                    </a:lnTo>
                    <a:cubicBezTo>
                      <a:pt x="2048231" y="8835"/>
                      <a:pt x="1770416" y="18269"/>
                      <a:pt x="1699761" y="19329"/>
                    </a:cubicBezTo>
                    <a:lnTo>
                      <a:pt x="1702528" y="18269"/>
                    </a:lnTo>
                    <a:cubicBezTo>
                      <a:pt x="1594874" y="21589"/>
                      <a:pt x="1373893" y="21069"/>
                      <a:pt x="1262633" y="30217"/>
                    </a:cubicBezTo>
                    <a:cubicBezTo>
                      <a:pt x="1245424" y="23683"/>
                      <a:pt x="1221694" y="25217"/>
                      <a:pt x="1203739" y="23390"/>
                    </a:cubicBezTo>
                    <a:cubicBezTo>
                      <a:pt x="1213720" y="26117"/>
                      <a:pt x="1210300" y="30751"/>
                      <a:pt x="1202505" y="30484"/>
                    </a:cubicBezTo>
                    <a:cubicBezTo>
                      <a:pt x="1147805" y="29730"/>
                      <a:pt x="1198811" y="35004"/>
                      <a:pt x="1143491" y="37798"/>
                    </a:cubicBezTo>
                    <a:cubicBezTo>
                      <a:pt x="1079790" y="43879"/>
                      <a:pt x="836019" y="36958"/>
                      <a:pt x="779472" y="31391"/>
                    </a:cubicBezTo>
                    <a:cubicBezTo>
                      <a:pt x="749102" y="41025"/>
                      <a:pt x="711184" y="33738"/>
                      <a:pt x="681427" y="39832"/>
                    </a:cubicBezTo>
                    <a:lnTo>
                      <a:pt x="684420" y="37558"/>
                    </a:lnTo>
                    <a:cubicBezTo>
                      <a:pt x="652463" y="41185"/>
                      <a:pt x="471554" y="32257"/>
                      <a:pt x="434409" y="35705"/>
                    </a:cubicBezTo>
                    <a:lnTo>
                      <a:pt x="439403" y="37085"/>
                    </a:lnTo>
                    <a:cubicBezTo>
                      <a:pt x="407012" y="43065"/>
                      <a:pt x="411426" y="32524"/>
                      <a:pt x="385903" y="29244"/>
                    </a:cubicBezTo>
                    <a:cubicBezTo>
                      <a:pt x="389257" y="40052"/>
                      <a:pt x="361500" y="46193"/>
                      <a:pt x="350919" y="47006"/>
                    </a:cubicBezTo>
                    <a:lnTo>
                      <a:pt x="351319" y="44639"/>
                    </a:lnTo>
                    <a:cubicBezTo>
                      <a:pt x="335357" y="46459"/>
                      <a:pt x="299199" y="55847"/>
                      <a:pt x="272842" y="57301"/>
                    </a:cubicBezTo>
                    <a:lnTo>
                      <a:pt x="273876" y="51386"/>
                    </a:lnTo>
                    <a:cubicBezTo>
                      <a:pt x="251893" y="57741"/>
                      <a:pt x="210561" y="55100"/>
                      <a:pt x="194759" y="55720"/>
                    </a:cubicBezTo>
                    <a:cubicBezTo>
                      <a:pt x="158628" y="53273"/>
                      <a:pt x="102901" y="42979"/>
                      <a:pt x="54588" y="50793"/>
                    </a:cubicBezTo>
                    <a:lnTo>
                      <a:pt x="23378" y="33938"/>
                    </a:lnTo>
                    <a:lnTo>
                      <a:pt x="18811" y="35611"/>
                    </a:lnTo>
                    <a:cubicBezTo>
                      <a:pt x="18811" y="35611"/>
                      <a:pt x="-31456" y="239150"/>
                      <a:pt x="32352" y="282502"/>
                    </a:cubicBezTo>
                    <a:lnTo>
                      <a:pt x="31339" y="288403"/>
                    </a:lnTo>
                    <a:lnTo>
                      <a:pt x="43954" y="287643"/>
                    </a:lnTo>
                    <a:cubicBezTo>
                      <a:pt x="59089" y="290550"/>
                      <a:pt x="66090" y="283709"/>
                      <a:pt x="65063" y="289596"/>
                    </a:cubicBezTo>
                    <a:lnTo>
                      <a:pt x="44327" y="288876"/>
                    </a:lnTo>
                    <a:cubicBezTo>
                      <a:pt x="59536" y="290583"/>
                      <a:pt x="48914" y="293717"/>
                      <a:pt x="43114" y="297057"/>
                    </a:cubicBezTo>
                    <a:cubicBezTo>
                      <a:pt x="49461" y="297624"/>
                      <a:pt x="55628" y="298337"/>
                      <a:pt x="60682" y="300144"/>
                    </a:cubicBezTo>
                    <a:cubicBezTo>
                      <a:pt x="63676" y="297877"/>
                      <a:pt x="58482" y="297697"/>
                      <a:pt x="56115" y="296410"/>
                    </a:cubicBezTo>
                    <a:cubicBezTo>
                      <a:pt x="64296" y="294330"/>
                      <a:pt x="75691" y="288783"/>
                      <a:pt x="85652" y="291503"/>
                    </a:cubicBezTo>
                    <a:cubicBezTo>
                      <a:pt x="101227" y="292057"/>
                      <a:pt x="86646" y="301064"/>
                      <a:pt x="104821" y="301704"/>
                    </a:cubicBezTo>
                    <a:cubicBezTo>
                      <a:pt x="200667" y="306272"/>
                      <a:pt x="293532" y="313112"/>
                      <a:pt x="390404" y="311779"/>
                    </a:cubicBezTo>
                    <a:cubicBezTo>
                      <a:pt x="392604" y="314226"/>
                      <a:pt x="389984" y="314139"/>
                      <a:pt x="387183" y="315239"/>
                    </a:cubicBezTo>
                    <a:cubicBezTo>
                      <a:pt x="416367" y="312692"/>
                      <a:pt x="442310" y="313613"/>
                      <a:pt x="468880" y="310972"/>
                    </a:cubicBezTo>
                    <a:cubicBezTo>
                      <a:pt x="476261" y="313613"/>
                      <a:pt x="478275" y="317253"/>
                      <a:pt x="480462" y="319707"/>
                    </a:cubicBezTo>
                    <a:cubicBezTo>
                      <a:pt x="476068" y="314799"/>
                      <a:pt x="627213" y="314353"/>
                      <a:pt x="629607" y="315626"/>
                    </a:cubicBezTo>
                    <a:close/>
                  </a:path>
                </a:pathLst>
              </a:custGeom>
              <a:ln/>
            </p:spPr>
            <p:style>
              <a:lnRef idx="2">
                <a:schemeClr val="accent2">
                  <a:shade val="50000"/>
                </a:schemeClr>
              </a:lnRef>
              <a:fillRef idx="1">
                <a:schemeClr val="accent2"/>
              </a:fillRef>
              <a:effectRef idx="0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en-US"/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3942DDFE-07B6-F159-DFCF-7E15D6082A77}"/>
                  </a:ext>
                </a:extLst>
              </p:cNvPr>
              <p:cNvSpPr txBox="1"/>
              <p:nvPr/>
            </p:nvSpPr>
            <p:spPr>
              <a:xfrm>
                <a:off x="3771197" y="78645"/>
                <a:ext cx="1434797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>
                    <a:solidFill>
                      <a:schemeClr val="bg1"/>
                    </a:solidFill>
                  </a:rPr>
                  <a:t>EXTREME OVERHEATING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583F390E-1B5E-AAAA-25EC-447B087E4FC8}"/>
                  </a:ext>
                </a:extLst>
              </p:cNvPr>
              <p:cNvSpPr txBox="1"/>
              <p:nvPr/>
            </p:nvSpPr>
            <p:spPr>
              <a:xfrm>
                <a:off x="3771197" y="633532"/>
                <a:ext cx="1734767" cy="6001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/>
                  <a:t>Fast heart rate and breathing, passing out, high body temperature</a:t>
                </a:r>
              </a:p>
            </p:txBody>
          </p:sp>
        </p:grpSp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FC9F58FA-EBEC-035E-1578-FF6601724810}"/>
                </a:ext>
              </a:extLst>
            </p:cNvPr>
            <p:cNvGrpSpPr/>
            <p:nvPr/>
          </p:nvGrpSpPr>
          <p:grpSpPr>
            <a:xfrm>
              <a:off x="3787341" y="1288210"/>
              <a:ext cx="1734767" cy="932143"/>
              <a:chOff x="1854584" y="3429037"/>
              <a:chExt cx="1734767" cy="932143"/>
            </a:xfrm>
          </p:grpSpPr>
          <p:sp>
            <p:nvSpPr>
              <p:cNvPr id="20" name="Graphic 2" descr="A brushstroke">
                <a:extLst>
                  <a:ext uri="{FF2B5EF4-FFF2-40B4-BE49-F238E27FC236}">
                    <a16:creationId xmlns:a16="http://schemas.microsoft.com/office/drawing/2014/main" id="{E72536A4-62AD-BDCC-1594-87D207FDD1B3}"/>
                  </a:ext>
                </a:extLst>
              </p:cNvPr>
              <p:cNvSpPr/>
              <p:nvPr/>
            </p:nvSpPr>
            <p:spPr>
              <a:xfrm>
                <a:off x="1891360" y="3429037"/>
                <a:ext cx="1032813" cy="320246"/>
              </a:xfrm>
              <a:custGeom>
                <a:avLst/>
                <a:gdLst>
                  <a:gd name="connsiteX0" fmla="*/ 42687 w 2401948"/>
                  <a:gd name="connsiteY0" fmla="*/ 296990 h 320246"/>
                  <a:gd name="connsiteX1" fmla="*/ 10363 w 2401948"/>
                  <a:gd name="connsiteY1" fmla="*/ 288863 h 320246"/>
                  <a:gd name="connsiteX2" fmla="*/ 42687 w 2401948"/>
                  <a:gd name="connsiteY2" fmla="*/ 296990 h 320246"/>
                  <a:gd name="connsiteX3" fmla="*/ 42927 w 2401948"/>
                  <a:gd name="connsiteY3" fmla="*/ 297130 h 320246"/>
                  <a:gd name="connsiteX4" fmla="*/ 43114 w 2401948"/>
                  <a:gd name="connsiteY4" fmla="*/ 297044 h 320246"/>
                  <a:gd name="connsiteX5" fmla="*/ 42687 w 2401948"/>
                  <a:gd name="connsiteY5" fmla="*/ 296990 h 320246"/>
                  <a:gd name="connsiteX6" fmla="*/ 42927 w 2401948"/>
                  <a:gd name="connsiteY6" fmla="*/ 297130 h 320246"/>
                  <a:gd name="connsiteX7" fmla="*/ 2392981 w 2401948"/>
                  <a:gd name="connsiteY7" fmla="*/ 9101 h 320246"/>
                  <a:gd name="connsiteX8" fmla="*/ 2383013 w 2401948"/>
                  <a:gd name="connsiteY8" fmla="*/ 9501 h 320246"/>
                  <a:gd name="connsiteX9" fmla="*/ 2392981 w 2401948"/>
                  <a:gd name="connsiteY9" fmla="*/ 9101 h 320246"/>
                  <a:gd name="connsiteX10" fmla="*/ 629607 w 2401948"/>
                  <a:gd name="connsiteY10" fmla="*/ 315626 h 320246"/>
                  <a:gd name="connsiteX11" fmla="*/ 631454 w 2401948"/>
                  <a:gd name="connsiteY11" fmla="*/ 304972 h 320246"/>
                  <a:gd name="connsiteX12" fmla="*/ 666385 w 2401948"/>
                  <a:gd name="connsiteY12" fmla="*/ 314533 h 320246"/>
                  <a:gd name="connsiteX13" fmla="*/ 719698 w 2401948"/>
                  <a:gd name="connsiteY13" fmla="*/ 308085 h 320246"/>
                  <a:gd name="connsiteX14" fmla="*/ 731673 w 2401948"/>
                  <a:gd name="connsiteY14" fmla="*/ 314459 h 320246"/>
                  <a:gd name="connsiteX15" fmla="*/ 753256 w 2401948"/>
                  <a:gd name="connsiteY15" fmla="*/ 310465 h 320246"/>
                  <a:gd name="connsiteX16" fmla="*/ 748848 w 2401948"/>
                  <a:gd name="connsiteY16" fmla="*/ 305552 h 320246"/>
                  <a:gd name="connsiteX17" fmla="*/ 767644 w 2401948"/>
                  <a:gd name="connsiteY17" fmla="*/ 302658 h 320246"/>
                  <a:gd name="connsiteX18" fmla="*/ 768818 w 2401948"/>
                  <a:gd name="connsiteY18" fmla="*/ 310999 h 320246"/>
                  <a:gd name="connsiteX19" fmla="*/ 1106660 w 2401948"/>
                  <a:gd name="connsiteY19" fmla="*/ 317686 h 320246"/>
                  <a:gd name="connsiteX20" fmla="*/ 1077316 w 2401948"/>
                  <a:gd name="connsiteY20" fmla="*/ 305958 h 320246"/>
                  <a:gd name="connsiteX21" fmla="*/ 1104080 w 2401948"/>
                  <a:gd name="connsiteY21" fmla="*/ 302138 h 320246"/>
                  <a:gd name="connsiteX22" fmla="*/ 1145411 w 2401948"/>
                  <a:gd name="connsiteY22" fmla="*/ 320247 h 320246"/>
                  <a:gd name="connsiteX23" fmla="*/ 1149425 w 2401948"/>
                  <a:gd name="connsiteY23" fmla="*/ 312052 h 320246"/>
                  <a:gd name="connsiteX24" fmla="*/ 1156379 w 2401948"/>
                  <a:gd name="connsiteY24" fmla="*/ 317066 h 320246"/>
                  <a:gd name="connsiteX25" fmla="*/ 1224975 w 2401948"/>
                  <a:gd name="connsiteY25" fmla="*/ 314839 h 320246"/>
                  <a:gd name="connsiteX26" fmla="*/ 1289103 w 2401948"/>
                  <a:gd name="connsiteY26" fmla="*/ 306398 h 320246"/>
                  <a:gd name="connsiteX27" fmla="*/ 1287709 w 2401948"/>
                  <a:gd name="connsiteY27" fmla="*/ 299204 h 320246"/>
                  <a:gd name="connsiteX28" fmla="*/ 1313459 w 2401948"/>
                  <a:gd name="connsiteY28" fmla="*/ 301304 h 320246"/>
                  <a:gd name="connsiteX29" fmla="*/ 1338635 w 2401948"/>
                  <a:gd name="connsiteY29" fmla="*/ 291490 h 320246"/>
                  <a:gd name="connsiteX30" fmla="*/ 1352411 w 2401948"/>
                  <a:gd name="connsiteY30" fmla="*/ 302671 h 320246"/>
                  <a:gd name="connsiteX31" fmla="*/ 1373406 w 2401948"/>
                  <a:gd name="connsiteY31" fmla="*/ 302238 h 320246"/>
                  <a:gd name="connsiteX32" fmla="*/ 1363379 w 2401948"/>
                  <a:gd name="connsiteY32" fmla="*/ 299497 h 320246"/>
                  <a:gd name="connsiteX33" fmla="*/ 1421306 w 2401948"/>
                  <a:gd name="connsiteY33" fmla="*/ 296784 h 320246"/>
                  <a:gd name="connsiteX34" fmla="*/ 1411558 w 2401948"/>
                  <a:gd name="connsiteY34" fmla="*/ 292877 h 320246"/>
                  <a:gd name="connsiteX35" fmla="*/ 1446702 w 2401948"/>
                  <a:gd name="connsiteY35" fmla="*/ 301244 h 320246"/>
                  <a:gd name="connsiteX36" fmla="*/ 1430514 w 2401948"/>
                  <a:gd name="connsiteY36" fmla="*/ 304238 h 320246"/>
                  <a:gd name="connsiteX37" fmla="*/ 1494235 w 2401948"/>
                  <a:gd name="connsiteY37" fmla="*/ 298171 h 320246"/>
                  <a:gd name="connsiteX38" fmla="*/ 1486454 w 2401948"/>
                  <a:gd name="connsiteY38" fmla="*/ 297904 h 320246"/>
                  <a:gd name="connsiteX39" fmla="*/ 1685072 w 2401948"/>
                  <a:gd name="connsiteY39" fmla="*/ 267987 h 320246"/>
                  <a:gd name="connsiteX40" fmla="*/ 1673291 w 2401948"/>
                  <a:gd name="connsiteY40" fmla="*/ 260433 h 320246"/>
                  <a:gd name="connsiteX41" fmla="*/ 1695293 w 2401948"/>
                  <a:gd name="connsiteY41" fmla="*/ 254072 h 320246"/>
                  <a:gd name="connsiteX42" fmla="*/ 1682492 w 2401948"/>
                  <a:gd name="connsiteY42" fmla="*/ 276135 h 320246"/>
                  <a:gd name="connsiteX43" fmla="*/ 2018440 w 2401948"/>
                  <a:gd name="connsiteY43" fmla="*/ 274661 h 320246"/>
                  <a:gd name="connsiteX44" fmla="*/ 2021401 w 2401948"/>
                  <a:gd name="connsiteY44" fmla="*/ 287849 h 320246"/>
                  <a:gd name="connsiteX45" fmla="*/ 2048804 w 2401948"/>
                  <a:gd name="connsiteY45" fmla="*/ 280488 h 320246"/>
                  <a:gd name="connsiteX46" fmla="*/ 2044984 w 2401948"/>
                  <a:gd name="connsiteY46" fmla="*/ 287489 h 320246"/>
                  <a:gd name="connsiteX47" fmla="*/ 2060946 w 2401948"/>
                  <a:gd name="connsiteY47" fmla="*/ 285682 h 320246"/>
                  <a:gd name="connsiteX48" fmla="*/ 2050985 w 2401948"/>
                  <a:gd name="connsiteY48" fmla="*/ 267494 h 320246"/>
                  <a:gd name="connsiteX49" fmla="*/ 2074367 w 2401948"/>
                  <a:gd name="connsiteY49" fmla="*/ 268307 h 320246"/>
                  <a:gd name="connsiteX50" fmla="*/ 2073327 w 2401948"/>
                  <a:gd name="connsiteY50" fmla="*/ 274221 h 320246"/>
                  <a:gd name="connsiteX51" fmla="*/ 2109519 w 2401948"/>
                  <a:gd name="connsiteY51" fmla="*/ 261226 h 320246"/>
                  <a:gd name="connsiteX52" fmla="*/ 2229334 w 2401948"/>
                  <a:gd name="connsiteY52" fmla="*/ 263080 h 320246"/>
                  <a:gd name="connsiteX53" fmla="*/ 2212345 w 2401948"/>
                  <a:gd name="connsiteY53" fmla="*/ 270801 h 320246"/>
                  <a:gd name="connsiteX54" fmla="*/ 2230347 w 2401948"/>
                  <a:gd name="connsiteY54" fmla="*/ 272621 h 320246"/>
                  <a:gd name="connsiteX55" fmla="*/ 2239342 w 2401948"/>
                  <a:gd name="connsiteY55" fmla="*/ 265807 h 320246"/>
                  <a:gd name="connsiteX56" fmla="*/ 2330006 w 2401948"/>
                  <a:gd name="connsiteY56" fmla="*/ 254738 h 320246"/>
                  <a:gd name="connsiteX57" fmla="*/ 2383953 w 2401948"/>
                  <a:gd name="connsiteY57" fmla="*/ 15909 h 320246"/>
                  <a:gd name="connsiteX58" fmla="*/ 2401949 w 2401948"/>
                  <a:gd name="connsiteY58" fmla="*/ 17742 h 320246"/>
                  <a:gd name="connsiteX59" fmla="*/ 2376385 w 2401948"/>
                  <a:gd name="connsiteY59" fmla="*/ 14449 h 320246"/>
                  <a:gd name="connsiteX60" fmla="*/ 2374978 w 2401948"/>
                  <a:gd name="connsiteY60" fmla="*/ 22736 h 320246"/>
                  <a:gd name="connsiteX61" fmla="*/ 2352222 w 2401948"/>
                  <a:gd name="connsiteY61" fmla="*/ 18376 h 320246"/>
                  <a:gd name="connsiteX62" fmla="*/ 2383006 w 2401948"/>
                  <a:gd name="connsiteY62" fmla="*/ 9495 h 320246"/>
                  <a:gd name="connsiteX63" fmla="*/ 2350822 w 2401948"/>
                  <a:gd name="connsiteY63" fmla="*/ 11188 h 320246"/>
                  <a:gd name="connsiteX64" fmla="*/ 2337060 w 2401948"/>
                  <a:gd name="connsiteY64" fmla="*/ 0 h 320246"/>
                  <a:gd name="connsiteX65" fmla="*/ 2299676 w 2401948"/>
                  <a:gd name="connsiteY65" fmla="*/ 4621 h 320246"/>
                  <a:gd name="connsiteX66" fmla="*/ 2299896 w 2401948"/>
                  <a:gd name="connsiteY66" fmla="*/ 3427 h 320246"/>
                  <a:gd name="connsiteX67" fmla="*/ 2226207 w 2401948"/>
                  <a:gd name="connsiteY67" fmla="*/ 6788 h 320246"/>
                  <a:gd name="connsiteX68" fmla="*/ 2229174 w 2401948"/>
                  <a:gd name="connsiteY68" fmla="*/ 4521 h 320246"/>
                  <a:gd name="connsiteX69" fmla="*/ 2182688 w 2401948"/>
                  <a:gd name="connsiteY69" fmla="*/ 1687 h 320246"/>
                  <a:gd name="connsiteX70" fmla="*/ 2181494 w 2401948"/>
                  <a:gd name="connsiteY70" fmla="*/ 8768 h 320246"/>
                  <a:gd name="connsiteX71" fmla="*/ 2132742 w 2401948"/>
                  <a:gd name="connsiteY71" fmla="*/ 3487 h 320246"/>
                  <a:gd name="connsiteX72" fmla="*/ 2118566 w 2401948"/>
                  <a:gd name="connsiteY72" fmla="*/ 10128 h 320246"/>
                  <a:gd name="connsiteX73" fmla="*/ 1699761 w 2401948"/>
                  <a:gd name="connsiteY73" fmla="*/ 19329 h 320246"/>
                  <a:gd name="connsiteX74" fmla="*/ 1702528 w 2401948"/>
                  <a:gd name="connsiteY74" fmla="*/ 18269 h 320246"/>
                  <a:gd name="connsiteX75" fmla="*/ 1262633 w 2401948"/>
                  <a:gd name="connsiteY75" fmla="*/ 30217 h 320246"/>
                  <a:gd name="connsiteX76" fmla="*/ 1203739 w 2401948"/>
                  <a:gd name="connsiteY76" fmla="*/ 23390 h 320246"/>
                  <a:gd name="connsiteX77" fmla="*/ 1202505 w 2401948"/>
                  <a:gd name="connsiteY77" fmla="*/ 30484 h 320246"/>
                  <a:gd name="connsiteX78" fmla="*/ 1143491 w 2401948"/>
                  <a:gd name="connsiteY78" fmla="*/ 37798 h 320246"/>
                  <a:gd name="connsiteX79" fmla="*/ 779472 w 2401948"/>
                  <a:gd name="connsiteY79" fmla="*/ 31391 h 320246"/>
                  <a:gd name="connsiteX80" fmla="*/ 681427 w 2401948"/>
                  <a:gd name="connsiteY80" fmla="*/ 39832 h 320246"/>
                  <a:gd name="connsiteX81" fmla="*/ 684420 w 2401948"/>
                  <a:gd name="connsiteY81" fmla="*/ 37558 h 320246"/>
                  <a:gd name="connsiteX82" fmla="*/ 434409 w 2401948"/>
                  <a:gd name="connsiteY82" fmla="*/ 35705 h 320246"/>
                  <a:gd name="connsiteX83" fmla="*/ 439403 w 2401948"/>
                  <a:gd name="connsiteY83" fmla="*/ 37085 h 320246"/>
                  <a:gd name="connsiteX84" fmla="*/ 385903 w 2401948"/>
                  <a:gd name="connsiteY84" fmla="*/ 29244 h 320246"/>
                  <a:gd name="connsiteX85" fmla="*/ 350919 w 2401948"/>
                  <a:gd name="connsiteY85" fmla="*/ 47006 h 320246"/>
                  <a:gd name="connsiteX86" fmla="*/ 351319 w 2401948"/>
                  <a:gd name="connsiteY86" fmla="*/ 44639 h 320246"/>
                  <a:gd name="connsiteX87" fmla="*/ 272842 w 2401948"/>
                  <a:gd name="connsiteY87" fmla="*/ 57301 h 320246"/>
                  <a:gd name="connsiteX88" fmla="*/ 273876 w 2401948"/>
                  <a:gd name="connsiteY88" fmla="*/ 51386 h 320246"/>
                  <a:gd name="connsiteX89" fmla="*/ 194759 w 2401948"/>
                  <a:gd name="connsiteY89" fmla="*/ 55720 h 320246"/>
                  <a:gd name="connsiteX90" fmla="*/ 54588 w 2401948"/>
                  <a:gd name="connsiteY90" fmla="*/ 50793 h 320246"/>
                  <a:gd name="connsiteX91" fmla="*/ 23378 w 2401948"/>
                  <a:gd name="connsiteY91" fmla="*/ 33938 h 320246"/>
                  <a:gd name="connsiteX92" fmla="*/ 18811 w 2401948"/>
                  <a:gd name="connsiteY92" fmla="*/ 35611 h 320246"/>
                  <a:gd name="connsiteX93" fmla="*/ 32352 w 2401948"/>
                  <a:gd name="connsiteY93" fmla="*/ 282502 h 320246"/>
                  <a:gd name="connsiteX94" fmla="*/ 31339 w 2401948"/>
                  <a:gd name="connsiteY94" fmla="*/ 288403 h 320246"/>
                  <a:gd name="connsiteX95" fmla="*/ 43954 w 2401948"/>
                  <a:gd name="connsiteY95" fmla="*/ 287643 h 320246"/>
                  <a:gd name="connsiteX96" fmla="*/ 65063 w 2401948"/>
                  <a:gd name="connsiteY96" fmla="*/ 289596 h 320246"/>
                  <a:gd name="connsiteX97" fmla="*/ 44327 w 2401948"/>
                  <a:gd name="connsiteY97" fmla="*/ 288876 h 320246"/>
                  <a:gd name="connsiteX98" fmla="*/ 43114 w 2401948"/>
                  <a:gd name="connsiteY98" fmla="*/ 297057 h 320246"/>
                  <a:gd name="connsiteX99" fmla="*/ 60682 w 2401948"/>
                  <a:gd name="connsiteY99" fmla="*/ 300144 h 320246"/>
                  <a:gd name="connsiteX100" fmla="*/ 56115 w 2401948"/>
                  <a:gd name="connsiteY100" fmla="*/ 296410 h 320246"/>
                  <a:gd name="connsiteX101" fmla="*/ 85652 w 2401948"/>
                  <a:gd name="connsiteY101" fmla="*/ 291503 h 320246"/>
                  <a:gd name="connsiteX102" fmla="*/ 104821 w 2401948"/>
                  <a:gd name="connsiteY102" fmla="*/ 301704 h 320246"/>
                  <a:gd name="connsiteX103" fmla="*/ 390404 w 2401948"/>
                  <a:gd name="connsiteY103" fmla="*/ 311779 h 320246"/>
                  <a:gd name="connsiteX104" fmla="*/ 387183 w 2401948"/>
                  <a:gd name="connsiteY104" fmla="*/ 315239 h 320246"/>
                  <a:gd name="connsiteX105" fmla="*/ 468880 w 2401948"/>
                  <a:gd name="connsiteY105" fmla="*/ 310972 h 320246"/>
                  <a:gd name="connsiteX106" fmla="*/ 480462 w 2401948"/>
                  <a:gd name="connsiteY106" fmla="*/ 319707 h 320246"/>
                  <a:gd name="connsiteX107" fmla="*/ 629607 w 2401948"/>
                  <a:gd name="connsiteY107" fmla="*/ 315626 h 3202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  <a:cxn ang="0">
                    <a:pos x="connsiteX69" y="connsiteY69"/>
                  </a:cxn>
                  <a:cxn ang="0">
                    <a:pos x="connsiteX70" y="connsiteY70"/>
                  </a:cxn>
                  <a:cxn ang="0">
                    <a:pos x="connsiteX71" y="connsiteY71"/>
                  </a:cxn>
                  <a:cxn ang="0">
                    <a:pos x="connsiteX72" y="connsiteY72"/>
                  </a:cxn>
                  <a:cxn ang="0">
                    <a:pos x="connsiteX73" y="connsiteY73"/>
                  </a:cxn>
                  <a:cxn ang="0">
                    <a:pos x="connsiteX74" y="connsiteY74"/>
                  </a:cxn>
                  <a:cxn ang="0">
                    <a:pos x="connsiteX75" y="connsiteY75"/>
                  </a:cxn>
                  <a:cxn ang="0">
                    <a:pos x="connsiteX76" y="connsiteY76"/>
                  </a:cxn>
                  <a:cxn ang="0">
                    <a:pos x="connsiteX77" y="connsiteY77"/>
                  </a:cxn>
                  <a:cxn ang="0">
                    <a:pos x="connsiteX78" y="connsiteY78"/>
                  </a:cxn>
                  <a:cxn ang="0">
                    <a:pos x="connsiteX79" y="connsiteY79"/>
                  </a:cxn>
                  <a:cxn ang="0">
                    <a:pos x="connsiteX80" y="connsiteY80"/>
                  </a:cxn>
                  <a:cxn ang="0">
                    <a:pos x="connsiteX81" y="connsiteY81"/>
                  </a:cxn>
                  <a:cxn ang="0">
                    <a:pos x="connsiteX82" y="connsiteY82"/>
                  </a:cxn>
                  <a:cxn ang="0">
                    <a:pos x="connsiteX83" y="connsiteY83"/>
                  </a:cxn>
                  <a:cxn ang="0">
                    <a:pos x="connsiteX84" y="connsiteY84"/>
                  </a:cxn>
                  <a:cxn ang="0">
                    <a:pos x="connsiteX85" y="connsiteY85"/>
                  </a:cxn>
                  <a:cxn ang="0">
                    <a:pos x="connsiteX86" y="connsiteY86"/>
                  </a:cxn>
                  <a:cxn ang="0">
                    <a:pos x="connsiteX87" y="connsiteY87"/>
                  </a:cxn>
                  <a:cxn ang="0">
                    <a:pos x="connsiteX88" y="connsiteY88"/>
                  </a:cxn>
                  <a:cxn ang="0">
                    <a:pos x="connsiteX89" y="connsiteY89"/>
                  </a:cxn>
                  <a:cxn ang="0">
                    <a:pos x="connsiteX90" y="connsiteY90"/>
                  </a:cxn>
                  <a:cxn ang="0">
                    <a:pos x="connsiteX91" y="connsiteY91"/>
                  </a:cxn>
                  <a:cxn ang="0">
                    <a:pos x="connsiteX92" y="connsiteY92"/>
                  </a:cxn>
                  <a:cxn ang="0">
                    <a:pos x="connsiteX93" y="connsiteY93"/>
                  </a:cxn>
                  <a:cxn ang="0">
                    <a:pos x="connsiteX94" y="connsiteY94"/>
                  </a:cxn>
                  <a:cxn ang="0">
                    <a:pos x="connsiteX95" y="connsiteY95"/>
                  </a:cxn>
                  <a:cxn ang="0">
                    <a:pos x="connsiteX96" y="connsiteY96"/>
                  </a:cxn>
                  <a:cxn ang="0">
                    <a:pos x="connsiteX97" y="connsiteY97"/>
                  </a:cxn>
                  <a:cxn ang="0">
                    <a:pos x="connsiteX98" y="connsiteY98"/>
                  </a:cxn>
                  <a:cxn ang="0">
                    <a:pos x="connsiteX99" y="connsiteY99"/>
                  </a:cxn>
                  <a:cxn ang="0">
                    <a:pos x="connsiteX100" y="connsiteY100"/>
                  </a:cxn>
                  <a:cxn ang="0">
                    <a:pos x="connsiteX101" y="connsiteY101"/>
                  </a:cxn>
                  <a:cxn ang="0">
                    <a:pos x="connsiteX102" y="connsiteY102"/>
                  </a:cxn>
                  <a:cxn ang="0">
                    <a:pos x="connsiteX103" y="connsiteY103"/>
                  </a:cxn>
                  <a:cxn ang="0">
                    <a:pos x="connsiteX104" y="connsiteY104"/>
                  </a:cxn>
                  <a:cxn ang="0">
                    <a:pos x="connsiteX105" y="connsiteY105"/>
                  </a:cxn>
                  <a:cxn ang="0">
                    <a:pos x="connsiteX106" y="connsiteY106"/>
                  </a:cxn>
                  <a:cxn ang="0">
                    <a:pos x="connsiteX107" y="connsiteY107"/>
                  </a:cxn>
                </a:cxnLst>
                <a:rect l="l" t="t" r="r" b="b"/>
                <a:pathLst>
                  <a:path w="2401948" h="320246">
                    <a:moveTo>
                      <a:pt x="42687" y="296990"/>
                    </a:moveTo>
                    <a:cubicBezTo>
                      <a:pt x="30572" y="295917"/>
                      <a:pt x="17777" y="295297"/>
                      <a:pt x="10363" y="288863"/>
                    </a:cubicBezTo>
                    <a:cubicBezTo>
                      <a:pt x="23451" y="288149"/>
                      <a:pt x="33366" y="290830"/>
                      <a:pt x="42687" y="296990"/>
                    </a:cubicBezTo>
                    <a:close/>
                    <a:moveTo>
                      <a:pt x="42927" y="297130"/>
                    </a:moveTo>
                    <a:cubicBezTo>
                      <a:pt x="42974" y="297097"/>
                      <a:pt x="43060" y="297070"/>
                      <a:pt x="43114" y="297044"/>
                    </a:cubicBezTo>
                    <a:cubicBezTo>
                      <a:pt x="42947" y="297037"/>
                      <a:pt x="42827" y="297011"/>
                      <a:pt x="42687" y="296990"/>
                    </a:cubicBezTo>
                    <a:cubicBezTo>
                      <a:pt x="42780" y="297057"/>
                      <a:pt x="42854" y="297070"/>
                      <a:pt x="42927" y="297130"/>
                    </a:cubicBezTo>
                    <a:close/>
                    <a:moveTo>
                      <a:pt x="2392981" y="9101"/>
                    </a:moveTo>
                    <a:cubicBezTo>
                      <a:pt x="2389954" y="9228"/>
                      <a:pt x="2386507" y="9355"/>
                      <a:pt x="2383013" y="9501"/>
                    </a:cubicBezTo>
                    <a:cubicBezTo>
                      <a:pt x="2386347" y="9695"/>
                      <a:pt x="2389747" y="9715"/>
                      <a:pt x="2392981" y="9101"/>
                    </a:cubicBezTo>
                    <a:close/>
                    <a:moveTo>
                      <a:pt x="629607" y="315626"/>
                    </a:moveTo>
                    <a:lnTo>
                      <a:pt x="631454" y="304972"/>
                    </a:lnTo>
                    <a:cubicBezTo>
                      <a:pt x="660191" y="304818"/>
                      <a:pt x="639821" y="317166"/>
                      <a:pt x="666385" y="314533"/>
                    </a:cubicBezTo>
                    <a:cubicBezTo>
                      <a:pt x="676779" y="299457"/>
                      <a:pt x="710517" y="316093"/>
                      <a:pt x="719698" y="308085"/>
                    </a:cubicBezTo>
                    <a:cubicBezTo>
                      <a:pt x="719491" y="309285"/>
                      <a:pt x="732500" y="309739"/>
                      <a:pt x="731673" y="314459"/>
                    </a:cubicBezTo>
                    <a:cubicBezTo>
                      <a:pt x="735653" y="306272"/>
                      <a:pt x="745055" y="312559"/>
                      <a:pt x="753256" y="310465"/>
                    </a:cubicBezTo>
                    <a:cubicBezTo>
                      <a:pt x="756229" y="308192"/>
                      <a:pt x="751075" y="308019"/>
                      <a:pt x="748848" y="305552"/>
                    </a:cubicBezTo>
                    <a:lnTo>
                      <a:pt x="767644" y="302658"/>
                    </a:lnTo>
                    <a:cubicBezTo>
                      <a:pt x="774992" y="305291"/>
                      <a:pt x="776805" y="310106"/>
                      <a:pt x="768818" y="310999"/>
                    </a:cubicBezTo>
                    <a:cubicBezTo>
                      <a:pt x="817937" y="313933"/>
                      <a:pt x="1053747" y="321774"/>
                      <a:pt x="1106660" y="317686"/>
                    </a:cubicBezTo>
                    <a:cubicBezTo>
                      <a:pt x="1099859" y="311506"/>
                      <a:pt x="1083524" y="315680"/>
                      <a:pt x="1077316" y="305958"/>
                    </a:cubicBezTo>
                    <a:cubicBezTo>
                      <a:pt x="1091305" y="300511"/>
                      <a:pt x="1097912" y="307865"/>
                      <a:pt x="1104080" y="302138"/>
                    </a:cubicBezTo>
                    <a:cubicBezTo>
                      <a:pt x="1109447" y="316593"/>
                      <a:pt x="1134823" y="305598"/>
                      <a:pt x="1145411" y="320247"/>
                    </a:cubicBezTo>
                    <a:lnTo>
                      <a:pt x="1149425" y="312052"/>
                    </a:lnTo>
                    <a:lnTo>
                      <a:pt x="1156379" y="317066"/>
                    </a:lnTo>
                    <a:cubicBezTo>
                      <a:pt x="1217900" y="308539"/>
                      <a:pt x="1170435" y="312906"/>
                      <a:pt x="1224975" y="314839"/>
                    </a:cubicBezTo>
                    <a:cubicBezTo>
                      <a:pt x="1256539" y="313579"/>
                      <a:pt x="1271540" y="302211"/>
                      <a:pt x="1289103" y="306398"/>
                    </a:cubicBezTo>
                    <a:cubicBezTo>
                      <a:pt x="1286496" y="306312"/>
                      <a:pt x="1279535" y="301298"/>
                      <a:pt x="1287709" y="299204"/>
                    </a:cubicBezTo>
                    <a:cubicBezTo>
                      <a:pt x="1289103" y="306398"/>
                      <a:pt x="1309479" y="294044"/>
                      <a:pt x="1313459" y="301304"/>
                    </a:cubicBezTo>
                    <a:cubicBezTo>
                      <a:pt x="1321467" y="300398"/>
                      <a:pt x="1347417" y="301324"/>
                      <a:pt x="1338635" y="291490"/>
                    </a:cubicBezTo>
                    <a:cubicBezTo>
                      <a:pt x="1343043" y="296397"/>
                      <a:pt x="1366192" y="298411"/>
                      <a:pt x="1352411" y="302671"/>
                    </a:cubicBezTo>
                    <a:cubicBezTo>
                      <a:pt x="1360218" y="302958"/>
                      <a:pt x="1367786" y="304405"/>
                      <a:pt x="1373406" y="302238"/>
                    </a:cubicBezTo>
                    <a:lnTo>
                      <a:pt x="1363379" y="299497"/>
                    </a:lnTo>
                    <a:cubicBezTo>
                      <a:pt x="1389755" y="298071"/>
                      <a:pt x="1404124" y="305685"/>
                      <a:pt x="1421306" y="296784"/>
                    </a:cubicBezTo>
                    <a:lnTo>
                      <a:pt x="1411558" y="292877"/>
                    </a:lnTo>
                    <a:cubicBezTo>
                      <a:pt x="1427327" y="292257"/>
                      <a:pt x="1440515" y="291517"/>
                      <a:pt x="1446702" y="301244"/>
                    </a:cubicBezTo>
                    <a:lnTo>
                      <a:pt x="1430514" y="304238"/>
                    </a:lnTo>
                    <a:cubicBezTo>
                      <a:pt x="1456664" y="303985"/>
                      <a:pt x="1472439" y="303351"/>
                      <a:pt x="1494235" y="298171"/>
                    </a:cubicBezTo>
                    <a:lnTo>
                      <a:pt x="1486454" y="297904"/>
                    </a:lnTo>
                    <a:cubicBezTo>
                      <a:pt x="1514224" y="288183"/>
                      <a:pt x="1659489" y="280155"/>
                      <a:pt x="1685072" y="267987"/>
                    </a:cubicBezTo>
                    <a:lnTo>
                      <a:pt x="1673291" y="260433"/>
                    </a:lnTo>
                    <a:lnTo>
                      <a:pt x="1695293" y="254072"/>
                    </a:lnTo>
                    <a:cubicBezTo>
                      <a:pt x="1692686" y="253978"/>
                      <a:pt x="1684672" y="278595"/>
                      <a:pt x="1682492" y="276135"/>
                    </a:cubicBezTo>
                    <a:cubicBezTo>
                      <a:pt x="1729638" y="275434"/>
                      <a:pt x="1974895" y="269574"/>
                      <a:pt x="2018440" y="274661"/>
                    </a:cubicBezTo>
                    <a:cubicBezTo>
                      <a:pt x="2036009" y="278848"/>
                      <a:pt x="2021601" y="286656"/>
                      <a:pt x="2021401" y="287849"/>
                    </a:cubicBezTo>
                    <a:cubicBezTo>
                      <a:pt x="2042784" y="285029"/>
                      <a:pt x="2030622" y="279842"/>
                      <a:pt x="2048804" y="280488"/>
                    </a:cubicBezTo>
                    <a:cubicBezTo>
                      <a:pt x="2053765" y="281849"/>
                      <a:pt x="2047777" y="286409"/>
                      <a:pt x="2044984" y="287489"/>
                    </a:cubicBezTo>
                    <a:cubicBezTo>
                      <a:pt x="2052951" y="286596"/>
                      <a:pt x="2060339" y="289210"/>
                      <a:pt x="2060946" y="285682"/>
                    </a:cubicBezTo>
                    <a:cubicBezTo>
                      <a:pt x="2050985" y="282942"/>
                      <a:pt x="2055198" y="273581"/>
                      <a:pt x="2050985" y="267494"/>
                    </a:cubicBezTo>
                    <a:lnTo>
                      <a:pt x="2074367" y="268307"/>
                    </a:lnTo>
                    <a:lnTo>
                      <a:pt x="2073327" y="274221"/>
                    </a:lnTo>
                    <a:cubicBezTo>
                      <a:pt x="2078541" y="274401"/>
                      <a:pt x="2086549" y="258046"/>
                      <a:pt x="2109519" y="261226"/>
                    </a:cubicBezTo>
                    <a:cubicBezTo>
                      <a:pt x="2148270" y="263786"/>
                      <a:pt x="2190362" y="261713"/>
                      <a:pt x="2229334" y="263080"/>
                    </a:cubicBezTo>
                    <a:cubicBezTo>
                      <a:pt x="2228727" y="266627"/>
                      <a:pt x="2220546" y="268720"/>
                      <a:pt x="2212345" y="270801"/>
                    </a:cubicBezTo>
                    <a:cubicBezTo>
                      <a:pt x="2217572" y="270981"/>
                      <a:pt x="2225533" y="270074"/>
                      <a:pt x="2230347" y="272621"/>
                    </a:cubicBezTo>
                    <a:cubicBezTo>
                      <a:pt x="2220932" y="266353"/>
                      <a:pt x="2246703" y="268447"/>
                      <a:pt x="2239342" y="265807"/>
                    </a:cubicBezTo>
                    <a:cubicBezTo>
                      <a:pt x="2267885" y="251352"/>
                      <a:pt x="2304810" y="264553"/>
                      <a:pt x="2330006" y="254738"/>
                    </a:cubicBezTo>
                    <a:cubicBezTo>
                      <a:pt x="2332206" y="241737"/>
                      <a:pt x="2383953" y="31371"/>
                      <a:pt x="2383953" y="15909"/>
                    </a:cubicBezTo>
                    <a:cubicBezTo>
                      <a:pt x="2391774" y="16189"/>
                      <a:pt x="2399555" y="16469"/>
                      <a:pt x="2401949" y="17742"/>
                    </a:cubicBezTo>
                    <a:cubicBezTo>
                      <a:pt x="2399928" y="14109"/>
                      <a:pt x="2384553" y="12368"/>
                      <a:pt x="2376385" y="14449"/>
                    </a:cubicBezTo>
                    <a:lnTo>
                      <a:pt x="2374978" y="22736"/>
                    </a:lnTo>
                    <a:cubicBezTo>
                      <a:pt x="2356176" y="25643"/>
                      <a:pt x="2370571" y="17816"/>
                      <a:pt x="2352222" y="18376"/>
                    </a:cubicBezTo>
                    <a:cubicBezTo>
                      <a:pt x="2351242" y="11595"/>
                      <a:pt x="2368131" y="10148"/>
                      <a:pt x="2383006" y="9495"/>
                    </a:cubicBezTo>
                    <a:cubicBezTo>
                      <a:pt x="2369611" y="8708"/>
                      <a:pt x="2356276" y="3767"/>
                      <a:pt x="2350822" y="11188"/>
                    </a:cubicBezTo>
                    <a:cubicBezTo>
                      <a:pt x="2338234" y="8368"/>
                      <a:pt x="2352222" y="2900"/>
                      <a:pt x="2337060" y="0"/>
                    </a:cubicBezTo>
                    <a:cubicBezTo>
                      <a:pt x="2326266" y="1994"/>
                      <a:pt x="2312077" y="8628"/>
                      <a:pt x="2299676" y="4621"/>
                    </a:cubicBezTo>
                    <a:lnTo>
                      <a:pt x="2299896" y="3427"/>
                    </a:lnTo>
                    <a:cubicBezTo>
                      <a:pt x="2269739" y="-3574"/>
                      <a:pt x="2253757" y="13708"/>
                      <a:pt x="2226207" y="6788"/>
                    </a:cubicBezTo>
                    <a:lnTo>
                      <a:pt x="2229174" y="4521"/>
                    </a:lnTo>
                    <a:cubicBezTo>
                      <a:pt x="2219432" y="600"/>
                      <a:pt x="2200257" y="5867"/>
                      <a:pt x="2182688" y="1687"/>
                    </a:cubicBezTo>
                    <a:cubicBezTo>
                      <a:pt x="2187702" y="3054"/>
                      <a:pt x="2192056" y="7961"/>
                      <a:pt x="2181494" y="8768"/>
                    </a:cubicBezTo>
                    <a:cubicBezTo>
                      <a:pt x="2161292" y="4494"/>
                      <a:pt x="2147510" y="8768"/>
                      <a:pt x="2132742" y="3487"/>
                    </a:cubicBezTo>
                    <a:lnTo>
                      <a:pt x="2118566" y="10128"/>
                    </a:lnTo>
                    <a:cubicBezTo>
                      <a:pt x="2048231" y="8835"/>
                      <a:pt x="1770416" y="18269"/>
                      <a:pt x="1699761" y="19329"/>
                    </a:cubicBezTo>
                    <a:lnTo>
                      <a:pt x="1702528" y="18269"/>
                    </a:lnTo>
                    <a:cubicBezTo>
                      <a:pt x="1594874" y="21589"/>
                      <a:pt x="1373893" y="21069"/>
                      <a:pt x="1262633" y="30217"/>
                    </a:cubicBezTo>
                    <a:cubicBezTo>
                      <a:pt x="1245424" y="23683"/>
                      <a:pt x="1221694" y="25217"/>
                      <a:pt x="1203739" y="23390"/>
                    </a:cubicBezTo>
                    <a:cubicBezTo>
                      <a:pt x="1213720" y="26117"/>
                      <a:pt x="1210300" y="30751"/>
                      <a:pt x="1202505" y="30484"/>
                    </a:cubicBezTo>
                    <a:cubicBezTo>
                      <a:pt x="1147805" y="29730"/>
                      <a:pt x="1198811" y="35004"/>
                      <a:pt x="1143491" y="37798"/>
                    </a:cubicBezTo>
                    <a:cubicBezTo>
                      <a:pt x="1079790" y="43879"/>
                      <a:pt x="836019" y="36958"/>
                      <a:pt x="779472" y="31391"/>
                    </a:cubicBezTo>
                    <a:cubicBezTo>
                      <a:pt x="749102" y="41025"/>
                      <a:pt x="711184" y="33738"/>
                      <a:pt x="681427" y="39832"/>
                    </a:cubicBezTo>
                    <a:lnTo>
                      <a:pt x="684420" y="37558"/>
                    </a:lnTo>
                    <a:cubicBezTo>
                      <a:pt x="652463" y="41185"/>
                      <a:pt x="471554" y="32257"/>
                      <a:pt x="434409" y="35705"/>
                    </a:cubicBezTo>
                    <a:lnTo>
                      <a:pt x="439403" y="37085"/>
                    </a:lnTo>
                    <a:cubicBezTo>
                      <a:pt x="407012" y="43065"/>
                      <a:pt x="411426" y="32524"/>
                      <a:pt x="385903" y="29244"/>
                    </a:cubicBezTo>
                    <a:cubicBezTo>
                      <a:pt x="389257" y="40052"/>
                      <a:pt x="361500" y="46193"/>
                      <a:pt x="350919" y="47006"/>
                    </a:cubicBezTo>
                    <a:lnTo>
                      <a:pt x="351319" y="44639"/>
                    </a:lnTo>
                    <a:cubicBezTo>
                      <a:pt x="335357" y="46459"/>
                      <a:pt x="299199" y="55847"/>
                      <a:pt x="272842" y="57301"/>
                    </a:cubicBezTo>
                    <a:lnTo>
                      <a:pt x="273876" y="51386"/>
                    </a:lnTo>
                    <a:cubicBezTo>
                      <a:pt x="251893" y="57741"/>
                      <a:pt x="210561" y="55100"/>
                      <a:pt x="194759" y="55720"/>
                    </a:cubicBezTo>
                    <a:cubicBezTo>
                      <a:pt x="158628" y="53273"/>
                      <a:pt x="102901" y="42979"/>
                      <a:pt x="54588" y="50793"/>
                    </a:cubicBezTo>
                    <a:lnTo>
                      <a:pt x="23378" y="33938"/>
                    </a:lnTo>
                    <a:lnTo>
                      <a:pt x="18811" y="35611"/>
                    </a:lnTo>
                    <a:cubicBezTo>
                      <a:pt x="18811" y="35611"/>
                      <a:pt x="-31456" y="239150"/>
                      <a:pt x="32352" y="282502"/>
                    </a:cubicBezTo>
                    <a:lnTo>
                      <a:pt x="31339" y="288403"/>
                    </a:lnTo>
                    <a:lnTo>
                      <a:pt x="43954" y="287643"/>
                    </a:lnTo>
                    <a:cubicBezTo>
                      <a:pt x="59089" y="290550"/>
                      <a:pt x="66090" y="283709"/>
                      <a:pt x="65063" y="289596"/>
                    </a:cubicBezTo>
                    <a:lnTo>
                      <a:pt x="44327" y="288876"/>
                    </a:lnTo>
                    <a:cubicBezTo>
                      <a:pt x="59536" y="290583"/>
                      <a:pt x="48914" y="293717"/>
                      <a:pt x="43114" y="297057"/>
                    </a:cubicBezTo>
                    <a:cubicBezTo>
                      <a:pt x="49461" y="297624"/>
                      <a:pt x="55628" y="298337"/>
                      <a:pt x="60682" y="300144"/>
                    </a:cubicBezTo>
                    <a:cubicBezTo>
                      <a:pt x="63676" y="297877"/>
                      <a:pt x="58482" y="297697"/>
                      <a:pt x="56115" y="296410"/>
                    </a:cubicBezTo>
                    <a:cubicBezTo>
                      <a:pt x="64296" y="294330"/>
                      <a:pt x="75691" y="288783"/>
                      <a:pt x="85652" y="291503"/>
                    </a:cubicBezTo>
                    <a:cubicBezTo>
                      <a:pt x="101227" y="292057"/>
                      <a:pt x="86646" y="301064"/>
                      <a:pt x="104821" y="301704"/>
                    </a:cubicBezTo>
                    <a:cubicBezTo>
                      <a:pt x="200667" y="306272"/>
                      <a:pt x="293532" y="313112"/>
                      <a:pt x="390404" y="311779"/>
                    </a:cubicBezTo>
                    <a:cubicBezTo>
                      <a:pt x="392604" y="314226"/>
                      <a:pt x="389984" y="314139"/>
                      <a:pt x="387183" y="315239"/>
                    </a:cubicBezTo>
                    <a:cubicBezTo>
                      <a:pt x="416367" y="312692"/>
                      <a:pt x="442310" y="313613"/>
                      <a:pt x="468880" y="310972"/>
                    </a:cubicBezTo>
                    <a:cubicBezTo>
                      <a:pt x="476261" y="313613"/>
                      <a:pt x="478275" y="317253"/>
                      <a:pt x="480462" y="319707"/>
                    </a:cubicBezTo>
                    <a:cubicBezTo>
                      <a:pt x="476068" y="314799"/>
                      <a:pt x="627213" y="314353"/>
                      <a:pt x="629607" y="315626"/>
                    </a:cubicBezTo>
                    <a:close/>
                  </a:path>
                </a:pathLst>
              </a:custGeom>
              <a:ln/>
            </p:spPr>
            <p:style>
              <a:lnRef idx="2">
                <a:schemeClr val="accent2">
                  <a:shade val="50000"/>
                </a:schemeClr>
              </a:lnRef>
              <a:fillRef idx="1">
                <a:schemeClr val="accent2"/>
              </a:fillRef>
              <a:effectRef idx="0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en-US"/>
              </a:p>
            </p:txBody>
          </p:sp>
          <p:grpSp>
            <p:nvGrpSpPr>
              <p:cNvPr id="21" name="Group 20">
                <a:extLst>
                  <a:ext uri="{FF2B5EF4-FFF2-40B4-BE49-F238E27FC236}">
                    <a16:creationId xmlns:a16="http://schemas.microsoft.com/office/drawing/2014/main" id="{DC145051-BFC0-2043-F828-70B285020A67}"/>
                  </a:ext>
                </a:extLst>
              </p:cNvPr>
              <p:cNvGrpSpPr/>
              <p:nvPr/>
            </p:nvGrpSpPr>
            <p:grpSpPr>
              <a:xfrm>
                <a:off x="1854584" y="3442684"/>
                <a:ext cx="1734767" cy="918496"/>
                <a:chOff x="12738721" y="4116477"/>
                <a:chExt cx="1889389" cy="1200615"/>
              </a:xfrm>
            </p:grpSpPr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id="{DC26FCF6-8105-07FD-A482-E76D313CF5E5}"/>
                    </a:ext>
                  </a:extLst>
                </p:cNvPr>
                <p:cNvSpPr txBox="1"/>
                <p:nvPr/>
              </p:nvSpPr>
              <p:spPr>
                <a:xfrm>
                  <a:off x="12878200" y="4116477"/>
                  <a:ext cx="976408" cy="40231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>
                      <a:solidFill>
                        <a:schemeClr val="bg1"/>
                      </a:solidFill>
                    </a:rPr>
                    <a:t>SEIZURE</a:t>
                  </a:r>
                </a:p>
              </p:txBody>
            </p:sp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id="{20D5383B-BCFD-EDA4-1607-F302C8703D84}"/>
                    </a:ext>
                  </a:extLst>
                </p:cNvPr>
                <p:cNvSpPr txBox="1"/>
                <p:nvPr/>
              </p:nvSpPr>
              <p:spPr>
                <a:xfrm>
                  <a:off x="12738721" y="4532586"/>
                  <a:ext cx="1889389" cy="78450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dirty="0"/>
                    <a:t>Uncontrollable body jerking, twitching, and movement</a:t>
                  </a:r>
                </a:p>
              </p:txBody>
            </p:sp>
          </p:grpSp>
        </p:grpSp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id="{A86AFDAC-6B77-F290-A635-5AC2DD4E499A}"/>
                </a:ext>
              </a:extLst>
            </p:cNvPr>
            <p:cNvGrpSpPr/>
            <p:nvPr/>
          </p:nvGrpSpPr>
          <p:grpSpPr>
            <a:xfrm>
              <a:off x="3761074" y="2269307"/>
              <a:ext cx="1734767" cy="932143"/>
              <a:chOff x="1854584" y="3429037"/>
              <a:chExt cx="1734767" cy="932143"/>
            </a:xfrm>
          </p:grpSpPr>
          <p:sp>
            <p:nvSpPr>
              <p:cNvPr id="25" name="Graphic 2" descr="A brushstroke">
                <a:extLst>
                  <a:ext uri="{FF2B5EF4-FFF2-40B4-BE49-F238E27FC236}">
                    <a16:creationId xmlns:a16="http://schemas.microsoft.com/office/drawing/2014/main" id="{22224D85-D9EC-90CB-08AB-B4973BF0FAD5}"/>
                  </a:ext>
                </a:extLst>
              </p:cNvPr>
              <p:cNvSpPr/>
              <p:nvPr/>
            </p:nvSpPr>
            <p:spPr>
              <a:xfrm>
                <a:off x="1891360" y="3429037"/>
                <a:ext cx="1180297" cy="320246"/>
              </a:xfrm>
              <a:custGeom>
                <a:avLst/>
                <a:gdLst>
                  <a:gd name="connsiteX0" fmla="*/ 42687 w 2401948"/>
                  <a:gd name="connsiteY0" fmla="*/ 296990 h 320246"/>
                  <a:gd name="connsiteX1" fmla="*/ 10363 w 2401948"/>
                  <a:gd name="connsiteY1" fmla="*/ 288863 h 320246"/>
                  <a:gd name="connsiteX2" fmla="*/ 42687 w 2401948"/>
                  <a:gd name="connsiteY2" fmla="*/ 296990 h 320246"/>
                  <a:gd name="connsiteX3" fmla="*/ 42927 w 2401948"/>
                  <a:gd name="connsiteY3" fmla="*/ 297130 h 320246"/>
                  <a:gd name="connsiteX4" fmla="*/ 43114 w 2401948"/>
                  <a:gd name="connsiteY4" fmla="*/ 297044 h 320246"/>
                  <a:gd name="connsiteX5" fmla="*/ 42687 w 2401948"/>
                  <a:gd name="connsiteY5" fmla="*/ 296990 h 320246"/>
                  <a:gd name="connsiteX6" fmla="*/ 42927 w 2401948"/>
                  <a:gd name="connsiteY6" fmla="*/ 297130 h 320246"/>
                  <a:gd name="connsiteX7" fmla="*/ 2392981 w 2401948"/>
                  <a:gd name="connsiteY7" fmla="*/ 9101 h 320246"/>
                  <a:gd name="connsiteX8" fmla="*/ 2383013 w 2401948"/>
                  <a:gd name="connsiteY8" fmla="*/ 9501 h 320246"/>
                  <a:gd name="connsiteX9" fmla="*/ 2392981 w 2401948"/>
                  <a:gd name="connsiteY9" fmla="*/ 9101 h 320246"/>
                  <a:gd name="connsiteX10" fmla="*/ 629607 w 2401948"/>
                  <a:gd name="connsiteY10" fmla="*/ 315626 h 320246"/>
                  <a:gd name="connsiteX11" fmla="*/ 631454 w 2401948"/>
                  <a:gd name="connsiteY11" fmla="*/ 304972 h 320246"/>
                  <a:gd name="connsiteX12" fmla="*/ 666385 w 2401948"/>
                  <a:gd name="connsiteY12" fmla="*/ 314533 h 320246"/>
                  <a:gd name="connsiteX13" fmla="*/ 719698 w 2401948"/>
                  <a:gd name="connsiteY13" fmla="*/ 308085 h 320246"/>
                  <a:gd name="connsiteX14" fmla="*/ 731673 w 2401948"/>
                  <a:gd name="connsiteY14" fmla="*/ 314459 h 320246"/>
                  <a:gd name="connsiteX15" fmla="*/ 753256 w 2401948"/>
                  <a:gd name="connsiteY15" fmla="*/ 310465 h 320246"/>
                  <a:gd name="connsiteX16" fmla="*/ 748848 w 2401948"/>
                  <a:gd name="connsiteY16" fmla="*/ 305552 h 320246"/>
                  <a:gd name="connsiteX17" fmla="*/ 767644 w 2401948"/>
                  <a:gd name="connsiteY17" fmla="*/ 302658 h 320246"/>
                  <a:gd name="connsiteX18" fmla="*/ 768818 w 2401948"/>
                  <a:gd name="connsiteY18" fmla="*/ 310999 h 320246"/>
                  <a:gd name="connsiteX19" fmla="*/ 1106660 w 2401948"/>
                  <a:gd name="connsiteY19" fmla="*/ 317686 h 320246"/>
                  <a:gd name="connsiteX20" fmla="*/ 1077316 w 2401948"/>
                  <a:gd name="connsiteY20" fmla="*/ 305958 h 320246"/>
                  <a:gd name="connsiteX21" fmla="*/ 1104080 w 2401948"/>
                  <a:gd name="connsiteY21" fmla="*/ 302138 h 320246"/>
                  <a:gd name="connsiteX22" fmla="*/ 1145411 w 2401948"/>
                  <a:gd name="connsiteY22" fmla="*/ 320247 h 320246"/>
                  <a:gd name="connsiteX23" fmla="*/ 1149425 w 2401948"/>
                  <a:gd name="connsiteY23" fmla="*/ 312052 h 320246"/>
                  <a:gd name="connsiteX24" fmla="*/ 1156379 w 2401948"/>
                  <a:gd name="connsiteY24" fmla="*/ 317066 h 320246"/>
                  <a:gd name="connsiteX25" fmla="*/ 1224975 w 2401948"/>
                  <a:gd name="connsiteY25" fmla="*/ 314839 h 320246"/>
                  <a:gd name="connsiteX26" fmla="*/ 1289103 w 2401948"/>
                  <a:gd name="connsiteY26" fmla="*/ 306398 h 320246"/>
                  <a:gd name="connsiteX27" fmla="*/ 1287709 w 2401948"/>
                  <a:gd name="connsiteY27" fmla="*/ 299204 h 320246"/>
                  <a:gd name="connsiteX28" fmla="*/ 1313459 w 2401948"/>
                  <a:gd name="connsiteY28" fmla="*/ 301304 h 320246"/>
                  <a:gd name="connsiteX29" fmla="*/ 1338635 w 2401948"/>
                  <a:gd name="connsiteY29" fmla="*/ 291490 h 320246"/>
                  <a:gd name="connsiteX30" fmla="*/ 1352411 w 2401948"/>
                  <a:gd name="connsiteY30" fmla="*/ 302671 h 320246"/>
                  <a:gd name="connsiteX31" fmla="*/ 1373406 w 2401948"/>
                  <a:gd name="connsiteY31" fmla="*/ 302238 h 320246"/>
                  <a:gd name="connsiteX32" fmla="*/ 1363379 w 2401948"/>
                  <a:gd name="connsiteY32" fmla="*/ 299497 h 320246"/>
                  <a:gd name="connsiteX33" fmla="*/ 1421306 w 2401948"/>
                  <a:gd name="connsiteY33" fmla="*/ 296784 h 320246"/>
                  <a:gd name="connsiteX34" fmla="*/ 1411558 w 2401948"/>
                  <a:gd name="connsiteY34" fmla="*/ 292877 h 320246"/>
                  <a:gd name="connsiteX35" fmla="*/ 1446702 w 2401948"/>
                  <a:gd name="connsiteY35" fmla="*/ 301244 h 320246"/>
                  <a:gd name="connsiteX36" fmla="*/ 1430514 w 2401948"/>
                  <a:gd name="connsiteY36" fmla="*/ 304238 h 320246"/>
                  <a:gd name="connsiteX37" fmla="*/ 1494235 w 2401948"/>
                  <a:gd name="connsiteY37" fmla="*/ 298171 h 320246"/>
                  <a:gd name="connsiteX38" fmla="*/ 1486454 w 2401948"/>
                  <a:gd name="connsiteY38" fmla="*/ 297904 h 320246"/>
                  <a:gd name="connsiteX39" fmla="*/ 1685072 w 2401948"/>
                  <a:gd name="connsiteY39" fmla="*/ 267987 h 320246"/>
                  <a:gd name="connsiteX40" fmla="*/ 1673291 w 2401948"/>
                  <a:gd name="connsiteY40" fmla="*/ 260433 h 320246"/>
                  <a:gd name="connsiteX41" fmla="*/ 1695293 w 2401948"/>
                  <a:gd name="connsiteY41" fmla="*/ 254072 h 320246"/>
                  <a:gd name="connsiteX42" fmla="*/ 1682492 w 2401948"/>
                  <a:gd name="connsiteY42" fmla="*/ 276135 h 320246"/>
                  <a:gd name="connsiteX43" fmla="*/ 2018440 w 2401948"/>
                  <a:gd name="connsiteY43" fmla="*/ 274661 h 320246"/>
                  <a:gd name="connsiteX44" fmla="*/ 2021401 w 2401948"/>
                  <a:gd name="connsiteY44" fmla="*/ 287849 h 320246"/>
                  <a:gd name="connsiteX45" fmla="*/ 2048804 w 2401948"/>
                  <a:gd name="connsiteY45" fmla="*/ 280488 h 320246"/>
                  <a:gd name="connsiteX46" fmla="*/ 2044984 w 2401948"/>
                  <a:gd name="connsiteY46" fmla="*/ 287489 h 320246"/>
                  <a:gd name="connsiteX47" fmla="*/ 2060946 w 2401948"/>
                  <a:gd name="connsiteY47" fmla="*/ 285682 h 320246"/>
                  <a:gd name="connsiteX48" fmla="*/ 2050985 w 2401948"/>
                  <a:gd name="connsiteY48" fmla="*/ 267494 h 320246"/>
                  <a:gd name="connsiteX49" fmla="*/ 2074367 w 2401948"/>
                  <a:gd name="connsiteY49" fmla="*/ 268307 h 320246"/>
                  <a:gd name="connsiteX50" fmla="*/ 2073327 w 2401948"/>
                  <a:gd name="connsiteY50" fmla="*/ 274221 h 320246"/>
                  <a:gd name="connsiteX51" fmla="*/ 2109519 w 2401948"/>
                  <a:gd name="connsiteY51" fmla="*/ 261226 h 320246"/>
                  <a:gd name="connsiteX52" fmla="*/ 2229334 w 2401948"/>
                  <a:gd name="connsiteY52" fmla="*/ 263080 h 320246"/>
                  <a:gd name="connsiteX53" fmla="*/ 2212345 w 2401948"/>
                  <a:gd name="connsiteY53" fmla="*/ 270801 h 320246"/>
                  <a:gd name="connsiteX54" fmla="*/ 2230347 w 2401948"/>
                  <a:gd name="connsiteY54" fmla="*/ 272621 h 320246"/>
                  <a:gd name="connsiteX55" fmla="*/ 2239342 w 2401948"/>
                  <a:gd name="connsiteY55" fmla="*/ 265807 h 320246"/>
                  <a:gd name="connsiteX56" fmla="*/ 2330006 w 2401948"/>
                  <a:gd name="connsiteY56" fmla="*/ 254738 h 320246"/>
                  <a:gd name="connsiteX57" fmla="*/ 2383953 w 2401948"/>
                  <a:gd name="connsiteY57" fmla="*/ 15909 h 320246"/>
                  <a:gd name="connsiteX58" fmla="*/ 2401949 w 2401948"/>
                  <a:gd name="connsiteY58" fmla="*/ 17742 h 320246"/>
                  <a:gd name="connsiteX59" fmla="*/ 2376385 w 2401948"/>
                  <a:gd name="connsiteY59" fmla="*/ 14449 h 320246"/>
                  <a:gd name="connsiteX60" fmla="*/ 2374978 w 2401948"/>
                  <a:gd name="connsiteY60" fmla="*/ 22736 h 320246"/>
                  <a:gd name="connsiteX61" fmla="*/ 2352222 w 2401948"/>
                  <a:gd name="connsiteY61" fmla="*/ 18376 h 320246"/>
                  <a:gd name="connsiteX62" fmla="*/ 2383006 w 2401948"/>
                  <a:gd name="connsiteY62" fmla="*/ 9495 h 320246"/>
                  <a:gd name="connsiteX63" fmla="*/ 2350822 w 2401948"/>
                  <a:gd name="connsiteY63" fmla="*/ 11188 h 320246"/>
                  <a:gd name="connsiteX64" fmla="*/ 2337060 w 2401948"/>
                  <a:gd name="connsiteY64" fmla="*/ 0 h 320246"/>
                  <a:gd name="connsiteX65" fmla="*/ 2299676 w 2401948"/>
                  <a:gd name="connsiteY65" fmla="*/ 4621 h 320246"/>
                  <a:gd name="connsiteX66" fmla="*/ 2299896 w 2401948"/>
                  <a:gd name="connsiteY66" fmla="*/ 3427 h 320246"/>
                  <a:gd name="connsiteX67" fmla="*/ 2226207 w 2401948"/>
                  <a:gd name="connsiteY67" fmla="*/ 6788 h 320246"/>
                  <a:gd name="connsiteX68" fmla="*/ 2229174 w 2401948"/>
                  <a:gd name="connsiteY68" fmla="*/ 4521 h 320246"/>
                  <a:gd name="connsiteX69" fmla="*/ 2182688 w 2401948"/>
                  <a:gd name="connsiteY69" fmla="*/ 1687 h 320246"/>
                  <a:gd name="connsiteX70" fmla="*/ 2181494 w 2401948"/>
                  <a:gd name="connsiteY70" fmla="*/ 8768 h 320246"/>
                  <a:gd name="connsiteX71" fmla="*/ 2132742 w 2401948"/>
                  <a:gd name="connsiteY71" fmla="*/ 3487 h 320246"/>
                  <a:gd name="connsiteX72" fmla="*/ 2118566 w 2401948"/>
                  <a:gd name="connsiteY72" fmla="*/ 10128 h 320246"/>
                  <a:gd name="connsiteX73" fmla="*/ 1699761 w 2401948"/>
                  <a:gd name="connsiteY73" fmla="*/ 19329 h 320246"/>
                  <a:gd name="connsiteX74" fmla="*/ 1702528 w 2401948"/>
                  <a:gd name="connsiteY74" fmla="*/ 18269 h 320246"/>
                  <a:gd name="connsiteX75" fmla="*/ 1262633 w 2401948"/>
                  <a:gd name="connsiteY75" fmla="*/ 30217 h 320246"/>
                  <a:gd name="connsiteX76" fmla="*/ 1203739 w 2401948"/>
                  <a:gd name="connsiteY76" fmla="*/ 23390 h 320246"/>
                  <a:gd name="connsiteX77" fmla="*/ 1202505 w 2401948"/>
                  <a:gd name="connsiteY77" fmla="*/ 30484 h 320246"/>
                  <a:gd name="connsiteX78" fmla="*/ 1143491 w 2401948"/>
                  <a:gd name="connsiteY78" fmla="*/ 37798 h 320246"/>
                  <a:gd name="connsiteX79" fmla="*/ 779472 w 2401948"/>
                  <a:gd name="connsiteY79" fmla="*/ 31391 h 320246"/>
                  <a:gd name="connsiteX80" fmla="*/ 681427 w 2401948"/>
                  <a:gd name="connsiteY80" fmla="*/ 39832 h 320246"/>
                  <a:gd name="connsiteX81" fmla="*/ 684420 w 2401948"/>
                  <a:gd name="connsiteY81" fmla="*/ 37558 h 320246"/>
                  <a:gd name="connsiteX82" fmla="*/ 434409 w 2401948"/>
                  <a:gd name="connsiteY82" fmla="*/ 35705 h 320246"/>
                  <a:gd name="connsiteX83" fmla="*/ 439403 w 2401948"/>
                  <a:gd name="connsiteY83" fmla="*/ 37085 h 320246"/>
                  <a:gd name="connsiteX84" fmla="*/ 385903 w 2401948"/>
                  <a:gd name="connsiteY84" fmla="*/ 29244 h 320246"/>
                  <a:gd name="connsiteX85" fmla="*/ 350919 w 2401948"/>
                  <a:gd name="connsiteY85" fmla="*/ 47006 h 320246"/>
                  <a:gd name="connsiteX86" fmla="*/ 351319 w 2401948"/>
                  <a:gd name="connsiteY86" fmla="*/ 44639 h 320246"/>
                  <a:gd name="connsiteX87" fmla="*/ 272842 w 2401948"/>
                  <a:gd name="connsiteY87" fmla="*/ 57301 h 320246"/>
                  <a:gd name="connsiteX88" fmla="*/ 273876 w 2401948"/>
                  <a:gd name="connsiteY88" fmla="*/ 51386 h 320246"/>
                  <a:gd name="connsiteX89" fmla="*/ 194759 w 2401948"/>
                  <a:gd name="connsiteY89" fmla="*/ 55720 h 320246"/>
                  <a:gd name="connsiteX90" fmla="*/ 54588 w 2401948"/>
                  <a:gd name="connsiteY90" fmla="*/ 50793 h 320246"/>
                  <a:gd name="connsiteX91" fmla="*/ 23378 w 2401948"/>
                  <a:gd name="connsiteY91" fmla="*/ 33938 h 320246"/>
                  <a:gd name="connsiteX92" fmla="*/ 18811 w 2401948"/>
                  <a:gd name="connsiteY92" fmla="*/ 35611 h 320246"/>
                  <a:gd name="connsiteX93" fmla="*/ 32352 w 2401948"/>
                  <a:gd name="connsiteY93" fmla="*/ 282502 h 320246"/>
                  <a:gd name="connsiteX94" fmla="*/ 31339 w 2401948"/>
                  <a:gd name="connsiteY94" fmla="*/ 288403 h 320246"/>
                  <a:gd name="connsiteX95" fmla="*/ 43954 w 2401948"/>
                  <a:gd name="connsiteY95" fmla="*/ 287643 h 320246"/>
                  <a:gd name="connsiteX96" fmla="*/ 65063 w 2401948"/>
                  <a:gd name="connsiteY96" fmla="*/ 289596 h 320246"/>
                  <a:gd name="connsiteX97" fmla="*/ 44327 w 2401948"/>
                  <a:gd name="connsiteY97" fmla="*/ 288876 h 320246"/>
                  <a:gd name="connsiteX98" fmla="*/ 43114 w 2401948"/>
                  <a:gd name="connsiteY98" fmla="*/ 297057 h 320246"/>
                  <a:gd name="connsiteX99" fmla="*/ 60682 w 2401948"/>
                  <a:gd name="connsiteY99" fmla="*/ 300144 h 320246"/>
                  <a:gd name="connsiteX100" fmla="*/ 56115 w 2401948"/>
                  <a:gd name="connsiteY100" fmla="*/ 296410 h 320246"/>
                  <a:gd name="connsiteX101" fmla="*/ 85652 w 2401948"/>
                  <a:gd name="connsiteY101" fmla="*/ 291503 h 320246"/>
                  <a:gd name="connsiteX102" fmla="*/ 104821 w 2401948"/>
                  <a:gd name="connsiteY102" fmla="*/ 301704 h 320246"/>
                  <a:gd name="connsiteX103" fmla="*/ 390404 w 2401948"/>
                  <a:gd name="connsiteY103" fmla="*/ 311779 h 320246"/>
                  <a:gd name="connsiteX104" fmla="*/ 387183 w 2401948"/>
                  <a:gd name="connsiteY104" fmla="*/ 315239 h 320246"/>
                  <a:gd name="connsiteX105" fmla="*/ 468880 w 2401948"/>
                  <a:gd name="connsiteY105" fmla="*/ 310972 h 320246"/>
                  <a:gd name="connsiteX106" fmla="*/ 480462 w 2401948"/>
                  <a:gd name="connsiteY106" fmla="*/ 319707 h 320246"/>
                  <a:gd name="connsiteX107" fmla="*/ 629607 w 2401948"/>
                  <a:gd name="connsiteY107" fmla="*/ 315626 h 3202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  <a:cxn ang="0">
                    <a:pos x="connsiteX69" y="connsiteY69"/>
                  </a:cxn>
                  <a:cxn ang="0">
                    <a:pos x="connsiteX70" y="connsiteY70"/>
                  </a:cxn>
                  <a:cxn ang="0">
                    <a:pos x="connsiteX71" y="connsiteY71"/>
                  </a:cxn>
                  <a:cxn ang="0">
                    <a:pos x="connsiteX72" y="connsiteY72"/>
                  </a:cxn>
                  <a:cxn ang="0">
                    <a:pos x="connsiteX73" y="connsiteY73"/>
                  </a:cxn>
                  <a:cxn ang="0">
                    <a:pos x="connsiteX74" y="connsiteY74"/>
                  </a:cxn>
                  <a:cxn ang="0">
                    <a:pos x="connsiteX75" y="connsiteY75"/>
                  </a:cxn>
                  <a:cxn ang="0">
                    <a:pos x="connsiteX76" y="connsiteY76"/>
                  </a:cxn>
                  <a:cxn ang="0">
                    <a:pos x="connsiteX77" y="connsiteY77"/>
                  </a:cxn>
                  <a:cxn ang="0">
                    <a:pos x="connsiteX78" y="connsiteY78"/>
                  </a:cxn>
                  <a:cxn ang="0">
                    <a:pos x="connsiteX79" y="connsiteY79"/>
                  </a:cxn>
                  <a:cxn ang="0">
                    <a:pos x="connsiteX80" y="connsiteY80"/>
                  </a:cxn>
                  <a:cxn ang="0">
                    <a:pos x="connsiteX81" y="connsiteY81"/>
                  </a:cxn>
                  <a:cxn ang="0">
                    <a:pos x="connsiteX82" y="connsiteY82"/>
                  </a:cxn>
                  <a:cxn ang="0">
                    <a:pos x="connsiteX83" y="connsiteY83"/>
                  </a:cxn>
                  <a:cxn ang="0">
                    <a:pos x="connsiteX84" y="connsiteY84"/>
                  </a:cxn>
                  <a:cxn ang="0">
                    <a:pos x="connsiteX85" y="connsiteY85"/>
                  </a:cxn>
                  <a:cxn ang="0">
                    <a:pos x="connsiteX86" y="connsiteY86"/>
                  </a:cxn>
                  <a:cxn ang="0">
                    <a:pos x="connsiteX87" y="connsiteY87"/>
                  </a:cxn>
                  <a:cxn ang="0">
                    <a:pos x="connsiteX88" y="connsiteY88"/>
                  </a:cxn>
                  <a:cxn ang="0">
                    <a:pos x="connsiteX89" y="connsiteY89"/>
                  </a:cxn>
                  <a:cxn ang="0">
                    <a:pos x="connsiteX90" y="connsiteY90"/>
                  </a:cxn>
                  <a:cxn ang="0">
                    <a:pos x="connsiteX91" y="connsiteY91"/>
                  </a:cxn>
                  <a:cxn ang="0">
                    <a:pos x="connsiteX92" y="connsiteY92"/>
                  </a:cxn>
                  <a:cxn ang="0">
                    <a:pos x="connsiteX93" y="connsiteY93"/>
                  </a:cxn>
                  <a:cxn ang="0">
                    <a:pos x="connsiteX94" y="connsiteY94"/>
                  </a:cxn>
                  <a:cxn ang="0">
                    <a:pos x="connsiteX95" y="connsiteY95"/>
                  </a:cxn>
                  <a:cxn ang="0">
                    <a:pos x="connsiteX96" y="connsiteY96"/>
                  </a:cxn>
                  <a:cxn ang="0">
                    <a:pos x="connsiteX97" y="connsiteY97"/>
                  </a:cxn>
                  <a:cxn ang="0">
                    <a:pos x="connsiteX98" y="connsiteY98"/>
                  </a:cxn>
                  <a:cxn ang="0">
                    <a:pos x="connsiteX99" y="connsiteY99"/>
                  </a:cxn>
                  <a:cxn ang="0">
                    <a:pos x="connsiteX100" y="connsiteY100"/>
                  </a:cxn>
                  <a:cxn ang="0">
                    <a:pos x="connsiteX101" y="connsiteY101"/>
                  </a:cxn>
                  <a:cxn ang="0">
                    <a:pos x="connsiteX102" y="connsiteY102"/>
                  </a:cxn>
                  <a:cxn ang="0">
                    <a:pos x="connsiteX103" y="connsiteY103"/>
                  </a:cxn>
                  <a:cxn ang="0">
                    <a:pos x="connsiteX104" y="connsiteY104"/>
                  </a:cxn>
                  <a:cxn ang="0">
                    <a:pos x="connsiteX105" y="connsiteY105"/>
                  </a:cxn>
                  <a:cxn ang="0">
                    <a:pos x="connsiteX106" y="connsiteY106"/>
                  </a:cxn>
                  <a:cxn ang="0">
                    <a:pos x="connsiteX107" y="connsiteY107"/>
                  </a:cxn>
                </a:cxnLst>
                <a:rect l="l" t="t" r="r" b="b"/>
                <a:pathLst>
                  <a:path w="2401948" h="320246">
                    <a:moveTo>
                      <a:pt x="42687" y="296990"/>
                    </a:moveTo>
                    <a:cubicBezTo>
                      <a:pt x="30572" y="295917"/>
                      <a:pt x="17777" y="295297"/>
                      <a:pt x="10363" y="288863"/>
                    </a:cubicBezTo>
                    <a:cubicBezTo>
                      <a:pt x="23451" y="288149"/>
                      <a:pt x="33366" y="290830"/>
                      <a:pt x="42687" y="296990"/>
                    </a:cubicBezTo>
                    <a:close/>
                    <a:moveTo>
                      <a:pt x="42927" y="297130"/>
                    </a:moveTo>
                    <a:cubicBezTo>
                      <a:pt x="42974" y="297097"/>
                      <a:pt x="43060" y="297070"/>
                      <a:pt x="43114" y="297044"/>
                    </a:cubicBezTo>
                    <a:cubicBezTo>
                      <a:pt x="42947" y="297037"/>
                      <a:pt x="42827" y="297011"/>
                      <a:pt x="42687" y="296990"/>
                    </a:cubicBezTo>
                    <a:cubicBezTo>
                      <a:pt x="42780" y="297057"/>
                      <a:pt x="42854" y="297070"/>
                      <a:pt x="42927" y="297130"/>
                    </a:cubicBezTo>
                    <a:close/>
                    <a:moveTo>
                      <a:pt x="2392981" y="9101"/>
                    </a:moveTo>
                    <a:cubicBezTo>
                      <a:pt x="2389954" y="9228"/>
                      <a:pt x="2386507" y="9355"/>
                      <a:pt x="2383013" y="9501"/>
                    </a:cubicBezTo>
                    <a:cubicBezTo>
                      <a:pt x="2386347" y="9695"/>
                      <a:pt x="2389747" y="9715"/>
                      <a:pt x="2392981" y="9101"/>
                    </a:cubicBezTo>
                    <a:close/>
                    <a:moveTo>
                      <a:pt x="629607" y="315626"/>
                    </a:moveTo>
                    <a:lnTo>
                      <a:pt x="631454" y="304972"/>
                    </a:lnTo>
                    <a:cubicBezTo>
                      <a:pt x="660191" y="304818"/>
                      <a:pt x="639821" y="317166"/>
                      <a:pt x="666385" y="314533"/>
                    </a:cubicBezTo>
                    <a:cubicBezTo>
                      <a:pt x="676779" y="299457"/>
                      <a:pt x="710517" y="316093"/>
                      <a:pt x="719698" y="308085"/>
                    </a:cubicBezTo>
                    <a:cubicBezTo>
                      <a:pt x="719491" y="309285"/>
                      <a:pt x="732500" y="309739"/>
                      <a:pt x="731673" y="314459"/>
                    </a:cubicBezTo>
                    <a:cubicBezTo>
                      <a:pt x="735653" y="306272"/>
                      <a:pt x="745055" y="312559"/>
                      <a:pt x="753256" y="310465"/>
                    </a:cubicBezTo>
                    <a:cubicBezTo>
                      <a:pt x="756229" y="308192"/>
                      <a:pt x="751075" y="308019"/>
                      <a:pt x="748848" y="305552"/>
                    </a:cubicBezTo>
                    <a:lnTo>
                      <a:pt x="767644" y="302658"/>
                    </a:lnTo>
                    <a:cubicBezTo>
                      <a:pt x="774992" y="305291"/>
                      <a:pt x="776805" y="310106"/>
                      <a:pt x="768818" y="310999"/>
                    </a:cubicBezTo>
                    <a:cubicBezTo>
                      <a:pt x="817937" y="313933"/>
                      <a:pt x="1053747" y="321774"/>
                      <a:pt x="1106660" y="317686"/>
                    </a:cubicBezTo>
                    <a:cubicBezTo>
                      <a:pt x="1099859" y="311506"/>
                      <a:pt x="1083524" y="315680"/>
                      <a:pt x="1077316" y="305958"/>
                    </a:cubicBezTo>
                    <a:cubicBezTo>
                      <a:pt x="1091305" y="300511"/>
                      <a:pt x="1097912" y="307865"/>
                      <a:pt x="1104080" y="302138"/>
                    </a:cubicBezTo>
                    <a:cubicBezTo>
                      <a:pt x="1109447" y="316593"/>
                      <a:pt x="1134823" y="305598"/>
                      <a:pt x="1145411" y="320247"/>
                    </a:cubicBezTo>
                    <a:lnTo>
                      <a:pt x="1149425" y="312052"/>
                    </a:lnTo>
                    <a:lnTo>
                      <a:pt x="1156379" y="317066"/>
                    </a:lnTo>
                    <a:cubicBezTo>
                      <a:pt x="1217900" y="308539"/>
                      <a:pt x="1170435" y="312906"/>
                      <a:pt x="1224975" y="314839"/>
                    </a:cubicBezTo>
                    <a:cubicBezTo>
                      <a:pt x="1256539" y="313579"/>
                      <a:pt x="1271540" y="302211"/>
                      <a:pt x="1289103" y="306398"/>
                    </a:cubicBezTo>
                    <a:cubicBezTo>
                      <a:pt x="1286496" y="306312"/>
                      <a:pt x="1279535" y="301298"/>
                      <a:pt x="1287709" y="299204"/>
                    </a:cubicBezTo>
                    <a:cubicBezTo>
                      <a:pt x="1289103" y="306398"/>
                      <a:pt x="1309479" y="294044"/>
                      <a:pt x="1313459" y="301304"/>
                    </a:cubicBezTo>
                    <a:cubicBezTo>
                      <a:pt x="1321467" y="300398"/>
                      <a:pt x="1347417" y="301324"/>
                      <a:pt x="1338635" y="291490"/>
                    </a:cubicBezTo>
                    <a:cubicBezTo>
                      <a:pt x="1343043" y="296397"/>
                      <a:pt x="1366192" y="298411"/>
                      <a:pt x="1352411" y="302671"/>
                    </a:cubicBezTo>
                    <a:cubicBezTo>
                      <a:pt x="1360218" y="302958"/>
                      <a:pt x="1367786" y="304405"/>
                      <a:pt x="1373406" y="302238"/>
                    </a:cubicBezTo>
                    <a:lnTo>
                      <a:pt x="1363379" y="299497"/>
                    </a:lnTo>
                    <a:cubicBezTo>
                      <a:pt x="1389755" y="298071"/>
                      <a:pt x="1404124" y="305685"/>
                      <a:pt x="1421306" y="296784"/>
                    </a:cubicBezTo>
                    <a:lnTo>
                      <a:pt x="1411558" y="292877"/>
                    </a:lnTo>
                    <a:cubicBezTo>
                      <a:pt x="1427327" y="292257"/>
                      <a:pt x="1440515" y="291517"/>
                      <a:pt x="1446702" y="301244"/>
                    </a:cubicBezTo>
                    <a:lnTo>
                      <a:pt x="1430514" y="304238"/>
                    </a:lnTo>
                    <a:cubicBezTo>
                      <a:pt x="1456664" y="303985"/>
                      <a:pt x="1472439" y="303351"/>
                      <a:pt x="1494235" y="298171"/>
                    </a:cubicBezTo>
                    <a:lnTo>
                      <a:pt x="1486454" y="297904"/>
                    </a:lnTo>
                    <a:cubicBezTo>
                      <a:pt x="1514224" y="288183"/>
                      <a:pt x="1659489" y="280155"/>
                      <a:pt x="1685072" y="267987"/>
                    </a:cubicBezTo>
                    <a:lnTo>
                      <a:pt x="1673291" y="260433"/>
                    </a:lnTo>
                    <a:lnTo>
                      <a:pt x="1695293" y="254072"/>
                    </a:lnTo>
                    <a:cubicBezTo>
                      <a:pt x="1692686" y="253978"/>
                      <a:pt x="1684672" y="278595"/>
                      <a:pt x="1682492" y="276135"/>
                    </a:cubicBezTo>
                    <a:cubicBezTo>
                      <a:pt x="1729638" y="275434"/>
                      <a:pt x="1974895" y="269574"/>
                      <a:pt x="2018440" y="274661"/>
                    </a:cubicBezTo>
                    <a:cubicBezTo>
                      <a:pt x="2036009" y="278848"/>
                      <a:pt x="2021601" y="286656"/>
                      <a:pt x="2021401" y="287849"/>
                    </a:cubicBezTo>
                    <a:cubicBezTo>
                      <a:pt x="2042784" y="285029"/>
                      <a:pt x="2030622" y="279842"/>
                      <a:pt x="2048804" y="280488"/>
                    </a:cubicBezTo>
                    <a:cubicBezTo>
                      <a:pt x="2053765" y="281849"/>
                      <a:pt x="2047777" y="286409"/>
                      <a:pt x="2044984" y="287489"/>
                    </a:cubicBezTo>
                    <a:cubicBezTo>
                      <a:pt x="2052951" y="286596"/>
                      <a:pt x="2060339" y="289210"/>
                      <a:pt x="2060946" y="285682"/>
                    </a:cubicBezTo>
                    <a:cubicBezTo>
                      <a:pt x="2050985" y="282942"/>
                      <a:pt x="2055198" y="273581"/>
                      <a:pt x="2050985" y="267494"/>
                    </a:cubicBezTo>
                    <a:lnTo>
                      <a:pt x="2074367" y="268307"/>
                    </a:lnTo>
                    <a:lnTo>
                      <a:pt x="2073327" y="274221"/>
                    </a:lnTo>
                    <a:cubicBezTo>
                      <a:pt x="2078541" y="274401"/>
                      <a:pt x="2086549" y="258046"/>
                      <a:pt x="2109519" y="261226"/>
                    </a:cubicBezTo>
                    <a:cubicBezTo>
                      <a:pt x="2148270" y="263786"/>
                      <a:pt x="2190362" y="261713"/>
                      <a:pt x="2229334" y="263080"/>
                    </a:cubicBezTo>
                    <a:cubicBezTo>
                      <a:pt x="2228727" y="266627"/>
                      <a:pt x="2220546" y="268720"/>
                      <a:pt x="2212345" y="270801"/>
                    </a:cubicBezTo>
                    <a:cubicBezTo>
                      <a:pt x="2217572" y="270981"/>
                      <a:pt x="2225533" y="270074"/>
                      <a:pt x="2230347" y="272621"/>
                    </a:cubicBezTo>
                    <a:cubicBezTo>
                      <a:pt x="2220932" y="266353"/>
                      <a:pt x="2246703" y="268447"/>
                      <a:pt x="2239342" y="265807"/>
                    </a:cubicBezTo>
                    <a:cubicBezTo>
                      <a:pt x="2267885" y="251352"/>
                      <a:pt x="2304810" y="264553"/>
                      <a:pt x="2330006" y="254738"/>
                    </a:cubicBezTo>
                    <a:cubicBezTo>
                      <a:pt x="2332206" y="241737"/>
                      <a:pt x="2383953" y="31371"/>
                      <a:pt x="2383953" y="15909"/>
                    </a:cubicBezTo>
                    <a:cubicBezTo>
                      <a:pt x="2391774" y="16189"/>
                      <a:pt x="2399555" y="16469"/>
                      <a:pt x="2401949" y="17742"/>
                    </a:cubicBezTo>
                    <a:cubicBezTo>
                      <a:pt x="2399928" y="14109"/>
                      <a:pt x="2384553" y="12368"/>
                      <a:pt x="2376385" y="14449"/>
                    </a:cubicBezTo>
                    <a:lnTo>
                      <a:pt x="2374978" y="22736"/>
                    </a:lnTo>
                    <a:cubicBezTo>
                      <a:pt x="2356176" y="25643"/>
                      <a:pt x="2370571" y="17816"/>
                      <a:pt x="2352222" y="18376"/>
                    </a:cubicBezTo>
                    <a:cubicBezTo>
                      <a:pt x="2351242" y="11595"/>
                      <a:pt x="2368131" y="10148"/>
                      <a:pt x="2383006" y="9495"/>
                    </a:cubicBezTo>
                    <a:cubicBezTo>
                      <a:pt x="2369611" y="8708"/>
                      <a:pt x="2356276" y="3767"/>
                      <a:pt x="2350822" y="11188"/>
                    </a:cubicBezTo>
                    <a:cubicBezTo>
                      <a:pt x="2338234" y="8368"/>
                      <a:pt x="2352222" y="2900"/>
                      <a:pt x="2337060" y="0"/>
                    </a:cubicBezTo>
                    <a:cubicBezTo>
                      <a:pt x="2326266" y="1994"/>
                      <a:pt x="2312077" y="8628"/>
                      <a:pt x="2299676" y="4621"/>
                    </a:cubicBezTo>
                    <a:lnTo>
                      <a:pt x="2299896" y="3427"/>
                    </a:lnTo>
                    <a:cubicBezTo>
                      <a:pt x="2269739" y="-3574"/>
                      <a:pt x="2253757" y="13708"/>
                      <a:pt x="2226207" y="6788"/>
                    </a:cubicBezTo>
                    <a:lnTo>
                      <a:pt x="2229174" y="4521"/>
                    </a:lnTo>
                    <a:cubicBezTo>
                      <a:pt x="2219432" y="600"/>
                      <a:pt x="2200257" y="5867"/>
                      <a:pt x="2182688" y="1687"/>
                    </a:cubicBezTo>
                    <a:cubicBezTo>
                      <a:pt x="2187702" y="3054"/>
                      <a:pt x="2192056" y="7961"/>
                      <a:pt x="2181494" y="8768"/>
                    </a:cubicBezTo>
                    <a:cubicBezTo>
                      <a:pt x="2161292" y="4494"/>
                      <a:pt x="2147510" y="8768"/>
                      <a:pt x="2132742" y="3487"/>
                    </a:cubicBezTo>
                    <a:lnTo>
                      <a:pt x="2118566" y="10128"/>
                    </a:lnTo>
                    <a:cubicBezTo>
                      <a:pt x="2048231" y="8835"/>
                      <a:pt x="1770416" y="18269"/>
                      <a:pt x="1699761" y="19329"/>
                    </a:cubicBezTo>
                    <a:lnTo>
                      <a:pt x="1702528" y="18269"/>
                    </a:lnTo>
                    <a:cubicBezTo>
                      <a:pt x="1594874" y="21589"/>
                      <a:pt x="1373893" y="21069"/>
                      <a:pt x="1262633" y="30217"/>
                    </a:cubicBezTo>
                    <a:cubicBezTo>
                      <a:pt x="1245424" y="23683"/>
                      <a:pt x="1221694" y="25217"/>
                      <a:pt x="1203739" y="23390"/>
                    </a:cubicBezTo>
                    <a:cubicBezTo>
                      <a:pt x="1213720" y="26117"/>
                      <a:pt x="1210300" y="30751"/>
                      <a:pt x="1202505" y="30484"/>
                    </a:cubicBezTo>
                    <a:cubicBezTo>
                      <a:pt x="1147805" y="29730"/>
                      <a:pt x="1198811" y="35004"/>
                      <a:pt x="1143491" y="37798"/>
                    </a:cubicBezTo>
                    <a:cubicBezTo>
                      <a:pt x="1079790" y="43879"/>
                      <a:pt x="836019" y="36958"/>
                      <a:pt x="779472" y="31391"/>
                    </a:cubicBezTo>
                    <a:cubicBezTo>
                      <a:pt x="749102" y="41025"/>
                      <a:pt x="711184" y="33738"/>
                      <a:pt x="681427" y="39832"/>
                    </a:cubicBezTo>
                    <a:lnTo>
                      <a:pt x="684420" y="37558"/>
                    </a:lnTo>
                    <a:cubicBezTo>
                      <a:pt x="652463" y="41185"/>
                      <a:pt x="471554" y="32257"/>
                      <a:pt x="434409" y="35705"/>
                    </a:cubicBezTo>
                    <a:lnTo>
                      <a:pt x="439403" y="37085"/>
                    </a:lnTo>
                    <a:cubicBezTo>
                      <a:pt x="407012" y="43065"/>
                      <a:pt x="411426" y="32524"/>
                      <a:pt x="385903" y="29244"/>
                    </a:cubicBezTo>
                    <a:cubicBezTo>
                      <a:pt x="389257" y="40052"/>
                      <a:pt x="361500" y="46193"/>
                      <a:pt x="350919" y="47006"/>
                    </a:cubicBezTo>
                    <a:lnTo>
                      <a:pt x="351319" y="44639"/>
                    </a:lnTo>
                    <a:cubicBezTo>
                      <a:pt x="335357" y="46459"/>
                      <a:pt x="299199" y="55847"/>
                      <a:pt x="272842" y="57301"/>
                    </a:cubicBezTo>
                    <a:lnTo>
                      <a:pt x="273876" y="51386"/>
                    </a:lnTo>
                    <a:cubicBezTo>
                      <a:pt x="251893" y="57741"/>
                      <a:pt x="210561" y="55100"/>
                      <a:pt x="194759" y="55720"/>
                    </a:cubicBezTo>
                    <a:cubicBezTo>
                      <a:pt x="158628" y="53273"/>
                      <a:pt x="102901" y="42979"/>
                      <a:pt x="54588" y="50793"/>
                    </a:cubicBezTo>
                    <a:lnTo>
                      <a:pt x="23378" y="33938"/>
                    </a:lnTo>
                    <a:lnTo>
                      <a:pt x="18811" y="35611"/>
                    </a:lnTo>
                    <a:cubicBezTo>
                      <a:pt x="18811" y="35611"/>
                      <a:pt x="-31456" y="239150"/>
                      <a:pt x="32352" y="282502"/>
                    </a:cubicBezTo>
                    <a:lnTo>
                      <a:pt x="31339" y="288403"/>
                    </a:lnTo>
                    <a:lnTo>
                      <a:pt x="43954" y="287643"/>
                    </a:lnTo>
                    <a:cubicBezTo>
                      <a:pt x="59089" y="290550"/>
                      <a:pt x="66090" y="283709"/>
                      <a:pt x="65063" y="289596"/>
                    </a:cubicBezTo>
                    <a:lnTo>
                      <a:pt x="44327" y="288876"/>
                    </a:lnTo>
                    <a:cubicBezTo>
                      <a:pt x="59536" y="290583"/>
                      <a:pt x="48914" y="293717"/>
                      <a:pt x="43114" y="297057"/>
                    </a:cubicBezTo>
                    <a:cubicBezTo>
                      <a:pt x="49461" y="297624"/>
                      <a:pt x="55628" y="298337"/>
                      <a:pt x="60682" y="300144"/>
                    </a:cubicBezTo>
                    <a:cubicBezTo>
                      <a:pt x="63676" y="297877"/>
                      <a:pt x="58482" y="297697"/>
                      <a:pt x="56115" y="296410"/>
                    </a:cubicBezTo>
                    <a:cubicBezTo>
                      <a:pt x="64296" y="294330"/>
                      <a:pt x="75691" y="288783"/>
                      <a:pt x="85652" y="291503"/>
                    </a:cubicBezTo>
                    <a:cubicBezTo>
                      <a:pt x="101227" y="292057"/>
                      <a:pt x="86646" y="301064"/>
                      <a:pt x="104821" y="301704"/>
                    </a:cubicBezTo>
                    <a:cubicBezTo>
                      <a:pt x="200667" y="306272"/>
                      <a:pt x="293532" y="313112"/>
                      <a:pt x="390404" y="311779"/>
                    </a:cubicBezTo>
                    <a:cubicBezTo>
                      <a:pt x="392604" y="314226"/>
                      <a:pt x="389984" y="314139"/>
                      <a:pt x="387183" y="315239"/>
                    </a:cubicBezTo>
                    <a:cubicBezTo>
                      <a:pt x="416367" y="312692"/>
                      <a:pt x="442310" y="313613"/>
                      <a:pt x="468880" y="310972"/>
                    </a:cubicBezTo>
                    <a:cubicBezTo>
                      <a:pt x="476261" y="313613"/>
                      <a:pt x="478275" y="317253"/>
                      <a:pt x="480462" y="319707"/>
                    </a:cubicBezTo>
                    <a:cubicBezTo>
                      <a:pt x="476068" y="314799"/>
                      <a:pt x="627213" y="314353"/>
                      <a:pt x="629607" y="315626"/>
                    </a:cubicBezTo>
                    <a:close/>
                  </a:path>
                </a:pathLst>
              </a:custGeom>
              <a:ln/>
            </p:spPr>
            <p:style>
              <a:lnRef idx="2">
                <a:schemeClr val="accent2">
                  <a:shade val="50000"/>
                </a:schemeClr>
              </a:lnRef>
              <a:fillRef idx="1">
                <a:schemeClr val="accent2"/>
              </a:fillRef>
              <a:effectRef idx="0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en-US"/>
              </a:p>
            </p:txBody>
          </p:sp>
          <p:grpSp>
            <p:nvGrpSpPr>
              <p:cNvPr id="26" name="Group 25">
                <a:extLst>
                  <a:ext uri="{FF2B5EF4-FFF2-40B4-BE49-F238E27FC236}">
                    <a16:creationId xmlns:a16="http://schemas.microsoft.com/office/drawing/2014/main" id="{2340C374-86E8-F74C-CDE1-BFF2AB7ADF81}"/>
                  </a:ext>
                </a:extLst>
              </p:cNvPr>
              <p:cNvGrpSpPr/>
              <p:nvPr/>
            </p:nvGrpSpPr>
            <p:grpSpPr>
              <a:xfrm>
                <a:off x="1854584" y="3442684"/>
                <a:ext cx="1734767" cy="918496"/>
                <a:chOff x="12738721" y="4116477"/>
                <a:chExt cx="1889389" cy="1200615"/>
              </a:xfrm>
            </p:grpSpPr>
            <p:sp>
              <p:nvSpPr>
                <p:cNvPr id="27" name="TextBox 26">
                  <a:extLst>
                    <a:ext uri="{FF2B5EF4-FFF2-40B4-BE49-F238E27FC236}">
                      <a16:creationId xmlns:a16="http://schemas.microsoft.com/office/drawing/2014/main" id="{A3FBD222-2E83-3001-0DAE-ADD7D1F38097}"/>
                    </a:ext>
                  </a:extLst>
                </p:cNvPr>
                <p:cNvSpPr txBox="1"/>
                <p:nvPr/>
              </p:nvSpPr>
              <p:spPr>
                <a:xfrm>
                  <a:off x="12853004" y="4116477"/>
                  <a:ext cx="1211270" cy="40231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>
                      <a:solidFill>
                        <a:schemeClr val="bg1"/>
                      </a:solidFill>
                    </a:rPr>
                    <a:t>PSYCHOSIS</a:t>
                  </a:r>
                </a:p>
              </p:txBody>
            </p:sp>
            <p:sp>
              <p:nvSpPr>
                <p:cNvPr id="28" name="TextBox 27">
                  <a:extLst>
                    <a:ext uri="{FF2B5EF4-FFF2-40B4-BE49-F238E27FC236}">
                      <a16:creationId xmlns:a16="http://schemas.microsoft.com/office/drawing/2014/main" id="{FF2E0408-029F-8699-C305-FAC2556F3A12}"/>
                    </a:ext>
                  </a:extLst>
                </p:cNvPr>
                <p:cNvSpPr txBox="1"/>
                <p:nvPr/>
              </p:nvSpPr>
              <p:spPr>
                <a:xfrm>
                  <a:off x="12738721" y="4532586"/>
                  <a:ext cx="1889389" cy="78450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dirty="0"/>
                    <a:t>Only in cases that could lead to hurting self or others</a:t>
                  </a:r>
                </a:p>
              </p:txBody>
            </p:sp>
          </p:grpSp>
        </p:grpSp>
      </p:grpSp>
      <p:sp>
        <p:nvSpPr>
          <p:cNvPr id="29" name="TextBox 28">
            <a:extLst>
              <a:ext uri="{FF2B5EF4-FFF2-40B4-BE49-F238E27FC236}">
                <a16:creationId xmlns:a16="http://schemas.microsoft.com/office/drawing/2014/main" id="{6E12ADA2-99CF-80DC-346F-8AB4A28F6090}"/>
              </a:ext>
            </a:extLst>
          </p:cNvPr>
          <p:cNvSpPr txBox="1"/>
          <p:nvPr/>
        </p:nvSpPr>
        <p:spPr>
          <a:xfrm>
            <a:off x="5523174" y="545841"/>
            <a:ext cx="1741144" cy="25545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regon’s </a:t>
            </a:r>
            <a:r>
              <a:rPr lang="en-US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ood Samaritan Laws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rotect people that report, witness, or experience an overdose. If police respond to an overdose in Oregon. You can’t be charged, served warrants or probation violations for being in a drug house or intent to sell. You can be arrested for other crimes.</a:t>
            </a:r>
            <a:endParaRPr lang="en-US" sz="1200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5B6CB59B-8ECF-B26C-0AD7-61C7C266BEF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ackgroundRemoval t="10000" b="90000" l="10000" r="9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149114" y="2105207"/>
            <a:ext cx="600165" cy="6001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664786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PRIME+ v2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652B91"/>
      </a:accent1>
      <a:accent2>
        <a:srgbClr val="B3A1D3"/>
      </a:accent2>
      <a:accent3>
        <a:srgbClr val="FBAE3D"/>
      </a:accent3>
      <a:accent4>
        <a:srgbClr val="0B8595"/>
      </a:accent4>
      <a:accent5>
        <a:srgbClr val="E7710F"/>
      </a:accent5>
      <a:accent6>
        <a:srgbClr val="075963"/>
      </a:accent6>
      <a:hlink>
        <a:srgbClr val="C7581B"/>
      </a:hlink>
      <a:folHlink>
        <a:srgbClr val="FF9933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352</TotalTime>
  <Words>512</Words>
  <Application>Microsoft Macintosh PowerPoint</Application>
  <PresentationFormat>Custom</PresentationFormat>
  <Paragraphs>91</Paragraphs>
  <Slides>4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Dreaming Outloud Pro</vt:lpstr>
      <vt:lpstr>Wingdings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yn Kappesser</dc:creator>
  <cp:lastModifiedBy>Linda Peng</cp:lastModifiedBy>
  <cp:revision>13</cp:revision>
  <dcterms:created xsi:type="dcterms:W3CDTF">2023-05-23T20:49:54Z</dcterms:created>
  <dcterms:modified xsi:type="dcterms:W3CDTF">2024-06-18T23:10:20Z</dcterms:modified>
</cp:coreProperties>
</file>